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20104100" cy="14224000"/>
  <p:notesSz cx="20104100" cy="1422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12" d="100"/>
          <a:sy n="212" d="100"/>
        </p:scale>
        <p:origin x="-10232" y="-8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1507807" y="4409440"/>
            <a:ext cx="17088486" cy="2987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3015615" y="7965440"/>
            <a:ext cx="14072870" cy="355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1005205" y="3271520"/>
            <a:ext cx="8745284" cy="93878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10353611" y="3271520"/>
            <a:ext cx="8745284" cy="93878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10483357" y="3753560"/>
            <a:ext cx="59690" cy="0"/>
          </a:xfrm>
          <a:custGeom>
            <a:avLst/>
            <a:gdLst/>
            <a:ahLst/>
            <a:cxnLst/>
            <a:rect l="l" t="t" r="r" b="b"/>
            <a:pathLst>
              <a:path w="59690">
                <a:moveTo>
                  <a:pt x="0" y="0"/>
                </a:moveTo>
                <a:lnTo>
                  <a:pt x="5965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bk object 17"/>
          <p:cNvSpPr/>
          <p:nvPr/>
        </p:nvSpPr>
        <p:spPr>
          <a:xfrm>
            <a:off x="10008316" y="375356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83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" name="bk object 18"/>
          <p:cNvSpPr/>
          <p:nvPr/>
        </p:nvSpPr>
        <p:spPr>
          <a:xfrm>
            <a:off x="5786574" y="8175812"/>
            <a:ext cx="2440940" cy="0"/>
          </a:xfrm>
          <a:custGeom>
            <a:avLst/>
            <a:gdLst/>
            <a:ahLst/>
            <a:cxnLst/>
            <a:rect l="l" t="t" r="r" b="b"/>
            <a:pathLst>
              <a:path w="2440940">
                <a:moveTo>
                  <a:pt x="2440405" y="0"/>
                </a:move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bk object 19"/>
          <p:cNvSpPr/>
          <p:nvPr/>
        </p:nvSpPr>
        <p:spPr>
          <a:xfrm>
            <a:off x="8215406" y="8117707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045" y="58105"/>
                </a:moveTo>
                <a:lnTo>
                  <a:pt x="0" y="0"/>
                </a:lnTo>
                <a:lnTo>
                  <a:pt x="0" y="116150"/>
                </a:lnTo>
                <a:lnTo>
                  <a:pt x="58045" y="58105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1005205" y="568960"/>
            <a:ext cx="18093690" cy="22758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1005205" y="3271520"/>
            <a:ext cx="18093690" cy="93878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6835394" y="13228320"/>
            <a:ext cx="6433312" cy="711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1005205" y="13228320"/>
            <a:ext cx="4623943" cy="711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6/20/20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14474953" y="13228320"/>
            <a:ext cx="4623943" cy="711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720117" y="405876"/>
            <a:ext cx="124396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46990" rIns="0" bIns="0" rtlCol="0">
            <a:spAutoFit/>
          </a:bodyPr>
          <a:lstStyle/>
          <a:p>
            <a:pPr marL="437515" marR="208279" indent="-219710">
              <a:lnSpc>
                <a:spcPts val="580"/>
              </a:lnSpc>
              <a:spcBef>
                <a:spcPts val="370"/>
              </a:spcBef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Algorithm: N17 Diagnosis  Proposi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9720117" y="1027695"/>
            <a:ext cx="1753235" cy="454025"/>
          </a:xfrm>
          <a:custGeom>
            <a:avLst/>
            <a:gdLst/>
            <a:ahLst/>
            <a:cxnLst/>
            <a:rect l="l" t="t" r="r" b="b"/>
            <a:pathLst>
              <a:path w="1753234" h="454025">
                <a:moveTo>
                  <a:pt x="0" y="0"/>
                </a:moveTo>
                <a:lnTo>
                  <a:pt x="0" y="453833"/>
                </a:lnTo>
                <a:lnTo>
                  <a:pt x="1753232" y="453833"/>
                </a:lnTo>
                <a:lnTo>
                  <a:pt x="1753232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 txBox="1"/>
          <p:nvPr/>
        </p:nvSpPr>
        <p:spPr>
          <a:xfrm>
            <a:off x="10824471" y="1325623"/>
            <a:ext cx="504825" cy="125730"/>
          </a:xfrm>
          <a:prstGeom prst="rect">
            <a:avLst/>
          </a:prstGeom>
          <a:solidFill>
            <a:srgbClr val="D7E3BF"/>
          </a:solidFill>
          <a:ln w="3175">
            <a:solidFill>
              <a:srgbClr val="231F20"/>
            </a:solidFill>
          </a:ln>
        </p:spPr>
        <p:txBody>
          <a:bodyPr vert="horz" wrap="square" lIns="0" tIns="4445" rIns="0" bIns="0" rtlCol="0">
            <a:spAutoFit/>
          </a:bodyPr>
          <a:lstStyle/>
          <a:p>
            <a:pPr marL="173355" marR="92075" indent="-69215">
              <a:lnSpc>
                <a:spcPct val="1137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Difference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in  Minutes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9762532" y="1064521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29209" rIns="0" bIns="0" rtlCol="0">
            <a:spAutoFit/>
          </a:bodyPr>
          <a:lstStyle/>
          <a:p>
            <a:pPr marL="114935" marR="48260" indent="-57785">
              <a:lnSpc>
                <a:spcPct val="113700"/>
              </a:lnSpc>
              <a:spcBef>
                <a:spcPts val="229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</a:t>
            </a:r>
            <a:r>
              <a:rPr sz="300" spc="-8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(Minutes)  First sCr</a:t>
            </a:r>
            <a:r>
              <a:rPr sz="300" spc="-3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9762532" y="1276389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29209" rIns="0" bIns="0" rtlCol="0">
            <a:spAutoFit/>
          </a:bodyPr>
          <a:lstStyle/>
          <a:p>
            <a:pPr marL="105410" marR="45720" indent="-46355">
              <a:lnSpc>
                <a:spcPct val="113700"/>
              </a:lnSpc>
              <a:spcBef>
                <a:spcPts val="229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(Minutes)  Second sCr</a:t>
            </a:r>
            <a:r>
              <a:rPr sz="300" spc="-3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10839146" y="1091694"/>
            <a:ext cx="480695" cy="121920"/>
          </a:xfrm>
          <a:custGeom>
            <a:avLst/>
            <a:gdLst/>
            <a:ahLst/>
            <a:cxnLst/>
            <a:rect l="l" t="t" r="r" b="b"/>
            <a:pathLst>
              <a:path w="480695" h="121919">
                <a:moveTo>
                  <a:pt x="480112" y="0"/>
                </a:moveTo>
                <a:lnTo>
                  <a:pt x="29887" y="0"/>
                </a:lnTo>
                <a:lnTo>
                  <a:pt x="0" y="121328"/>
                </a:lnTo>
                <a:lnTo>
                  <a:pt x="450224" y="121328"/>
                </a:lnTo>
                <a:lnTo>
                  <a:pt x="48011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10839146" y="1091694"/>
            <a:ext cx="480695" cy="121920"/>
          </a:xfrm>
          <a:custGeom>
            <a:avLst/>
            <a:gdLst/>
            <a:ahLst/>
            <a:cxnLst/>
            <a:rect l="l" t="t" r="r" b="b"/>
            <a:pathLst>
              <a:path w="480695" h="121919">
                <a:moveTo>
                  <a:pt x="0" y="121328"/>
                </a:moveTo>
                <a:lnTo>
                  <a:pt x="450224" y="121328"/>
                </a:lnTo>
                <a:lnTo>
                  <a:pt x="480112" y="0"/>
                </a:lnTo>
                <a:lnTo>
                  <a:pt x="29887" y="0"/>
                </a:lnTo>
                <a:lnTo>
                  <a:pt x="0" y="12132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 txBox="1"/>
          <p:nvPr/>
        </p:nvSpPr>
        <p:spPr>
          <a:xfrm>
            <a:off x="10920515" y="1091587"/>
            <a:ext cx="334645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22860" marR="5080" indent="-23495">
              <a:lnSpc>
                <a:spcPct val="113700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2</a:t>
            </a:r>
            <a:r>
              <a:rPr sz="300" spc="-9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–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</a:t>
            </a:r>
            <a:r>
              <a:rPr sz="300" spc="-6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1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10334873" y="1151571"/>
            <a:ext cx="492125" cy="0"/>
          </a:xfrm>
          <a:custGeom>
            <a:avLst/>
            <a:gdLst/>
            <a:ahLst/>
            <a:cxnLst/>
            <a:rect l="l" t="t" r="r" b="b"/>
            <a:pathLst>
              <a:path w="492125">
                <a:moveTo>
                  <a:pt x="0" y="0"/>
                </a:moveTo>
                <a:lnTo>
                  <a:pt x="492103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10823933" y="1136305"/>
            <a:ext cx="15240" cy="31115"/>
          </a:xfrm>
          <a:custGeom>
            <a:avLst/>
            <a:gdLst/>
            <a:ahLst/>
            <a:cxnLst/>
            <a:rect l="l" t="t" r="r" b="b"/>
            <a:pathLst>
              <a:path w="15240" h="31115">
                <a:moveTo>
                  <a:pt x="15212" y="15265"/>
                </a:moveTo>
                <a:lnTo>
                  <a:pt x="0" y="0"/>
                </a:lnTo>
                <a:lnTo>
                  <a:pt x="0" y="30531"/>
                </a:lnTo>
                <a:lnTo>
                  <a:pt x="15212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10337020" y="1151571"/>
            <a:ext cx="60960" cy="212090"/>
          </a:xfrm>
          <a:custGeom>
            <a:avLst/>
            <a:gdLst/>
            <a:ahLst/>
            <a:cxnLst/>
            <a:rect l="l" t="t" r="r" b="b"/>
            <a:pathLst>
              <a:path w="60959" h="212090">
                <a:moveTo>
                  <a:pt x="0" y="211826"/>
                </a:moveTo>
                <a:lnTo>
                  <a:pt x="60729" y="211826"/>
                </a:lnTo>
                <a:lnTo>
                  <a:pt x="6072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11076637" y="1213022"/>
            <a:ext cx="0" cy="100965"/>
          </a:xfrm>
          <a:custGeom>
            <a:avLst/>
            <a:gdLst/>
            <a:ahLst/>
            <a:cxnLst/>
            <a:rect l="l" t="t" r="r" b="b"/>
            <a:pathLst>
              <a:path h="100965">
                <a:moveTo>
                  <a:pt x="0" y="0"/>
                </a:moveTo>
                <a:lnTo>
                  <a:pt x="0" y="100413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11061365" y="1310363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 txBox="1"/>
          <p:nvPr/>
        </p:nvSpPr>
        <p:spPr>
          <a:xfrm>
            <a:off x="10804366" y="2217810"/>
            <a:ext cx="520700" cy="125730"/>
          </a:xfrm>
          <a:prstGeom prst="rect">
            <a:avLst/>
          </a:prstGeom>
          <a:solidFill>
            <a:srgbClr val="D7E3BF"/>
          </a:solidFill>
          <a:ln w="3175">
            <a:solidFill>
              <a:srgbClr val="231F20"/>
            </a:solidFill>
          </a:ln>
        </p:spPr>
        <p:txBody>
          <a:bodyPr vert="horz" wrap="square" lIns="0" tIns="127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"/>
              </a:spcBef>
            </a:pPr>
            <a:endParaRPr sz="250">
              <a:latin typeface="Times New Roman"/>
              <a:cs typeface="Times New Roman"/>
            </a:endParaRPr>
          </a:p>
          <a:p>
            <a:pPr marL="4381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Increase in</a:t>
            </a:r>
            <a:r>
              <a:rPr sz="300" spc="-3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ercent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9762532" y="1956707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17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5"/>
              </a:spcBef>
            </a:pPr>
            <a:endParaRPr sz="400">
              <a:latin typeface="Times New Roman"/>
              <a:cs typeface="Times New Roman"/>
            </a:endParaRPr>
          </a:p>
          <a:p>
            <a:pPr marL="11493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rst sCr</a:t>
            </a:r>
            <a:r>
              <a:rPr sz="3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9762532" y="2168534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17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5"/>
              </a:spcBef>
            </a:pPr>
            <a:endParaRPr sz="400">
              <a:latin typeface="Times New Roman"/>
              <a:cs typeface="Times New Roman"/>
            </a:endParaRPr>
          </a:p>
          <a:p>
            <a:pPr marL="105410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econd sCr</a:t>
            </a:r>
            <a:r>
              <a:rPr sz="300" spc="-2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10772868" y="1973220"/>
            <a:ext cx="626110" cy="141605"/>
          </a:xfrm>
          <a:custGeom>
            <a:avLst/>
            <a:gdLst/>
            <a:ahLst/>
            <a:cxnLst/>
            <a:rect l="l" t="t" r="r" b="b"/>
            <a:pathLst>
              <a:path w="626109" h="141605">
                <a:moveTo>
                  <a:pt x="626090" y="0"/>
                </a:moveTo>
                <a:lnTo>
                  <a:pt x="38955" y="0"/>
                </a:lnTo>
                <a:lnTo>
                  <a:pt x="0" y="141026"/>
                </a:lnTo>
                <a:lnTo>
                  <a:pt x="587135" y="141026"/>
                </a:lnTo>
                <a:lnTo>
                  <a:pt x="626090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10772868" y="1973220"/>
            <a:ext cx="626110" cy="141605"/>
          </a:xfrm>
          <a:custGeom>
            <a:avLst/>
            <a:gdLst/>
            <a:ahLst/>
            <a:cxnLst/>
            <a:rect l="l" t="t" r="r" b="b"/>
            <a:pathLst>
              <a:path w="626109" h="141605">
                <a:moveTo>
                  <a:pt x="0" y="141026"/>
                </a:moveTo>
                <a:lnTo>
                  <a:pt x="587135" y="141026"/>
                </a:lnTo>
                <a:lnTo>
                  <a:pt x="626090" y="0"/>
                </a:lnTo>
                <a:lnTo>
                  <a:pt x="38955" y="0"/>
                </a:lnTo>
                <a:lnTo>
                  <a:pt x="0" y="14102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/>
          <p:nvPr/>
        </p:nvSpPr>
        <p:spPr>
          <a:xfrm>
            <a:off x="9720117" y="1919881"/>
            <a:ext cx="1753235" cy="454025"/>
          </a:xfrm>
          <a:prstGeom prst="rect">
            <a:avLst/>
          </a:prstGeom>
          <a:ln w="6580">
            <a:solidFill>
              <a:srgbClr val="231F2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endParaRPr sz="300">
              <a:latin typeface="Times New Roman"/>
              <a:cs typeface="Times New Roman"/>
            </a:endParaRPr>
          </a:p>
          <a:p>
            <a:pPr marL="982344" algn="ctr">
              <a:lnSpc>
                <a:spcPct val="100000"/>
              </a:lnSpc>
              <a:spcBef>
                <a:spcPts val="21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100/</a:t>
            </a:r>
            <a:endParaRPr sz="300">
              <a:latin typeface="Consolas"/>
              <a:cs typeface="Consolas"/>
            </a:endParaRPr>
          </a:p>
          <a:p>
            <a:pPr marL="982344"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(Value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1 *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2)</a:t>
            </a:r>
            <a:r>
              <a:rPr sz="300" spc="10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-</a:t>
            </a:r>
            <a:endParaRPr sz="300">
              <a:latin typeface="Consolas"/>
              <a:cs typeface="Consolas"/>
            </a:endParaRPr>
          </a:p>
          <a:p>
            <a:pPr marL="981710"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100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21" name="object 21"/>
          <p:cNvSpPr/>
          <p:nvPr/>
        </p:nvSpPr>
        <p:spPr>
          <a:xfrm>
            <a:off x="10334873" y="2043715"/>
            <a:ext cx="424180" cy="0"/>
          </a:xfrm>
          <a:custGeom>
            <a:avLst/>
            <a:gdLst/>
            <a:ahLst/>
            <a:cxnLst/>
            <a:rect l="l" t="t" r="r" b="b"/>
            <a:pathLst>
              <a:path w="424179">
                <a:moveTo>
                  <a:pt x="0" y="0"/>
                </a:moveTo>
                <a:lnTo>
                  <a:pt x="423737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" name="object 22"/>
          <p:cNvSpPr/>
          <p:nvPr/>
        </p:nvSpPr>
        <p:spPr>
          <a:xfrm>
            <a:off x="10755508" y="202845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15265"/>
                </a:moveTo>
                <a:lnTo>
                  <a:pt x="0" y="0"/>
                </a:lnTo>
                <a:lnTo>
                  <a:pt x="0" y="30526"/>
                </a:lnTo>
                <a:lnTo>
                  <a:pt x="15271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" name="object 23"/>
          <p:cNvSpPr/>
          <p:nvPr/>
        </p:nvSpPr>
        <p:spPr>
          <a:xfrm>
            <a:off x="10337020" y="2043715"/>
            <a:ext cx="60960" cy="212090"/>
          </a:xfrm>
          <a:custGeom>
            <a:avLst/>
            <a:gdLst/>
            <a:ahLst/>
            <a:cxnLst/>
            <a:rect l="l" t="t" r="r" b="b"/>
            <a:pathLst>
              <a:path w="60959" h="212089">
                <a:moveTo>
                  <a:pt x="0" y="211868"/>
                </a:moveTo>
                <a:lnTo>
                  <a:pt x="60729" y="211868"/>
                </a:lnTo>
                <a:lnTo>
                  <a:pt x="6072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" name="object 24"/>
          <p:cNvSpPr/>
          <p:nvPr/>
        </p:nvSpPr>
        <p:spPr>
          <a:xfrm>
            <a:off x="11066436" y="2114247"/>
            <a:ext cx="0" cy="91440"/>
          </a:xfrm>
          <a:custGeom>
            <a:avLst/>
            <a:gdLst/>
            <a:ahLst/>
            <a:cxnLst/>
            <a:rect l="l" t="t" r="r" b="b"/>
            <a:pathLst>
              <a:path h="91439">
                <a:moveTo>
                  <a:pt x="0" y="0"/>
                </a:moveTo>
                <a:lnTo>
                  <a:pt x="0" y="91327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" name="object 25"/>
          <p:cNvSpPr/>
          <p:nvPr/>
        </p:nvSpPr>
        <p:spPr>
          <a:xfrm>
            <a:off x="11051164" y="2202550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" name="object 26"/>
          <p:cNvSpPr txBox="1"/>
          <p:nvPr/>
        </p:nvSpPr>
        <p:spPr>
          <a:xfrm>
            <a:off x="12702921" y="1325933"/>
            <a:ext cx="574040" cy="125730"/>
          </a:xfrm>
          <a:prstGeom prst="rect">
            <a:avLst/>
          </a:prstGeom>
          <a:solidFill>
            <a:srgbClr val="D7E3BF"/>
          </a:solidFill>
          <a:ln w="3175">
            <a:solidFill>
              <a:srgbClr val="231F20"/>
            </a:solidFill>
          </a:ln>
        </p:spPr>
        <p:txBody>
          <a:bodyPr vert="horz" wrap="square" lIns="0" tIns="127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10"/>
              </a:spcBef>
            </a:pPr>
            <a:endParaRPr sz="250">
              <a:latin typeface="Times New Roman"/>
              <a:cs typeface="Times New Roman"/>
            </a:endParaRPr>
          </a:p>
          <a:p>
            <a:pPr marL="29209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lternate Increase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</a:t>
            </a:r>
            <a:r>
              <a:rPr sz="300" spc="-1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ercent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11689871" y="1064521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17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5"/>
              </a:spcBef>
            </a:pPr>
            <a:endParaRPr sz="400">
              <a:latin typeface="Times New Roman"/>
              <a:cs typeface="Times New Roman"/>
            </a:endParaRPr>
          </a:p>
          <a:p>
            <a:pPr marL="115570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rst sCr</a:t>
            </a:r>
            <a:r>
              <a:rPr sz="3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11689871" y="1276389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17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5"/>
              </a:spcBef>
            </a:pPr>
            <a:endParaRPr sz="400">
              <a:latin typeface="Times New Roman"/>
              <a:cs typeface="Times New Roman"/>
            </a:endParaRPr>
          </a:p>
          <a:p>
            <a:pPr marL="10604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econd sCr</a:t>
            </a:r>
            <a:r>
              <a:rPr sz="300" spc="-2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29" name="object 29"/>
          <p:cNvSpPr/>
          <p:nvPr/>
        </p:nvSpPr>
        <p:spPr>
          <a:xfrm>
            <a:off x="12800697" y="1064497"/>
            <a:ext cx="398145" cy="191135"/>
          </a:xfrm>
          <a:custGeom>
            <a:avLst/>
            <a:gdLst/>
            <a:ahLst/>
            <a:cxnLst/>
            <a:rect l="l" t="t" r="r" b="b"/>
            <a:pathLst>
              <a:path w="398144" h="191134">
                <a:moveTo>
                  <a:pt x="397906" y="0"/>
                </a:moveTo>
                <a:lnTo>
                  <a:pt x="24757" y="0"/>
                </a:lnTo>
                <a:lnTo>
                  <a:pt x="0" y="190947"/>
                </a:lnTo>
                <a:lnTo>
                  <a:pt x="373208" y="190947"/>
                </a:lnTo>
                <a:lnTo>
                  <a:pt x="39790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" name="object 30"/>
          <p:cNvSpPr/>
          <p:nvPr/>
        </p:nvSpPr>
        <p:spPr>
          <a:xfrm>
            <a:off x="12800697" y="1064497"/>
            <a:ext cx="398145" cy="191135"/>
          </a:xfrm>
          <a:custGeom>
            <a:avLst/>
            <a:gdLst/>
            <a:ahLst/>
            <a:cxnLst/>
            <a:rect l="l" t="t" r="r" b="b"/>
            <a:pathLst>
              <a:path w="398144" h="191134">
                <a:moveTo>
                  <a:pt x="0" y="190947"/>
                </a:moveTo>
                <a:lnTo>
                  <a:pt x="373208" y="190947"/>
                </a:lnTo>
                <a:lnTo>
                  <a:pt x="397906" y="0"/>
                </a:lnTo>
                <a:lnTo>
                  <a:pt x="24757" y="0"/>
                </a:lnTo>
                <a:lnTo>
                  <a:pt x="0" y="19094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" name="object 31"/>
          <p:cNvSpPr txBox="1"/>
          <p:nvPr/>
        </p:nvSpPr>
        <p:spPr>
          <a:xfrm>
            <a:off x="11647427" y="1027695"/>
            <a:ext cx="1753870" cy="454025"/>
          </a:xfrm>
          <a:prstGeom prst="rect">
            <a:avLst/>
          </a:prstGeom>
          <a:ln w="6580">
            <a:solidFill>
              <a:srgbClr val="231F20"/>
            </a:solidFill>
          </a:ln>
        </p:spPr>
        <p:txBody>
          <a:bodyPr vert="horz" wrap="square" lIns="0" tIns="254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0"/>
              </a:spcBef>
            </a:pPr>
            <a:endParaRPr sz="350">
              <a:latin typeface="Times New Roman"/>
              <a:cs typeface="Times New Roman"/>
            </a:endParaRPr>
          </a:p>
          <a:p>
            <a:pPr marL="978535" algn="ctr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100</a:t>
            </a:r>
            <a:r>
              <a:rPr sz="300" spc="15" dirty="0">
                <a:solidFill>
                  <a:srgbClr val="949698"/>
                </a:solidFill>
                <a:latin typeface="Consolas"/>
                <a:cs typeface="Consolas"/>
              </a:rPr>
              <a:t>/</a:t>
            </a:r>
            <a:endParaRPr sz="300">
              <a:latin typeface="Consolas"/>
              <a:cs typeface="Consolas"/>
            </a:endParaRPr>
          </a:p>
          <a:p>
            <a:pPr marL="955675"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2</a:t>
            </a:r>
            <a:r>
              <a:rPr sz="300" spc="-1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949698"/>
                </a:solidFill>
                <a:latin typeface="Consolas"/>
                <a:cs typeface="Consolas"/>
              </a:rPr>
              <a:t>*</a:t>
            </a:r>
            <a:endParaRPr sz="300">
              <a:latin typeface="Consolas"/>
              <a:cs typeface="Consolas"/>
            </a:endParaRPr>
          </a:p>
          <a:p>
            <a:pPr marL="955675"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949698"/>
                </a:solidFill>
                <a:latin typeface="Consolas"/>
                <a:cs typeface="Consolas"/>
              </a:rPr>
              <a:t>(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2</a:t>
            </a:r>
            <a:r>
              <a:rPr sz="300" spc="15" dirty="0">
                <a:solidFill>
                  <a:srgbClr val="949698"/>
                </a:solidFill>
                <a:latin typeface="Consolas"/>
                <a:cs typeface="Consolas"/>
              </a:rPr>
              <a:t>–</a:t>
            </a:r>
            <a:r>
              <a:rPr sz="300" spc="-15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  <a:p>
            <a:pPr marL="955675" algn="ctr">
              <a:lnSpc>
                <a:spcPct val="100000"/>
              </a:lnSpc>
              <a:spcBef>
                <a:spcPts val="5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1</a:t>
            </a:r>
            <a:r>
              <a:rPr sz="300" spc="15" dirty="0">
                <a:solidFill>
                  <a:srgbClr val="949698"/>
                </a:solidFill>
                <a:latin typeface="Consolas"/>
                <a:cs typeface="Consolas"/>
              </a:rPr>
              <a:t>)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32" name="object 32"/>
          <p:cNvSpPr/>
          <p:nvPr/>
        </p:nvSpPr>
        <p:spPr>
          <a:xfrm>
            <a:off x="12262242" y="1151571"/>
            <a:ext cx="529590" cy="0"/>
          </a:xfrm>
          <a:custGeom>
            <a:avLst/>
            <a:gdLst/>
            <a:ahLst/>
            <a:cxnLst/>
            <a:rect l="l" t="t" r="r" b="b"/>
            <a:pathLst>
              <a:path w="529590">
                <a:moveTo>
                  <a:pt x="0" y="0"/>
                </a:moveTo>
                <a:lnTo>
                  <a:pt x="529328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12788587" y="1136305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65"/>
                </a:moveTo>
                <a:lnTo>
                  <a:pt x="0" y="0"/>
                </a:lnTo>
                <a:lnTo>
                  <a:pt x="0" y="30531"/>
                </a:lnTo>
                <a:lnTo>
                  <a:pt x="15271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12264390" y="1151571"/>
            <a:ext cx="60960" cy="212090"/>
          </a:xfrm>
          <a:custGeom>
            <a:avLst/>
            <a:gdLst/>
            <a:ahLst/>
            <a:cxnLst/>
            <a:rect l="l" t="t" r="r" b="b"/>
            <a:pathLst>
              <a:path w="60959" h="212090">
                <a:moveTo>
                  <a:pt x="0" y="211826"/>
                </a:moveTo>
                <a:lnTo>
                  <a:pt x="60670" y="211826"/>
                </a:lnTo>
                <a:lnTo>
                  <a:pt x="6067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/>
          <p:nvPr/>
        </p:nvSpPr>
        <p:spPr>
          <a:xfrm>
            <a:off x="12987242" y="1255444"/>
            <a:ext cx="635" cy="53340"/>
          </a:xfrm>
          <a:custGeom>
            <a:avLst/>
            <a:gdLst/>
            <a:ahLst/>
            <a:cxnLst/>
            <a:rect l="l" t="t" r="r" b="b"/>
            <a:pathLst>
              <a:path w="634" h="53340">
                <a:moveTo>
                  <a:pt x="59" y="0"/>
                </a:moveTo>
                <a:lnTo>
                  <a:pt x="0" y="53296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" name="object 36"/>
          <p:cNvSpPr/>
          <p:nvPr/>
        </p:nvSpPr>
        <p:spPr>
          <a:xfrm>
            <a:off x="12971970" y="130571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" name="object 37"/>
          <p:cNvSpPr/>
          <p:nvPr/>
        </p:nvSpPr>
        <p:spPr>
          <a:xfrm>
            <a:off x="10604697" y="2845732"/>
            <a:ext cx="234315" cy="174625"/>
          </a:xfrm>
          <a:custGeom>
            <a:avLst/>
            <a:gdLst/>
            <a:ahLst/>
            <a:cxnLst/>
            <a:rect l="l" t="t" r="r" b="b"/>
            <a:pathLst>
              <a:path w="234315" h="174625">
                <a:moveTo>
                  <a:pt x="0" y="0"/>
                </a:moveTo>
                <a:lnTo>
                  <a:pt x="0" y="174082"/>
                </a:lnTo>
                <a:lnTo>
                  <a:pt x="233792" y="174082"/>
                </a:lnTo>
                <a:lnTo>
                  <a:pt x="23379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" name="object 38"/>
          <p:cNvSpPr/>
          <p:nvPr/>
        </p:nvSpPr>
        <p:spPr>
          <a:xfrm>
            <a:off x="10606845" y="3057606"/>
            <a:ext cx="234315" cy="174625"/>
          </a:xfrm>
          <a:custGeom>
            <a:avLst/>
            <a:gdLst/>
            <a:ahLst/>
            <a:cxnLst/>
            <a:rect l="l" t="t" r="r" b="b"/>
            <a:pathLst>
              <a:path w="234315" h="174625">
                <a:moveTo>
                  <a:pt x="0" y="0"/>
                </a:moveTo>
                <a:lnTo>
                  <a:pt x="0" y="174076"/>
                </a:lnTo>
                <a:lnTo>
                  <a:pt x="233792" y="174076"/>
                </a:lnTo>
                <a:lnTo>
                  <a:pt x="23379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" name="object 39"/>
          <p:cNvSpPr/>
          <p:nvPr/>
        </p:nvSpPr>
        <p:spPr>
          <a:xfrm>
            <a:off x="10838490" y="2932782"/>
            <a:ext cx="361950" cy="0"/>
          </a:xfrm>
          <a:custGeom>
            <a:avLst/>
            <a:gdLst/>
            <a:ahLst/>
            <a:cxnLst/>
            <a:rect l="l" t="t" r="r" b="b"/>
            <a:pathLst>
              <a:path w="361950">
                <a:moveTo>
                  <a:pt x="0" y="0"/>
                </a:moveTo>
                <a:lnTo>
                  <a:pt x="36151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" name="object 40"/>
          <p:cNvSpPr/>
          <p:nvPr/>
        </p:nvSpPr>
        <p:spPr>
          <a:xfrm>
            <a:off x="11196963" y="291751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15265"/>
                </a:moveTo>
                <a:lnTo>
                  <a:pt x="0" y="0"/>
                </a:lnTo>
                <a:lnTo>
                  <a:pt x="0" y="30531"/>
                </a:lnTo>
                <a:lnTo>
                  <a:pt x="15271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" name="object 41"/>
          <p:cNvSpPr/>
          <p:nvPr/>
        </p:nvSpPr>
        <p:spPr>
          <a:xfrm>
            <a:off x="10840637" y="2932782"/>
            <a:ext cx="247650" cy="212090"/>
          </a:xfrm>
          <a:custGeom>
            <a:avLst/>
            <a:gdLst/>
            <a:ahLst/>
            <a:cxnLst/>
            <a:rect l="l" t="t" r="r" b="b"/>
            <a:pathLst>
              <a:path w="247650" h="212089">
                <a:moveTo>
                  <a:pt x="0" y="211874"/>
                </a:moveTo>
                <a:lnTo>
                  <a:pt x="247274" y="211874"/>
                </a:lnTo>
                <a:lnTo>
                  <a:pt x="247274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" name="object 42"/>
          <p:cNvSpPr/>
          <p:nvPr/>
        </p:nvSpPr>
        <p:spPr>
          <a:xfrm>
            <a:off x="11212235" y="2821368"/>
            <a:ext cx="440690" cy="226695"/>
          </a:xfrm>
          <a:custGeom>
            <a:avLst/>
            <a:gdLst/>
            <a:ahLst/>
            <a:cxnLst/>
            <a:rect l="l" t="t" r="r" b="b"/>
            <a:pathLst>
              <a:path w="440690" h="226694">
                <a:moveTo>
                  <a:pt x="440142" y="113131"/>
                </a:moveTo>
                <a:lnTo>
                  <a:pt x="220071" y="0"/>
                </a:lnTo>
                <a:lnTo>
                  <a:pt x="0" y="113131"/>
                </a:lnTo>
                <a:lnTo>
                  <a:pt x="220071" y="226263"/>
                </a:lnTo>
                <a:lnTo>
                  <a:pt x="440142" y="11313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/>
          <p:nvPr/>
        </p:nvSpPr>
        <p:spPr>
          <a:xfrm>
            <a:off x="11212235" y="2821368"/>
            <a:ext cx="440690" cy="226695"/>
          </a:xfrm>
          <a:custGeom>
            <a:avLst/>
            <a:gdLst/>
            <a:ahLst/>
            <a:cxnLst/>
            <a:rect l="l" t="t" r="r" b="b"/>
            <a:pathLst>
              <a:path w="440690" h="226694">
                <a:moveTo>
                  <a:pt x="220071" y="226263"/>
                </a:moveTo>
                <a:lnTo>
                  <a:pt x="440142" y="113131"/>
                </a:lnTo>
                <a:lnTo>
                  <a:pt x="220071" y="0"/>
                </a:lnTo>
                <a:lnTo>
                  <a:pt x="0" y="113131"/>
                </a:lnTo>
                <a:lnTo>
                  <a:pt x="220071" y="226263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" name="object 44"/>
          <p:cNvSpPr/>
          <p:nvPr/>
        </p:nvSpPr>
        <p:spPr>
          <a:xfrm>
            <a:off x="12023140" y="2910101"/>
            <a:ext cx="340360" cy="51435"/>
          </a:xfrm>
          <a:custGeom>
            <a:avLst/>
            <a:gdLst/>
            <a:ahLst/>
            <a:cxnLst/>
            <a:rect l="l" t="t" r="r" b="b"/>
            <a:pathLst>
              <a:path w="340359" h="51435">
                <a:moveTo>
                  <a:pt x="0" y="0"/>
                </a:moveTo>
                <a:lnTo>
                  <a:pt x="0" y="51280"/>
                </a:lnTo>
                <a:lnTo>
                  <a:pt x="339860" y="51280"/>
                </a:lnTo>
                <a:lnTo>
                  <a:pt x="33986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" name="object 45"/>
          <p:cNvSpPr/>
          <p:nvPr/>
        </p:nvSpPr>
        <p:spPr>
          <a:xfrm>
            <a:off x="12023677" y="3088854"/>
            <a:ext cx="340360" cy="51435"/>
          </a:xfrm>
          <a:custGeom>
            <a:avLst/>
            <a:gdLst/>
            <a:ahLst/>
            <a:cxnLst/>
            <a:rect l="l" t="t" r="r" b="b"/>
            <a:pathLst>
              <a:path w="340359" h="51435">
                <a:moveTo>
                  <a:pt x="0" y="0"/>
                </a:moveTo>
                <a:lnTo>
                  <a:pt x="0" y="51280"/>
                </a:lnTo>
                <a:lnTo>
                  <a:pt x="339860" y="51280"/>
                </a:lnTo>
                <a:lnTo>
                  <a:pt x="33986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" name="object 46"/>
          <p:cNvSpPr/>
          <p:nvPr/>
        </p:nvSpPr>
        <p:spPr>
          <a:xfrm>
            <a:off x="12448548" y="2935708"/>
            <a:ext cx="340360" cy="0"/>
          </a:xfrm>
          <a:custGeom>
            <a:avLst/>
            <a:gdLst/>
            <a:ahLst/>
            <a:cxnLst/>
            <a:rect l="l" t="t" r="r" b="b"/>
            <a:pathLst>
              <a:path w="340359">
                <a:moveTo>
                  <a:pt x="0" y="0"/>
                </a:moveTo>
                <a:lnTo>
                  <a:pt x="339801" y="0"/>
                </a:lnTo>
              </a:path>
            </a:pathLst>
          </a:custGeom>
          <a:ln w="74253">
            <a:solidFill>
              <a:srgbClr val="D7E3B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" name="object 47"/>
          <p:cNvSpPr/>
          <p:nvPr/>
        </p:nvSpPr>
        <p:spPr>
          <a:xfrm>
            <a:off x="12448547" y="2898581"/>
            <a:ext cx="340360" cy="74295"/>
          </a:xfrm>
          <a:custGeom>
            <a:avLst/>
            <a:gdLst/>
            <a:ahLst/>
            <a:cxnLst/>
            <a:rect l="l" t="t" r="r" b="b"/>
            <a:pathLst>
              <a:path w="340359" h="74294">
                <a:moveTo>
                  <a:pt x="0" y="0"/>
                </a:moveTo>
                <a:lnTo>
                  <a:pt x="0" y="74253"/>
                </a:lnTo>
                <a:lnTo>
                  <a:pt x="339801" y="74253"/>
                </a:lnTo>
                <a:lnTo>
                  <a:pt x="33980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" name="object 48"/>
          <p:cNvSpPr txBox="1"/>
          <p:nvPr/>
        </p:nvSpPr>
        <p:spPr>
          <a:xfrm>
            <a:off x="12702921" y="2211886"/>
            <a:ext cx="610870" cy="125730"/>
          </a:xfrm>
          <a:prstGeom prst="rect">
            <a:avLst/>
          </a:prstGeom>
          <a:solidFill>
            <a:srgbClr val="D7E3BF"/>
          </a:solidFill>
          <a:ln w="3175">
            <a:solidFill>
              <a:srgbClr val="231F20"/>
            </a:solidFill>
          </a:ln>
        </p:spPr>
        <p:txBody>
          <a:bodyPr vert="horz" wrap="square" lIns="0" tIns="5080" rIns="0" bIns="0" rtlCol="0">
            <a:spAutoFit/>
          </a:bodyPr>
          <a:lstStyle/>
          <a:p>
            <a:pPr marL="260985" marR="55244" indent="-194945">
              <a:lnSpc>
                <a:spcPct val="113700"/>
              </a:lnSpc>
              <a:spcBef>
                <a:spcPts val="4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Relative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Increase</a:t>
            </a:r>
            <a:r>
              <a:rPr sz="300" spc="-6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  Hour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49" name="object 49"/>
          <p:cNvSpPr/>
          <p:nvPr/>
        </p:nvSpPr>
        <p:spPr>
          <a:xfrm>
            <a:off x="12604846" y="1975326"/>
            <a:ext cx="783590" cy="125730"/>
          </a:xfrm>
          <a:custGeom>
            <a:avLst/>
            <a:gdLst/>
            <a:ahLst/>
            <a:cxnLst/>
            <a:rect l="l" t="t" r="r" b="b"/>
            <a:pathLst>
              <a:path w="783590" h="125730">
                <a:moveTo>
                  <a:pt x="783403" y="0"/>
                </a:moveTo>
                <a:lnTo>
                  <a:pt x="48739" y="0"/>
                </a:lnTo>
                <a:lnTo>
                  <a:pt x="0" y="125277"/>
                </a:lnTo>
                <a:lnTo>
                  <a:pt x="734664" y="125277"/>
                </a:lnTo>
                <a:lnTo>
                  <a:pt x="783403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" name="object 50"/>
          <p:cNvSpPr/>
          <p:nvPr/>
        </p:nvSpPr>
        <p:spPr>
          <a:xfrm>
            <a:off x="12604846" y="1975326"/>
            <a:ext cx="783590" cy="125730"/>
          </a:xfrm>
          <a:custGeom>
            <a:avLst/>
            <a:gdLst/>
            <a:ahLst/>
            <a:cxnLst/>
            <a:rect l="l" t="t" r="r" b="b"/>
            <a:pathLst>
              <a:path w="783590" h="125730">
                <a:moveTo>
                  <a:pt x="0" y="125277"/>
                </a:moveTo>
                <a:lnTo>
                  <a:pt x="734664" y="125277"/>
                </a:lnTo>
                <a:lnTo>
                  <a:pt x="783403" y="0"/>
                </a:lnTo>
                <a:lnTo>
                  <a:pt x="48739" y="0"/>
                </a:lnTo>
                <a:lnTo>
                  <a:pt x="0" y="12527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" name="object 51"/>
          <p:cNvSpPr txBox="1"/>
          <p:nvPr/>
        </p:nvSpPr>
        <p:spPr>
          <a:xfrm>
            <a:off x="11647427" y="1913653"/>
            <a:ext cx="1753870" cy="454025"/>
          </a:xfrm>
          <a:prstGeom prst="rect">
            <a:avLst/>
          </a:prstGeom>
          <a:ln w="6580">
            <a:solidFill>
              <a:srgbClr val="231F2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endParaRPr sz="300">
              <a:latin typeface="Times New Roman"/>
              <a:cs typeface="Times New Roman"/>
            </a:endParaRPr>
          </a:p>
          <a:p>
            <a:pPr marL="1041400" marR="61594">
              <a:lnSpc>
                <a:spcPct val="113700"/>
              </a:lnSpc>
              <a:spcBef>
                <a:spcPts val="225"/>
              </a:spcBef>
            </a:pPr>
            <a:r>
              <a:rPr sz="300" spc="10" dirty="0">
                <a:solidFill>
                  <a:srgbClr val="949698"/>
                </a:solidFill>
                <a:latin typeface="Consolas"/>
                <a:cs typeface="Consolas"/>
              </a:rPr>
              <a:t>((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100</a:t>
            </a:r>
            <a:r>
              <a:rPr sz="300" spc="10" dirty="0">
                <a:solidFill>
                  <a:srgbClr val="949698"/>
                </a:solidFill>
                <a:latin typeface="Consolas"/>
                <a:cs typeface="Consolas"/>
              </a:rPr>
              <a:t>/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1 </a:t>
            </a:r>
            <a:r>
              <a:rPr sz="300" spc="20" dirty="0">
                <a:solidFill>
                  <a:srgbClr val="949698"/>
                </a:solidFill>
                <a:latin typeface="Consolas"/>
                <a:cs typeface="Consolas"/>
              </a:rPr>
              <a:t>*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2</a:t>
            </a:r>
            <a:r>
              <a:rPr sz="300" spc="10" dirty="0">
                <a:solidFill>
                  <a:srgbClr val="949698"/>
                </a:solidFill>
                <a:latin typeface="Consolas"/>
                <a:cs typeface="Consolas"/>
              </a:rPr>
              <a:t>)-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100</a:t>
            </a:r>
            <a:r>
              <a:rPr sz="300" spc="10" dirty="0">
                <a:solidFill>
                  <a:srgbClr val="949698"/>
                </a:solidFill>
                <a:latin typeface="Consolas"/>
                <a:cs typeface="Consolas"/>
              </a:rPr>
              <a:t>)/  </a:t>
            </a:r>
            <a:r>
              <a:rPr sz="300" spc="15" dirty="0">
                <a:solidFill>
                  <a:srgbClr val="949698"/>
                </a:solidFill>
                <a:latin typeface="Consolas"/>
                <a:cs typeface="Consolas"/>
              </a:rPr>
              <a:t>(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2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–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30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1</a:t>
            </a:r>
            <a:r>
              <a:rPr sz="300" spc="10" dirty="0">
                <a:solidFill>
                  <a:srgbClr val="949698"/>
                </a:solidFill>
                <a:latin typeface="Consolas"/>
                <a:cs typeface="Consolas"/>
              </a:rPr>
              <a:t>)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2" name="object 52"/>
          <p:cNvSpPr/>
          <p:nvPr/>
        </p:nvSpPr>
        <p:spPr>
          <a:xfrm>
            <a:off x="12374455" y="2010284"/>
            <a:ext cx="236655" cy="227617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" name="object 53"/>
          <p:cNvSpPr/>
          <p:nvPr/>
        </p:nvSpPr>
        <p:spPr>
          <a:xfrm>
            <a:off x="12987242" y="2100603"/>
            <a:ext cx="0" cy="94615"/>
          </a:xfrm>
          <a:custGeom>
            <a:avLst/>
            <a:gdLst/>
            <a:ahLst/>
            <a:cxnLst/>
            <a:rect l="l" t="t" r="r" b="b"/>
            <a:pathLst>
              <a:path h="94614">
                <a:moveTo>
                  <a:pt x="0" y="0"/>
                </a:moveTo>
                <a:lnTo>
                  <a:pt x="0" y="9409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" name="object 54"/>
          <p:cNvSpPr/>
          <p:nvPr/>
        </p:nvSpPr>
        <p:spPr>
          <a:xfrm>
            <a:off x="12971970" y="219167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0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" name="object 55"/>
          <p:cNvSpPr/>
          <p:nvPr/>
        </p:nvSpPr>
        <p:spPr>
          <a:xfrm>
            <a:off x="14676225" y="1136000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30">
                <a:moveTo>
                  <a:pt x="609327" y="0"/>
                </a:moveTo>
                <a:lnTo>
                  <a:pt x="37941" y="0"/>
                </a:lnTo>
                <a:lnTo>
                  <a:pt x="0" y="125319"/>
                </a:lnTo>
                <a:lnTo>
                  <a:pt x="571385" y="125319"/>
                </a:lnTo>
                <a:lnTo>
                  <a:pt x="609327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" name="object 56"/>
          <p:cNvSpPr/>
          <p:nvPr/>
        </p:nvSpPr>
        <p:spPr>
          <a:xfrm>
            <a:off x="14676225" y="1136001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30">
                <a:moveTo>
                  <a:pt x="0" y="125319"/>
                </a:moveTo>
                <a:lnTo>
                  <a:pt x="571385" y="125319"/>
                </a:lnTo>
                <a:lnTo>
                  <a:pt x="609327" y="0"/>
                </a:lnTo>
                <a:lnTo>
                  <a:pt x="37941" y="0"/>
                </a:lnTo>
                <a:lnTo>
                  <a:pt x="0" y="12531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" name="object 57"/>
          <p:cNvSpPr/>
          <p:nvPr/>
        </p:nvSpPr>
        <p:spPr>
          <a:xfrm>
            <a:off x="14164138" y="1073797"/>
            <a:ext cx="1497330" cy="144145"/>
          </a:xfrm>
          <a:custGeom>
            <a:avLst/>
            <a:gdLst/>
            <a:ahLst/>
            <a:cxnLst/>
            <a:rect l="l" t="t" r="r" b="b"/>
            <a:pathLst>
              <a:path w="1497330" h="144144">
                <a:moveTo>
                  <a:pt x="0" y="142870"/>
                </a:moveTo>
                <a:lnTo>
                  <a:pt x="378816" y="143526"/>
                </a:lnTo>
                <a:lnTo>
                  <a:pt x="379114" y="524"/>
                </a:lnTo>
                <a:lnTo>
                  <a:pt x="1496651" y="0"/>
                </a:lnTo>
                <a:lnTo>
                  <a:pt x="1496830" y="50003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" name="object 58"/>
          <p:cNvSpPr/>
          <p:nvPr/>
        </p:nvSpPr>
        <p:spPr>
          <a:xfrm>
            <a:off x="15645702" y="1120687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131"/>
                </a:lnTo>
                <a:lnTo>
                  <a:pt x="15331" y="15313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" name="object 59"/>
          <p:cNvSpPr/>
          <p:nvPr/>
        </p:nvSpPr>
        <p:spPr>
          <a:xfrm>
            <a:off x="14794225" y="1356555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" name="object 60"/>
          <p:cNvSpPr/>
          <p:nvPr/>
        </p:nvSpPr>
        <p:spPr>
          <a:xfrm>
            <a:off x="14794225" y="1356555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" name="object 61"/>
          <p:cNvSpPr/>
          <p:nvPr/>
        </p:nvSpPr>
        <p:spPr>
          <a:xfrm>
            <a:off x="14794225" y="1625849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2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" name="object 62"/>
          <p:cNvSpPr/>
          <p:nvPr/>
        </p:nvSpPr>
        <p:spPr>
          <a:xfrm>
            <a:off x="14794225" y="1625849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2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2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" name="object 63"/>
          <p:cNvSpPr/>
          <p:nvPr/>
        </p:nvSpPr>
        <p:spPr>
          <a:xfrm>
            <a:off x="14794225" y="189496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69">
                <a:moveTo>
                  <a:pt x="520081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81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" name="object 64"/>
          <p:cNvSpPr/>
          <p:nvPr/>
        </p:nvSpPr>
        <p:spPr>
          <a:xfrm>
            <a:off x="14794225" y="189496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69">
                <a:moveTo>
                  <a:pt x="260040" y="267360"/>
                </a:moveTo>
                <a:lnTo>
                  <a:pt x="520081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" name="object 65"/>
          <p:cNvSpPr/>
          <p:nvPr/>
        </p:nvSpPr>
        <p:spPr>
          <a:xfrm>
            <a:off x="14620388" y="1458847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5">
                <a:moveTo>
                  <a:pt x="0" y="0"/>
                </a:moveTo>
                <a:lnTo>
                  <a:pt x="0" y="62644"/>
                </a:lnTo>
                <a:lnTo>
                  <a:pt x="105710" y="62644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" name="object 66"/>
          <p:cNvSpPr/>
          <p:nvPr/>
        </p:nvSpPr>
        <p:spPr>
          <a:xfrm>
            <a:off x="14620388" y="1728141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710" y="62644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14620388" y="1996987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50"/>
                </a:lnTo>
                <a:lnTo>
                  <a:pt x="105710" y="62650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" name="object 68"/>
          <p:cNvSpPr/>
          <p:nvPr/>
        </p:nvSpPr>
        <p:spPr>
          <a:xfrm>
            <a:off x="14738328" y="1490173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4">
                <a:moveTo>
                  <a:pt x="55897" y="4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/>
          <p:nvPr/>
        </p:nvSpPr>
        <p:spPr>
          <a:xfrm>
            <a:off x="14726098" y="1474907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0"/>
                </a:moveTo>
                <a:lnTo>
                  <a:pt x="0" y="15265"/>
                </a:lnTo>
                <a:lnTo>
                  <a:pt x="15212" y="30531"/>
                </a:lnTo>
                <a:lnTo>
                  <a:pt x="1527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" name="object 70"/>
          <p:cNvSpPr/>
          <p:nvPr/>
        </p:nvSpPr>
        <p:spPr>
          <a:xfrm>
            <a:off x="14738328" y="1759460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897" y="47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" name="object 71"/>
          <p:cNvSpPr/>
          <p:nvPr/>
        </p:nvSpPr>
        <p:spPr>
          <a:xfrm>
            <a:off x="14726098" y="1744194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0"/>
                </a:moveTo>
                <a:lnTo>
                  <a:pt x="0" y="15265"/>
                </a:lnTo>
                <a:lnTo>
                  <a:pt x="15212" y="30531"/>
                </a:lnTo>
                <a:lnTo>
                  <a:pt x="1527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" name="object 72"/>
          <p:cNvSpPr/>
          <p:nvPr/>
        </p:nvSpPr>
        <p:spPr>
          <a:xfrm>
            <a:off x="14738328" y="2028402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89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" name="object 73"/>
          <p:cNvSpPr/>
          <p:nvPr/>
        </p:nvSpPr>
        <p:spPr>
          <a:xfrm>
            <a:off x="14726098" y="201313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76"/>
                </a:lnTo>
                <a:lnTo>
                  <a:pt x="15212" y="30531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" name="object 74"/>
          <p:cNvSpPr/>
          <p:nvPr/>
        </p:nvSpPr>
        <p:spPr>
          <a:xfrm>
            <a:off x="15551500" y="135409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" name="object 75"/>
          <p:cNvSpPr/>
          <p:nvPr/>
        </p:nvSpPr>
        <p:spPr>
          <a:xfrm>
            <a:off x="15551500" y="135409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" name="object 76"/>
          <p:cNvSpPr/>
          <p:nvPr/>
        </p:nvSpPr>
        <p:spPr>
          <a:xfrm>
            <a:off x="15551500" y="1622555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" name="object 77"/>
          <p:cNvSpPr/>
          <p:nvPr/>
        </p:nvSpPr>
        <p:spPr>
          <a:xfrm>
            <a:off x="15551500" y="1622555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" name="object 78"/>
          <p:cNvSpPr/>
          <p:nvPr/>
        </p:nvSpPr>
        <p:spPr>
          <a:xfrm>
            <a:off x="13573483" y="1080878"/>
            <a:ext cx="228600" cy="174625"/>
          </a:xfrm>
          <a:custGeom>
            <a:avLst/>
            <a:gdLst/>
            <a:ahLst/>
            <a:cxnLst/>
            <a:rect l="l" t="t" r="r" b="b"/>
            <a:pathLst>
              <a:path w="228600" h="174625">
                <a:moveTo>
                  <a:pt x="0" y="0"/>
                </a:moveTo>
                <a:lnTo>
                  <a:pt x="0" y="174082"/>
                </a:lnTo>
                <a:lnTo>
                  <a:pt x="228542" y="174082"/>
                </a:lnTo>
                <a:lnTo>
                  <a:pt x="22854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" name="object 79"/>
          <p:cNvSpPr/>
          <p:nvPr/>
        </p:nvSpPr>
        <p:spPr>
          <a:xfrm>
            <a:off x="13575690" y="1292711"/>
            <a:ext cx="228600" cy="174625"/>
          </a:xfrm>
          <a:custGeom>
            <a:avLst/>
            <a:gdLst/>
            <a:ahLst/>
            <a:cxnLst/>
            <a:rect l="l" t="t" r="r" b="b"/>
            <a:pathLst>
              <a:path w="228600" h="174625">
                <a:moveTo>
                  <a:pt x="0" y="0"/>
                </a:moveTo>
                <a:lnTo>
                  <a:pt x="0" y="174076"/>
                </a:lnTo>
                <a:lnTo>
                  <a:pt x="228542" y="174076"/>
                </a:lnTo>
                <a:lnTo>
                  <a:pt x="22854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" name="object 80"/>
          <p:cNvSpPr/>
          <p:nvPr/>
        </p:nvSpPr>
        <p:spPr>
          <a:xfrm>
            <a:off x="13804172" y="1216978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4">
                <a:moveTo>
                  <a:pt x="0" y="162783"/>
                </a:moveTo>
                <a:lnTo>
                  <a:pt x="532788" y="159490"/>
                </a:lnTo>
                <a:lnTo>
                  <a:pt x="53260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" name="object 81"/>
          <p:cNvSpPr/>
          <p:nvPr/>
        </p:nvSpPr>
        <p:spPr>
          <a:xfrm>
            <a:off x="13836865" y="1080878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" name="object 82"/>
          <p:cNvSpPr/>
          <p:nvPr/>
        </p:nvSpPr>
        <p:spPr>
          <a:xfrm>
            <a:off x="13836863" y="1080878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" name="object 83"/>
          <p:cNvSpPr/>
          <p:nvPr/>
        </p:nvSpPr>
        <p:spPr>
          <a:xfrm>
            <a:off x="13837581" y="129271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" name="object 84"/>
          <p:cNvSpPr/>
          <p:nvPr/>
        </p:nvSpPr>
        <p:spPr>
          <a:xfrm>
            <a:off x="13837580" y="129271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" name="object 85"/>
          <p:cNvSpPr/>
          <p:nvPr/>
        </p:nvSpPr>
        <p:spPr>
          <a:xfrm>
            <a:off x="15376528" y="1456431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5">
                <a:moveTo>
                  <a:pt x="0" y="0"/>
                </a:moveTo>
                <a:lnTo>
                  <a:pt x="0" y="62644"/>
                </a:lnTo>
                <a:lnTo>
                  <a:pt x="105650" y="62644"/>
                </a:lnTo>
                <a:lnTo>
                  <a:pt x="10565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" name="object 86"/>
          <p:cNvSpPr/>
          <p:nvPr/>
        </p:nvSpPr>
        <p:spPr>
          <a:xfrm>
            <a:off x="15376528" y="1724890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650" y="62644"/>
                </a:lnTo>
                <a:lnTo>
                  <a:pt x="10565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" name="object 87"/>
          <p:cNvSpPr/>
          <p:nvPr/>
        </p:nvSpPr>
        <p:spPr>
          <a:xfrm>
            <a:off x="15495542" y="1487494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4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" name="object 88"/>
          <p:cNvSpPr/>
          <p:nvPr/>
        </p:nvSpPr>
        <p:spPr>
          <a:xfrm>
            <a:off x="15483372" y="1472228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331" y="0"/>
                </a:moveTo>
                <a:lnTo>
                  <a:pt x="0" y="15224"/>
                </a:lnTo>
                <a:lnTo>
                  <a:pt x="15152" y="30531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" name="object 89"/>
          <p:cNvSpPr/>
          <p:nvPr/>
        </p:nvSpPr>
        <p:spPr>
          <a:xfrm>
            <a:off x="15495542" y="1755952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" name="object 90"/>
          <p:cNvSpPr/>
          <p:nvPr/>
        </p:nvSpPr>
        <p:spPr>
          <a:xfrm>
            <a:off x="15483372" y="174068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76"/>
                </a:lnTo>
                <a:lnTo>
                  <a:pt x="15152" y="30531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" name="object 91"/>
          <p:cNvSpPr/>
          <p:nvPr/>
        </p:nvSpPr>
        <p:spPr>
          <a:xfrm>
            <a:off x="15314307" y="1136000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4">
                <a:moveTo>
                  <a:pt x="652816" y="0"/>
                </a:moveTo>
                <a:lnTo>
                  <a:pt x="40625" y="0"/>
                </a:lnTo>
                <a:lnTo>
                  <a:pt x="0" y="74259"/>
                </a:lnTo>
                <a:lnTo>
                  <a:pt x="612190" y="74259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" name="object 92"/>
          <p:cNvSpPr/>
          <p:nvPr/>
        </p:nvSpPr>
        <p:spPr>
          <a:xfrm>
            <a:off x="15314307" y="113600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4">
                <a:moveTo>
                  <a:pt x="0" y="74259"/>
                </a:moveTo>
                <a:lnTo>
                  <a:pt x="612190" y="74259"/>
                </a:lnTo>
                <a:lnTo>
                  <a:pt x="652816" y="0"/>
                </a:lnTo>
                <a:lnTo>
                  <a:pt x="40625" y="0"/>
                </a:lnTo>
                <a:lnTo>
                  <a:pt x="0" y="7425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" name="object 93"/>
          <p:cNvSpPr/>
          <p:nvPr/>
        </p:nvSpPr>
        <p:spPr>
          <a:xfrm>
            <a:off x="15020680" y="1074101"/>
            <a:ext cx="0" cy="50165"/>
          </a:xfrm>
          <a:custGeom>
            <a:avLst/>
            <a:gdLst/>
            <a:ahLst/>
            <a:cxnLst/>
            <a:rect l="l" t="t" r="r" b="b"/>
            <a:pathLst>
              <a:path h="50165">
                <a:moveTo>
                  <a:pt x="0" y="0"/>
                </a:moveTo>
                <a:lnTo>
                  <a:pt x="0" y="4969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" name="object 94"/>
          <p:cNvSpPr/>
          <p:nvPr/>
        </p:nvSpPr>
        <p:spPr>
          <a:xfrm>
            <a:off x="15005408" y="112073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5" name="object 95"/>
          <p:cNvSpPr/>
          <p:nvPr/>
        </p:nvSpPr>
        <p:spPr>
          <a:xfrm>
            <a:off x="14623846" y="2326998"/>
            <a:ext cx="652780" cy="125730"/>
          </a:xfrm>
          <a:custGeom>
            <a:avLst/>
            <a:gdLst/>
            <a:ahLst/>
            <a:cxnLst/>
            <a:rect l="l" t="t" r="r" b="b"/>
            <a:pathLst>
              <a:path w="652780" h="125730">
                <a:moveTo>
                  <a:pt x="652756" y="0"/>
                </a:moveTo>
                <a:lnTo>
                  <a:pt x="15212" y="0"/>
                </a:lnTo>
                <a:lnTo>
                  <a:pt x="0" y="125277"/>
                </a:lnTo>
                <a:lnTo>
                  <a:pt x="637544" y="125277"/>
                </a:lnTo>
                <a:lnTo>
                  <a:pt x="65275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6" name="object 96"/>
          <p:cNvSpPr/>
          <p:nvPr/>
        </p:nvSpPr>
        <p:spPr>
          <a:xfrm>
            <a:off x="14623846" y="2326998"/>
            <a:ext cx="652780" cy="125730"/>
          </a:xfrm>
          <a:custGeom>
            <a:avLst/>
            <a:gdLst/>
            <a:ahLst/>
            <a:cxnLst/>
            <a:rect l="l" t="t" r="r" b="b"/>
            <a:pathLst>
              <a:path w="652780" h="125730">
                <a:moveTo>
                  <a:pt x="0" y="125277"/>
                </a:moveTo>
                <a:lnTo>
                  <a:pt x="637544" y="125277"/>
                </a:lnTo>
                <a:lnTo>
                  <a:pt x="652756" y="0"/>
                </a:lnTo>
                <a:lnTo>
                  <a:pt x="15212" y="0"/>
                </a:lnTo>
                <a:lnTo>
                  <a:pt x="0" y="12527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7" name="object 97"/>
          <p:cNvSpPr/>
          <p:nvPr/>
        </p:nvSpPr>
        <p:spPr>
          <a:xfrm>
            <a:off x="15660609" y="1073797"/>
            <a:ext cx="437515" cy="1241425"/>
          </a:xfrm>
          <a:custGeom>
            <a:avLst/>
            <a:gdLst/>
            <a:ahLst/>
            <a:cxnLst/>
            <a:rect l="l" t="t" r="r" b="b"/>
            <a:pathLst>
              <a:path w="437515" h="1241425">
                <a:moveTo>
                  <a:pt x="178" y="0"/>
                </a:moveTo>
                <a:lnTo>
                  <a:pt x="437100" y="524"/>
                </a:lnTo>
                <a:lnTo>
                  <a:pt x="437100" y="1181787"/>
                </a:lnTo>
                <a:lnTo>
                  <a:pt x="0" y="1181787"/>
                </a:lnTo>
                <a:lnTo>
                  <a:pt x="357" y="1241007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8" name="object 98"/>
          <p:cNvSpPr/>
          <p:nvPr/>
        </p:nvSpPr>
        <p:spPr>
          <a:xfrm>
            <a:off x="15645696" y="2311643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80" h="15875">
                <a:moveTo>
                  <a:pt x="30484" y="0"/>
                </a:moveTo>
                <a:lnTo>
                  <a:pt x="0" y="178"/>
                </a:lnTo>
                <a:lnTo>
                  <a:pt x="15331" y="15355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9" name="object 99"/>
          <p:cNvSpPr/>
          <p:nvPr/>
        </p:nvSpPr>
        <p:spPr>
          <a:xfrm>
            <a:off x="15314307" y="2326998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4">
                <a:moveTo>
                  <a:pt x="652816" y="0"/>
                </a:moveTo>
                <a:lnTo>
                  <a:pt x="40625" y="0"/>
                </a:lnTo>
                <a:lnTo>
                  <a:pt x="0" y="74265"/>
                </a:lnTo>
                <a:lnTo>
                  <a:pt x="612190" y="74265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0" name="object 100"/>
          <p:cNvSpPr/>
          <p:nvPr/>
        </p:nvSpPr>
        <p:spPr>
          <a:xfrm>
            <a:off x="15314307" y="2326998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4">
                <a:moveTo>
                  <a:pt x="0" y="74265"/>
                </a:moveTo>
                <a:lnTo>
                  <a:pt x="612190" y="74265"/>
                </a:lnTo>
                <a:lnTo>
                  <a:pt x="652816" y="0"/>
                </a:lnTo>
                <a:lnTo>
                  <a:pt x="40625" y="0"/>
                </a:lnTo>
                <a:lnTo>
                  <a:pt x="0" y="74265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1" name="object 101"/>
          <p:cNvSpPr/>
          <p:nvPr/>
        </p:nvSpPr>
        <p:spPr>
          <a:xfrm>
            <a:off x="14957921" y="2255542"/>
            <a:ext cx="702945" cy="59690"/>
          </a:xfrm>
          <a:custGeom>
            <a:avLst/>
            <a:gdLst/>
            <a:ahLst/>
            <a:cxnLst/>
            <a:rect l="l" t="t" r="r" b="b"/>
            <a:pathLst>
              <a:path w="702944" h="59689">
                <a:moveTo>
                  <a:pt x="702689" y="41"/>
                </a:moveTo>
                <a:lnTo>
                  <a:pt x="596" y="0"/>
                </a:lnTo>
                <a:lnTo>
                  <a:pt x="0" y="5926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2" name="object 102"/>
          <p:cNvSpPr/>
          <p:nvPr/>
        </p:nvSpPr>
        <p:spPr>
          <a:xfrm>
            <a:off x="14942709" y="2311559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80" h="15875">
                <a:moveTo>
                  <a:pt x="30484" y="304"/>
                </a:moveTo>
                <a:lnTo>
                  <a:pt x="0" y="0"/>
                </a:lnTo>
                <a:lnTo>
                  <a:pt x="15092" y="15438"/>
                </a:lnTo>
                <a:lnTo>
                  <a:pt x="30484" y="30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3" name="object 103"/>
          <p:cNvSpPr/>
          <p:nvPr/>
        </p:nvSpPr>
        <p:spPr>
          <a:xfrm>
            <a:off x="15054265" y="1261320"/>
            <a:ext cx="0" cy="83185"/>
          </a:xfrm>
          <a:custGeom>
            <a:avLst/>
            <a:gdLst/>
            <a:ahLst/>
            <a:cxnLst/>
            <a:rect l="l" t="t" r="r" b="b"/>
            <a:pathLst>
              <a:path h="83184">
                <a:moveTo>
                  <a:pt x="0" y="0"/>
                </a:moveTo>
                <a:lnTo>
                  <a:pt x="0" y="82993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4" name="object 104"/>
          <p:cNvSpPr/>
          <p:nvPr/>
        </p:nvSpPr>
        <p:spPr>
          <a:xfrm>
            <a:off x="15038999" y="1341289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5" name="object 105"/>
          <p:cNvSpPr/>
          <p:nvPr/>
        </p:nvSpPr>
        <p:spPr>
          <a:xfrm>
            <a:off x="15811540" y="1210260"/>
            <a:ext cx="0" cy="132080"/>
          </a:xfrm>
          <a:custGeom>
            <a:avLst/>
            <a:gdLst/>
            <a:ahLst/>
            <a:cxnLst/>
            <a:rect l="l" t="t" r="r" b="b"/>
            <a:pathLst>
              <a:path h="132080">
                <a:moveTo>
                  <a:pt x="0" y="0"/>
                </a:moveTo>
                <a:lnTo>
                  <a:pt x="0" y="13160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6" name="object 106"/>
          <p:cNvSpPr/>
          <p:nvPr/>
        </p:nvSpPr>
        <p:spPr>
          <a:xfrm>
            <a:off x="15796274" y="1338831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7" name="object 107"/>
          <p:cNvSpPr/>
          <p:nvPr/>
        </p:nvSpPr>
        <p:spPr>
          <a:xfrm>
            <a:off x="14794225" y="253781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8" name="object 108"/>
          <p:cNvSpPr/>
          <p:nvPr/>
        </p:nvSpPr>
        <p:spPr>
          <a:xfrm>
            <a:off x="14794225" y="253781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9" name="object 109"/>
          <p:cNvSpPr/>
          <p:nvPr/>
        </p:nvSpPr>
        <p:spPr>
          <a:xfrm>
            <a:off x="14794225" y="280711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0" name="object 110"/>
          <p:cNvSpPr/>
          <p:nvPr/>
        </p:nvSpPr>
        <p:spPr>
          <a:xfrm>
            <a:off x="14794225" y="280711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1" name="object 111"/>
          <p:cNvSpPr/>
          <p:nvPr/>
        </p:nvSpPr>
        <p:spPr>
          <a:xfrm>
            <a:off x="14794225" y="307626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2" name="object 112"/>
          <p:cNvSpPr/>
          <p:nvPr/>
        </p:nvSpPr>
        <p:spPr>
          <a:xfrm>
            <a:off x="14794225" y="307626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3" name="object 113"/>
          <p:cNvSpPr/>
          <p:nvPr/>
        </p:nvSpPr>
        <p:spPr>
          <a:xfrm>
            <a:off x="15054265" y="2452276"/>
            <a:ext cx="0" cy="73660"/>
          </a:xfrm>
          <a:custGeom>
            <a:avLst/>
            <a:gdLst/>
            <a:ahLst/>
            <a:cxnLst/>
            <a:rect l="l" t="t" r="r" b="b"/>
            <a:pathLst>
              <a:path h="73660">
                <a:moveTo>
                  <a:pt x="0" y="0"/>
                </a:moveTo>
                <a:lnTo>
                  <a:pt x="0" y="7329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4" name="object 114"/>
          <p:cNvSpPr/>
          <p:nvPr/>
        </p:nvSpPr>
        <p:spPr>
          <a:xfrm>
            <a:off x="15038999" y="2522551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5" name="object 115"/>
          <p:cNvSpPr/>
          <p:nvPr/>
        </p:nvSpPr>
        <p:spPr>
          <a:xfrm>
            <a:off x="15550610" y="2545578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69">
                <a:moveTo>
                  <a:pt x="520022" y="133707"/>
                </a:moveTo>
                <a:lnTo>
                  <a:pt x="259981" y="0"/>
                </a:lnTo>
                <a:lnTo>
                  <a:pt x="0" y="133707"/>
                </a:lnTo>
                <a:lnTo>
                  <a:pt x="259981" y="267366"/>
                </a:lnTo>
                <a:lnTo>
                  <a:pt x="520022" y="133707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6" name="object 116"/>
          <p:cNvSpPr/>
          <p:nvPr/>
        </p:nvSpPr>
        <p:spPr>
          <a:xfrm>
            <a:off x="15550610" y="2545578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69">
                <a:moveTo>
                  <a:pt x="259981" y="267366"/>
                </a:moveTo>
                <a:lnTo>
                  <a:pt x="520022" y="133707"/>
                </a:lnTo>
                <a:lnTo>
                  <a:pt x="259981" y="0"/>
                </a:lnTo>
                <a:lnTo>
                  <a:pt x="0" y="133707"/>
                </a:lnTo>
                <a:lnTo>
                  <a:pt x="259981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7" name="object 117"/>
          <p:cNvSpPr/>
          <p:nvPr/>
        </p:nvSpPr>
        <p:spPr>
          <a:xfrm>
            <a:off x="15550610" y="2814042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69">
                <a:moveTo>
                  <a:pt x="520022" y="133659"/>
                </a:moveTo>
                <a:lnTo>
                  <a:pt x="259981" y="0"/>
                </a:lnTo>
                <a:lnTo>
                  <a:pt x="0" y="133659"/>
                </a:lnTo>
                <a:lnTo>
                  <a:pt x="259981" y="267366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8" name="object 118"/>
          <p:cNvSpPr/>
          <p:nvPr/>
        </p:nvSpPr>
        <p:spPr>
          <a:xfrm>
            <a:off x="15550610" y="2814042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69">
                <a:moveTo>
                  <a:pt x="259981" y="267366"/>
                </a:moveTo>
                <a:lnTo>
                  <a:pt x="520022" y="133659"/>
                </a:lnTo>
                <a:lnTo>
                  <a:pt x="259981" y="0"/>
                </a:lnTo>
                <a:lnTo>
                  <a:pt x="0" y="133659"/>
                </a:lnTo>
                <a:lnTo>
                  <a:pt x="259981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9" name="object 119"/>
          <p:cNvSpPr/>
          <p:nvPr/>
        </p:nvSpPr>
        <p:spPr>
          <a:xfrm>
            <a:off x="15810472" y="2401264"/>
            <a:ext cx="0" cy="132080"/>
          </a:xfrm>
          <a:custGeom>
            <a:avLst/>
            <a:gdLst/>
            <a:ahLst/>
            <a:cxnLst/>
            <a:rect l="l" t="t" r="r" b="b"/>
            <a:pathLst>
              <a:path h="132080">
                <a:moveTo>
                  <a:pt x="0" y="0"/>
                </a:moveTo>
                <a:lnTo>
                  <a:pt x="0" y="13159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0" name="object 120"/>
          <p:cNvSpPr/>
          <p:nvPr/>
        </p:nvSpPr>
        <p:spPr>
          <a:xfrm>
            <a:off x="15795200" y="2529787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1" name="object 121"/>
          <p:cNvSpPr/>
          <p:nvPr/>
        </p:nvSpPr>
        <p:spPr>
          <a:xfrm>
            <a:off x="15376528" y="2647698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650" y="62644"/>
                </a:lnTo>
                <a:lnTo>
                  <a:pt x="10565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2" name="object 122"/>
          <p:cNvSpPr/>
          <p:nvPr/>
        </p:nvSpPr>
        <p:spPr>
          <a:xfrm>
            <a:off x="15376528" y="2916108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650" y="62644"/>
                </a:lnTo>
                <a:lnTo>
                  <a:pt x="10565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3" name="object 123"/>
          <p:cNvSpPr/>
          <p:nvPr/>
        </p:nvSpPr>
        <p:spPr>
          <a:xfrm>
            <a:off x="15495542" y="2678754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4" name="object 124"/>
          <p:cNvSpPr/>
          <p:nvPr/>
        </p:nvSpPr>
        <p:spPr>
          <a:xfrm>
            <a:off x="15483372" y="2663494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76"/>
                </a:lnTo>
                <a:lnTo>
                  <a:pt x="15152" y="30526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5" name="object 125"/>
          <p:cNvSpPr/>
          <p:nvPr/>
        </p:nvSpPr>
        <p:spPr>
          <a:xfrm>
            <a:off x="15495542" y="2947177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6" name="object 126"/>
          <p:cNvSpPr/>
          <p:nvPr/>
        </p:nvSpPr>
        <p:spPr>
          <a:xfrm>
            <a:off x="15483372" y="293195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76"/>
                </a:lnTo>
                <a:lnTo>
                  <a:pt x="15152" y="30526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7" name="object 127"/>
          <p:cNvSpPr/>
          <p:nvPr/>
        </p:nvSpPr>
        <p:spPr>
          <a:xfrm>
            <a:off x="14620268" y="2640062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710" y="62644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8" name="object 128"/>
          <p:cNvSpPr/>
          <p:nvPr/>
        </p:nvSpPr>
        <p:spPr>
          <a:xfrm>
            <a:off x="14620268" y="2909355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710" y="62644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9" name="object 129"/>
          <p:cNvSpPr/>
          <p:nvPr/>
        </p:nvSpPr>
        <p:spPr>
          <a:xfrm>
            <a:off x="14620268" y="3178255"/>
            <a:ext cx="106045" cy="62865"/>
          </a:xfrm>
          <a:custGeom>
            <a:avLst/>
            <a:gdLst/>
            <a:ahLst/>
            <a:cxnLst/>
            <a:rect l="l" t="t" r="r" b="b"/>
            <a:pathLst>
              <a:path w="106044" h="62864">
                <a:moveTo>
                  <a:pt x="0" y="0"/>
                </a:moveTo>
                <a:lnTo>
                  <a:pt x="0" y="62644"/>
                </a:lnTo>
                <a:lnTo>
                  <a:pt x="105710" y="62644"/>
                </a:lnTo>
                <a:lnTo>
                  <a:pt x="105710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0" name="object 130"/>
          <p:cNvSpPr/>
          <p:nvPr/>
        </p:nvSpPr>
        <p:spPr>
          <a:xfrm>
            <a:off x="14738148" y="2671387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47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1" name="object 131"/>
          <p:cNvSpPr/>
          <p:nvPr/>
        </p:nvSpPr>
        <p:spPr>
          <a:xfrm>
            <a:off x="14725919" y="2656121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2" name="object 132"/>
          <p:cNvSpPr/>
          <p:nvPr/>
        </p:nvSpPr>
        <p:spPr>
          <a:xfrm>
            <a:off x="14738148" y="2940686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4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3" name="object 133"/>
          <p:cNvSpPr/>
          <p:nvPr/>
        </p:nvSpPr>
        <p:spPr>
          <a:xfrm>
            <a:off x="14725919" y="292545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24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4" name="object 134"/>
          <p:cNvSpPr/>
          <p:nvPr/>
        </p:nvSpPr>
        <p:spPr>
          <a:xfrm>
            <a:off x="14738148" y="3209622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5" name="object 135"/>
          <p:cNvSpPr/>
          <p:nvPr/>
        </p:nvSpPr>
        <p:spPr>
          <a:xfrm>
            <a:off x="14725919" y="3194398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91" y="0"/>
                </a:moveTo>
                <a:lnTo>
                  <a:pt x="0" y="15176"/>
                </a:lnTo>
                <a:lnTo>
                  <a:pt x="15212" y="30531"/>
                </a:lnTo>
                <a:lnTo>
                  <a:pt x="1539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6" name="object 136"/>
          <p:cNvSpPr/>
          <p:nvPr/>
        </p:nvSpPr>
        <p:spPr>
          <a:xfrm>
            <a:off x="13659806" y="2174297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30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7" name="object 137"/>
          <p:cNvSpPr/>
          <p:nvPr/>
        </p:nvSpPr>
        <p:spPr>
          <a:xfrm>
            <a:off x="13659804" y="2174297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30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8" name="object 138"/>
          <p:cNvSpPr/>
          <p:nvPr/>
        </p:nvSpPr>
        <p:spPr>
          <a:xfrm>
            <a:off x="14673242" y="1521492"/>
            <a:ext cx="0" cy="207010"/>
          </a:xfrm>
          <a:custGeom>
            <a:avLst/>
            <a:gdLst/>
            <a:ahLst/>
            <a:cxnLst/>
            <a:rect l="l" t="t" r="r" b="b"/>
            <a:pathLst>
              <a:path h="207010">
                <a:moveTo>
                  <a:pt x="0" y="20664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9" name="object 139"/>
          <p:cNvSpPr/>
          <p:nvPr/>
        </p:nvSpPr>
        <p:spPr>
          <a:xfrm>
            <a:off x="14673242" y="1790786"/>
            <a:ext cx="0" cy="206375"/>
          </a:xfrm>
          <a:custGeom>
            <a:avLst/>
            <a:gdLst/>
            <a:ahLst/>
            <a:cxnLst/>
            <a:rect l="l" t="t" r="r" b="b"/>
            <a:pathLst>
              <a:path h="206375">
                <a:moveTo>
                  <a:pt x="0" y="206207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0" name="object 140"/>
          <p:cNvSpPr/>
          <p:nvPr/>
        </p:nvSpPr>
        <p:spPr>
          <a:xfrm>
            <a:off x="14673064" y="2702706"/>
            <a:ext cx="0" cy="207010"/>
          </a:xfrm>
          <a:custGeom>
            <a:avLst/>
            <a:gdLst/>
            <a:ahLst/>
            <a:cxnLst/>
            <a:rect l="l" t="t" r="r" b="b"/>
            <a:pathLst>
              <a:path h="207010">
                <a:moveTo>
                  <a:pt x="0" y="206654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1" name="object 141"/>
          <p:cNvSpPr/>
          <p:nvPr/>
        </p:nvSpPr>
        <p:spPr>
          <a:xfrm>
            <a:off x="14673064" y="2972000"/>
            <a:ext cx="0" cy="206375"/>
          </a:xfrm>
          <a:custGeom>
            <a:avLst/>
            <a:gdLst/>
            <a:ahLst/>
            <a:cxnLst/>
            <a:rect l="l" t="t" r="r" b="b"/>
            <a:pathLst>
              <a:path h="206375">
                <a:moveTo>
                  <a:pt x="0" y="206254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2" name="object 142"/>
          <p:cNvSpPr/>
          <p:nvPr/>
        </p:nvSpPr>
        <p:spPr>
          <a:xfrm>
            <a:off x="15429323" y="2710342"/>
            <a:ext cx="0" cy="206375"/>
          </a:xfrm>
          <a:custGeom>
            <a:avLst/>
            <a:gdLst/>
            <a:ahLst/>
            <a:cxnLst/>
            <a:rect l="l" t="t" r="r" b="b"/>
            <a:pathLst>
              <a:path h="206375">
                <a:moveTo>
                  <a:pt x="0" y="20577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3" name="object 143"/>
          <p:cNvSpPr/>
          <p:nvPr/>
        </p:nvSpPr>
        <p:spPr>
          <a:xfrm>
            <a:off x="15429323" y="1519076"/>
            <a:ext cx="0" cy="206375"/>
          </a:xfrm>
          <a:custGeom>
            <a:avLst/>
            <a:gdLst/>
            <a:ahLst/>
            <a:cxnLst/>
            <a:rect l="l" t="t" r="r" b="b"/>
            <a:pathLst>
              <a:path h="206375">
                <a:moveTo>
                  <a:pt x="0" y="205819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4" name="object 144"/>
          <p:cNvSpPr/>
          <p:nvPr/>
        </p:nvSpPr>
        <p:spPr>
          <a:xfrm>
            <a:off x="14245508" y="1787534"/>
            <a:ext cx="1184910" cy="449580"/>
          </a:xfrm>
          <a:custGeom>
            <a:avLst/>
            <a:gdLst/>
            <a:ahLst/>
            <a:cxnLst/>
            <a:rect l="l" t="t" r="r" b="b"/>
            <a:pathLst>
              <a:path w="1184909" h="449580">
                <a:moveTo>
                  <a:pt x="0" y="449407"/>
                </a:moveTo>
                <a:lnTo>
                  <a:pt x="1184411" y="449407"/>
                </a:lnTo>
                <a:lnTo>
                  <a:pt x="118381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5" name="object 145"/>
          <p:cNvSpPr/>
          <p:nvPr/>
        </p:nvSpPr>
        <p:spPr>
          <a:xfrm>
            <a:off x="14233219" y="222167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6" name="object 146"/>
          <p:cNvSpPr/>
          <p:nvPr/>
        </p:nvSpPr>
        <p:spPr>
          <a:xfrm>
            <a:off x="14672705" y="2059638"/>
            <a:ext cx="635" cy="165100"/>
          </a:xfrm>
          <a:custGeom>
            <a:avLst/>
            <a:gdLst/>
            <a:ahLst/>
            <a:cxnLst/>
            <a:rect l="l" t="t" r="r" b="b"/>
            <a:pathLst>
              <a:path w="634" h="165100">
                <a:moveTo>
                  <a:pt x="0" y="165062"/>
                </a:moveTo>
                <a:lnTo>
                  <a:pt x="536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7" name="object 147"/>
          <p:cNvSpPr/>
          <p:nvPr/>
        </p:nvSpPr>
        <p:spPr>
          <a:xfrm>
            <a:off x="14657492" y="222163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83"/>
                </a:moveTo>
                <a:lnTo>
                  <a:pt x="0" y="0"/>
                </a:lnTo>
                <a:lnTo>
                  <a:pt x="15212" y="15307"/>
                </a:lnTo>
                <a:lnTo>
                  <a:pt x="30543" y="8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8" name="object 148"/>
          <p:cNvSpPr/>
          <p:nvPr/>
        </p:nvSpPr>
        <p:spPr>
          <a:xfrm>
            <a:off x="14431457" y="2249135"/>
            <a:ext cx="242570" cy="391160"/>
          </a:xfrm>
          <a:custGeom>
            <a:avLst/>
            <a:gdLst/>
            <a:ahLst/>
            <a:cxnLst/>
            <a:rect l="l" t="t" r="r" b="b"/>
            <a:pathLst>
              <a:path w="242569" h="391160">
                <a:moveTo>
                  <a:pt x="0" y="0"/>
                </a:moveTo>
                <a:lnTo>
                  <a:pt x="0" y="323508"/>
                </a:lnTo>
                <a:lnTo>
                  <a:pt x="242501" y="323508"/>
                </a:lnTo>
                <a:lnTo>
                  <a:pt x="241607" y="39093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9" name="object 149"/>
          <p:cNvSpPr/>
          <p:nvPr/>
        </p:nvSpPr>
        <p:spPr>
          <a:xfrm>
            <a:off x="14416185" y="2236941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15265"/>
                </a:moveTo>
                <a:lnTo>
                  <a:pt x="15271" y="0"/>
                </a:lnTo>
                <a:lnTo>
                  <a:pt x="0" y="15265"/>
                </a:lnTo>
                <a:lnTo>
                  <a:pt x="30543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0" name="object 150"/>
          <p:cNvSpPr/>
          <p:nvPr/>
        </p:nvSpPr>
        <p:spPr>
          <a:xfrm>
            <a:off x="14431457" y="2572644"/>
            <a:ext cx="998219" cy="783590"/>
          </a:xfrm>
          <a:custGeom>
            <a:avLst/>
            <a:gdLst/>
            <a:ahLst/>
            <a:cxnLst/>
            <a:rect l="l" t="t" r="r" b="b"/>
            <a:pathLst>
              <a:path w="998219" h="783589">
                <a:moveTo>
                  <a:pt x="0" y="0"/>
                </a:moveTo>
                <a:lnTo>
                  <a:pt x="0" y="783397"/>
                </a:lnTo>
                <a:lnTo>
                  <a:pt x="997867" y="783397"/>
                </a:lnTo>
                <a:lnTo>
                  <a:pt x="997867" y="40610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1" name="object 151"/>
          <p:cNvSpPr/>
          <p:nvPr/>
        </p:nvSpPr>
        <p:spPr>
          <a:xfrm>
            <a:off x="10882516" y="3672631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29">
                <a:moveTo>
                  <a:pt x="609267" y="0"/>
                </a:moveTo>
                <a:lnTo>
                  <a:pt x="37881" y="0"/>
                </a:lnTo>
                <a:lnTo>
                  <a:pt x="0" y="125277"/>
                </a:lnTo>
                <a:lnTo>
                  <a:pt x="571385" y="125277"/>
                </a:lnTo>
                <a:lnTo>
                  <a:pt x="609267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2" name="object 152"/>
          <p:cNvSpPr/>
          <p:nvPr/>
        </p:nvSpPr>
        <p:spPr>
          <a:xfrm>
            <a:off x="10882516" y="3672631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29">
                <a:moveTo>
                  <a:pt x="0" y="125277"/>
                </a:moveTo>
                <a:lnTo>
                  <a:pt x="571385" y="125277"/>
                </a:lnTo>
                <a:lnTo>
                  <a:pt x="609267" y="0"/>
                </a:lnTo>
                <a:lnTo>
                  <a:pt x="37881" y="0"/>
                </a:lnTo>
                <a:lnTo>
                  <a:pt x="0" y="12527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3" name="object 153"/>
          <p:cNvSpPr/>
          <p:nvPr/>
        </p:nvSpPr>
        <p:spPr>
          <a:xfrm>
            <a:off x="10370428" y="3609682"/>
            <a:ext cx="1905000" cy="144145"/>
          </a:xfrm>
          <a:custGeom>
            <a:avLst/>
            <a:gdLst/>
            <a:ahLst/>
            <a:cxnLst/>
            <a:rect l="l" t="t" r="r" b="b"/>
            <a:pathLst>
              <a:path w="1905000" h="144145">
                <a:moveTo>
                  <a:pt x="0" y="143616"/>
                </a:moveTo>
                <a:lnTo>
                  <a:pt x="485421" y="142566"/>
                </a:lnTo>
                <a:lnTo>
                  <a:pt x="483691" y="0"/>
                </a:lnTo>
                <a:lnTo>
                  <a:pt x="1904580" y="966"/>
                </a:lnTo>
                <a:lnTo>
                  <a:pt x="1904222" y="5075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4" name="object 154"/>
          <p:cNvSpPr/>
          <p:nvPr/>
        </p:nvSpPr>
        <p:spPr>
          <a:xfrm>
            <a:off x="12259438" y="3657234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262"/>
                </a:moveTo>
                <a:lnTo>
                  <a:pt x="0" y="0"/>
                </a:lnTo>
                <a:lnTo>
                  <a:pt x="15092" y="15397"/>
                </a:lnTo>
                <a:lnTo>
                  <a:pt x="30484" y="262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5" name="object 155"/>
          <p:cNvSpPr/>
          <p:nvPr/>
        </p:nvSpPr>
        <p:spPr>
          <a:xfrm>
            <a:off x="11000516" y="389314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81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6" name="object 156"/>
          <p:cNvSpPr/>
          <p:nvPr/>
        </p:nvSpPr>
        <p:spPr>
          <a:xfrm>
            <a:off x="11000516" y="389314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7" name="object 157"/>
          <p:cNvSpPr/>
          <p:nvPr/>
        </p:nvSpPr>
        <p:spPr>
          <a:xfrm>
            <a:off x="11000516" y="4162479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8" name="object 158"/>
          <p:cNvSpPr/>
          <p:nvPr/>
        </p:nvSpPr>
        <p:spPr>
          <a:xfrm>
            <a:off x="11000516" y="4162479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9" name="object 159"/>
          <p:cNvSpPr/>
          <p:nvPr/>
        </p:nvSpPr>
        <p:spPr>
          <a:xfrm>
            <a:off x="11000516" y="443159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6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0" name="object 160"/>
          <p:cNvSpPr/>
          <p:nvPr/>
        </p:nvSpPr>
        <p:spPr>
          <a:xfrm>
            <a:off x="11000516" y="443159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6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1" name="object 161"/>
          <p:cNvSpPr/>
          <p:nvPr/>
        </p:nvSpPr>
        <p:spPr>
          <a:xfrm>
            <a:off x="10938354" y="4011579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2" name="object 162"/>
          <p:cNvSpPr/>
          <p:nvPr/>
        </p:nvSpPr>
        <p:spPr>
          <a:xfrm>
            <a:off x="10938354" y="4280872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3" name="object 163"/>
          <p:cNvSpPr/>
          <p:nvPr/>
        </p:nvSpPr>
        <p:spPr>
          <a:xfrm>
            <a:off x="10950524" y="4565253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4" name="object 164"/>
          <p:cNvSpPr/>
          <p:nvPr/>
        </p:nvSpPr>
        <p:spPr>
          <a:xfrm>
            <a:off x="10938354" y="454999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26"/>
                </a:moveTo>
                <a:lnTo>
                  <a:pt x="15271" y="0"/>
                </a:lnTo>
                <a:lnTo>
                  <a:pt x="0" y="15260"/>
                </a:lnTo>
                <a:lnTo>
                  <a:pt x="15271" y="30526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5" name="object 165"/>
          <p:cNvSpPr/>
          <p:nvPr/>
        </p:nvSpPr>
        <p:spPr>
          <a:xfrm>
            <a:off x="12112326" y="389581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6" name="object 166"/>
          <p:cNvSpPr/>
          <p:nvPr/>
        </p:nvSpPr>
        <p:spPr>
          <a:xfrm>
            <a:off x="12112326" y="389581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7" name="object 167"/>
          <p:cNvSpPr/>
          <p:nvPr/>
        </p:nvSpPr>
        <p:spPr>
          <a:xfrm>
            <a:off x="12112326" y="416427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8" name="object 168"/>
          <p:cNvSpPr/>
          <p:nvPr/>
        </p:nvSpPr>
        <p:spPr>
          <a:xfrm>
            <a:off x="12112326" y="416427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9" name="object 169"/>
          <p:cNvSpPr/>
          <p:nvPr/>
        </p:nvSpPr>
        <p:spPr>
          <a:xfrm>
            <a:off x="9783830" y="3617467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82"/>
                </a:lnTo>
                <a:lnTo>
                  <a:pt x="224485" y="174082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0" name="object 170"/>
          <p:cNvSpPr/>
          <p:nvPr/>
        </p:nvSpPr>
        <p:spPr>
          <a:xfrm>
            <a:off x="9785977" y="3829341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82"/>
                </a:lnTo>
                <a:lnTo>
                  <a:pt x="224485" y="174082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1" name="object 171"/>
          <p:cNvSpPr/>
          <p:nvPr/>
        </p:nvSpPr>
        <p:spPr>
          <a:xfrm>
            <a:off x="10010463" y="3753560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5">
                <a:moveTo>
                  <a:pt x="0" y="162831"/>
                </a:moveTo>
                <a:lnTo>
                  <a:pt x="532788" y="159544"/>
                </a:lnTo>
                <a:lnTo>
                  <a:pt x="53254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2" name="object 172"/>
          <p:cNvSpPr/>
          <p:nvPr/>
        </p:nvSpPr>
        <p:spPr>
          <a:xfrm>
            <a:off x="10043155" y="361746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3" name="object 173"/>
          <p:cNvSpPr/>
          <p:nvPr/>
        </p:nvSpPr>
        <p:spPr>
          <a:xfrm>
            <a:off x="10043155" y="361746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4" name="object 174"/>
          <p:cNvSpPr/>
          <p:nvPr/>
        </p:nvSpPr>
        <p:spPr>
          <a:xfrm>
            <a:off x="10043871" y="382934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142" y="174082"/>
                </a:lnTo>
                <a:lnTo>
                  <a:pt x="44014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5" name="object 175"/>
          <p:cNvSpPr/>
          <p:nvPr/>
        </p:nvSpPr>
        <p:spPr>
          <a:xfrm>
            <a:off x="10043871" y="382934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142" y="174082"/>
                </a:lnTo>
                <a:lnTo>
                  <a:pt x="44014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6" name="object 176"/>
          <p:cNvSpPr/>
          <p:nvPr/>
        </p:nvSpPr>
        <p:spPr>
          <a:xfrm>
            <a:off x="12060425" y="4014210"/>
            <a:ext cx="15240" cy="31115"/>
          </a:xfrm>
          <a:custGeom>
            <a:avLst/>
            <a:gdLst/>
            <a:ahLst/>
            <a:cxnLst/>
            <a:rect l="l" t="t" r="r" b="b"/>
            <a:pathLst>
              <a:path w="15240" h="31114">
                <a:moveTo>
                  <a:pt x="15212" y="30531"/>
                </a:moveTo>
                <a:lnTo>
                  <a:pt x="15212" y="0"/>
                </a:lnTo>
                <a:lnTo>
                  <a:pt x="0" y="15265"/>
                </a:lnTo>
                <a:lnTo>
                  <a:pt x="15212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7" name="object 177"/>
          <p:cNvSpPr/>
          <p:nvPr/>
        </p:nvSpPr>
        <p:spPr>
          <a:xfrm>
            <a:off x="12061499" y="4282668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8" name="object 178"/>
          <p:cNvSpPr/>
          <p:nvPr/>
        </p:nvSpPr>
        <p:spPr>
          <a:xfrm>
            <a:off x="11927809" y="367263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652816" y="0"/>
                </a:moveTo>
                <a:lnTo>
                  <a:pt x="40625" y="0"/>
                </a:lnTo>
                <a:lnTo>
                  <a:pt x="0" y="74265"/>
                </a:lnTo>
                <a:lnTo>
                  <a:pt x="612190" y="74265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9" name="object 179"/>
          <p:cNvSpPr/>
          <p:nvPr/>
        </p:nvSpPr>
        <p:spPr>
          <a:xfrm>
            <a:off x="11927809" y="367263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0" y="74265"/>
                </a:moveTo>
                <a:lnTo>
                  <a:pt x="612190" y="74265"/>
                </a:lnTo>
                <a:lnTo>
                  <a:pt x="652816" y="0"/>
                </a:lnTo>
                <a:lnTo>
                  <a:pt x="40625" y="0"/>
                </a:lnTo>
                <a:lnTo>
                  <a:pt x="0" y="74265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0" name="object 180"/>
          <p:cNvSpPr/>
          <p:nvPr/>
        </p:nvSpPr>
        <p:spPr>
          <a:xfrm>
            <a:off x="11226970" y="3610732"/>
            <a:ext cx="0" cy="50165"/>
          </a:xfrm>
          <a:custGeom>
            <a:avLst/>
            <a:gdLst/>
            <a:ahLst/>
            <a:cxnLst/>
            <a:rect l="l" t="t" r="r" b="b"/>
            <a:pathLst>
              <a:path h="50164">
                <a:moveTo>
                  <a:pt x="0" y="0"/>
                </a:moveTo>
                <a:lnTo>
                  <a:pt x="0" y="4969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1" name="object 181"/>
          <p:cNvSpPr/>
          <p:nvPr/>
        </p:nvSpPr>
        <p:spPr>
          <a:xfrm>
            <a:off x="11211698" y="3657365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0"/>
                </a:moveTo>
                <a:lnTo>
                  <a:pt x="0" y="0"/>
                </a:lnTo>
                <a:lnTo>
                  <a:pt x="15271" y="15265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2" name="object 182"/>
          <p:cNvSpPr/>
          <p:nvPr/>
        </p:nvSpPr>
        <p:spPr>
          <a:xfrm>
            <a:off x="10892896" y="4963075"/>
            <a:ext cx="590550" cy="125730"/>
          </a:xfrm>
          <a:custGeom>
            <a:avLst/>
            <a:gdLst/>
            <a:ahLst/>
            <a:cxnLst/>
            <a:rect l="l" t="t" r="r" b="b"/>
            <a:pathLst>
              <a:path w="590550" h="125729">
                <a:moveTo>
                  <a:pt x="589939" y="0"/>
                </a:moveTo>
                <a:lnTo>
                  <a:pt x="13780" y="0"/>
                </a:lnTo>
                <a:lnTo>
                  <a:pt x="0" y="125319"/>
                </a:lnTo>
                <a:lnTo>
                  <a:pt x="576218" y="125319"/>
                </a:lnTo>
                <a:lnTo>
                  <a:pt x="589939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3" name="object 183"/>
          <p:cNvSpPr/>
          <p:nvPr/>
        </p:nvSpPr>
        <p:spPr>
          <a:xfrm>
            <a:off x="10892896" y="4963075"/>
            <a:ext cx="590550" cy="125730"/>
          </a:xfrm>
          <a:custGeom>
            <a:avLst/>
            <a:gdLst/>
            <a:ahLst/>
            <a:cxnLst/>
            <a:rect l="l" t="t" r="r" b="b"/>
            <a:pathLst>
              <a:path w="590550" h="125729">
                <a:moveTo>
                  <a:pt x="0" y="125319"/>
                </a:moveTo>
                <a:lnTo>
                  <a:pt x="576218" y="125319"/>
                </a:lnTo>
                <a:lnTo>
                  <a:pt x="589939" y="0"/>
                </a:lnTo>
                <a:lnTo>
                  <a:pt x="13780" y="0"/>
                </a:lnTo>
                <a:lnTo>
                  <a:pt x="0" y="12531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4" name="object 184"/>
          <p:cNvSpPr/>
          <p:nvPr/>
        </p:nvSpPr>
        <p:spPr>
          <a:xfrm>
            <a:off x="12241720" y="3610648"/>
            <a:ext cx="424815" cy="1350010"/>
          </a:xfrm>
          <a:custGeom>
            <a:avLst/>
            <a:gdLst/>
            <a:ahLst/>
            <a:cxnLst/>
            <a:rect l="l" t="t" r="r" b="b"/>
            <a:pathLst>
              <a:path w="424815" h="1350010">
                <a:moveTo>
                  <a:pt x="33288" y="0"/>
                </a:moveTo>
                <a:lnTo>
                  <a:pt x="424751" y="787"/>
                </a:lnTo>
                <a:lnTo>
                  <a:pt x="422842" y="1294698"/>
                </a:lnTo>
                <a:lnTo>
                  <a:pt x="0" y="1295968"/>
                </a:lnTo>
                <a:lnTo>
                  <a:pt x="656" y="134965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5" name="object 185"/>
          <p:cNvSpPr/>
          <p:nvPr/>
        </p:nvSpPr>
        <p:spPr>
          <a:xfrm>
            <a:off x="12227104" y="4957062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0"/>
                </a:moveTo>
                <a:lnTo>
                  <a:pt x="0" y="351"/>
                </a:lnTo>
                <a:lnTo>
                  <a:pt x="15450" y="15438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6" name="object 186"/>
          <p:cNvSpPr/>
          <p:nvPr/>
        </p:nvSpPr>
        <p:spPr>
          <a:xfrm>
            <a:off x="11895834" y="497250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652816" y="0"/>
                </a:moveTo>
                <a:lnTo>
                  <a:pt x="40625" y="0"/>
                </a:lnTo>
                <a:lnTo>
                  <a:pt x="0" y="74265"/>
                </a:lnTo>
                <a:lnTo>
                  <a:pt x="612190" y="74265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7" name="object 187"/>
          <p:cNvSpPr/>
          <p:nvPr/>
        </p:nvSpPr>
        <p:spPr>
          <a:xfrm>
            <a:off x="11895834" y="497250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0" y="74265"/>
                </a:moveTo>
                <a:lnTo>
                  <a:pt x="612190" y="74265"/>
                </a:lnTo>
                <a:lnTo>
                  <a:pt x="652816" y="0"/>
                </a:lnTo>
                <a:lnTo>
                  <a:pt x="40625" y="0"/>
                </a:lnTo>
                <a:lnTo>
                  <a:pt x="0" y="74265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8" name="object 188"/>
          <p:cNvSpPr/>
          <p:nvPr/>
        </p:nvSpPr>
        <p:spPr>
          <a:xfrm>
            <a:off x="11194815" y="4905346"/>
            <a:ext cx="1047115" cy="45720"/>
          </a:xfrm>
          <a:custGeom>
            <a:avLst/>
            <a:gdLst/>
            <a:ahLst/>
            <a:cxnLst/>
            <a:rect l="l" t="t" r="r" b="b"/>
            <a:pathLst>
              <a:path w="1047115" h="45720">
                <a:moveTo>
                  <a:pt x="1046904" y="1270"/>
                </a:moveTo>
                <a:lnTo>
                  <a:pt x="0" y="0"/>
                </a:lnTo>
                <a:lnTo>
                  <a:pt x="0" y="4552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89" name="object 189"/>
          <p:cNvSpPr/>
          <p:nvPr/>
        </p:nvSpPr>
        <p:spPr>
          <a:xfrm>
            <a:off x="11179543" y="4947810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41"/>
                </a:moveTo>
                <a:lnTo>
                  <a:pt x="0" y="0"/>
                </a:lnTo>
                <a:lnTo>
                  <a:pt x="15271" y="15265"/>
                </a:lnTo>
                <a:lnTo>
                  <a:pt x="30484" y="4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0" name="object 190"/>
          <p:cNvSpPr/>
          <p:nvPr/>
        </p:nvSpPr>
        <p:spPr>
          <a:xfrm>
            <a:off x="11260556" y="3797909"/>
            <a:ext cx="0" cy="83185"/>
          </a:xfrm>
          <a:custGeom>
            <a:avLst/>
            <a:gdLst/>
            <a:ahLst/>
            <a:cxnLst/>
            <a:rect l="l" t="t" r="r" b="b"/>
            <a:pathLst>
              <a:path h="83185">
                <a:moveTo>
                  <a:pt x="0" y="0"/>
                </a:moveTo>
                <a:lnTo>
                  <a:pt x="0" y="8304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1" name="object 191"/>
          <p:cNvSpPr/>
          <p:nvPr/>
        </p:nvSpPr>
        <p:spPr>
          <a:xfrm>
            <a:off x="11245284" y="3877878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2" name="object 192"/>
          <p:cNvSpPr/>
          <p:nvPr/>
        </p:nvSpPr>
        <p:spPr>
          <a:xfrm>
            <a:off x="12372367" y="3746897"/>
            <a:ext cx="0" cy="137160"/>
          </a:xfrm>
          <a:custGeom>
            <a:avLst/>
            <a:gdLst/>
            <a:ahLst/>
            <a:cxnLst/>
            <a:rect l="l" t="t" r="r" b="b"/>
            <a:pathLst>
              <a:path h="137160">
                <a:moveTo>
                  <a:pt x="0" y="0"/>
                </a:moveTo>
                <a:lnTo>
                  <a:pt x="0" y="13672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3" name="object 193"/>
          <p:cNvSpPr/>
          <p:nvPr/>
        </p:nvSpPr>
        <p:spPr>
          <a:xfrm>
            <a:off x="12357095" y="388055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0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4" name="object 194"/>
          <p:cNvSpPr/>
          <p:nvPr/>
        </p:nvSpPr>
        <p:spPr>
          <a:xfrm>
            <a:off x="11000516" y="517389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5" name="object 195"/>
          <p:cNvSpPr/>
          <p:nvPr/>
        </p:nvSpPr>
        <p:spPr>
          <a:xfrm>
            <a:off x="11000516" y="517389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6" name="object 196"/>
          <p:cNvSpPr/>
          <p:nvPr/>
        </p:nvSpPr>
        <p:spPr>
          <a:xfrm>
            <a:off x="11000516" y="544318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07"/>
                </a:moveTo>
                <a:lnTo>
                  <a:pt x="260040" y="0"/>
                </a:lnTo>
                <a:lnTo>
                  <a:pt x="0" y="133707"/>
                </a:lnTo>
                <a:lnTo>
                  <a:pt x="260040" y="267366"/>
                </a:lnTo>
                <a:lnTo>
                  <a:pt x="520081" y="133707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7" name="object 197"/>
          <p:cNvSpPr/>
          <p:nvPr/>
        </p:nvSpPr>
        <p:spPr>
          <a:xfrm>
            <a:off x="11000516" y="544318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6"/>
                </a:moveTo>
                <a:lnTo>
                  <a:pt x="520081" y="133707"/>
                </a:lnTo>
                <a:lnTo>
                  <a:pt x="260040" y="0"/>
                </a:lnTo>
                <a:lnTo>
                  <a:pt x="0" y="133707"/>
                </a:lnTo>
                <a:lnTo>
                  <a:pt x="260040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8" name="object 198"/>
          <p:cNvSpPr/>
          <p:nvPr/>
        </p:nvSpPr>
        <p:spPr>
          <a:xfrm>
            <a:off x="11000516" y="571234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4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9" name="object 199"/>
          <p:cNvSpPr/>
          <p:nvPr/>
        </p:nvSpPr>
        <p:spPr>
          <a:xfrm>
            <a:off x="11000516" y="571234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4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4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0" name="object 200"/>
          <p:cNvSpPr/>
          <p:nvPr/>
        </p:nvSpPr>
        <p:spPr>
          <a:xfrm>
            <a:off x="11260556" y="5088395"/>
            <a:ext cx="0" cy="73660"/>
          </a:xfrm>
          <a:custGeom>
            <a:avLst/>
            <a:gdLst/>
            <a:ahLst/>
            <a:cxnLst/>
            <a:rect l="l" t="t" r="r" b="b"/>
            <a:pathLst>
              <a:path h="73660">
                <a:moveTo>
                  <a:pt x="0" y="0"/>
                </a:moveTo>
                <a:lnTo>
                  <a:pt x="0" y="7330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1" name="object 201"/>
          <p:cNvSpPr/>
          <p:nvPr/>
        </p:nvSpPr>
        <p:spPr>
          <a:xfrm>
            <a:off x="11245284" y="5158628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2" name="object 202"/>
          <p:cNvSpPr/>
          <p:nvPr/>
        </p:nvSpPr>
        <p:spPr>
          <a:xfrm>
            <a:off x="12132072" y="5191087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81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3" name="object 203"/>
          <p:cNvSpPr/>
          <p:nvPr/>
        </p:nvSpPr>
        <p:spPr>
          <a:xfrm>
            <a:off x="12132072" y="5191087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4" name="object 204"/>
          <p:cNvSpPr/>
          <p:nvPr/>
        </p:nvSpPr>
        <p:spPr>
          <a:xfrm>
            <a:off x="12132072" y="545954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5" name="object 205"/>
          <p:cNvSpPr/>
          <p:nvPr/>
        </p:nvSpPr>
        <p:spPr>
          <a:xfrm>
            <a:off x="12132072" y="545954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6" name="object 206"/>
          <p:cNvSpPr/>
          <p:nvPr/>
        </p:nvSpPr>
        <p:spPr>
          <a:xfrm>
            <a:off x="12391993" y="5046767"/>
            <a:ext cx="0" cy="132080"/>
          </a:xfrm>
          <a:custGeom>
            <a:avLst/>
            <a:gdLst/>
            <a:ahLst/>
            <a:cxnLst/>
            <a:rect l="l" t="t" r="r" b="b"/>
            <a:pathLst>
              <a:path h="132079">
                <a:moveTo>
                  <a:pt x="0" y="0"/>
                </a:moveTo>
                <a:lnTo>
                  <a:pt x="0" y="13160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7" name="object 207"/>
          <p:cNvSpPr/>
          <p:nvPr/>
        </p:nvSpPr>
        <p:spPr>
          <a:xfrm>
            <a:off x="12376722" y="517529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8" name="object 208"/>
          <p:cNvSpPr/>
          <p:nvPr/>
        </p:nvSpPr>
        <p:spPr>
          <a:xfrm>
            <a:off x="12064840" y="5308997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76"/>
                </a:lnTo>
                <a:lnTo>
                  <a:pt x="15152" y="30531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9" name="object 209"/>
          <p:cNvSpPr/>
          <p:nvPr/>
        </p:nvSpPr>
        <p:spPr>
          <a:xfrm>
            <a:off x="12064840" y="557745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0"/>
                </a:moveTo>
                <a:lnTo>
                  <a:pt x="0" y="15182"/>
                </a:lnTo>
                <a:lnTo>
                  <a:pt x="15152" y="30531"/>
                </a:lnTo>
                <a:lnTo>
                  <a:pt x="1533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0" name="object 210"/>
          <p:cNvSpPr/>
          <p:nvPr/>
        </p:nvSpPr>
        <p:spPr>
          <a:xfrm>
            <a:off x="9866090" y="481037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1" name="object 211"/>
          <p:cNvSpPr/>
          <p:nvPr/>
        </p:nvSpPr>
        <p:spPr>
          <a:xfrm>
            <a:off x="9866090" y="481037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2" name="object 212"/>
          <p:cNvSpPr/>
          <p:nvPr/>
        </p:nvSpPr>
        <p:spPr>
          <a:xfrm>
            <a:off x="10451739" y="4360579"/>
            <a:ext cx="1350010" cy="512445"/>
          </a:xfrm>
          <a:custGeom>
            <a:avLst/>
            <a:gdLst/>
            <a:ahLst/>
            <a:cxnLst/>
            <a:rect l="l" t="t" r="r" b="b"/>
            <a:pathLst>
              <a:path w="1350009" h="512445">
                <a:moveTo>
                  <a:pt x="0" y="512439"/>
                </a:moveTo>
                <a:lnTo>
                  <a:pt x="1348645" y="512439"/>
                </a:lnTo>
                <a:lnTo>
                  <a:pt x="1349718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3" name="object 213"/>
          <p:cNvSpPr/>
          <p:nvPr/>
        </p:nvSpPr>
        <p:spPr>
          <a:xfrm>
            <a:off x="10439510" y="485775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4" name="object 214"/>
          <p:cNvSpPr/>
          <p:nvPr/>
        </p:nvSpPr>
        <p:spPr>
          <a:xfrm>
            <a:off x="10726873" y="485770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137"/>
                </a:lnTo>
                <a:lnTo>
                  <a:pt x="15331" y="15313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5" name="object 215"/>
          <p:cNvSpPr/>
          <p:nvPr/>
        </p:nvSpPr>
        <p:spPr>
          <a:xfrm>
            <a:off x="10504833" y="4884508"/>
            <a:ext cx="237490" cy="352425"/>
          </a:xfrm>
          <a:custGeom>
            <a:avLst/>
            <a:gdLst/>
            <a:ahLst/>
            <a:cxnLst/>
            <a:rect l="l" t="t" r="r" b="b"/>
            <a:pathLst>
              <a:path w="237490" h="352425">
                <a:moveTo>
                  <a:pt x="0" y="0"/>
                </a:moveTo>
                <a:lnTo>
                  <a:pt x="298" y="305045"/>
                </a:lnTo>
                <a:lnTo>
                  <a:pt x="237371" y="305612"/>
                </a:lnTo>
                <a:lnTo>
                  <a:pt x="236715" y="35215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6" name="object 216"/>
          <p:cNvSpPr/>
          <p:nvPr/>
        </p:nvSpPr>
        <p:spPr>
          <a:xfrm>
            <a:off x="10489562" y="487231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15224"/>
                </a:moveTo>
                <a:lnTo>
                  <a:pt x="15271" y="0"/>
                </a:lnTo>
                <a:lnTo>
                  <a:pt x="0" y="15265"/>
                </a:lnTo>
                <a:lnTo>
                  <a:pt x="30543" y="1522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17" name="object 217"/>
          <p:cNvSpPr/>
          <p:nvPr/>
        </p:nvSpPr>
        <p:spPr>
          <a:xfrm>
            <a:off x="10504714" y="5189554"/>
            <a:ext cx="1305560" cy="821690"/>
          </a:xfrm>
          <a:custGeom>
            <a:avLst/>
            <a:gdLst/>
            <a:ahLst/>
            <a:cxnLst/>
            <a:rect l="l" t="t" r="r" b="b"/>
            <a:pathLst>
              <a:path w="1305559" h="821689">
                <a:moveTo>
                  <a:pt x="417" y="0"/>
                </a:moveTo>
                <a:lnTo>
                  <a:pt x="0" y="821219"/>
                </a:lnTo>
                <a:lnTo>
                  <a:pt x="1305096" y="821279"/>
                </a:lnTo>
                <a:lnTo>
                  <a:pt x="1302948" y="459626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218" name="object 218"/>
          <p:cNvGraphicFramePr>
            <a:graphicFrameLocks noGrp="1"/>
          </p:cNvGraphicFramePr>
          <p:nvPr/>
        </p:nvGraphicFramePr>
        <p:xfrm>
          <a:off x="10543741" y="3955448"/>
          <a:ext cx="394970" cy="90488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74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74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41718">
                <a:tc gridSpan="2">
                  <a:txBody>
                    <a:bodyPr/>
                    <a:lstStyle/>
                    <a:p>
                      <a:pPr marL="3810" algn="ctr">
                        <a:lnSpc>
                          <a:spcPts val="33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AGE</a:t>
                      </a: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75" algn="ctr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Increase:</a:t>
                      </a:r>
                      <a:r>
                        <a:rPr sz="300" spc="-4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50-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75" algn="ctr">
                        <a:lnSpc>
                          <a:spcPts val="26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00% in</a:t>
                      </a:r>
                      <a:r>
                        <a:rPr sz="300" spc="-9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27574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41713">
                <a:tc gridSpan="2">
                  <a:txBody>
                    <a:bodyPr/>
                    <a:lstStyle/>
                    <a:p>
                      <a:pPr marL="3810" algn="ctr">
                        <a:lnSpc>
                          <a:spcPts val="33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-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2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810" algn="ctr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Increase:</a:t>
                      </a:r>
                      <a:r>
                        <a:rPr sz="300" spc="-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00-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75" algn="ctr">
                        <a:lnSpc>
                          <a:spcPts val="254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200% in</a:t>
                      </a:r>
                      <a:r>
                        <a:rPr sz="300" spc="-3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744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41718">
                <a:tc gridSpan="2">
                  <a:txBody>
                    <a:bodyPr/>
                    <a:lstStyle/>
                    <a:p>
                      <a:pPr marL="3810" algn="ctr">
                        <a:lnSpc>
                          <a:spcPts val="33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-9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26670" marR="14604" algn="ctr">
                        <a:lnSpc>
                          <a:spcPct val="1096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Increse:</a:t>
                      </a:r>
                      <a:r>
                        <a:rPr sz="300" spc="-8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&gt;200% </a:t>
                      </a:r>
                      <a:r>
                        <a:rPr sz="3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in</a:t>
                      </a:r>
                      <a:r>
                        <a:rPr sz="300" spc="-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2472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T w="3175">
                      <a:solidFill>
                        <a:srgbClr val="231F20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219" name="object 219"/>
          <p:cNvSpPr/>
          <p:nvPr/>
        </p:nvSpPr>
        <p:spPr>
          <a:xfrm>
            <a:off x="11540344" y="396683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0" name="object 220"/>
          <p:cNvSpPr/>
          <p:nvPr/>
        </p:nvSpPr>
        <p:spPr>
          <a:xfrm>
            <a:off x="11541418" y="4235289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1" name="object 221"/>
          <p:cNvSpPr/>
          <p:nvPr/>
        </p:nvSpPr>
        <p:spPr>
          <a:xfrm>
            <a:off x="11800385" y="4092120"/>
            <a:ext cx="1270" cy="143510"/>
          </a:xfrm>
          <a:custGeom>
            <a:avLst/>
            <a:gdLst/>
            <a:ahLst/>
            <a:cxnLst/>
            <a:rect l="l" t="t" r="r" b="b"/>
            <a:pathLst>
              <a:path w="1270" h="143510">
                <a:moveTo>
                  <a:pt x="1073" y="143174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2" name="object 222"/>
          <p:cNvSpPr/>
          <p:nvPr/>
        </p:nvSpPr>
        <p:spPr>
          <a:xfrm>
            <a:off x="10544505" y="5236635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3"/>
                </a:lnTo>
                <a:lnTo>
                  <a:pt x="394088" y="141713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3" name="object 223"/>
          <p:cNvSpPr/>
          <p:nvPr/>
        </p:nvSpPr>
        <p:spPr>
          <a:xfrm>
            <a:off x="10950822" y="5307506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32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4" name="object 224"/>
          <p:cNvSpPr/>
          <p:nvPr/>
        </p:nvSpPr>
        <p:spPr>
          <a:xfrm>
            <a:off x="10938592" y="529224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5" name="object 225"/>
          <p:cNvSpPr/>
          <p:nvPr/>
        </p:nvSpPr>
        <p:spPr>
          <a:xfrm>
            <a:off x="10950822" y="5576799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32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6" name="object 226"/>
          <p:cNvSpPr/>
          <p:nvPr/>
        </p:nvSpPr>
        <p:spPr>
          <a:xfrm>
            <a:off x="10938592" y="556153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7" name="object 227"/>
          <p:cNvSpPr/>
          <p:nvPr/>
        </p:nvSpPr>
        <p:spPr>
          <a:xfrm>
            <a:off x="10950822" y="5845962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32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8" name="object 228"/>
          <p:cNvSpPr/>
          <p:nvPr/>
        </p:nvSpPr>
        <p:spPr>
          <a:xfrm>
            <a:off x="10938592" y="583069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29" name="object 229"/>
          <p:cNvSpPr/>
          <p:nvPr/>
        </p:nvSpPr>
        <p:spPr>
          <a:xfrm>
            <a:off x="10741548" y="5378347"/>
            <a:ext cx="0" cy="127635"/>
          </a:xfrm>
          <a:custGeom>
            <a:avLst/>
            <a:gdLst/>
            <a:ahLst/>
            <a:cxnLst/>
            <a:rect l="l" t="t" r="r" b="b"/>
            <a:pathLst>
              <a:path h="127635">
                <a:moveTo>
                  <a:pt x="0" y="12761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0" name="object 230"/>
          <p:cNvSpPr/>
          <p:nvPr/>
        </p:nvSpPr>
        <p:spPr>
          <a:xfrm>
            <a:off x="10741548" y="5639701"/>
            <a:ext cx="0" cy="135890"/>
          </a:xfrm>
          <a:custGeom>
            <a:avLst/>
            <a:gdLst/>
            <a:ahLst/>
            <a:cxnLst/>
            <a:rect l="l" t="t" r="r" b="b"/>
            <a:pathLst>
              <a:path h="135889">
                <a:moveTo>
                  <a:pt x="0" y="13537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1" name="object 231"/>
          <p:cNvSpPr/>
          <p:nvPr/>
        </p:nvSpPr>
        <p:spPr>
          <a:xfrm>
            <a:off x="10544505" y="5505922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2" name="object 232"/>
          <p:cNvSpPr/>
          <p:nvPr/>
        </p:nvSpPr>
        <p:spPr>
          <a:xfrm>
            <a:off x="10544505" y="5775084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3" name="object 233"/>
          <p:cNvSpPr/>
          <p:nvPr/>
        </p:nvSpPr>
        <p:spPr>
          <a:xfrm>
            <a:off x="11546548" y="525548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3"/>
                </a:lnTo>
                <a:lnTo>
                  <a:pt x="520081" y="125283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4" name="object 234"/>
          <p:cNvSpPr/>
          <p:nvPr/>
        </p:nvSpPr>
        <p:spPr>
          <a:xfrm>
            <a:off x="11546547" y="525548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3"/>
                </a:lnTo>
                <a:lnTo>
                  <a:pt x="520081" y="125283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5" name="object 235"/>
          <p:cNvSpPr/>
          <p:nvPr/>
        </p:nvSpPr>
        <p:spPr>
          <a:xfrm>
            <a:off x="11547622" y="552389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6" name="object 236"/>
          <p:cNvSpPr/>
          <p:nvPr/>
        </p:nvSpPr>
        <p:spPr>
          <a:xfrm>
            <a:off x="11547622" y="552389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7" name="object 237"/>
          <p:cNvSpPr/>
          <p:nvPr/>
        </p:nvSpPr>
        <p:spPr>
          <a:xfrm>
            <a:off x="11806589" y="5380763"/>
            <a:ext cx="1270" cy="143510"/>
          </a:xfrm>
          <a:custGeom>
            <a:avLst/>
            <a:gdLst/>
            <a:ahLst/>
            <a:cxnLst/>
            <a:rect l="l" t="t" r="r" b="b"/>
            <a:pathLst>
              <a:path w="1270" h="143510">
                <a:moveTo>
                  <a:pt x="1073" y="14313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8" name="object 238"/>
          <p:cNvSpPr/>
          <p:nvPr/>
        </p:nvSpPr>
        <p:spPr>
          <a:xfrm>
            <a:off x="14316916" y="3672631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29">
                <a:moveTo>
                  <a:pt x="609267" y="0"/>
                </a:moveTo>
                <a:lnTo>
                  <a:pt x="37881" y="0"/>
                </a:lnTo>
                <a:lnTo>
                  <a:pt x="0" y="125277"/>
                </a:lnTo>
                <a:lnTo>
                  <a:pt x="571385" y="125277"/>
                </a:lnTo>
                <a:lnTo>
                  <a:pt x="609267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39" name="object 239"/>
          <p:cNvSpPr/>
          <p:nvPr/>
        </p:nvSpPr>
        <p:spPr>
          <a:xfrm>
            <a:off x="14316916" y="3672631"/>
            <a:ext cx="609600" cy="125730"/>
          </a:xfrm>
          <a:custGeom>
            <a:avLst/>
            <a:gdLst/>
            <a:ahLst/>
            <a:cxnLst/>
            <a:rect l="l" t="t" r="r" b="b"/>
            <a:pathLst>
              <a:path w="609600" h="125729">
                <a:moveTo>
                  <a:pt x="0" y="125277"/>
                </a:moveTo>
                <a:lnTo>
                  <a:pt x="571385" y="125277"/>
                </a:lnTo>
                <a:lnTo>
                  <a:pt x="609267" y="0"/>
                </a:lnTo>
                <a:lnTo>
                  <a:pt x="37881" y="0"/>
                </a:lnTo>
                <a:lnTo>
                  <a:pt x="0" y="12527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0" name="object 240"/>
          <p:cNvSpPr/>
          <p:nvPr/>
        </p:nvSpPr>
        <p:spPr>
          <a:xfrm>
            <a:off x="13804828" y="3609682"/>
            <a:ext cx="1905000" cy="144780"/>
          </a:xfrm>
          <a:custGeom>
            <a:avLst/>
            <a:gdLst/>
            <a:ahLst/>
            <a:cxnLst/>
            <a:rect l="l" t="t" r="r" b="b"/>
            <a:pathLst>
              <a:path w="1905000" h="144779">
                <a:moveTo>
                  <a:pt x="0" y="143616"/>
                </a:moveTo>
                <a:lnTo>
                  <a:pt x="481305" y="144272"/>
                </a:lnTo>
                <a:lnTo>
                  <a:pt x="483631" y="0"/>
                </a:lnTo>
                <a:lnTo>
                  <a:pt x="1904580" y="966"/>
                </a:lnTo>
                <a:lnTo>
                  <a:pt x="1904162" y="5075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1" name="object 241"/>
          <p:cNvSpPr/>
          <p:nvPr/>
        </p:nvSpPr>
        <p:spPr>
          <a:xfrm>
            <a:off x="15693780" y="3657234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80" h="15875">
                <a:moveTo>
                  <a:pt x="30484" y="262"/>
                </a:moveTo>
                <a:lnTo>
                  <a:pt x="0" y="0"/>
                </a:lnTo>
                <a:lnTo>
                  <a:pt x="15152" y="15397"/>
                </a:lnTo>
                <a:lnTo>
                  <a:pt x="30484" y="262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2" name="object 242"/>
          <p:cNvSpPr/>
          <p:nvPr/>
        </p:nvSpPr>
        <p:spPr>
          <a:xfrm>
            <a:off x="14434917" y="389314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22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3" name="object 243"/>
          <p:cNvSpPr/>
          <p:nvPr/>
        </p:nvSpPr>
        <p:spPr>
          <a:xfrm>
            <a:off x="14434917" y="389314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0"/>
                </a:moveTo>
                <a:lnTo>
                  <a:pt x="520022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4" name="object 244"/>
          <p:cNvSpPr/>
          <p:nvPr/>
        </p:nvSpPr>
        <p:spPr>
          <a:xfrm>
            <a:off x="14434917" y="4162479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5" name="object 245"/>
          <p:cNvSpPr/>
          <p:nvPr/>
        </p:nvSpPr>
        <p:spPr>
          <a:xfrm>
            <a:off x="14434917" y="4162479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260040" y="267318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6" name="object 246"/>
          <p:cNvSpPr/>
          <p:nvPr/>
        </p:nvSpPr>
        <p:spPr>
          <a:xfrm>
            <a:off x="14434917" y="4431593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6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7" name="object 247"/>
          <p:cNvSpPr/>
          <p:nvPr/>
        </p:nvSpPr>
        <p:spPr>
          <a:xfrm>
            <a:off x="14434917" y="4431593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6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8" name="object 248"/>
          <p:cNvSpPr/>
          <p:nvPr/>
        </p:nvSpPr>
        <p:spPr>
          <a:xfrm>
            <a:off x="13978667" y="3955974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49" name="object 249"/>
          <p:cNvSpPr/>
          <p:nvPr/>
        </p:nvSpPr>
        <p:spPr>
          <a:xfrm>
            <a:off x="14384925" y="4026845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0" name="object 250"/>
          <p:cNvSpPr/>
          <p:nvPr/>
        </p:nvSpPr>
        <p:spPr>
          <a:xfrm>
            <a:off x="14372755" y="4011579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1" name="object 251"/>
          <p:cNvSpPr/>
          <p:nvPr/>
        </p:nvSpPr>
        <p:spPr>
          <a:xfrm>
            <a:off x="14384925" y="4296138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2" name="object 252"/>
          <p:cNvSpPr/>
          <p:nvPr/>
        </p:nvSpPr>
        <p:spPr>
          <a:xfrm>
            <a:off x="14372755" y="4280872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3" name="object 253"/>
          <p:cNvSpPr/>
          <p:nvPr/>
        </p:nvSpPr>
        <p:spPr>
          <a:xfrm>
            <a:off x="14384925" y="4565253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4" name="object 254"/>
          <p:cNvSpPr/>
          <p:nvPr/>
        </p:nvSpPr>
        <p:spPr>
          <a:xfrm>
            <a:off x="14372755" y="454999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26"/>
                </a:moveTo>
                <a:lnTo>
                  <a:pt x="15271" y="0"/>
                </a:lnTo>
                <a:lnTo>
                  <a:pt x="0" y="15260"/>
                </a:lnTo>
                <a:lnTo>
                  <a:pt x="15271" y="30526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5" name="object 255"/>
          <p:cNvSpPr/>
          <p:nvPr/>
        </p:nvSpPr>
        <p:spPr>
          <a:xfrm>
            <a:off x="15546727" y="3895816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6" name="object 256"/>
          <p:cNvSpPr/>
          <p:nvPr/>
        </p:nvSpPr>
        <p:spPr>
          <a:xfrm>
            <a:off x="15546727" y="3895816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260040" y="267318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7" name="object 257"/>
          <p:cNvSpPr/>
          <p:nvPr/>
        </p:nvSpPr>
        <p:spPr>
          <a:xfrm>
            <a:off x="15546727" y="4164274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8" name="object 258"/>
          <p:cNvSpPr/>
          <p:nvPr/>
        </p:nvSpPr>
        <p:spPr>
          <a:xfrm>
            <a:off x="15546727" y="4164274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5" h="267335">
                <a:moveTo>
                  <a:pt x="260040" y="267318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59" name="object 259"/>
          <p:cNvSpPr/>
          <p:nvPr/>
        </p:nvSpPr>
        <p:spPr>
          <a:xfrm>
            <a:off x="13218230" y="3617467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82"/>
                </a:lnTo>
                <a:lnTo>
                  <a:pt x="224485" y="174082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0" name="object 260"/>
          <p:cNvSpPr/>
          <p:nvPr/>
        </p:nvSpPr>
        <p:spPr>
          <a:xfrm>
            <a:off x="13220379" y="3829341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82"/>
                </a:lnTo>
                <a:lnTo>
                  <a:pt x="224485" y="174082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1" name="object 261"/>
          <p:cNvSpPr/>
          <p:nvPr/>
        </p:nvSpPr>
        <p:spPr>
          <a:xfrm>
            <a:off x="13444864" y="3753560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5">
                <a:moveTo>
                  <a:pt x="0" y="162831"/>
                </a:moveTo>
                <a:lnTo>
                  <a:pt x="532788" y="159544"/>
                </a:lnTo>
                <a:lnTo>
                  <a:pt x="53254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2" name="object 262"/>
          <p:cNvSpPr/>
          <p:nvPr/>
        </p:nvSpPr>
        <p:spPr>
          <a:xfrm>
            <a:off x="13477496" y="361746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3" name="object 263"/>
          <p:cNvSpPr/>
          <p:nvPr/>
        </p:nvSpPr>
        <p:spPr>
          <a:xfrm>
            <a:off x="13477496" y="361746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4" name="object 264"/>
          <p:cNvSpPr/>
          <p:nvPr/>
        </p:nvSpPr>
        <p:spPr>
          <a:xfrm>
            <a:off x="13478212" y="382934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5" name="object 265"/>
          <p:cNvSpPr/>
          <p:nvPr/>
        </p:nvSpPr>
        <p:spPr>
          <a:xfrm>
            <a:off x="13478212" y="382934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82"/>
                </a:lnTo>
                <a:lnTo>
                  <a:pt x="440202" y="174082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6" name="object 266"/>
          <p:cNvSpPr/>
          <p:nvPr/>
        </p:nvSpPr>
        <p:spPr>
          <a:xfrm>
            <a:off x="15507002" y="4029476"/>
            <a:ext cx="40005" cy="0"/>
          </a:xfrm>
          <a:custGeom>
            <a:avLst/>
            <a:gdLst/>
            <a:ahLst/>
            <a:cxnLst/>
            <a:rect l="l" t="t" r="r" b="b"/>
            <a:pathLst>
              <a:path w="40005">
                <a:moveTo>
                  <a:pt x="3973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7" name="object 267"/>
          <p:cNvSpPr/>
          <p:nvPr/>
        </p:nvSpPr>
        <p:spPr>
          <a:xfrm>
            <a:off x="15494767" y="401421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8" name="object 268"/>
          <p:cNvSpPr/>
          <p:nvPr/>
        </p:nvSpPr>
        <p:spPr>
          <a:xfrm>
            <a:off x="15495900" y="4282668"/>
            <a:ext cx="15240" cy="31115"/>
          </a:xfrm>
          <a:custGeom>
            <a:avLst/>
            <a:gdLst/>
            <a:ahLst/>
            <a:cxnLst/>
            <a:rect l="l" t="t" r="r" b="b"/>
            <a:pathLst>
              <a:path w="15240" h="31114">
                <a:moveTo>
                  <a:pt x="15212" y="30531"/>
                </a:moveTo>
                <a:lnTo>
                  <a:pt x="15212" y="0"/>
                </a:lnTo>
                <a:lnTo>
                  <a:pt x="0" y="15265"/>
                </a:lnTo>
                <a:lnTo>
                  <a:pt x="15212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69" name="object 269"/>
          <p:cNvSpPr/>
          <p:nvPr/>
        </p:nvSpPr>
        <p:spPr>
          <a:xfrm>
            <a:off x="15362211" y="367263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652816" y="0"/>
                </a:moveTo>
                <a:lnTo>
                  <a:pt x="40566" y="0"/>
                </a:lnTo>
                <a:lnTo>
                  <a:pt x="0" y="74265"/>
                </a:lnTo>
                <a:lnTo>
                  <a:pt x="612190" y="74265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0" name="object 270"/>
          <p:cNvSpPr/>
          <p:nvPr/>
        </p:nvSpPr>
        <p:spPr>
          <a:xfrm>
            <a:off x="15362211" y="367263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0" y="74265"/>
                </a:moveTo>
                <a:lnTo>
                  <a:pt x="612190" y="74265"/>
                </a:lnTo>
                <a:lnTo>
                  <a:pt x="652816" y="0"/>
                </a:lnTo>
                <a:lnTo>
                  <a:pt x="40566" y="0"/>
                </a:lnTo>
                <a:lnTo>
                  <a:pt x="0" y="74265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1" name="object 271"/>
          <p:cNvSpPr/>
          <p:nvPr/>
        </p:nvSpPr>
        <p:spPr>
          <a:xfrm>
            <a:off x="14661311" y="3610732"/>
            <a:ext cx="0" cy="50165"/>
          </a:xfrm>
          <a:custGeom>
            <a:avLst/>
            <a:gdLst/>
            <a:ahLst/>
            <a:cxnLst/>
            <a:rect l="l" t="t" r="r" b="b"/>
            <a:pathLst>
              <a:path h="50164">
                <a:moveTo>
                  <a:pt x="0" y="0"/>
                </a:moveTo>
                <a:lnTo>
                  <a:pt x="0" y="4969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2" name="object 272"/>
          <p:cNvSpPr/>
          <p:nvPr/>
        </p:nvSpPr>
        <p:spPr>
          <a:xfrm>
            <a:off x="14646039" y="365736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3" name="object 273"/>
          <p:cNvSpPr/>
          <p:nvPr/>
        </p:nvSpPr>
        <p:spPr>
          <a:xfrm>
            <a:off x="14264419" y="4963075"/>
            <a:ext cx="653415" cy="125730"/>
          </a:xfrm>
          <a:custGeom>
            <a:avLst/>
            <a:gdLst/>
            <a:ahLst/>
            <a:cxnLst/>
            <a:rect l="l" t="t" r="r" b="b"/>
            <a:pathLst>
              <a:path w="653415" h="125729">
                <a:moveTo>
                  <a:pt x="652816" y="0"/>
                </a:moveTo>
                <a:lnTo>
                  <a:pt x="15271" y="0"/>
                </a:lnTo>
                <a:lnTo>
                  <a:pt x="0" y="125319"/>
                </a:lnTo>
                <a:lnTo>
                  <a:pt x="637604" y="125319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4" name="object 274"/>
          <p:cNvSpPr/>
          <p:nvPr/>
        </p:nvSpPr>
        <p:spPr>
          <a:xfrm>
            <a:off x="14264419" y="4963075"/>
            <a:ext cx="653415" cy="125730"/>
          </a:xfrm>
          <a:custGeom>
            <a:avLst/>
            <a:gdLst/>
            <a:ahLst/>
            <a:cxnLst/>
            <a:rect l="l" t="t" r="r" b="b"/>
            <a:pathLst>
              <a:path w="653415" h="125729">
                <a:moveTo>
                  <a:pt x="0" y="125319"/>
                </a:moveTo>
                <a:lnTo>
                  <a:pt x="637604" y="125319"/>
                </a:lnTo>
                <a:lnTo>
                  <a:pt x="652816" y="0"/>
                </a:lnTo>
                <a:lnTo>
                  <a:pt x="15271" y="0"/>
                </a:lnTo>
                <a:lnTo>
                  <a:pt x="0" y="12531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5" name="object 275"/>
          <p:cNvSpPr/>
          <p:nvPr/>
        </p:nvSpPr>
        <p:spPr>
          <a:xfrm>
            <a:off x="15676126" y="3610648"/>
            <a:ext cx="424815" cy="1350010"/>
          </a:xfrm>
          <a:custGeom>
            <a:avLst/>
            <a:gdLst/>
            <a:ahLst/>
            <a:cxnLst/>
            <a:rect l="l" t="t" r="r" b="b"/>
            <a:pathLst>
              <a:path w="424815" h="1350010">
                <a:moveTo>
                  <a:pt x="33288" y="0"/>
                </a:moveTo>
                <a:lnTo>
                  <a:pt x="424691" y="787"/>
                </a:lnTo>
                <a:lnTo>
                  <a:pt x="422842" y="1294698"/>
                </a:lnTo>
                <a:lnTo>
                  <a:pt x="0" y="1295968"/>
                </a:lnTo>
                <a:lnTo>
                  <a:pt x="596" y="134965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6" name="object 276"/>
          <p:cNvSpPr/>
          <p:nvPr/>
        </p:nvSpPr>
        <p:spPr>
          <a:xfrm>
            <a:off x="15661445" y="4957062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351"/>
                </a:lnTo>
                <a:lnTo>
                  <a:pt x="15450" y="15438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7" name="object 277"/>
          <p:cNvSpPr/>
          <p:nvPr/>
        </p:nvSpPr>
        <p:spPr>
          <a:xfrm>
            <a:off x="15330182" y="497250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652816" y="0"/>
                </a:moveTo>
                <a:lnTo>
                  <a:pt x="40625" y="0"/>
                </a:lnTo>
                <a:lnTo>
                  <a:pt x="0" y="74265"/>
                </a:lnTo>
                <a:lnTo>
                  <a:pt x="612190" y="74265"/>
                </a:lnTo>
                <a:lnTo>
                  <a:pt x="652816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8" name="object 278"/>
          <p:cNvSpPr/>
          <p:nvPr/>
        </p:nvSpPr>
        <p:spPr>
          <a:xfrm>
            <a:off x="15330182" y="4972501"/>
            <a:ext cx="653415" cy="74295"/>
          </a:xfrm>
          <a:custGeom>
            <a:avLst/>
            <a:gdLst/>
            <a:ahLst/>
            <a:cxnLst/>
            <a:rect l="l" t="t" r="r" b="b"/>
            <a:pathLst>
              <a:path w="653415" h="74295">
                <a:moveTo>
                  <a:pt x="0" y="74265"/>
                </a:moveTo>
                <a:lnTo>
                  <a:pt x="612190" y="74265"/>
                </a:lnTo>
                <a:lnTo>
                  <a:pt x="652816" y="0"/>
                </a:lnTo>
                <a:lnTo>
                  <a:pt x="40625" y="0"/>
                </a:lnTo>
                <a:lnTo>
                  <a:pt x="0" y="74265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79" name="object 279"/>
          <p:cNvSpPr/>
          <p:nvPr/>
        </p:nvSpPr>
        <p:spPr>
          <a:xfrm>
            <a:off x="14598493" y="4905346"/>
            <a:ext cx="1078230" cy="45720"/>
          </a:xfrm>
          <a:custGeom>
            <a:avLst/>
            <a:gdLst/>
            <a:ahLst/>
            <a:cxnLst/>
            <a:rect l="l" t="t" r="r" b="b"/>
            <a:pathLst>
              <a:path w="1078230" h="45720">
                <a:moveTo>
                  <a:pt x="1077627" y="1270"/>
                </a:moveTo>
                <a:lnTo>
                  <a:pt x="178" y="0"/>
                </a:lnTo>
                <a:lnTo>
                  <a:pt x="0" y="4552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0" name="object 280"/>
          <p:cNvSpPr/>
          <p:nvPr/>
        </p:nvSpPr>
        <p:spPr>
          <a:xfrm>
            <a:off x="14583221" y="4947762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131"/>
                </a:moveTo>
                <a:lnTo>
                  <a:pt x="0" y="0"/>
                </a:lnTo>
                <a:lnTo>
                  <a:pt x="15271" y="15313"/>
                </a:lnTo>
                <a:lnTo>
                  <a:pt x="30543" y="1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1" name="object 281"/>
          <p:cNvSpPr/>
          <p:nvPr/>
        </p:nvSpPr>
        <p:spPr>
          <a:xfrm>
            <a:off x="14694957" y="3797909"/>
            <a:ext cx="0" cy="83185"/>
          </a:xfrm>
          <a:custGeom>
            <a:avLst/>
            <a:gdLst/>
            <a:ahLst/>
            <a:cxnLst/>
            <a:rect l="l" t="t" r="r" b="b"/>
            <a:pathLst>
              <a:path h="83185">
                <a:moveTo>
                  <a:pt x="0" y="0"/>
                </a:moveTo>
                <a:lnTo>
                  <a:pt x="0" y="8304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2" name="object 282"/>
          <p:cNvSpPr/>
          <p:nvPr/>
        </p:nvSpPr>
        <p:spPr>
          <a:xfrm>
            <a:off x="14679685" y="3877878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80" h="15875">
                <a:moveTo>
                  <a:pt x="30484" y="0"/>
                </a:moveTo>
                <a:lnTo>
                  <a:pt x="0" y="0"/>
                </a:lnTo>
                <a:lnTo>
                  <a:pt x="15271" y="15265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3" name="object 283"/>
          <p:cNvSpPr/>
          <p:nvPr/>
        </p:nvSpPr>
        <p:spPr>
          <a:xfrm>
            <a:off x="15806768" y="3746897"/>
            <a:ext cx="0" cy="137160"/>
          </a:xfrm>
          <a:custGeom>
            <a:avLst/>
            <a:gdLst/>
            <a:ahLst/>
            <a:cxnLst/>
            <a:rect l="l" t="t" r="r" b="b"/>
            <a:pathLst>
              <a:path h="137160">
                <a:moveTo>
                  <a:pt x="0" y="0"/>
                </a:moveTo>
                <a:lnTo>
                  <a:pt x="0" y="13672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4" name="object 284"/>
          <p:cNvSpPr/>
          <p:nvPr/>
        </p:nvSpPr>
        <p:spPr>
          <a:xfrm>
            <a:off x="15791496" y="388055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0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5" name="object 285"/>
          <p:cNvSpPr/>
          <p:nvPr/>
        </p:nvSpPr>
        <p:spPr>
          <a:xfrm>
            <a:off x="14434917" y="517389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6" name="object 286"/>
          <p:cNvSpPr/>
          <p:nvPr/>
        </p:nvSpPr>
        <p:spPr>
          <a:xfrm>
            <a:off x="14434917" y="517389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0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7" name="object 287"/>
          <p:cNvSpPr/>
          <p:nvPr/>
        </p:nvSpPr>
        <p:spPr>
          <a:xfrm>
            <a:off x="14434917" y="5443182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707"/>
                </a:moveTo>
                <a:lnTo>
                  <a:pt x="260040" y="0"/>
                </a:lnTo>
                <a:lnTo>
                  <a:pt x="0" y="133707"/>
                </a:lnTo>
                <a:lnTo>
                  <a:pt x="260040" y="267366"/>
                </a:lnTo>
                <a:lnTo>
                  <a:pt x="520022" y="133707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8" name="object 288"/>
          <p:cNvSpPr/>
          <p:nvPr/>
        </p:nvSpPr>
        <p:spPr>
          <a:xfrm>
            <a:off x="14434917" y="5443182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6"/>
                </a:moveTo>
                <a:lnTo>
                  <a:pt x="520022" y="133707"/>
                </a:lnTo>
                <a:lnTo>
                  <a:pt x="260040" y="0"/>
                </a:lnTo>
                <a:lnTo>
                  <a:pt x="0" y="133707"/>
                </a:lnTo>
                <a:lnTo>
                  <a:pt x="260040" y="267366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89" name="object 289"/>
          <p:cNvSpPr/>
          <p:nvPr/>
        </p:nvSpPr>
        <p:spPr>
          <a:xfrm>
            <a:off x="14434917" y="571234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48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0" name="object 290"/>
          <p:cNvSpPr/>
          <p:nvPr/>
        </p:nvSpPr>
        <p:spPr>
          <a:xfrm>
            <a:off x="14434917" y="571234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48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4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1" name="object 291"/>
          <p:cNvSpPr/>
          <p:nvPr/>
        </p:nvSpPr>
        <p:spPr>
          <a:xfrm>
            <a:off x="14694957" y="5088395"/>
            <a:ext cx="0" cy="73660"/>
          </a:xfrm>
          <a:custGeom>
            <a:avLst/>
            <a:gdLst/>
            <a:ahLst/>
            <a:cxnLst/>
            <a:rect l="l" t="t" r="r" b="b"/>
            <a:pathLst>
              <a:path h="73660">
                <a:moveTo>
                  <a:pt x="0" y="0"/>
                </a:moveTo>
                <a:lnTo>
                  <a:pt x="0" y="7330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2" name="object 292"/>
          <p:cNvSpPr/>
          <p:nvPr/>
        </p:nvSpPr>
        <p:spPr>
          <a:xfrm>
            <a:off x="14679685" y="5158628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80" h="15875">
                <a:moveTo>
                  <a:pt x="30484" y="0"/>
                </a:moveTo>
                <a:lnTo>
                  <a:pt x="0" y="0"/>
                </a:lnTo>
                <a:lnTo>
                  <a:pt x="15271" y="15265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3" name="object 293"/>
          <p:cNvSpPr/>
          <p:nvPr/>
        </p:nvSpPr>
        <p:spPr>
          <a:xfrm>
            <a:off x="15566473" y="5191087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22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4" name="object 294"/>
          <p:cNvSpPr/>
          <p:nvPr/>
        </p:nvSpPr>
        <p:spPr>
          <a:xfrm>
            <a:off x="15566473" y="5191087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0"/>
                </a:moveTo>
                <a:lnTo>
                  <a:pt x="520022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5" name="object 295"/>
          <p:cNvSpPr/>
          <p:nvPr/>
        </p:nvSpPr>
        <p:spPr>
          <a:xfrm>
            <a:off x="15566473" y="5459545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520022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lnTo>
                  <a:pt x="520022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6" name="object 296"/>
          <p:cNvSpPr/>
          <p:nvPr/>
        </p:nvSpPr>
        <p:spPr>
          <a:xfrm>
            <a:off x="15566473" y="5459545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5" h="267970">
                <a:moveTo>
                  <a:pt x="260040" y="267360"/>
                </a:moveTo>
                <a:lnTo>
                  <a:pt x="520022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7" name="object 297"/>
          <p:cNvSpPr/>
          <p:nvPr/>
        </p:nvSpPr>
        <p:spPr>
          <a:xfrm>
            <a:off x="15826334" y="5046767"/>
            <a:ext cx="0" cy="132080"/>
          </a:xfrm>
          <a:custGeom>
            <a:avLst/>
            <a:gdLst/>
            <a:ahLst/>
            <a:cxnLst/>
            <a:rect l="l" t="t" r="r" b="b"/>
            <a:pathLst>
              <a:path h="132079">
                <a:moveTo>
                  <a:pt x="0" y="0"/>
                </a:moveTo>
                <a:lnTo>
                  <a:pt x="0" y="13160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8" name="object 298"/>
          <p:cNvSpPr/>
          <p:nvPr/>
        </p:nvSpPr>
        <p:spPr>
          <a:xfrm>
            <a:off x="15811069" y="517529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65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99" name="object 299"/>
          <p:cNvSpPr/>
          <p:nvPr/>
        </p:nvSpPr>
        <p:spPr>
          <a:xfrm>
            <a:off x="15511417" y="5324263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0" name="object 300"/>
          <p:cNvSpPr/>
          <p:nvPr/>
        </p:nvSpPr>
        <p:spPr>
          <a:xfrm>
            <a:off x="15499181" y="5308997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91" y="0"/>
                </a:moveTo>
                <a:lnTo>
                  <a:pt x="0" y="15176"/>
                </a:lnTo>
                <a:lnTo>
                  <a:pt x="15212" y="30531"/>
                </a:lnTo>
                <a:lnTo>
                  <a:pt x="1539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1" name="object 301"/>
          <p:cNvSpPr/>
          <p:nvPr/>
        </p:nvSpPr>
        <p:spPr>
          <a:xfrm>
            <a:off x="15511417" y="5592680"/>
            <a:ext cx="56515" cy="635"/>
          </a:xfrm>
          <a:custGeom>
            <a:avLst/>
            <a:gdLst/>
            <a:ahLst/>
            <a:cxnLst/>
            <a:rect l="l" t="t" r="r" b="b"/>
            <a:pathLst>
              <a:path w="56515" h="635">
                <a:moveTo>
                  <a:pt x="55957" y="26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2" name="object 302"/>
          <p:cNvSpPr/>
          <p:nvPr/>
        </p:nvSpPr>
        <p:spPr>
          <a:xfrm>
            <a:off x="15499181" y="557745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91" y="0"/>
                </a:moveTo>
                <a:lnTo>
                  <a:pt x="0" y="15182"/>
                </a:lnTo>
                <a:lnTo>
                  <a:pt x="15212" y="30531"/>
                </a:lnTo>
                <a:lnTo>
                  <a:pt x="15391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3" name="object 303"/>
          <p:cNvSpPr/>
          <p:nvPr/>
        </p:nvSpPr>
        <p:spPr>
          <a:xfrm>
            <a:off x="13300496" y="481037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4" name="object 304"/>
          <p:cNvSpPr/>
          <p:nvPr/>
        </p:nvSpPr>
        <p:spPr>
          <a:xfrm>
            <a:off x="13300496" y="481037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83"/>
                </a:lnTo>
                <a:lnTo>
                  <a:pt x="573414" y="125283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5" name="object 305"/>
          <p:cNvSpPr/>
          <p:nvPr/>
        </p:nvSpPr>
        <p:spPr>
          <a:xfrm>
            <a:off x="14175711" y="4097692"/>
            <a:ext cx="0" cy="127635"/>
          </a:xfrm>
          <a:custGeom>
            <a:avLst/>
            <a:gdLst/>
            <a:ahLst/>
            <a:cxnLst/>
            <a:rect l="l" t="t" r="r" b="b"/>
            <a:pathLst>
              <a:path h="127635">
                <a:moveTo>
                  <a:pt x="0" y="127556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6" name="object 306"/>
          <p:cNvSpPr/>
          <p:nvPr/>
        </p:nvSpPr>
        <p:spPr>
          <a:xfrm>
            <a:off x="14175711" y="4359040"/>
            <a:ext cx="0" cy="135890"/>
          </a:xfrm>
          <a:custGeom>
            <a:avLst/>
            <a:gdLst/>
            <a:ahLst/>
            <a:cxnLst/>
            <a:rect l="l" t="t" r="r" b="b"/>
            <a:pathLst>
              <a:path h="135889">
                <a:moveTo>
                  <a:pt x="0" y="13537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7" name="object 307"/>
          <p:cNvSpPr/>
          <p:nvPr/>
        </p:nvSpPr>
        <p:spPr>
          <a:xfrm>
            <a:off x="13886140" y="4360579"/>
            <a:ext cx="1350010" cy="512445"/>
          </a:xfrm>
          <a:custGeom>
            <a:avLst/>
            <a:gdLst/>
            <a:ahLst/>
            <a:cxnLst/>
            <a:rect l="l" t="t" r="r" b="b"/>
            <a:pathLst>
              <a:path w="1350009" h="512445">
                <a:moveTo>
                  <a:pt x="0" y="512439"/>
                </a:moveTo>
                <a:lnTo>
                  <a:pt x="1348585" y="512439"/>
                </a:lnTo>
                <a:lnTo>
                  <a:pt x="1349718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8" name="object 308"/>
          <p:cNvSpPr/>
          <p:nvPr/>
        </p:nvSpPr>
        <p:spPr>
          <a:xfrm>
            <a:off x="13873911" y="485775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09" name="object 309"/>
          <p:cNvSpPr/>
          <p:nvPr/>
        </p:nvSpPr>
        <p:spPr>
          <a:xfrm>
            <a:off x="14175711" y="4636142"/>
            <a:ext cx="1270" cy="224790"/>
          </a:xfrm>
          <a:custGeom>
            <a:avLst/>
            <a:gdLst/>
            <a:ahLst/>
            <a:cxnLst/>
            <a:rect l="l" t="t" r="r" b="b"/>
            <a:pathLst>
              <a:path w="1269" h="224789">
                <a:moveTo>
                  <a:pt x="835" y="22468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0" name="object 310"/>
          <p:cNvSpPr/>
          <p:nvPr/>
        </p:nvSpPr>
        <p:spPr>
          <a:xfrm>
            <a:off x="14161273" y="485770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137"/>
                </a:lnTo>
                <a:lnTo>
                  <a:pt x="15271" y="15313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1" name="object 311"/>
          <p:cNvSpPr/>
          <p:nvPr/>
        </p:nvSpPr>
        <p:spPr>
          <a:xfrm>
            <a:off x="13939234" y="4884508"/>
            <a:ext cx="237490" cy="352425"/>
          </a:xfrm>
          <a:custGeom>
            <a:avLst/>
            <a:gdLst/>
            <a:ahLst/>
            <a:cxnLst/>
            <a:rect l="l" t="t" r="r" b="b"/>
            <a:pathLst>
              <a:path w="237490" h="352425">
                <a:moveTo>
                  <a:pt x="0" y="0"/>
                </a:moveTo>
                <a:lnTo>
                  <a:pt x="298" y="305045"/>
                </a:lnTo>
                <a:lnTo>
                  <a:pt x="237311" y="305612"/>
                </a:lnTo>
                <a:lnTo>
                  <a:pt x="236655" y="35215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2" name="object 312"/>
          <p:cNvSpPr/>
          <p:nvPr/>
        </p:nvSpPr>
        <p:spPr>
          <a:xfrm>
            <a:off x="13923962" y="487231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15224"/>
                </a:moveTo>
                <a:lnTo>
                  <a:pt x="15271" y="0"/>
                </a:lnTo>
                <a:lnTo>
                  <a:pt x="0" y="15265"/>
                </a:lnTo>
                <a:lnTo>
                  <a:pt x="30543" y="1522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3" name="object 313"/>
          <p:cNvSpPr/>
          <p:nvPr/>
        </p:nvSpPr>
        <p:spPr>
          <a:xfrm>
            <a:off x="13939056" y="5189554"/>
            <a:ext cx="1305560" cy="821690"/>
          </a:xfrm>
          <a:custGeom>
            <a:avLst/>
            <a:gdLst/>
            <a:ahLst/>
            <a:cxnLst/>
            <a:rect l="l" t="t" r="r" b="b"/>
            <a:pathLst>
              <a:path w="1305559" h="821689">
                <a:moveTo>
                  <a:pt x="477" y="0"/>
                </a:moveTo>
                <a:lnTo>
                  <a:pt x="0" y="821219"/>
                </a:lnTo>
                <a:lnTo>
                  <a:pt x="1305155" y="821279"/>
                </a:lnTo>
                <a:lnTo>
                  <a:pt x="1303008" y="459626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4" name="object 314"/>
          <p:cNvSpPr/>
          <p:nvPr/>
        </p:nvSpPr>
        <p:spPr>
          <a:xfrm>
            <a:off x="13978667" y="4225267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3"/>
                </a:lnTo>
                <a:lnTo>
                  <a:pt x="394088" y="141713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5" name="object 315"/>
          <p:cNvSpPr/>
          <p:nvPr/>
        </p:nvSpPr>
        <p:spPr>
          <a:xfrm>
            <a:off x="13978667" y="4494423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6" name="object 316"/>
          <p:cNvSpPr/>
          <p:nvPr/>
        </p:nvSpPr>
        <p:spPr>
          <a:xfrm>
            <a:off x="14974684" y="396683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7" name="object 317"/>
          <p:cNvSpPr/>
          <p:nvPr/>
        </p:nvSpPr>
        <p:spPr>
          <a:xfrm>
            <a:off x="14975819" y="4235289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8" name="object 318"/>
          <p:cNvSpPr/>
          <p:nvPr/>
        </p:nvSpPr>
        <p:spPr>
          <a:xfrm>
            <a:off x="15234725" y="4092120"/>
            <a:ext cx="1270" cy="143510"/>
          </a:xfrm>
          <a:custGeom>
            <a:avLst/>
            <a:gdLst/>
            <a:ahLst/>
            <a:cxnLst/>
            <a:rect l="l" t="t" r="r" b="b"/>
            <a:pathLst>
              <a:path w="1269" h="143510">
                <a:moveTo>
                  <a:pt x="1133" y="143174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19" name="object 319"/>
          <p:cNvSpPr/>
          <p:nvPr/>
        </p:nvSpPr>
        <p:spPr>
          <a:xfrm>
            <a:off x="13978845" y="5236635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3"/>
                </a:lnTo>
                <a:lnTo>
                  <a:pt x="394088" y="141713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0" name="object 320"/>
          <p:cNvSpPr/>
          <p:nvPr/>
        </p:nvSpPr>
        <p:spPr>
          <a:xfrm>
            <a:off x="14385163" y="5307506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1" name="object 321"/>
          <p:cNvSpPr/>
          <p:nvPr/>
        </p:nvSpPr>
        <p:spPr>
          <a:xfrm>
            <a:off x="14372933" y="529224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2" name="object 322"/>
          <p:cNvSpPr/>
          <p:nvPr/>
        </p:nvSpPr>
        <p:spPr>
          <a:xfrm>
            <a:off x="14385163" y="5576799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3" name="object 323"/>
          <p:cNvSpPr/>
          <p:nvPr/>
        </p:nvSpPr>
        <p:spPr>
          <a:xfrm>
            <a:off x="14372933" y="556153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4" name="object 324"/>
          <p:cNvSpPr/>
          <p:nvPr/>
        </p:nvSpPr>
        <p:spPr>
          <a:xfrm>
            <a:off x="14385163" y="5845962"/>
            <a:ext cx="50165" cy="0"/>
          </a:xfrm>
          <a:custGeom>
            <a:avLst/>
            <a:gdLst/>
            <a:ahLst/>
            <a:cxnLst/>
            <a:rect l="l" t="t" r="r" b="b"/>
            <a:pathLst>
              <a:path w="50165">
                <a:moveTo>
                  <a:pt x="499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5" name="object 325"/>
          <p:cNvSpPr/>
          <p:nvPr/>
        </p:nvSpPr>
        <p:spPr>
          <a:xfrm>
            <a:off x="14372933" y="583069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30531"/>
                </a:moveTo>
                <a:lnTo>
                  <a:pt x="15271" y="0"/>
                </a:lnTo>
                <a:lnTo>
                  <a:pt x="0" y="15265"/>
                </a:lnTo>
                <a:lnTo>
                  <a:pt x="15271" y="3053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6" name="object 326"/>
          <p:cNvSpPr/>
          <p:nvPr/>
        </p:nvSpPr>
        <p:spPr>
          <a:xfrm>
            <a:off x="14175889" y="5378347"/>
            <a:ext cx="0" cy="127635"/>
          </a:xfrm>
          <a:custGeom>
            <a:avLst/>
            <a:gdLst/>
            <a:ahLst/>
            <a:cxnLst/>
            <a:rect l="l" t="t" r="r" b="b"/>
            <a:pathLst>
              <a:path h="127635">
                <a:moveTo>
                  <a:pt x="0" y="12761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7" name="object 327"/>
          <p:cNvSpPr/>
          <p:nvPr/>
        </p:nvSpPr>
        <p:spPr>
          <a:xfrm>
            <a:off x="14175889" y="5639701"/>
            <a:ext cx="0" cy="135890"/>
          </a:xfrm>
          <a:custGeom>
            <a:avLst/>
            <a:gdLst/>
            <a:ahLst/>
            <a:cxnLst/>
            <a:rect l="l" t="t" r="r" b="b"/>
            <a:pathLst>
              <a:path h="135889">
                <a:moveTo>
                  <a:pt x="0" y="13537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8" name="object 328"/>
          <p:cNvSpPr/>
          <p:nvPr/>
        </p:nvSpPr>
        <p:spPr>
          <a:xfrm>
            <a:off x="13978845" y="5505922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29" name="object 329"/>
          <p:cNvSpPr/>
          <p:nvPr/>
        </p:nvSpPr>
        <p:spPr>
          <a:xfrm>
            <a:off x="13978845" y="5775084"/>
            <a:ext cx="394335" cy="142240"/>
          </a:xfrm>
          <a:custGeom>
            <a:avLst/>
            <a:gdLst/>
            <a:ahLst/>
            <a:cxnLst/>
            <a:rect l="l" t="t" r="r" b="b"/>
            <a:pathLst>
              <a:path w="394334" h="142239">
                <a:moveTo>
                  <a:pt x="0" y="0"/>
                </a:moveTo>
                <a:lnTo>
                  <a:pt x="0" y="141718"/>
                </a:lnTo>
                <a:lnTo>
                  <a:pt x="394088" y="141718"/>
                </a:lnTo>
                <a:lnTo>
                  <a:pt x="394088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0" name="object 330"/>
          <p:cNvSpPr/>
          <p:nvPr/>
        </p:nvSpPr>
        <p:spPr>
          <a:xfrm>
            <a:off x="14980949" y="525548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3"/>
                </a:lnTo>
                <a:lnTo>
                  <a:pt x="520081" y="125283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1" name="object 331"/>
          <p:cNvSpPr/>
          <p:nvPr/>
        </p:nvSpPr>
        <p:spPr>
          <a:xfrm>
            <a:off x="14980949" y="525548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3"/>
                </a:lnTo>
                <a:lnTo>
                  <a:pt x="520081" y="125283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2" name="object 332"/>
          <p:cNvSpPr/>
          <p:nvPr/>
        </p:nvSpPr>
        <p:spPr>
          <a:xfrm>
            <a:off x="14982023" y="552389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3" name="object 333"/>
          <p:cNvSpPr/>
          <p:nvPr/>
        </p:nvSpPr>
        <p:spPr>
          <a:xfrm>
            <a:off x="14982023" y="5523890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89"/>
                </a:lnTo>
                <a:lnTo>
                  <a:pt x="520081" y="125289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4" name="object 334"/>
          <p:cNvSpPr/>
          <p:nvPr/>
        </p:nvSpPr>
        <p:spPr>
          <a:xfrm>
            <a:off x="15240989" y="5380763"/>
            <a:ext cx="1270" cy="143510"/>
          </a:xfrm>
          <a:custGeom>
            <a:avLst/>
            <a:gdLst/>
            <a:ahLst/>
            <a:cxnLst/>
            <a:rect l="l" t="t" r="r" b="b"/>
            <a:pathLst>
              <a:path w="1269" h="143510">
                <a:moveTo>
                  <a:pt x="1073" y="143132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5" name="object 335"/>
          <p:cNvSpPr/>
          <p:nvPr/>
        </p:nvSpPr>
        <p:spPr>
          <a:xfrm>
            <a:off x="11877580" y="2935094"/>
            <a:ext cx="133985" cy="0"/>
          </a:xfrm>
          <a:custGeom>
            <a:avLst/>
            <a:gdLst/>
            <a:ahLst/>
            <a:cxnLst/>
            <a:rect l="l" t="t" r="r" b="b"/>
            <a:pathLst>
              <a:path w="133984">
                <a:moveTo>
                  <a:pt x="0" y="0"/>
                </a:moveTo>
                <a:lnTo>
                  <a:pt x="13391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6" name="object 336"/>
          <p:cNvSpPr/>
          <p:nvPr/>
        </p:nvSpPr>
        <p:spPr>
          <a:xfrm>
            <a:off x="11651853" y="2935094"/>
            <a:ext cx="114300" cy="0"/>
          </a:xfrm>
          <a:custGeom>
            <a:avLst/>
            <a:gdLst/>
            <a:ahLst/>
            <a:cxnLst/>
            <a:rect l="l" t="t" r="r" b="b"/>
            <a:pathLst>
              <a:path w="114300">
                <a:moveTo>
                  <a:pt x="0" y="0"/>
                </a:moveTo>
                <a:lnTo>
                  <a:pt x="11405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7" name="object 337"/>
          <p:cNvSpPr/>
          <p:nvPr/>
        </p:nvSpPr>
        <p:spPr>
          <a:xfrm>
            <a:off x="12007868" y="2920415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15307"/>
                </a:moveTo>
                <a:lnTo>
                  <a:pt x="59" y="0"/>
                </a:lnTo>
                <a:lnTo>
                  <a:pt x="0" y="30531"/>
                </a:lnTo>
                <a:lnTo>
                  <a:pt x="15271" y="15307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8" name="object 338"/>
          <p:cNvSpPr/>
          <p:nvPr/>
        </p:nvSpPr>
        <p:spPr>
          <a:xfrm>
            <a:off x="11765903" y="2910101"/>
            <a:ext cx="111760" cy="51435"/>
          </a:xfrm>
          <a:custGeom>
            <a:avLst/>
            <a:gdLst/>
            <a:ahLst/>
            <a:cxnLst/>
            <a:rect l="l" t="t" r="r" b="b"/>
            <a:pathLst>
              <a:path w="111759" h="51435">
                <a:moveTo>
                  <a:pt x="0" y="0"/>
                </a:moveTo>
                <a:lnTo>
                  <a:pt x="0" y="51280"/>
                </a:lnTo>
                <a:lnTo>
                  <a:pt x="111676" y="51280"/>
                </a:lnTo>
                <a:lnTo>
                  <a:pt x="111676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9" name="object 339"/>
          <p:cNvSpPr/>
          <p:nvPr/>
        </p:nvSpPr>
        <p:spPr>
          <a:xfrm>
            <a:off x="11652377" y="2934494"/>
            <a:ext cx="359410" cy="180975"/>
          </a:xfrm>
          <a:custGeom>
            <a:avLst/>
            <a:gdLst/>
            <a:ahLst/>
            <a:cxnLst/>
            <a:rect l="l" t="t" r="r" b="b"/>
            <a:pathLst>
              <a:path w="359409" h="180975">
                <a:moveTo>
                  <a:pt x="0" y="0"/>
                </a:moveTo>
                <a:lnTo>
                  <a:pt x="119" y="180769"/>
                </a:lnTo>
                <a:lnTo>
                  <a:pt x="359069" y="180024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0" name="object 340"/>
          <p:cNvSpPr/>
          <p:nvPr/>
        </p:nvSpPr>
        <p:spPr>
          <a:xfrm>
            <a:off x="12008346" y="3099258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331" y="15224"/>
                </a:moveTo>
                <a:lnTo>
                  <a:pt x="0" y="0"/>
                </a:lnTo>
                <a:lnTo>
                  <a:pt x="59" y="30531"/>
                </a:lnTo>
                <a:lnTo>
                  <a:pt x="15331" y="1522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1" name="object 341"/>
          <p:cNvSpPr/>
          <p:nvPr/>
        </p:nvSpPr>
        <p:spPr>
          <a:xfrm>
            <a:off x="11767753" y="3114495"/>
            <a:ext cx="111760" cy="0"/>
          </a:xfrm>
          <a:custGeom>
            <a:avLst/>
            <a:gdLst/>
            <a:ahLst/>
            <a:cxnLst/>
            <a:rect l="l" t="t" r="r" b="b"/>
            <a:pathLst>
              <a:path w="111759">
                <a:moveTo>
                  <a:pt x="0" y="0"/>
                </a:moveTo>
                <a:lnTo>
                  <a:pt x="111676" y="0"/>
                </a:lnTo>
              </a:path>
            </a:pathLst>
          </a:custGeom>
          <a:ln w="51280">
            <a:solidFill>
              <a:srgbClr val="FFFFFF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2" name="object 342"/>
          <p:cNvSpPr/>
          <p:nvPr/>
        </p:nvSpPr>
        <p:spPr>
          <a:xfrm>
            <a:off x="11767753" y="3088854"/>
            <a:ext cx="111760" cy="51435"/>
          </a:xfrm>
          <a:custGeom>
            <a:avLst/>
            <a:gdLst/>
            <a:ahLst/>
            <a:cxnLst/>
            <a:rect l="l" t="t" r="r" b="b"/>
            <a:pathLst>
              <a:path w="111759" h="51435">
                <a:moveTo>
                  <a:pt x="0" y="0"/>
                </a:moveTo>
                <a:lnTo>
                  <a:pt x="0" y="51280"/>
                </a:lnTo>
                <a:lnTo>
                  <a:pt x="111676" y="51280"/>
                </a:lnTo>
                <a:lnTo>
                  <a:pt x="111676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3" name="object 343"/>
          <p:cNvSpPr/>
          <p:nvPr/>
        </p:nvSpPr>
        <p:spPr>
          <a:xfrm>
            <a:off x="12363001" y="2935723"/>
            <a:ext cx="73660" cy="0"/>
          </a:xfrm>
          <a:custGeom>
            <a:avLst/>
            <a:gdLst/>
            <a:ahLst/>
            <a:cxnLst/>
            <a:rect l="l" t="t" r="r" b="b"/>
            <a:pathLst>
              <a:path w="73659">
                <a:moveTo>
                  <a:pt x="0" y="0"/>
                </a:moveTo>
                <a:lnTo>
                  <a:pt x="73317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4" name="object 344"/>
          <p:cNvSpPr/>
          <p:nvPr/>
        </p:nvSpPr>
        <p:spPr>
          <a:xfrm>
            <a:off x="12433275" y="2920457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4">
                <a:moveTo>
                  <a:pt x="15271" y="15265"/>
                </a:moveTo>
                <a:lnTo>
                  <a:pt x="0" y="0"/>
                </a:lnTo>
                <a:lnTo>
                  <a:pt x="0" y="30531"/>
                </a:lnTo>
                <a:lnTo>
                  <a:pt x="15271" y="15265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5" name="object 345"/>
          <p:cNvSpPr/>
          <p:nvPr/>
        </p:nvSpPr>
        <p:spPr>
          <a:xfrm>
            <a:off x="12363538" y="2985071"/>
            <a:ext cx="255904" cy="130810"/>
          </a:xfrm>
          <a:custGeom>
            <a:avLst/>
            <a:gdLst/>
            <a:ahLst/>
            <a:cxnLst/>
            <a:rect l="l" t="t" r="r" b="b"/>
            <a:pathLst>
              <a:path w="255904" h="130810">
                <a:moveTo>
                  <a:pt x="0" y="129405"/>
                </a:moveTo>
                <a:lnTo>
                  <a:pt x="255745" y="130545"/>
                </a:lnTo>
                <a:lnTo>
                  <a:pt x="25497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6" name="object 346"/>
          <p:cNvSpPr/>
          <p:nvPr/>
        </p:nvSpPr>
        <p:spPr>
          <a:xfrm>
            <a:off x="12603295" y="2972841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15176"/>
                </a:moveTo>
                <a:lnTo>
                  <a:pt x="15152" y="0"/>
                </a:lnTo>
                <a:lnTo>
                  <a:pt x="0" y="15349"/>
                </a:lnTo>
                <a:lnTo>
                  <a:pt x="30484" y="15176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7" name="object 347"/>
          <p:cNvSpPr/>
          <p:nvPr/>
        </p:nvSpPr>
        <p:spPr>
          <a:xfrm>
            <a:off x="9720117" y="903246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34"/>
                </a:lnTo>
                <a:lnTo>
                  <a:pt x="783344" y="121334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8" name="object 348"/>
          <p:cNvSpPr txBox="1"/>
          <p:nvPr/>
        </p:nvSpPr>
        <p:spPr>
          <a:xfrm>
            <a:off x="9720642" y="903771"/>
            <a:ext cx="782320" cy="120650"/>
          </a:xfrm>
          <a:prstGeom prst="rect">
            <a:avLst/>
          </a:prstGeom>
          <a:solidFill>
            <a:srgbClr val="E97124"/>
          </a:solidFill>
        </p:spPr>
        <p:txBody>
          <a:bodyPr vert="horz" wrap="square" lIns="0" tIns="571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45"/>
              </a:spcBef>
            </a:pPr>
            <a:endParaRPr sz="200">
              <a:latin typeface="Times New Roman"/>
              <a:cs typeface="Times New Roman"/>
            </a:endParaRPr>
          </a:p>
          <a:p>
            <a:pPr marL="11239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easurement</a:t>
            </a:r>
            <a:r>
              <a:rPr sz="300" spc="-1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Dat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349" name="object 349"/>
          <p:cNvSpPr/>
          <p:nvPr/>
        </p:nvSpPr>
        <p:spPr>
          <a:xfrm>
            <a:off x="9720117" y="1795522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28"/>
                </a:lnTo>
                <a:lnTo>
                  <a:pt x="783344" y="121328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350" name="object 350"/>
          <p:cNvGraphicFramePr>
            <a:graphicFrameLocks noGrp="1"/>
          </p:cNvGraphicFramePr>
          <p:nvPr/>
        </p:nvGraphicFramePr>
        <p:xfrm>
          <a:off x="10587209" y="2684022"/>
          <a:ext cx="2237736" cy="57823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381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48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746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571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4510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019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7878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9751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24400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11493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Creatinine Tendency 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of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Chang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985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165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74930">
                        <a:lnSpc>
                          <a:spcPts val="315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508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1829">
                <a:tc>
                  <a:txBody>
                    <a:bodyPr/>
                    <a:lstStyle/>
                    <a:p>
                      <a:pPr marL="97790">
                        <a:lnSpc>
                          <a:spcPts val="31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 gridSpan="2">
                  <a:txBody>
                    <a:bodyPr/>
                    <a:lstStyle/>
                    <a:p>
                      <a:pPr marL="233045">
                        <a:lnSpc>
                          <a:spcPts val="31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</a:t>
                      </a:r>
                      <a:r>
                        <a:rPr sz="3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0795">
                        <a:lnSpc>
                          <a:spcPts val="310"/>
                        </a:lnSpc>
                      </a:pPr>
                      <a:r>
                        <a:rPr sz="3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10795">
                        <a:lnSpc>
                          <a:spcPts val="31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R="1270" algn="ctr">
                        <a:lnSpc>
                          <a:spcPts val="229"/>
                        </a:lnSpc>
                        <a:spcBef>
                          <a:spcPts val="75"/>
                        </a:spcBef>
                      </a:pPr>
                      <a:r>
                        <a:rPr sz="2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Yes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9525" marB="0"/>
                </a:tc>
                <a:tc>
                  <a:txBody>
                    <a:bodyPr/>
                    <a:lstStyle/>
                    <a:p>
                      <a:pPr marL="6985" algn="ctr">
                        <a:lnSpc>
                          <a:spcPts val="305"/>
                        </a:lnSpc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Increasing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97155">
                        <a:lnSpc>
                          <a:spcPts val="3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Tendency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635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9112">
                <a:tc>
                  <a:txBody>
                    <a:bodyPr/>
                    <a:lstStyle/>
                    <a:p>
                      <a:pPr marL="74930">
                        <a:lnSpc>
                          <a:spcPts val="325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30940">
                <a:tc>
                  <a:txBody>
                    <a:bodyPr/>
                    <a:lstStyle/>
                    <a:p>
                      <a:pPr marL="100330" marR="226060" indent="-34925">
                        <a:lnSpc>
                          <a:spcPct val="109400"/>
                        </a:lnSpc>
                        <a:spcBef>
                          <a:spcPts val="185"/>
                        </a:spcBef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3495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algn="ctr">
                        <a:lnSpc>
                          <a:spcPct val="100000"/>
                        </a:lnSpc>
                      </a:pPr>
                      <a:r>
                        <a:rPr sz="2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No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7620" algn="ctr">
                        <a:lnSpc>
                          <a:spcPct val="100000"/>
                        </a:lnSpc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Decreasing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381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0298">
                <a:tc>
                  <a:txBody>
                    <a:bodyPr/>
                    <a:lstStyle/>
                    <a:p>
                      <a:pPr marL="77470">
                        <a:lnSpc>
                          <a:spcPts val="34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</a:tbl>
          </a:graphicData>
        </a:graphic>
      </p:graphicFrame>
      <p:sp>
        <p:nvSpPr>
          <p:cNvPr id="351" name="object 351"/>
          <p:cNvSpPr txBox="1"/>
          <p:nvPr/>
        </p:nvSpPr>
        <p:spPr>
          <a:xfrm>
            <a:off x="9720642" y="1796047"/>
            <a:ext cx="782320" cy="120650"/>
          </a:xfrm>
          <a:prstGeom prst="rect">
            <a:avLst/>
          </a:prstGeom>
          <a:solidFill>
            <a:srgbClr val="E97124"/>
          </a:solidFill>
        </p:spPr>
        <p:txBody>
          <a:bodyPr vert="horz" wrap="square" lIns="0" tIns="635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0"/>
              </a:spcBef>
            </a:pPr>
            <a:endParaRPr sz="200">
              <a:latin typeface="Times New Roman"/>
              <a:cs typeface="Times New Roman"/>
            </a:endParaRPr>
          </a:p>
          <a:p>
            <a:pPr marL="17843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Creatinine Increase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%</a:t>
            </a:r>
            <a:endParaRPr sz="300">
              <a:latin typeface="Calibri"/>
              <a:cs typeface="Calibri"/>
            </a:endParaRPr>
          </a:p>
        </p:txBody>
      </p:sp>
      <p:graphicFrame>
        <p:nvGraphicFramePr>
          <p:cNvPr id="352" name="object 352"/>
          <p:cNvGraphicFramePr>
            <a:graphicFrameLocks noGrp="1"/>
          </p:cNvGraphicFramePr>
          <p:nvPr/>
        </p:nvGraphicFramePr>
        <p:xfrm>
          <a:off x="11667363" y="2149850"/>
          <a:ext cx="708023" cy="1740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36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365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406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87002">
                <a:tc rowSpan="2">
                  <a:txBody>
                    <a:bodyPr/>
                    <a:lstStyle/>
                    <a:p>
                      <a:pPr marL="49530" marR="37465" algn="ctr">
                        <a:lnSpc>
                          <a:spcPct val="109500"/>
                        </a:lnSpc>
                        <a:spcBef>
                          <a:spcPts val="60"/>
                        </a:spcBef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 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762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 marL="68580" marR="59690" indent="3810" algn="ctr">
                        <a:lnSpc>
                          <a:spcPct val="111600"/>
                        </a:lnSpc>
                        <a:spcBef>
                          <a:spcPts val="4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  (Hours)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econd</a:t>
                      </a:r>
                      <a:r>
                        <a:rPr sz="300" spc="-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Cr</a:t>
                      </a:r>
                      <a:r>
                        <a:rPr sz="300" spc="-3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7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62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53" name="object 353"/>
          <p:cNvGraphicFramePr>
            <a:graphicFrameLocks noGrp="1"/>
          </p:cNvGraphicFramePr>
          <p:nvPr/>
        </p:nvGraphicFramePr>
        <p:xfrm>
          <a:off x="11665215" y="1937975"/>
          <a:ext cx="708659" cy="17408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336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9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4005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87050">
                <a:tc rowSpan="2">
                  <a:txBody>
                    <a:bodyPr/>
                    <a:lstStyle/>
                    <a:p>
                      <a:pPr marL="60960" marR="48895" algn="ctr">
                        <a:lnSpc>
                          <a:spcPct val="109400"/>
                        </a:lnSpc>
                        <a:spcBef>
                          <a:spcPts val="60"/>
                        </a:spcBef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 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762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 rowSpan="2">
                  <a:txBody>
                    <a:bodyPr/>
                    <a:lstStyle/>
                    <a:p>
                      <a:pPr marL="94615" marR="82550" indent="635" algn="ctr">
                        <a:lnSpc>
                          <a:spcPct val="111500"/>
                        </a:lnSpc>
                        <a:spcBef>
                          <a:spcPts val="4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5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  (Hours) 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First sC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508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8703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762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508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317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354" name="object 354"/>
          <p:cNvSpPr/>
          <p:nvPr/>
        </p:nvSpPr>
        <p:spPr>
          <a:xfrm>
            <a:off x="11647427" y="1789288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34"/>
                </a:lnTo>
                <a:lnTo>
                  <a:pt x="783344" y="121334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5" name="object 355"/>
          <p:cNvSpPr txBox="1"/>
          <p:nvPr/>
        </p:nvSpPr>
        <p:spPr>
          <a:xfrm>
            <a:off x="11647951" y="1789813"/>
            <a:ext cx="782320" cy="120650"/>
          </a:xfrm>
          <a:prstGeom prst="rect">
            <a:avLst/>
          </a:prstGeom>
          <a:solidFill>
            <a:srgbClr val="E97124"/>
          </a:solidFill>
        </p:spPr>
        <p:txBody>
          <a:bodyPr vert="horz" wrap="square" lIns="0" tIns="635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0"/>
              </a:spcBef>
            </a:pPr>
            <a:endParaRPr sz="200">
              <a:latin typeface="Times New Roman"/>
              <a:cs typeface="Times New Roman"/>
            </a:endParaRPr>
          </a:p>
          <a:p>
            <a:pPr marL="15684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Relative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crease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per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Hour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356" name="object 356"/>
          <p:cNvSpPr/>
          <p:nvPr/>
        </p:nvSpPr>
        <p:spPr>
          <a:xfrm>
            <a:off x="11647427" y="903246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34"/>
                </a:lnTo>
                <a:lnTo>
                  <a:pt x="783344" y="121334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357" name="object 357"/>
          <p:cNvGraphicFramePr>
            <a:graphicFrameLocks noGrp="1"/>
          </p:cNvGraphicFramePr>
          <p:nvPr/>
        </p:nvGraphicFramePr>
        <p:xfrm>
          <a:off x="13198476" y="3454964"/>
          <a:ext cx="2938142" cy="258636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835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978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537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1876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842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2436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is Proposition: ICD-10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Cod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gridSpan="4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204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88265" algn="ctr">
                        <a:lnSpc>
                          <a:spcPts val="310"/>
                        </a:lnSpc>
                        <a:tabLst>
                          <a:tab pos="30924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	Value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5715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rowSpan="1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11760" marR="151765" algn="ctr">
                        <a:lnSpc>
                          <a:spcPct val="113700"/>
                        </a:lnSpc>
                      </a:pP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((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r>
                        <a:rPr sz="300" spc="-5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 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</a:t>
                      </a:r>
                      <a:r>
                        <a:rPr sz="300" spc="-3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20764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9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9621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30504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than</a:t>
                      </a:r>
                      <a:r>
                        <a:rPr sz="300" spc="-3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R="101600" algn="ctr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R="124460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</a:t>
                      </a:r>
                      <a:r>
                        <a:rPr sz="300" spc="-9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184785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8478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1907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Smaller than</a:t>
                      </a:r>
                      <a:r>
                        <a:rPr sz="300" spc="-2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rowSpan="1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49530">
                        <a:lnSpc>
                          <a:spcPct val="100000"/>
                        </a:lnSpc>
                        <a:spcBef>
                          <a:spcPts val="18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80670" marR="146050" indent="48260">
                        <a:lnSpc>
                          <a:spcPct val="111100"/>
                        </a:lnSpc>
                        <a:spcBef>
                          <a:spcPts val="225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 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und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50" spc="-8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4445" algn="ctr">
                        <a:lnSpc>
                          <a:spcPts val="225"/>
                        </a:lnSpc>
                      </a:pPr>
                      <a:r>
                        <a:rPr sz="200" u="sng" dirty="0">
                          <a:solidFill>
                            <a:srgbClr val="231F20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 </a:t>
                      </a:r>
                      <a:r>
                        <a:rPr sz="200" u="sng" spc="-30" dirty="0">
                          <a:solidFill>
                            <a:srgbClr val="231F20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    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00" spc="-3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00" spc="-3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374650" marR="240665" algn="ctr">
                        <a:lnSpc>
                          <a:spcPts val="210"/>
                        </a:lnSpc>
                        <a:spcBef>
                          <a:spcPts val="15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200" spc="-6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Hours 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und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122555" algn="ctr">
                        <a:lnSpc>
                          <a:spcPts val="204"/>
                        </a:lnSpc>
                      </a:pP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5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marL="17780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5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300355" marR="126364" indent="48260">
                        <a:lnSpc>
                          <a:spcPct val="111100"/>
                        </a:lnSpc>
                        <a:spcBef>
                          <a:spcPts val="185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 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</a:t>
                      </a:r>
                      <a:r>
                        <a:rPr sz="250" spc="-7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394335" marR="220979" algn="ctr">
                        <a:lnSpc>
                          <a:spcPts val="210"/>
                        </a:lnSpc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200" spc="-5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Hours 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161925" algn="ctr">
                        <a:lnSpc>
                          <a:spcPct val="100000"/>
                        </a:lnSpc>
                        <a:spcBef>
                          <a:spcPts val="65"/>
                        </a:spcBef>
                      </a:pP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0667">
                <a:tc>
                  <a:txBody>
                    <a:bodyPr/>
                    <a:lstStyle/>
                    <a:p>
                      <a:pPr marR="100330" algn="ctr">
                        <a:lnSpc>
                          <a:spcPts val="300"/>
                        </a:lnSpc>
                        <a:tabLst>
                          <a:tab pos="32067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	(Hours)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0443">
                <a:tc>
                  <a:txBody>
                    <a:bodyPr/>
                    <a:lstStyle/>
                    <a:p>
                      <a:pPr marR="76200" algn="ctr">
                        <a:lnSpc>
                          <a:spcPts val="345"/>
                        </a:lnSpc>
                        <a:tabLst>
                          <a:tab pos="297180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	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First sCr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0762">
                <a:tc>
                  <a:txBody>
                    <a:bodyPr/>
                    <a:lstStyle/>
                    <a:p>
                      <a:pPr marR="96520" algn="ctr">
                        <a:lnSpc>
                          <a:spcPts val="310"/>
                        </a:lnSpc>
                        <a:spcBef>
                          <a:spcPts val="225"/>
                        </a:spcBef>
                        <a:tabLst>
                          <a:tab pos="31940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	Value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8575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50667">
                <a:tc>
                  <a:txBody>
                    <a:bodyPr/>
                    <a:lstStyle/>
                    <a:p>
                      <a:pPr marR="17145" algn="ctr">
                        <a:lnSpc>
                          <a:spcPts val="300"/>
                        </a:lnSpc>
                        <a:tabLst>
                          <a:tab pos="23939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	(Hours)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55531">
                <a:tc>
                  <a:txBody>
                    <a:bodyPr/>
                    <a:lstStyle/>
                    <a:p>
                      <a:pPr marR="96520" algn="ctr">
                        <a:lnSpc>
                          <a:spcPts val="335"/>
                        </a:lnSpc>
                        <a:tabLst>
                          <a:tab pos="31940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	sC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598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 marR="5715" algn="r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1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1905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17780" algn="r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4445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874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R="5080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2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R="16510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1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796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R="5080" algn="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120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R="635" algn="ctr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is</a:t>
                      </a:r>
                      <a:r>
                        <a:rPr sz="3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Proposition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56934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R="5080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1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1430" algn="r">
                        <a:lnSpc>
                          <a:spcPct val="100000"/>
                        </a:lnSpc>
                        <a:spcBef>
                          <a:spcPts val="190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885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R="5080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2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0795" algn="r">
                        <a:lnSpc>
                          <a:spcPct val="100000"/>
                        </a:lnSpc>
                        <a:spcBef>
                          <a:spcPts val="18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1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2219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R="5080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7.9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</a:tbl>
          </a:graphicData>
        </a:graphic>
      </p:graphicFrame>
      <p:graphicFrame>
        <p:nvGraphicFramePr>
          <p:cNvPr id="358" name="object 358"/>
          <p:cNvGraphicFramePr>
            <a:graphicFrameLocks noGrp="1"/>
          </p:cNvGraphicFramePr>
          <p:nvPr/>
        </p:nvGraphicFramePr>
        <p:xfrm>
          <a:off x="9764075" y="3454964"/>
          <a:ext cx="2938778" cy="258636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835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290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579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6649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2436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2382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is Proposition: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Criteria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298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500">
                        <a:latin typeface="Times New Roman"/>
                        <a:cs typeface="Times New Roman"/>
                      </a:endParaRPr>
                    </a:p>
                    <a:p>
                      <a:pPr marL="72390">
                        <a:lnSpc>
                          <a:spcPct val="100000"/>
                        </a:lnSpc>
                        <a:tabLst>
                          <a:tab pos="328295" algn="l"/>
                        </a:tabLst>
                      </a:pPr>
                      <a:r>
                        <a:rPr sz="450" spc="22" baseline="37037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	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 Date</a:t>
                      </a:r>
                      <a:r>
                        <a:rPr sz="30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(Hours)</a:t>
                      </a:r>
                      <a:endParaRPr sz="300">
                        <a:latin typeface="Calibri"/>
                        <a:cs typeface="Calibri"/>
                      </a:endParaRPr>
                    </a:p>
                    <a:p>
                      <a:pPr marL="95250">
                        <a:lnSpc>
                          <a:spcPts val="270"/>
                        </a:lnSpc>
                        <a:spcBef>
                          <a:spcPts val="55"/>
                        </a:spcBef>
                        <a:tabLst>
                          <a:tab pos="370205" algn="l"/>
                        </a:tabLst>
                      </a:pPr>
                      <a:r>
                        <a:rPr sz="450" spc="22" baseline="37037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	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First sCr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  <a:p>
                      <a:pPr marL="72390">
                        <a:lnSpc>
                          <a:spcPts val="27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127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26034" marR="88900" algn="ctr">
                        <a:lnSpc>
                          <a:spcPct val="113700"/>
                        </a:lnSpc>
                      </a:pP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((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r>
                        <a:rPr sz="300" spc="-5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 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</a:t>
                      </a:r>
                      <a:r>
                        <a:rPr sz="300" spc="-2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7145">
                        <a:lnSpc>
                          <a:spcPct val="100000"/>
                        </a:lnSpc>
                        <a:spcBef>
                          <a:spcPts val="254"/>
                        </a:spcBef>
                      </a:pPr>
                      <a:r>
                        <a:rPr sz="300" u="sng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u="sng" spc="40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22555"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7145">
                        <a:lnSpc>
                          <a:spcPct val="100000"/>
                        </a:lnSpc>
                      </a:pPr>
                      <a:r>
                        <a:rPr sz="300" u="sng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u="sng" spc="40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11125"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6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4541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than</a:t>
                      </a:r>
                      <a:r>
                        <a:rPr sz="300" spc="-3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R="60960" algn="ctr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50165" marR="133985" algn="ctr">
                        <a:lnSpc>
                          <a:spcPts val="409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</a:t>
                      </a:r>
                      <a:r>
                        <a:rPr sz="300" spc="-1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9969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9969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3398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Smaller than</a:t>
                      </a:r>
                      <a:r>
                        <a:rPr sz="300" spc="-3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rowSpan="6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431165">
                        <a:lnSpc>
                          <a:spcPct val="100000"/>
                        </a:lnSpc>
                        <a:spcBef>
                          <a:spcPts val="18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45720">
                        <a:lnSpc>
                          <a:spcPct val="100000"/>
                        </a:lnSpc>
                        <a:spcBef>
                          <a:spcPts val="204"/>
                        </a:spcBef>
                        <a:tabLst>
                          <a:tab pos="709930" algn="l"/>
                        </a:tabLst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3</a:t>
                      </a:r>
                      <a:r>
                        <a:rPr sz="300" spc="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Increase:</a:t>
                      </a:r>
                      <a:r>
                        <a:rPr sz="300" u="sng" spc="10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	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5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 marL="57150">
                        <a:lnSpc>
                          <a:spcPct val="100000"/>
                        </a:lnSpc>
                        <a:spcBef>
                          <a:spcPts val="20"/>
                        </a:spcBef>
                        <a:tabLst>
                          <a:tab pos="661670" algn="l"/>
                        </a:tabLst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KREA2 &gt;=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4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mg/dl)'	</a:t>
                      </a:r>
                      <a:r>
                        <a:rPr sz="375" spc="22" baseline="11111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und </a:t>
                      </a:r>
                      <a:r>
                        <a:rPr sz="375" spc="15" baseline="11111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75" spc="22" baseline="11111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375" spc="-112" baseline="11111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75" spc="15" baseline="11111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375" baseline="11111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R="140970" algn="r">
                        <a:lnSpc>
                          <a:spcPts val="335"/>
                        </a:lnSpc>
                      </a:pPr>
                      <a:r>
                        <a:rPr sz="450" spc="22" baseline="-2777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 </a:t>
                      </a:r>
                      <a:r>
                        <a:rPr sz="450" spc="30" baseline="-2777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 </a:t>
                      </a:r>
                      <a:r>
                        <a:rPr sz="450" spc="15" baseline="-2777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Increase: </a:t>
                      </a:r>
                      <a:r>
                        <a:rPr sz="450" u="sng" spc="15" baseline="-27777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 </a:t>
                      </a:r>
                      <a:r>
                        <a:rPr sz="450" spc="15" baseline="-2777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 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Value</a:t>
                      </a:r>
                      <a:r>
                        <a:rPr sz="200" spc="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506730" algn="ctr">
                        <a:lnSpc>
                          <a:spcPts val="215"/>
                        </a:lnSpc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Hours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58419">
                        <a:lnSpc>
                          <a:spcPts val="265"/>
                        </a:lnSpc>
                        <a:spcBef>
                          <a:spcPts val="10"/>
                        </a:spcBef>
                        <a:tabLst>
                          <a:tab pos="814069" algn="l"/>
                        </a:tabLst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0.3 mg/dl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in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48h)'	</a:t>
                      </a:r>
                      <a:r>
                        <a:rPr sz="300" baseline="41666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endParaRPr sz="300" baseline="41666">
                        <a:latin typeface="Consolas"/>
                        <a:cs typeface="Consolas"/>
                      </a:endParaRPr>
                    </a:p>
                    <a:p>
                      <a:pPr marL="502920" algn="ctr">
                        <a:lnSpc>
                          <a:spcPts val="145"/>
                        </a:lnSpc>
                      </a:pP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200" spc="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7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marL="398780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5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75260" algn="r">
                        <a:lnSpc>
                          <a:spcPts val="345"/>
                        </a:lnSpc>
                        <a:spcBef>
                          <a:spcPts val="170"/>
                        </a:spcBef>
                        <a:tabLst>
                          <a:tab pos="677545" algn="l"/>
                        </a:tabLst>
                      </a:pPr>
                      <a:r>
                        <a:rPr sz="450" spc="22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450" spc="30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3</a:t>
                      </a:r>
                      <a:r>
                        <a:rPr sz="450" spc="37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450" spc="15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Decrease:</a:t>
                      </a:r>
                      <a:r>
                        <a:rPr sz="450" u="sng" spc="15" baseline="9259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450" spc="15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	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</a:t>
                      </a:r>
                      <a:r>
                        <a:rPr sz="250" spc="-5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 marR="127000" algn="r">
                        <a:lnSpc>
                          <a:spcPts val="345"/>
                        </a:lnSpc>
                        <a:tabLst>
                          <a:tab pos="560705" algn="l"/>
                        </a:tabLst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&gt;200%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in 7d)'	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</a:t>
                      </a:r>
                      <a:r>
                        <a:rPr sz="250" spc="-7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833755" marR="221615" indent="-780415">
                        <a:lnSpc>
                          <a:spcPct val="51400"/>
                        </a:lnSpc>
                        <a:tabLst>
                          <a:tab pos="775335" algn="l"/>
                        </a:tabLst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1</a:t>
                      </a:r>
                      <a:r>
                        <a:rPr sz="300" spc="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Decrease:</a:t>
                      </a:r>
                      <a:r>
                        <a:rPr sz="300" u="sng" spc="10" dirty="0">
                          <a:solidFill>
                            <a:srgbClr val="ED1F24"/>
                          </a:solidFill>
                          <a:uFill>
                            <a:solidFill>
                              <a:srgbClr val="231F20"/>
                            </a:solidFill>
                          </a:u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	</a:t>
                      </a:r>
                      <a:r>
                        <a:rPr sz="300" baseline="13888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300" spc="-7" baseline="13888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300" spc="-82" baseline="13888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baseline="13888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Hours 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153035" algn="r">
                        <a:lnSpc>
                          <a:spcPts val="330"/>
                        </a:lnSpc>
                        <a:tabLst>
                          <a:tab pos="603885" algn="l"/>
                        </a:tabLst>
                      </a:pPr>
                      <a:r>
                        <a:rPr sz="450" spc="15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50-100%</a:t>
                      </a:r>
                      <a:r>
                        <a:rPr sz="450" spc="30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450" spc="22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in</a:t>
                      </a:r>
                      <a:r>
                        <a:rPr sz="450" spc="37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450" spc="22" baseline="9259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	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3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97165">
                <a:tc>
                  <a:txBody>
                    <a:bodyPr/>
                    <a:lstStyle/>
                    <a:p>
                      <a:pPr marL="63500">
                        <a:lnSpc>
                          <a:spcPct val="100000"/>
                        </a:lnSpc>
                        <a:spcBef>
                          <a:spcPts val="225"/>
                        </a:spcBef>
                        <a:tabLst>
                          <a:tab pos="38290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	Value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97790">
                        <a:lnSpc>
                          <a:spcPct val="100000"/>
                        </a:lnSpc>
                        <a:spcBef>
                          <a:spcPts val="35"/>
                        </a:spcBef>
                        <a:tabLst>
                          <a:tab pos="337185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	(Hours)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4930">
                        <a:lnSpc>
                          <a:spcPct val="100000"/>
                        </a:lnSpc>
                        <a:spcBef>
                          <a:spcPts val="40"/>
                        </a:spcBef>
                        <a:tabLst>
                          <a:tab pos="394970" algn="l"/>
                        </a:tabLst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	sCr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8575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71381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260350" marR="183515" indent="-80645">
                        <a:lnSpc>
                          <a:spcPct val="1137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Criteria</a:t>
                      </a:r>
                      <a:r>
                        <a:rPr sz="300" spc="-5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is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Proposition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6411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-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75" algn="ctr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Decrease:</a:t>
                      </a:r>
                      <a:r>
                        <a:rPr sz="300" spc="-4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50-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2540" algn="ctr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00% in</a:t>
                      </a:r>
                      <a:r>
                        <a:rPr sz="300" spc="-8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928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2540" algn="ctr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-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2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75" algn="ctr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Decrease:</a:t>
                      </a:r>
                      <a:r>
                        <a:rPr sz="300" spc="-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00-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2540" algn="ctr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200% in</a:t>
                      </a:r>
                      <a:r>
                        <a:rPr sz="300" spc="-4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5715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2706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100330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r>
                        <a:rPr sz="300" spc="-9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747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(Decrease: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43180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&gt;200% in</a:t>
                      </a:r>
                      <a:r>
                        <a:rPr sz="300" spc="-3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7d)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5715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359" name="object 359"/>
          <p:cNvGraphicFramePr>
            <a:graphicFrameLocks noGrp="1"/>
          </p:cNvGraphicFramePr>
          <p:nvPr/>
        </p:nvGraphicFramePr>
        <p:xfrm>
          <a:off x="13557784" y="918339"/>
          <a:ext cx="2575558" cy="251175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082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746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7726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153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24359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14160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is Proposition: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tag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350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32747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71120" marR="14604" algn="ctr">
                        <a:lnSpc>
                          <a:spcPct val="1094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 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127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94615" marR="81280" indent="-635" algn="ctr">
                        <a:lnSpc>
                          <a:spcPct val="1115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  (Hours) First</a:t>
                      </a:r>
                      <a:r>
                        <a:rPr sz="300" spc="-8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  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5715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409575" marR="78105" algn="ctr">
                        <a:lnSpc>
                          <a:spcPct val="113700"/>
                        </a:lnSpc>
                      </a:pP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((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r>
                        <a:rPr sz="300" spc="-5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 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</a:t>
                      </a:r>
                      <a:r>
                        <a:rPr sz="300" spc="-2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506095" indent="-187325">
                        <a:lnSpc>
                          <a:spcPct val="100000"/>
                        </a:lnSpc>
                        <a:spcBef>
                          <a:spcPts val="5"/>
                        </a:spcBef>
                        <a:buClr>
                          <a:srgbClr val="ED1F24"/>
                        </a:buClr>
                        <a:buAutoNum type="arabicPlain"/>
                        <a:tabLst>
                          <a:tab pos="505459" algn="l"/>
                          <a:tab pos="506730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9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494030" indent="-175260">
                        <a:lnSpc>
                          <a:spcPct val="100000"/>
                        </a:lnSpc>
                        <a:buClr>
                          <a:srgbClr val="ED1F24"/>
                        </a:buClr>
                        <a:buAutoNum type="arabicPlain"/>
                        <a:tabLst>
                          <a:tab pos="494030" algn="l"/>
                          <a:tab pos="494665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528955" indent="-210185">
                        <a:lnSpc>
                          <a:spcPct val="100000"/>
                        </a:lnSpc>
                        <a:buClr>
                          <a:srgbClr val="ED1F24"/>
                        </a:buClr>
                        <a:buAutoNum type="arabicPlain"/>
                        <a:tabLst>
                          <a:tab pos="528955" algn="l"/>
                          <a:tab pos="529590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than</a:t>
                      </a:r>
                      <a:r>
                        <a:rPr sz="300" spc="-4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62255" algn="ctr">
                        <a:lnSpc>
                          <a:spcPct val="100000"/>
                        </a:lnSpc>
                        <a:spcBef>
                          <a:spcPts val="20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/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239395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*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(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300" spc="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</a:t>
                      </a:r>
                      <a:r>
                        <a:rPr sz="300" spc="-6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482600" indent="-163830">
                        <a:lnSpc>
                          <a:spcPct val="100000"/>
                        </a:lnSpc>
                        <a:spcBef>
                          <a:spcPts val="5"/>
                        </a:spcBef>
                        <a:buClr>
                          <a:srgbClr val="ED1F24"/>
                        </a:buClr>
                        <a:buAutoNum type="arabicPlain"/>
                        <a:tabLst>
                          <a:tab pos="482600" algn="l"/>
                          <a:tab pos="483234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5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482600" indent="-163830">
                        <a:lnSpc>
                          <a:spcPct val="100000"/>
                        </a:lnSpc>
                        <a:buClr>
                          <a:srgbClr val="ED1F24"/>
                        </a:buClr>
                        <a:buAutoNum type="arabicPlain"/>
                        <a:tabLst>
                          <a:tab pos="482600" algn="l"/>
                          <a:tab pos="483234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between -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 </a:t>
                      </a: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r>
                        <a:rPr sz="300" spc="-10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  <a:buClr>
                          <a:srgbClr val="ED1F24"/>
                        </a:buClr>
                        <a:buFont typeface="Consolas"/>
                        <a:buAutoNum type="arabicPlain"/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516890" indent="-198120">
                        <a:lnSpc>
                          <a:spcPct val="100000"/>
                        </a:lnSpc>
                        <a:buClr>
                          <a:srgbClr val="ED1F24"/>
                        </a:buClr>
                        <a:buAutoNum type="arabicPlain"/>
                        <a:tabLst>
                          <a:tab pos="516890" algn="l"/>
                          <a:tab pos="517525" algn="l"/>
                        </a:tabLst>
                      </a:pPr>
                      <a:r>
                        <a:rPr sz="30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Smaller than</a:t>
                      </a:r>
                      <a:r>
                        <a:rPr sz="300" spc="-3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-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20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34925">
                        <a:lnSpc>
                          <a:spcPct val="100000"/>
                        </a:lnSpc>
                        <a:spcBef>
                          <a:spcPts val="18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318135" marR="139700" indent="-220345">
                        <a:lnSpc>
                          <a:spcPct val="106500"/>
                        </a:lnSpc>
                        <a:tabLst>
                          <a:tab pos="366395" algn="l"/>
                        </a:tabLst>
                      </a:pPr>
                      <a:r>
                        <a:rPr sz="450" spc="30" baseline="-3703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		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 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und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50" spc="-7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170180" algn="ctr">
                        <a:lnSpc>
                          <a:spcPts val="195"/>
                        </a:lnSpc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Hours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98425">
                        <a:lnSpc>
                          <a:spcPts val="270"/>
                        </a:lnSpc>
                        <a:tabLst>
                          <a:tab pos="470534" algn="l"/>
                        </a:tabLst>
                      </a:pPr>
                      <a:r>
                        <a:rPr sz="300" spc="2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	</a:t>
                      </a:r>
                      <a:r>
                        <a:rPr sz="300" baseline="13888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endParaRPr sz="300" baseline="13888">
                        <a:latin typeface="Consolas"/>
                        <a:cs typeface="Consolas"/>
                      </a:endParaRPr>
                    </a:p>
                    <a:p>
                      <a:pPr marL="166370" algn="ctr">
                        <a:lnSpc>
                          <a:spcPts val="190"/>
                        </a:lnSpc>
                      </a:pP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2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marL="3492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2 </a:t>
                      </a:r>
                      <a:r>
                        <a:rPr sz="300" spc="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317500" marR="140970" indent="-219075">
                        <a:lnSpc>
                          <a:spcPct val="106500"/>
                        </a:lnSpc>
                        <a:tabLst>
                          <a:tab pos="365760" algn="l"/>
                        </a:tabLst>
                      </a:pPr>
                      <a:r>
                        <a:rPr sz="450" spc="30" baseline="-37037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		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 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</a:t>
                      </a:r>
                      <a:r>
                        <a:rPr sz="250" spc="-7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1000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68275" algn="ctr">
                        <a:lnSpc>
                          <a:spcPts val="175"/>
                        </a:lnSpc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=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48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Hours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98425">
                        <a:lnSpc>
                          <a:spcPts val="295"/>
                        </a:lnSpc>
                        <a:tabLst>
                          <a:tab pos="469265" algn="l"/>
                        </a:tabLst>
                      </a:pPr>
                      <a:r>
                        <a:rPr sz="450" spc="30" baseline="-18518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	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and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L="164465" algn="ctr"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gt;=</a:t>
                      </a:r>
                      <a:r>
                        <a:rPr sz="200" spc="-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75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547115">
                <a:tc>
                  <a:txBody>
                    <a:bodyPr/>
                    <a:lstStyle/>
                    <a:p>
                      <a:pPr marL="62230" algn="ctr">
                        <a:lnSpc>
                          <a:spcPct val="109400"/>
                        </a:lnSpc>
                        <a:spcBef>
                          <a:spcPts val="190"/>
                        </a:spcBef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 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413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 marL="129539" marR="114935" algn="ctr">
                        <a:lnSpc>
                          <a:spcPct val="111500"/>
                        </a:lnSpc>
                        <a:spcBef>
                          <a:spcPts val="17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  (Hours)</a:t>
                      </a:r>
                      <a:r>
                        <a:rPr sz="300" spc="-8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Cr</a:t>
                      </a:r>
                      <a:r>
                        <a:rPr sz="3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1590" marB="0"/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0753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52705" marR="216535" indent="-46355">
                        <a:lnSpc>
                          <a:spcPct val="1137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is</a:t>
                      </a:r>
                      <a:r>
                        <a:rPr sz="300" spc="-6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tage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Proposition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60" name="object 360"/>
          <p:cNvSpPr txBox="1"/>
          <p:nvPr/>
        </p:nvSpPr>
        <p:spPr>
          <a:xfrm>
            <a:off x="11647951" y="903771"/>
            <a:ext cx="782320" cy="120650"/>
          </a:xfrm>
          <a:prstGeom prst="rect">
            <a:avLst/>
          </a:prstGeom>
          <a:solidFill>
            <a:srgbClr val="E97124"/>
          </a:solidFill>
        </p:spPr>
        <p:txBody>
          <a:bodyPr vert="horz" wrap="square" lIns="0" tIns="1905" rIns="0" bIns="0" rtlCol="0">
            <a:spAutoFit/>
          </a:bodyPr>
          <a:lstStyle/>
          <a:p>
            <a:pPr marL="193675" marR="168275" indent="-15240">
              <a:lnSpc>
                <a:spcPct val="115100"/>
              </a:lnSpc>
              <a:spcBef>
                <a:spcPts val="1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Creatinine Increase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</a:t>
            </a:r>
            <a:r>
              <a:rPr sz="300" spc="-4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% 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(alternate</a:t>
            </a:r>
            <a:r>
              <a:rPr sz="300" spc="-1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Calculation)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361" name="object 361"/>
          <p:cNvSpPr/>
          <p:nvPr/>
        </p:nvSpPr>
        <p:spPr>
          <a:xfrm>
            <a:off x="13631051" y="6623024"/>
            <a:ext cx="2237740" cy="1419225"/>
          </a:xfrm>
          <a:custGeom>
            <a:avLst/>
            <a:gdLst/>
            <a:ahLst/>
            <a:cxnLst/>
            <a:rect l="l" t="t" r="r" b="b"/>
            <a:pathLst>
              <a:path w="2237740" h="1419225">
                <a:moveTo>
                  <a:pt x="0" y="148543"/>
                </a:moveTo>
                <a:lnTo>
                  <a:pt x="172644" y="148841"/>
                </a:lnTo>
                <a:lnTo>
                  <a:pt x="172227" y="0"/>
                </a:lnTo>
                <a:lnTo>
                  <a:pt x="2237580" y="0"/>
                </a:lnTo>
                <a:lnTo>
                  <a:pt x="2237580" y="1419039"/>
                </a:lnTo>
                <a:lnTo>
                  <a:pt x="2156507" y="141909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2" name="object 362"/>
          <p:cNvSpPr/>
          <p:nvPr/>
        </p:nvSpPr>
        <p:spPr>
          <a:xfrm>
            <a:off x="15775328" y="8026851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3" name="object 363"/>
          <p:cNvSpPr/>
          <p:nvPr/>
        </p:nvSpPr>
        <p:spPr>
          <a:xfrm>
            <a:off x="13044453" y="6635791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4" name="object 364"/>
          <p:cNvSpPr/>
          <p:nvPr/>
        </p:nvSpPr>
        <p:spPr>
          <a:xfrm>
            <a:off x="13046659" y="6847629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136"/>
                </a:lnTo>
                <a:lnTo>
                  <a:pt x="224426" y="174136"/>
                </a:lnTo>
                <a:lnTo>
                  <a:pt x="224426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5" name="object 365"/>
          <p:cNvSpPr/>
          <p:nvPr/>
        </p:nvSpPr>
        <p:spPr>
          <a:xfrm>
            <a:off x="13271086" y="6771866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5">
                <a:moveTo>
                  <a:pt x="0" y="162801"/>
                </a:moveTo>
                <a:lnTo>
                  <a:pt x="532788" y="159520"/>
                </a:lnTo>
                <a:lnTo>
                  <a:pt x="53260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6" name="object 366"/>
          <p:cNvSpPr/>
          <p:nvPr/>
        </p:nvSpPr>
        <p:spPr>
          <a:xfrm>
            <a:off x="13303778" y="663579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7" name="object 367"/>
          <p:cNvSpPr/>
          <p:nvPr/>
        </p:nvSpPr>
        <p:spPr>
          <a:xfrm>
            <a:off x="13303778" y="663579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8" name="object 368"/>
          <p:cNvSpPr/>
          <p:nvPr/>
        </p:nvSpPr>
        <p:spPr>
          <a:xfrm>
            <a:off x="13304494" y="6847630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136"/>
                </a:lnTo>
                <a:lnTo>
                  <a:pt x="440202" y="17413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69" name="object 369"/>
          <p:cNvSpPr/>
          <p:nvPr/>
        </p:nvSpPr>
        <p:spPr>
          <a:xfrm>
            <a:off x="13304493" y="6847629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136"/>
                </a:lnTo>
                <a:lnTo>
                  <a:pt x="440202" y="17413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0" name="object 370"/>
          <p:cNvSpPr/>
          <p:nvPr/>
        </p:nvSpPr>
        <p:spPr>
          <a:xfrm>
            <a:off x="14731944" y="6686378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1" name="object 371"/>
          <p:cNvSpPr/>
          <p:nvPr/>
        </p:nvSpPr>
        <p:spPr>
          <a:xfrm>
            <a:off x="14731944" y="6686378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2" name="object 372"/>
          <p:cNvSpPr/>
          <p:nvPr/>
        </p:nvSpPr>
        <p:spPr>
          <a:xfrm>
            <a:off x="15253099" y="6686378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3" name="object 373"/>
          <p:cNvSpPr/>
          <p:nvPr/>
        </p:nvSpPr>
        <p:spPr>
          <a:xfrm>
            <a:off x="15253099" y="6686378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4" name="object 374"/>
          <p:cNvSpPr/>
          <p:nvPr/>
        </p:nvSpPr>
        <p:spPr>
          <a:xfrm>
            <a:off x="14731944" y="6683337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25"/>
                </a:lnTo>
                <a:lnTo>
                  <a:pt x="1043384" y="276625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5" name="object 375"/>
          <p:cNvSpPr/>
          <p:nvPr/>
        </p:nvSpPr>
        <p:spPr>
          <a:xfrm>
            <a:off x="14731944" y="709854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6" name="object 376"/>
          <p:cNvSpPr/>
          <p:nvPr/>
        </p:nvSpPr>
        <p:spPr>
          <a:xfrm>
            <a:off x="14731944" y="709854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7" name="object 377"/>
          <p:cNvSpPr/>
          <p:nvPr/>
        </p:nvSpPr>
        <p:spPr>
          <a:xfrm>
            <a:off x="15253099" y="709854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8" name="object 378"/>
          <p:cNvSpPr/>
          <p:nvPr/>
        </p:nvSpPr>
        <p:spPr>
          <a:xfrm>
            <a:off x="15253099" y="709854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79" name="object 379"/>
          <p:cNvSpPr/>
          <p:nvPr/>
        </p:nvSpPr>
        <p:spPr>
          <a:xfrm>
            <a:off x="14731944" y="7095500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0" name="object 380"/>
          <p:cNvSpPr/>
          <p:nvPr/>
        </p:nvSpPr>
        <p:spPr>
          <a:xfrm>
            <a:off x="14731944" y="750581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1" name="object 381"/>
          <p:cNvSpPr/>
          <p:nvPr/>
        </p:nvSpPr>
        <p:spPr>
          <a:xfrm>
            <a:off x="14731944" y="750581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2" name="object 382"/>
          <p:cNvSpPr/>
          <p:nvPr/>
        </p:nvSpPr>
        <p:spPr>
          <a:xfrm>
            <a:off x="15253099" y="750581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3" name="object 383"/>
          <p:cNvSpPr/>
          <p:nvPr/>
        </p:nvSpPr>
        <p:spPr>
          <a:xfrm>
            <a:off x="15253099" y="750581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4" name="object 384"/>
          <p:cNvSpPr/>
          <p:nvPr/>
        </p:nvSpPr>
        <p:spPr>
          <a:xfrm>
            <a:off x="14731944" y="7502772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5" name="object 385"/>
          <p:cNvSpPr/>
          <p:nvPr/>
        </p:nvSpPr>
        <p:spPr>
          <a:xfrm>
            <a:off x="14731944" y="790682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6" name="object 386"/>
          <p:cNvSpPr/>
          <p:nvPr/>
        </p:nvSpPr>
        <p:spPr>
          <a:xfrm>
            <a:off x="14731944" y="790682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7" name="object 387"/>
          <p:cNvSpPr/>
          <p:nvPr/>
        </p:nvSpPr>
        <p:spPr>
          <a:xfrm>
            <a:off x="15253099" y="790682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8" name="object 388"/>
          <p:cNvSpPr/>
          <p:nvPr/>
        </p:nvSpPr>
        <p:spPr>
          <a:xfrm>
            <a:off x="15253099" y="790682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89" name="object 389"/>
          <p:cNvSpPr/>
          <p:nvPr/>
        </p:nvSpPr>
        <p:spPr>
          <a:xfrm>
            <a:off x="14731944" y="7903781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0" name="object 390"/>
          <p:cNvSpPr/>
          <p:nvPr/>
        </p:nvSpPr>
        <p:spPr>
          <a:xfrm>
            <a:off x="14073998" y="6757369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337"/>
                </a:lnTo>
                <a:lnTo>
                  <a:pt x="520081" y="12533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1" name="object 391"/>
          <p:cNvSpPr/>
          <p:nvPr/>
        </p:nvSpPr>
        <p:spPr>
          <a:xfrm>
            <a:off x="14073998" y="7169593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2" name="object 392"/>
          <p:cNvSpPr/>
          <p:nvPr/>
        </p:nvSpPr>
        <p:spPr>
          <a:xfrm>
            <a:off x="14073998" y="7576805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3" name="object 393"/>
          <p:cNvSpPr/>
          <p:nvPr/>
        </p:nvSpPr>
        <p:spPr>
          <a:xfrm>
            <a:off x="14073998" y="7977814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4" name="object 394"/>
          <p:cNvSpPr/>
          <p:nvPr/>
        </p:nvSpPr>
        <p:spPr>
          <a:xfrm>
            <a:off x="14073998" y="7977813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5" name="object 395"/>
          <p:cNvSpPr/>
          <p:nvPr/>
        </p:nvSpPr>
        <p:spPr>
          <a:xfrm>
            <a:off x="14603803" y="6820127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69" h="1904">
                <a:moveTo>
                  <a:pt x="128141" y="155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6" name="object 396"/>
          <p:cNvSpPr/>
          <p:nvPr/>
        </p:nvSpPr>
        <p:spPr>
          <a:xfrm>
            <a:off x="14594079" y="6808077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90"/>
                </a:lnTo>
                <a:lnTo>
                  <a:pt x="11990" y="2422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7" name="object 397"/>
          <p:cNvSpPr/>
          <p:nvPr/>
        </p:nvSpPr>
        <p:spPr>
          <a:xfrm>
            <a:off x="14603803" y="7232232"/>
            <a:ext cx="128270" cy="0"/>
          </a:xfrm>
          <a:custGeom>
            <a:avLst/>
            <a:gdLst/>
            <a:ahLst/>
            <a:cxnLst/>
            <a:rect l="l" t="t" r="r" b="b"/>
            <a:pathLst>
              <a:path w="128269">
                <a:moveTo>
                  <a:pt x="12814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8" name="object 398"/>
          <p:cNvSpPr/>
          <p:nvPr/>
        </p:nvSpPr>
        <p:spPr>
          <a:xfrm>
            <a:off x="14594079" y="7220122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99" name="object 399"/>
          <p:cNvSpPr/>
          <p:nvPr/>
        </p:nvSpPr>
        <p:spPr>
          <a:xfrm>
            <a:off x="14603803" y="7639444"/>
            <a:ext cx="128270" cy="0"/>
          </a:xfrm>
          <a:custGeom>
            <a:avLst/>
            <a:gdLst/>
            <a:ahLst/>
            <a:cxnLst/>
            <a:rect l="l" t="t" r="r" b="b"/>
            <a:pathLst>
              <a:path w="128269">
                <a:moveTo>
                  <a:pt x="12814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0" name="object 400"/>
          <p:cNvSpPr/>
          <p:nvPr/>
        </p:nvSpPr>
        <p:spPr>
          <a:xfrm>
            <a:off x="14594079" y="7627334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1" name="object 401"/>
          <p:cNvSpPr/>
          <p:nvPr/>
        </p:nvSpPr>
        <p:spPr>
          <a:xfrm>
            <a:off x="14603803" y="8040572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69" h="1904">
                <a:moveTo>
                  <a:pt x="128141" y="155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2" name="object 402"/>
          <p:cNvSpPr/>
          <p:nvPr/>
        </p:nvSpPr>
        <p:spPr>
          <a:xfrm>
            <a:off x="14594079" y="8028521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31"/>
                </a:lnTo>
                <a:lnTo>
                  <a:pt x="11990" y="2422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3" name="object 403"/>
          <p:cNvSpPr/>
          <p:nvPr/>
        </p:nvSpPr>
        <p:spPr>
          <a:xfrm>
            <a:off x="15785053" y="7641055"/>
            <a:ext cx="83820" cy="0"/>
          </a:xfrm>
          <a:custGeom>
            <a:avLst/>
            <a:gdLst/>
            <a:ahLst/>
            <a:cxnLst/>
            <a:rect l="l" t="t" r="r" b="b"/>
            <a:pathLst>
              <a:path w="83819">
                <a:moveTo>
                  <a:pt x="83578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4" name="object 404"/>
          <p:cNvSpPr/>
          <p:nvPr/>
        </p:nvSpPr>
        <p:spPr>
          <a:xfrm>
            <a:off x="15775328" y="7628945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5" name="object 405"/>
          <p:cNvSpPr/>
          <p:nvPr/>
        </p:nvSpPr>
        <p:spPr>
          <a:xfrm>
            <a:off x="13798029" y="6819173"/>
            <a:ext cx="276225" cy="1221740"/>
          </a:xfrm>
          <a:custGeom>
            <a:avLst/>
            <a:gdLst/>
            <a:ahLst/>
            <a:cxnLst/>
            <a:rect l="l" t="t" r="r" b="b"/>
            <a:pathLst>
              <a:path w="276225" h="1221740">
                <a:moveTo>
                  <a:pt x="275969" y="894"/>
                </a:moveTo>
                <a:lnTo>
                  <a:pt x="149498" y="0"/>
                </a:lnTo>
                <a:lnTo>
                  <a:pt x="149498" y="1221398"/>
                </a:lnTo>
                <a:lnTo>
                  <a:pt x="0" y="122139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6" name="object 406"/>
          <p:cNvSpPr/>
          <p:nvPr/>
        </p:nvSpPr>
        <p:spPr>
          <a:xfrm>
            <a:off x="13788364" y="8028461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7" name="object 407"/>
          <p:cNvSpPr/>
          <p:nvPr/>
        </p:nvSpPr>
        <p:spPr>
          <a:xfrm>
            <a:off x="13947526" y="7639444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8" name="object 408"/>
          <p:cNvSpPr/>
          <p:nvPr/>
        </p:nvSpPr>
        <p:spPr>
          <a:xfrm>
            <a:off x="13947526" y="7232232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09" name="object 409"/>
          <p:cNvSpPr/>
          <p:nvPr/>
        </p:nvSpPr>
        <p:spPr>
          <a:xfrm>
            <a:off x="13947526" y="8040452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0" name="object 410"/>
          <p:cNvSpPr/>
          <p:nvPr/>
        </p:nvSpPr>
        <p:spPr>
          <a:xfrm>
            <a:off x="13188283" y="797781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1" name="object 411"/>
          <p:cNvSpPr/>
          <p:nvPr/>
        </p:nvSpPr>
        <p:spPr>
          <a:xfrm>
            <a:off x="13188283" y="7977813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412" name="object 412"/>
          <p:cNvGraphicFramePr>
            <a:graphicFrameLocks noGrp="1"/>
          </p:cNvGraphicFramePr>
          <p:nvPr/>
        </p:nvGraphicFramePr>
        <p:xfrm>
          <a:off x="13024698" y="6473299"/>
          <a:ext cx="2898773" cy="17719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86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549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44577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921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352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5468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1023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24323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3906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evorschlag:</a:t>
                      </a:r>
                      <a:r>
                        <a:rPr sz="300" spc="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Kriterien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5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454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84455" marR="31750" indent="-12065">
                        <a:lnSpc>
                          <a:spcPct val="1093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 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302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86995" marR="18415" indent="-23495">
                        <a:lnSpc>
                          <a:spcPct val="1093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556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54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54305" marR="161290" algn="ctr">
                        <a:lnSpc>
                          <a:spcPct val="1093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7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(Hours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R="8890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econd 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eGF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54940" marR="160655" algn="ctr">
                        <a:lnSpc>
                          <a:spcPct val="1093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7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(Hours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R="7620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econd 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eGF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29527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877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unde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5: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15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0795" marR="85725">
                        <a:lnSpc>
                          <a:spcPct val="1095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All</a:t>
                      </a:r>
                      <a:r>
                        <a:rPr sz="300" spc="-7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values  over</a:t>
                      </a:r>
                      <a:r>
                        <a:rPr sz="300" spc="-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91d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92710" marR="70485" algn="ctr">
                        <a:lnSpc>
                          <a:spcPct val="110800"/>
                        </a:lnSpc>
                        <a:spcBef>
                          <a:spcPts val="190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78105" marR="278130" indent="6985">
                        <a:lnSpc>
                          <a:spcPct val="100000"/>
                        </a:lnSpc>
                        <a:spcBef>
                          <a:spcPts val="114"/>
                        </a:spcBef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 Value1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6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15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656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9527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877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unde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4: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0795" marR="85725">
                        <a:lnSpc>
                          <a:spcPct val="1093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All</a:t>
                      </a:r>
                      <a:r>
                        <a:rPr sz="300" spc="-7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values  over</a:t>
                      </a:r>
                      <a:r>
                        <a:rPr sz="300" spc="-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91d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92710" marR="70485" algn="ctr">
                        <a:lnSpc>
                          <a:spcPct val="110900"/>
                        </a:lnSpc>
                        <a:spcBef>
                          <a:spcPts val="234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5090" marR="286385"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0025" algn="ctr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3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4230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29527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877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unde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3: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6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0795" marR="85725">
                        <a:lnSpc>
                          <a:spcPct val="1096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All</a:t>
                      </a:r>
                      <a:r>
                        <a:rPr sz="300" spc="-7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values  over</a:t>
                      </a:r>
                      <a:r>
                        <a:rPr sz="300" spc="-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91d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92710" marR="70485" algn="ctr">
                        <a:lnSpc>
                          <a:spcPct val="1109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5090" marR="286385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002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224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25400" marR="132715" indent="80010">
                        <a:lnSpc>
                          <a:spcPct val="113599"/>
                        </a:lnSpc>
                      </a:pP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KRITERIEN_ 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EVORSC</a:t>
                      </a:r>
                      <a:r>
                        <a:rPr sz="300" spc="-3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H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LAG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29527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STAG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31877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under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2: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1079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90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10795" marR="85725">
                        <a:lnSpc>
                          <a:spcPct val="109300"/>
                        </a:lnSpc>
                      </a:pP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All</a:t>
                      </a:r>
                      <a:r>
                        <a:rPr sz="300" spc="-7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values  over</a:t>
                      </a:r>
                      <a:r>
                        <a:rPr sz="300" spc="-3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91d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92710" marR="70485" algn="ctr">
                        <a:lnSpc>
                          <a:spcPct val="1109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5090" marR="286385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002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13" name="object 413"/>
          <p:cNvSpPr/>
          <p:nvPr/>
        </p:nvSpPr>
        <p:spPr>
          <a:xfrm>
            <a:off x="13631051" y="8519252"/>
            <a:ext cx="2237740" cy="1419225"/>
          </a:xfrm>
          <a:custGeom>
            <a:avLst/>
            <a:gdLst/>
            <a:ahLst/>
            <a:cxnLst/>
            <a:rect l="l" t="t" r="r" b="b"/>
            <a:pathLst>
              <a:path w="2237740" h="1419225">
                <a:moveTo>
                  <a:pt x="0" y="148603"/>
                </a:moveTo>
                <a:lnTo>
                  <a:pt x="172644" y="148841"/>
                </a:lnTo>
                <a:lnTo>
                  <a:pt x="172227" y="0"/>
                </a:lnTo>
                <a:lnTo>
                  <a:pt x="2237580" y="0"/>
                </a:lnTo>
                <a:lnTo>
                  <a:pt x="2237580" y="1419039"/>
                </a:lnTo>
                <a:lnTo>
                  <a:pt x="2156507" y="141909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4" name="object 414"/>
          <p:cNvSpPr/>
          <p:nvPr/>
        </p:nvSpPr>
        <p:spPr>
          <a:xfrm>
            <a:off x="15775328" y="9923079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5" name="object 415"/>
          <p:cNvSpPr/>
          <p:nvPr/>
        </p:nvSpPr>
        <p:spPr>
          <a:xfrm>
            <a:off x="13044453" y="8532018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6" name="object 416"/>
          <p:cNvSpPr/>
          <p:nvPr/>
        </p:nvSpPr>
        <p:spPr>
          <a:xfrm>
            <a:off x="13046659" y="8743857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136"/>
                </a:lnTo>
                <a:lnTo>
                  <a:pt x="224426" y="174136"/>
                </a:lnTo>
                <a:lnTo>
                  <a:pt x="224426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7" name="object 417"/>
          <p:cNvSpPr/>
          <p:nvPr/>
        </p:nvSpPr>
        <p:spPr>
          <a:xfrm>
            <a:off x="13271086" y="8668094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5">
                <a:moveTo>
                  <a:pt x="0" y="162861"/>
                </a:moveTo>
                <a:lnTo>
                  <a:pt x="532788" y="159580"/>
                </a:lnTo>
                <a:lnTo>
                  <a:pt x="53260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8" name="object 418"/>
          <p:cNvSpPr/>
          <p:nvPr/>
        </p:nvSpPr>
        <p:spPr>
          <a:xfrm>
            <a:off x="13303778" y="8532019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19" name="object 419"/>
          <p:cNvSpPr/>
          <p:nvPr/>
        </p:nvSpPr>
        <p:spPr>
          <a:xfrm>
            <a:off x="13303778" y="8532018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0" name="object 420"/>
          <p:cNvSpPr/>
          <p:nvPr/>
        </p:nvSpPr>
        <p:spPr>
          <a:xfrm>
            <a:off x="13304494" y="874385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136"/>
                </a:lnTo>
                <a:lnTo>
                  <a:pt x="440202" y="17413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1" name="object 421"/>
          <p:cNvSpPr/>
          <p:nvPr/>
        </p:nvSpPr>
        <p:spPr>
          <a:xfrm>
            <a:off x="13304493" y="8743857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136"/>
                </a:lnTo>
                <a:lnTo>
                  <a:pt x="440202" y="17413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2" name="object 422"/>
          <p:cNvSpPr/>
          <p:nvPr/>
        </p:nvSpPr>
        <p:spPr>
          <a:xfrm>
            <a:off x="14731944" y="85826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3" name="object 423"/>
          <p:cNvSpPr/>
          <p:nvPr/>
        </p:nvSpPr>
        <p:spPr>
          <a:xfrm>
            <a:off x="14731944" y="85826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4" name="object 424"/>
          <p:cNvSpPr/>
          <p:nvPr/>
        </p:nvSpPr>
        <p:spPr>
          <a:xfrm>
            <a:off x="15253099" y="85826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5" name="object 425"/>
          <p:cNvSpPr/>
          <p:nvPr/>
        </p:nvSpPr>
        <p:spPr>
          <a:xfrm>
            <a:off x="15253099" y="85826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6" name="object 426"/>
          <p:cNvSpPr/>
          <p:nvPr/>
        </p:nvSpPr>
        <p:spPr>
          <a:xfrm>
            <a:off x="14731944" y="8579564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7" name="object 427"/>
          <p:cNvSpPr/>
          <p:nvPr/>
        </p:nvSpPr>
        <p:spPr>
          <a:xfrm>
            <a:off x="14731944" y="8994830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8" name="object 428"/>
          <p:cNvSpPr/>
          <p:nvPr/>
        </p:nvSpPr>
        <p:spPr>
          <a:xfrm>
            <a:off x="14731944" y="8994830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29" name="object 429"/>
          <p:cNvSpPr/>
          <p:nvPr/>
        </p:nvSpPr>
        <p:spPr>
          <a:xfrm>
            <a:off x="15253099" y="8994830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0" name="object 430"/>
          <p:cNvSpPr/>
          <p:nvPr/>
        </p:nvSpPr>
        <p:spPr>
          <a:xfrm>
            <a:off x="15253099" y="8994830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1" name="object 431"/>
          <p:cNvSpPr/>
          <p:nvPr/>
        </p:nvSpPr>
        <p:spPr>
          <a:xfrm>
            <a:off x="14731944" y="8991788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2" name="object 432"/>
          <p:cNvSpPr/>
          <p:nvPr/>
        </p:nvSpPr>
        <p:spPr>
          <a:xfrm>
            <a:off x="14731944" y="940204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3" name="object 433"/>
          <p:cNvSpPr/>
          <p:nvPr/>
        </p:nvSpPr>
        <p:spPr>
          <a:xfrm>
            <a:off x="14731944" y="940204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4" name="object 434"/>
          <p:cNvSpPr/>
          <p:nvPr/>
        </p:nvSpPr>
        <p:spPr>
          <a:xfrm>
            <a:off x="15253099" y="940204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5" name="object 435"/>
          <p:cNvSpPr/>
          <p:nvPr/>
        </p:nvSpPr>
        <p:spPr>
          <a:xfrm>
            <a:off x="15253099" y="9402043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6" name="object 436"/>
          <p:cNvSpPr/>
          <p:nvPr/>
        </p:nvSpPr>
        <p:spPr>
          <a:xfrm>
            <a:off x="14731944" y="9399000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7" name="object 437"/>
          <p:cNvSpPr/>
          <p:nvPr/>
        </p:nvSpPr>
        <p:spPr>
          <a:xfrm>
            <a:off x="14731944" y="980305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8" name="object 438"/>
          <p:cNvSpPr/>
          <p:nvPr/>
        </p:nvSpPr>
        <p:spPr>
          <a:xfrm>
            <a:off x="14731944" y="980305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9" name="object 439"/>
          <p:cNvSpPr/>
          <p:nvPr/>
        </p:nvSpPr>
        <p:spPr>
          <a:xfrm>
            <a:off x="15253099" y="980305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0" name="object 440"/>
          <p:cNvSpPr/>
          <p:nvPr/>
        </p:nvSpPr>
        <p:spPr>
          <a:xfrm>
            <a:off x="15253099" y="980305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1" name="object 441"/>
          <p:cNvSpPr/>
          <p:nvPr/>
        </p:nvSpPr>
        <p:spPr>
          <a:xfrm>
            <a:off x="14731944" y="9800008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2" name="object 442"/>
          <p:cNvSpPr/>
          <p:nvPr/>
        </p:nvSpPr>
        <p:spPr>
          <a:xfrm>
            <a:off x="14073998" y="8653657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3" name="object 443"/>
          <p:cNvSpPr/>
          <p:nvPr/>
        </p:nvSpPr>
        <p:spPr>
          <a:xfrm>
            <a:off x="14073998" y="906582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4" name="object 444"/>
          <p:cNvSpPr/>
          <p:nvPr/>
        </p:nvSpPr>
        <p:spPr>
          <a:xfrm>
            <a:off x="14073998" y="9473093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5" name="object 445"/>
          <p:cNvSpPr/>
          <p:nvPr/>
        </p:nvSpPr>
        <p:spPr>
          <a:xfrm>
            <a:off x="14073998" y="9874042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6" name="object 446"/>
          <p:cNvSpPr/>
          <p:nvPr/>
        </p:nvSpPr>
        <p:spPr>
          <a:xfrm>
            <a:off x="14073998" y="9874042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7" name="object 447"/>
          <p:cNvSpPr/>
          <p:nvPr/>
        </p:nvSpPr>
        <p:spPr>
          <a:xfrm>
            <a:off x="14603803" y="8716416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69" h="1904">
                <a:moveTo>
                  <a:pt x="128141" y="149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8" name="object 448"/>
          <p:cNvSpPr/>
          <p:nvPr/>
        </p:nvSpPr>
        <p:spPr>
          <a:xfrm>
            <a:off x="14594079" y="8704305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90"/>
                </a:lnTo>
                <a:lnTo>
                  <a:pt x="11990" y="2422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49" name="object 449"/>
          <p:cNvSpPr/>
          <p:nvPr/>
        </p:nvSpPr>
        <p:spPr>
          <a:xfrm>
            <a:off x="14603803" y="9128460"/>
            <a:ext cx="128270" cy="0"/>
          </a:xfrm>
          <a:custGeom>
            <a:avLst/>
            <a:gdLst/>
            <a:ahLst/>
            <a:cxnLst/>
            <a:rect l="l" t="t" r="r" b="b"/>
            <a:pathLst>
              <a:path w="128269">
                <a:moveTo>
                  <a:pt x="12814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0" name="object 450"/>
          <p:cNvSpPr/>
          <p:nvPr/>
        </p:nvSpPr>
        <p:spPr>
          <a:xfrm>
            <a:off x="14594079" y="9116350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1" name="object 451"/>
          <p:cNvSpPr/>
          <p:nvPr/>
        </p:nvSpPr>
        <p:spPr>
          <a:xfrm>
            <a:off x="14603803" y="9535672"/>
            <a:ext cx="128270" cy="0"/>
          </a:xfrm>
          <a:custGeom>
            <a:avLst/>
            <a:gdLst/>
            <a:ahLst/>
            <a:cxnLst/>
            <a:rect l="l" t="t" r="r" b="b"/>
            <a:pathLst>
              <a:path w="128269">
                <a:moveTo>
                  <a:pt x="12814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2" name="object 452"/>
          <p:cNvSpPr/>
          <p:nvPr/>
        </p:nvSpPr>
        <p:spPr>
          <a:xfrm>
            <a:off x="14594079" y="9523562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3" name="object 453"/>
          <p:cNvSpPr/>
          <p:nvPr/>
        </p:nvSpPr>
        <p:spPr>
          <a:xfrm>
            <a:off x="14603803" y="9936860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69" h="1904">
                <a:moveTo>
                  <a:pt x="128141" y="149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4" name="object 454"/>
          <p:cNvSpPr/>
          <p:nvPr/>
        </p:nvSpPr>
        <p:spPr>
          <a:xfrm>
            <a:off x="14594079" y="9924750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31"/>
                </a:lnTo>
                <a:lnTo>
                  <a:pt x="11990" y="2422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5" name="object 455"/>
          <p:cNvSpPr/>
          <p:nvPr/>
        </p:nvSpPr>
        <p:spPr>
          <a:xfrm>
            <a:off x="15785053" y="9537283"/>
            <a:ext cx="83820" cy="0"/>
          </a:xfrm>
          <a:custGeom>
            <a:avLst/>
            <a:gdLst/>
            <a:ahLst/>
            <a:cxnLst/>
            <a:rect l="l" t="t" r="r" b="b"/>
            <a:pathLst>
              <a:path w="83819">
                <a:moveTo>
                  <a:pt x="83578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6" name="object 456"/>
          <p:cNvSpPr/>
          <p:nvPr/>
        </p:nvSpPr>
        <p:spPr>
          <a:xfrm>
            <a:off x="15775328" y="9525173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69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7" name="object 457"/>
          <p:cNvSpPr/>
          <p:nvPr/>
        </p:nvSpPr>
        <p:spPr>
          <a:xfrm>
            <a:off x="15785053" y="9130131"/>
            <a:ext cx="83820" cy="635"/>
          </a:xfrm>
          <a:custGeom>
            <a:avLst/>
            <a:gdLst/>
            <a:ahLst/>
            <a:cxnLst/>
            <a:rect l="l" t="t" r="r" b="b"/>
            <a:pathLst>
              <a:path w="83819" h="634">
                <a:moveTo>
                  <a:pt x="83578" y="29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8" name="object 458"/>
          <p:cNvSpPr/>
          <p:nvPr/>
        </p:nvSpPr>
        <p:spPr>
          <a:xfrm>
            <a:off x="15775328" y="9118020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69" y="0"/>
                </a:moveTo>
                <a:lnTo>
                  <a:pt x="0" y="12110"/>
                </a:lnTo>
                <a:lnTo>
                  <a:pt x="12050" y="24220"/>
                </a:lnTo>
                <a:lnTo>
                  <a:pt x="1216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59" name="object 459"/>
          <p:cNvSpPr/>
          <p:nvPr/>
        </p:nvSpPr>
        <p:spPr>
          <a:xfrm>
            <a:off x="15785053" y="8717967"/>
            <a:ext cx="83820" cy="635"/>
          </a:xfrm>
          <a:custGeom>
            <a:avLst/>
            <a:gdLst/>
            <a:ahLst/>
            <a:cxnLst/>
            <a:rect l="l" t="t" r="r" b="b"/>
            <a:pathLst>
              <a:path w="83819" h="634">
                <a:moveTo>
                  <a:pt x="83578" y="23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0" name="object 460"/>
          <p:cNvSpPr/>
          <p:nvPr/>
        </p:nvSpPr>
        <p:spPr>
          <a:xfrm>
            <a:off x="15775328" y="8705856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69" y="0"/>
                </a:moveTo>
                <a:lnTo>
                  <a:pt x="0" y="12050"/>
                </a:lnTo>
                <a:lnTo>
                  <a:pt x="12050" y="24220"/>
                </a:lnTo>
                <a:lnTo>
                  <a:pt x="1216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1" name="object 461"/>
          <p:cNvSpPr/>
          <p:nvPr/>
        </p:nvSpPr>
        <p:spPr>
          <a:xfrm>
            <a:off x="13798029" y="8715402"/>
            <a:ext cx="276225" cy="1221740"/>
          </a:xfrm>
          <a:custGeom>
            <a:avLst/>
            <a:gdLst/>
            <a:ahLst/>
            <a:cxnLst/>
            <a:rect l="l" t="t" r="r" b="b"/>
            <a:pathLst>
              <a:path w="276225" h="1221740">
                <a:moveTo>
                  <a:pt x="275969" y="894"/>
                </a:moveTo>
                <a:lnTo>
                  <a:pt x="149498" y="0"/>
                </a:lnTo>
                <a:lnTo>
                  <a:pt x="149498" y="1221398"/>
                </a:lnTo>
                <a:lnTo>
                  <a:pt x="0" y="122139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2" name="object 462"/>
          <p:cNvSpPr/>
          <p:nvPr/>
        </p:nvSpPr>
        <p:spPr>
          <a:xfrm>
            <a:off x="13788364" y="9924690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3" name="object 463"/>
          <p:cNvSpPr/>
          <p:nvPr/>
        </p:nvSpPr>
        <p:spPr>
          <a:xfrm>
            <a:off x="13947526" y="9535672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4" name="object 464"/>
          <p:cNvSpPr/>
          <p:nvPr/>
        </p:nvSpPr>
        <p:spPr>
          <a:xfrm>
            <a:off x="13947526" y="9128460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5" name="object 465"/>
          <p:cNvSpPr/>
          <p:nvPr/>
        </p:nvSpPr>
        <p:spPr>
          <a:xfrm>
            <a:off x="13947526" y="9936681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6" name="object 466"/>
          <p:cNvSpPr/>
          <p:nvPr/>
        </p:nvSpPr>
        <p:spPr>
          <a:xfrm>
            <a:off x="13188283" y="9874042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67" name="object 467"/>
          <p:cNvSpPr/>
          <p:nvPr/>
        </p:nvSpPr>
        <p:spPr>
          <a:xfrm>
            <a:off x="13188283" y="9874042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468" name="object 468"/>
          <p:cNvGraphicFramePr>
            <a:graphicFrameLocks noGrp="1"/>
          </p:cNvGraphicFramePr>
          <p:nvPr/>
        </p:nvGraphicFramePr>
        <p:xfrm>
          <a:off x="13024698" y="8369527"/>
          <a:ext cx="2895599" cy="177190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2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00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734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3278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64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24323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20129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is</a:t>
                      </a:r>
                      <a:r>
                        <a:rPr sz="30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Proposition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501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84455" marR="26034" indent="-12065">
                        <a:lnSpc>
                          <a:spcPct val="1093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 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302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86995" marR="12700" indent="-23495">
                        <a:lnSpc>
                          <a:spcPct val="1096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5565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54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60020" marR="161290" algn="ctr">
                        <a:lnSpc>
                          <a:spcPct val="1093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8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(Hours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R="3175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econd 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eGF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0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60655" marR="160655" algn="ctr">
                        <a:lnSpc>
                          <a:spcPct val="1097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300" spc="-7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(Hours)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R="1905" algn="ctr"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econd </a:t>
                      </a:r>
                      <a:r>
                        <a:rPr sz="300" spc="2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eGFR</a:t>
                      </a:r>
                      <a:r>
                        <a:rPr sz="300" spc="-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Valu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127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60655" algn="r">
                        <a:lnSpc>
                          <a:spcPct val="100000"/>
                        </a:lnSpc>
                        <a:spcBef>
                          <a:spcPts val="180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8.5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67640" marR="73660" algn="ctr">
                        <a:lnSpc>
                          <a:spcPct val="110900"/>
                        </a:lnSpc>
                        <a:spcBef>
                          <a:spcPts val="195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marL="81280" marR="286385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200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15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653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60655" algn="r">
                        <a:lnSpc>
                          <a:spcPct val="100000"/>
                        </a:lnSpc>
                        <a:spcBef>
                          <a:spcPts val="220"/>
                        </a:spcBef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8.4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67640" marR="73660" algn="ctr">
                        <a:lnSpc>
                          <a:spcPct val="110900"/>
                        </a:lnSpc>
                        <a:spcBef>
                          <a:spcPts val="229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6385" algn="ctr"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200" algn="ctr"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3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425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60655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8.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67640" marR="73660" algn="ctr">
                        <a:lnSpc>
                          <a:spcPct val="1109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6385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200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176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99695" marR="121285" indent="-80645">
                        <a:lnSpc>
                          <a:spcPct val="113599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Criteria</a:t>
                      </a:r>
                      <a:r>
                        <a:rPr sz="300" spc="-5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is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Proposition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R="160655" algn="r">
                        <a:lnSpc>
                          <a:spcPct val="100000"/>
                        </a:lnSpc>
                      </a:pPr>
                      <a:r>
                        <a:rPr sz="30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N18.2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85725" algn="ctr">
                        <a:lnSpc>
                          <a:spcPct val="1000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RMITTLUNG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</a:t>
                      </a:r>
                      <a:r>
                        <a:rPr sz="25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RMITTLUNG1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 marL="225425" marR="130810" algn="ctr">
                        <a:lnSpc>
                          <a:spcPts val="330"/>
                        </a:lnSpc>
                        <a:spcBef>
                          <a:spcPts val="15"/>
                        </a:spcBef>
                      </a:pP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öss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oder</a:t>
                      </a:r>
                      <a:r>
                        <a:rPr sz="250" spc="-6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leich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6385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200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69" name="object 469"/>
          <p:cNvSpPr txBox="1"/>
          <p:nvPr/>
        </p:nvSpPr>
        <p:spPr>
          <a:xfrm>
            <a:off x="11142199" y="7360194"/>
            <a:ext cx="504825" cy="125730"/>
          </a:xfrm>
          <a:prstGeom prst="rect">
            <a:avLst/>
          </a:prstGeom>
          <a:solidFill>
            <a:srgbClr val="D7E3BF"/>
          </a:solidFill>
          <a:ln w="3175">
            <a:solidFill>
              <a:srgbClr val="231F20"/>
            </a:solidFill>
          </a:ln>
        </p:spPr>
        <p:txBody>
          <a:bodyPr vert="horz" wrap="square" lIns="0" tIns="2540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20"/>
              </a:spcBef>
            </a:pPr>
            <a:endParaRPr sz="250">
              <a:latin typeface="Times New Roman"/>
              <a:cs typeface="Times New Roman"/>
            </a:endParaRPr>
          </a:p>
          <a:p>
            <a:pPr marL="36195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Difference in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Hours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470" name="object 470"/>
          <p:cNvSpPr txBox="1"/>
          <p:nvPr/>
        </p:nvSpPr>
        <p:spPr>
          <a:xfrm>
            <a:off x="10080231" y="7099079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3655" rIns="0" bIns="0" rtlCol="0">
            <a:spAutoFit/>
          </a:bodyPr>
          <a:lstStyle/>
          <a:p>
            <a:pPr marL="103505" marR="48260" indent="-46355">
              <a:lnSpc>
                <a:spcPct val="109600"/>
              </a:lnSpc>
              <a:spcBef>
                <a:spcPts val="26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(Minutes)  First eGFR</a:t>
            </a:r>
            <a:r>
              <a:rPr sz="300" spc="-3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471" name="object 471"/>
          <p:cNvSpPr txBox="1"/>
          <p:nvPr/>
        </p:nvSpPr>
        <p:spPr>
          <a:xfrm>
            <a:off x="10080231" y="7310918"/>
            <a:ext cx="574040" cy="174625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33655" rIns="0" bIns="0" rtlCol="0">
            <a:spAutoFit/>
          </a:bodyPr>
          <a:lstStyle/>
          <a:p>
            <a:pPr marL="93980" marR="45720" indent="-34925">
              <a:lnSpc>
                <a:spcPct val="109500"/>
              </a:lnSpc>
              <a:spcBef>
                <a:spcPts val="26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</a:t>
            </a:r>
            <a:r>
              <a:rPr sz="30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(Minutes)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econd eGFR</a:t>
            </a:r>
            <a:r>
              <a:rPr sz="30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472" name="object 472"/>
          <p:cNvSpPr/>
          <p:nvPr/>
        </p:nvSpPr>
        <p:spPr>
          <a:xfrm>
            <a:off x="11156874" y="7126223"/>
            <a:ext cx="480695" cy="121920"/>
          </a:xfrm>
          <a:custGeom>
            <a:avLst/>
            <a:gdLst/>
            <a:ahLst/>
            <a:cxnLst/>
            <a:rect l="l" t="t" r="r" b="b"/>
            <a:pathLst>
              <a:path w="480695" h="121920">
                <a:moveTo>
                  <a:pt x="480112" y="0"/>
                </a:moveTo>
                <a:lnTo>
                  <a:pt x="29887" y="0"/>
                </a:lnTo>
                <a:lnTo>
                  <a:pt x="0" y="121340"/>
                </a:lnTo>
                <a:lnTo>
                  <a:pt x="450224" y="121340"/>
                </a:lnTo>
                <a:lnTo>
                  <a:pt x="48011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3" name="object 473"/>
          <p:cNvSpPr/>
          <p:nvPr/>
        </p:nvSpPr>
        <p:spPr>
          <a:xfrm>
            <a:off x="11156874" y="7126223"/>
            <a:ext cx="480695" cy="121920"/>
          </a:xfrm>
          <a:custGeom>
            <a:avLst/>
            <a:gdLst/>
            <a:ahLst/>
            <a:cxnLst/>
            <a:rect l="l" t="t" r="r" b="b"/>
            <a:pathLst>
              <a:path w="480695" h="121920">
                <a:moveTo>
                  <a:pt x="0" y="121340"/>
                </a:moveTo>
                <a:lnTo>
                  <a:pt x="450224" y="121340"/>
                </a:lnTo>
                <a:lnTo>
                  <a:pt x="480112" y="0"/>
                </a:lnTo>
                <a:lnTo>
                  <a:pt x="29887" y="0"/>
                </a:lnTo>
                <a:lnTo>
                  <a:pt x="0" y="12134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4" name="object 474"/>
          <p:cNvSpPr txBox="1"/>
          <p:nvPr/>
        </p:nvSpPr>
        <p:spPr>
          <a:xfrm>
            <a:off x="10037846" y="7062272"/>
            <a:ext cx="1753235" cy="454025"/>
          </a:xfrm>
          <a:prstGeom prst="rect">
            <a:avLst/>
          </a:prstGeom>
          <a:ln w="6580">
            <a:solidFill>
              <a:srgbClr val="231F2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endParaRPr sz="300">
              <a:latin typeface="Times New Roman"/>
              <a:cs typeface="Times New Roman"/>
            </a:endParaRPr>
          </a:p>
          <a:p>
            <a:pPr marL="1303020" marR="165735" indent="-160655">
              <a:lnSpc>
                <a:spcPct val="113599"/>
              </a:lnSpc>
              <a:spcBef>
                <a:spcPts val="254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2 </a:t>
            </a:r>
            <a:r>
              <a:rPr sz="300" spc="20" dirty="0">
                <a:solidFill>
                  <a:srgbClr val="231F20"/>
                </a:solidFill>
                <a:latin typeface="Consolas"/>
                <a:cs typeface="Consolas"/>
              </a:rPr>
              <a:t>–</a:t>
            </a:r>
            <a:r>
              <a:rPr sz="300" spc="-6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 Date1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475" name="object 475"/>
          <p:cNvSpPr/>
          <p:nvPr/>
        </p:nvSpPr>
        <p:spPr>
          <a:xfrm>
            <a:off x="10652601" y="7186117"/>
            <a:ext cx="492125" cy="0"/>
          </a:xfrm>
          <a:custGeom>
            <a:avLst/>
            <a:gdLst/>
            <a:ahLst/>
            <a:cxnLst/>
            <a:rect l="l" t="t" r="r" b="b"/>
            <a:pathLst>
              <a:path w="492125">
                <a:moveTo>
                  <a:pt x="0" y="0"/>
                </a:moveTo>
                <a:lnTo>
                  <a:pt x="492103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6" name="object 476"/>
          <p:cNvSpPr/>
          <p:nvPr/>
        </p:nvSpPr>
        <p:spPr>
          <a:xfrm>
            <a:off x="11141602" y="7170846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7" name="object 477"/>
          <p:cNvSpPr/>
          <p:nvPr/>
        </p:nvSpPr>
        <p:spPr>
          <a:xfrm>
            <a:off x="10654749" y="7186117"/>
            <a:ext cx="60960" cy="212090"/>
          </a:xfrm>
          <a:custGeom>
            <a:avLst/>
            <a:gdLst/>
            <a:ahLst/>
            <a:cxnLst/>
            <a:rect l="l" t="t" r="r" b="b"/>
            <a:pathLst>
              <a:path w="60959" h="212090">
                <a:moveTo>
                  <a:pt x="0" y="211838"/>
                </a:moveTo>
                <a:lnTo>
                  <a:pt x="60729" y="211838"/>
                </a:lnTo>
                <a:lnTo>
                  <a:pt x="6072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8" name="object 478"/>
          <p:cNvSpPr/>
          <p:nvPr/>
        </p:nvSpPr>
        <p:spPr>
          <a:xfrm>
            <a:off x="11394365" y="7247563"/>
            <a:ext cx="0" cy="100965"/>
          </a:xfrm>
          <a:custGeom>
            <a:avLst/>
            <a:gdLst/>
            <a:ahLst/>
            <a:cxnLst/>
            <a:rect l="l" t="t" r="r" b="b"/>
            <a:pathLst>
              <a:path h="100965">
                <a:moveTo>
                  <a:pt x="0" y="0"/>
                </a:moveTo>
                <a:lnTo>
                  <a:pt x="0" y="10040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79" name="object 479"/>
          <p:cNvSpPr/>
          <p:nvPr/>
        </p:nvSpPr>
        <p:spPr>
          <a:xfrm>
            <a:off x="11379093" y="7344922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0"/>
                </a:moveTo>
                <a:lnTo>
                  <a:pt x="0" y="0"/>
                </a:lnTo>
                <a:lnTo>
                  <a:pt x="15271" y="15271"/>
                </a:lnTo>
                <a:lnTo>
                  <a:pt x="30484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0" name="object 480"/>
          <p:cNvSpPr/>
          <p:nvPr/>
        </p:nvSpPr>
        <p:spPr>
          <a:xfrm>
            <a:off x="10037846" y="6937769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1" name="object 481"/>
          <p:cNvSpPr txBox="1"/>
          <p:nvPr/>
        </p:nvSpPr>
        <p:spPr>
          <a:xfrm>
            <a:off x="10038370" y="6938295"/>
            <a:ext cx="782320" cy="120650"/>
          </a:xfrm>
          <a:prstGeom prst="rect">
            <a:avLst/>
          </a:prstGeom>
          <a:solidFill>
            <a:srgbClr val="E97124"/>
          </a:solidFill>
        </p:spPr>
        <p:txBody>
          <a:bodyPr vert="horz" wrap="square" lIns="0" tIns="0" rIns="0" bIns="0" rtlCol="0">
            <a:spAutoFit/>
          </a:bodyPr>
          <a:lstStyle/>
          <a:p>
            <a:pPr>
              <a:lnSpc>
                <a:spcPct val="100000"/>
              </a:lnSpc>
            </a:pPr>
            <a:endParaRPr sz="250">
              <a:latin typeface="Times New Roman"/>
              <a:cs typeface="Times New Roman"/>
            </a:endParaRPr>
          </a:p>
          <a:p>
            <a:pPr marL="187960">
              <a:lnSpc>
                <a:spcPct val="100000"/>
              </a:lnSpc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 Value</a:t>
            </a:r>
            <a:r>
              <a:rPr sz="300" spc="-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at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482" name="object 482"/>
          <p:cNvSpPr/>
          <p:nvPr/>
        </p:nvSpPr>
        <p:spPr>
          <a:xfrm>
            <a:off x="10635003" y="7920126"/>
            <a:ext cx="2237740" cy="1419225"/>
          </a:xfrm>
          <a:custGeom>
            <a:avLst/>
            <a:gdLst/>
            <a:ahLst/>
            <a:cxnLst/>
            <a:rect l="l" t="t" r="r" b="b"/>
            <a:pathLst>
              <a:path w="2237740" h="1419225">
                <a:moveTo>
                  <a:pt x="0" y="148603"/>
                </a:moveTo>
                <a:lnTo>
                  <a:pt x="172644" y="148901"/>
                </a:lnTo>
                <a:lnTo>
                  <a:pt x="172167" y="0"/>
                </a:lnTo>
                <a:lnTo>
                  <a:pt x="2237520" y="0"/>
                </a:lnTo>
                <a:lnTo>
                  <a:pt x="2237520" y="1419039"/>
                </a:lnTo>
                <a:lnTo>
                  <a:pt x="2156507" y="141909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3" name="object 483"/>
          <p:cNvSpPr/>
          <p:nvPr/>
        </p:nvSpPr>
        <p:spPr>
          <a:xfrm>
            <a:off x="12779281" y="932395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4" name="object 484"/>
          <p:cNvSpPr/>
          <p:nvPr/>
        </p:nvSpPr>
        <p:spPr>
          <a:xfrm>
            <a:off x="10048405" y="7932952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5" name="object 485"/>
          <p:cNvSpPr/>
          <p:nvPr/>
        </p:nvSpPr>
        <p:spPr>
          <a:xfrm>
            <a:off x="10050552" y="8144791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6" name="object 486"/>
          <p:cNvSpPr/>
          <p:nvPr/>
        </p:nvSpPr>
        <p:spPr>
          <a:xfrm>
            <a:off x="10275038" y="8069028"/>
            <a:ext cx="533400" cy="163195"/>
          </a:xfrm>
          <a:custGeom>
            <a:avLst/>
            <a:gdLst/>
            <a:ahLst/>
            <a:cxnLst/>
            <a:rect l="l" t="t" r="r" b="b"/>
            <a:pathLst>
              <a:path w="533400" h="163195">
                <a:moveTo>
                  <a:pt x="0" y="162801"/>
                </a:moveTo>
                <a:lnTo>
                  <a:pt x="532788" y="159520"/>
                </a:lnTo>
                <a:lnTo>
                  <a:pt x="532609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7" name="object 487"/>
          <p:cNvSpPr/>
          <p:nvPr/>
        </p:nvSpPr>
        <p:spPr>
          <a:xfrm>
            <a:off x="10307670" y="7932952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8" name="object 488"/>
          <p:cNvSpPr/>
          <p:nvPr/>
        </p:nvSpPr>
        <p:spPr>
          <a:xfrm>
            <a:off x="10307670" y="7932952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89" name="object 489"/>
          <p:cNvSpPr/>
          <p:nvPr/>
        </p:nvSpPr>
        <p:spPr>
          <a:xfrm>
            <a:off x="10308386" y="814479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0" name="object 490"/>
          <p:cNvSpPr/>
          <p:nvPr/>
        </p:nvSpPr>
        <p:spPr>
          <a:xfrm>
            <a:off x="10308386" y="8144791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1" name="object 491"/>
          <p:cNvSpPr/>
          <p:nvPr/>
        </p:nvSpPr>
        <p:spPr>
          <a:xfrm>
            <a:off x="11735896" y="7983480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2" name="object 492"/>
          <p:cNvSpPr/>
          <p:nvPr/>
        </p:nvSpPr>
        <p:spPr>
          <a:xfrm>
            <a:off x="11735896" y="7983480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3" name="object 493"/>
          <p:cNvSpPr/>
          <p:nvPr/>
        </p:nvSpPr>
        <p:spPr>
          <a:xfrm>
            <a:off x="12257051" y="7983480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4" name="object 494"/>
          <p:cNvSpPr/>
          <p:nvPr/>
        </p:nvSpPr>
        <p:spPr>
          <a:xfrm>
            <a:off x="12257051" y="7983480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5" name="object 495"/>
          <p:cNvSpPr/>
          <p:nvPr/>
        </p:nvSpPr>
        <p:spPr>
          <a:xfrm>
            <a:off x="11735896" y="7980439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6" name="object 496"/>
          <p:cNvSpPr/>
          <p:nvPr/>
        </p:nvSpPr>
        <p:spPr>
          <a:xfrm>
            <a:off x="11735896" y="839570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7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7" name="object 497"/>
          <p:cNvSpPr/>
          <p:nvPr/>
        </p:nvSpPr>
        <p:spPr>
          <a:xfrm>
            <a:off x="11735896" y="839570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8" name="object 498"/>
          <p:cNvSpPr/>
          <p:nvPr/>
        </p:nvSpPr>
        <p:spPr>
          <a:xfrm>
            <a:off x="12257051" y="839570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7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99" name="object 499"/>
          <p:cNvSpPr/>
          <p:nvPr/>
        </p:nvSpPr>
        <p:spPr>
          <a:xfrm>
            <a:off x="12257051" y="839570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0" name="object 500"/>
          <p:cNvSpPr/>
          <p:nvPr/>
        </p:nvSpPr>
        <p:spPr>
          <a:xfrm>
            <a:off x="11735896" y="8392662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1" name="object 501"/>
          <p:cNvSpPr/>
          <p:nvPr/>
        </p:nvSpPr>
        <p:spPr>
          <a:xfrm>
            <a:off x="11735896" y="880297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2" name="object 502"/>
          <p:cNvSpPr/>
          <p:nvPr/>
        </p:nvSpPr>
        <p:spPr>
          <a:xfrm>
            <a:off x="11735896" y="880297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3" name="object 503"/>
          <p:cNvSpPr/>
          <p:nvPr/>
        </p:nvSpPr>
        <p:spPr>
          <a:xfrm>
            <a:off x="12257051" y="880297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4" name="object 504"/>
          <p:cNvSpPr/>
          <p:nvPr/>
        </p:nvSpPr>
        <p:spPr>
          <a:xfrm>
            <a:off x="12257051" y="880297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5" name="object 505"/>
          <p:cNvSpPr/>
          <p:nvPr/>
        </p:nvSpPr>
        <p:spPr>
          <a:xfrm>
            <a:off x="11735896" y="8799874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6" name="object 506"/>
          <p:cNvSpPr/>
          <p:nvPr/>
        </p:nvSpPr>
        <p:spPr>
          <a:xfrm>
            <a:off x="11735896" y="920392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7" name="object 507"/>
          <p:cNvSpPr/>
          <p:nvPr/>
        </p:nvSpPr>
        <p:spPr>
          <a:xfrm>
            <a:off x="11735896" y="920392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8" name="object 508"/>
          <p:cNvSpPr/>
          <p:nvPr/>
        </p:nvSpPr>
        <p:spPr>
          <a:xfrm>
            <a:off x="12257051" y="920392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09" name="object 509"/>
          <p:cNvSpPr/>
          <p:nvPr/>
        </p:nvSpPr>
        <p:spPr>
          <a:xfrm>
            <a:off x="12257051" y="920392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0" name="object 510"/>
          <p:cNvSpPr/>
          <p:nvPr/>
        </p:nvSpPr>
        <p:spPr>
          <a:xfrm>
            <a:off x="11735896" y="9200883"/>
            <a:ext cx="1043940" cy="276860"/>
          </a:xfrm>
          <a:custGeom>
            <a:avLst/>
            <a:gdLst/>
            <a:ahLst/>
            <a:cxnLst/>
            <a:rect l="l" t="t" r="r" b="b"/>
            <a:pathLst>
              <a:path w="1043940" h="276859">
                <a:moveTo>
                  <a:pt x="0" y="0"/>
                </a:moveTo>
                <a:lnTo>
                  <a:pt x="0" y="276684"/>
                </a:lnTo>
                <a:lnTo>
                  <a:pt x="1043384" y="276684"/>
                </a:lnTo>
                <a:lnTo>
                  <a:pt x="104338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1" name="object 511"/>
          <p:cNvSpPr/>
          <p:nvPr/>
        </p:nvSpPr>
        <p:spPr>
          <a:xfrm>
            <a:off x="11077949" y="8054531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2" name="object 512"/>
          <p:cNvSpPr/>
          <p:nvPr/>
        </p:nvSpPr>
        <p:spPr>
          <a:xfrm>
            <a:off x="11077949" y="8466695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3" name="object 513"/>
          <p:cNvSpPr/>
          <p:nvPr/>
        </p:nvSpPr>
        <p:spPr>
          <a:xfrm>
            <a:off x="11077949" y="8873967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4" name="object 514"/>
          <p:cNvSpPr/>
          <p:nvPr/>
        </p:nvSpPr>
        <p:spPr>
          <a:xfrm>
            <a:off x="11077950" y="9274976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5" name="object 515"/>
          <p:cNvSpPr/>
          <p:nvPr/>
        </p:nvSpPr>
        <p:spPr>
          <a:xfrm>
            <a:off x="11077949" y="9274975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6" name="object 516"/>
          <p:cNvSpPr/>
          <p:nvPr/>
        </p:nvSpPr>
        <p:spPr>
          <a:xfrm>
            <a:off x="11607695" y="8117289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70" h="1904">
                <a:moveTo>
                  <a:pt x="128200" y="155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7" name="object 517"/>
          <p:cNvSpPr/>
          <p:nvPr/>
        </p:nvSpPr>
        <p:spPr>
          <a:xfrm>
            <a:off x="11598031" y="8105239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31"/>
                </a:lnTo>
                <a:lnTo>
                  <a:pt x="11931" y="2422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8" name="object 518"/>
          <p:cNvSpPr/>
          <p:nvPr/>
        </p:nvSpPr>
        <p:spPr>
          <a:xfrm>
            <a:off x="11607695" y="8529334"/>
            <a:ext cx="128270" cy="0"/>
          </a:xfrm>
          <a:custGeom>
            <a:avLst/>
            <a:gdLst/>
            <a:ahLst/>
            <a:cxnLst/>
            <a:rect l="l" t="t" r="r" b="b"/>
            <a:pathLst>
              <a:path w="128270">
                <a:moveTo>
                  <a:pt x="12820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19" name="object 519"/>
          <p:cNvSpPr/>
          <p:nvPr/>
        </p:nvSpPr>
        <p:spPr>
          <a:xfrm>
            <a:off x="11598031" y="8517224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0" name="object 520"/>
          <p:cNvSpPr/>
          <p:nvPr/>
        </p:nvSpPr>
        <p:spPr>
          <a:xfrm>
            <a:off x="11607695" y="8936606"/>
            <a:ext cx="128270" cy="0"/>
          </a:xfrm>
          <a:custGeom>
            <a:avLst/>
            <a:gdLst/>
            <a:ahLst/>
            <a:cxnLst/>
            <a:rect l="l" t="t" r="r" b="b"/>
            <a:pathLst>
              <a:path w="128270">
                <a:moveTo>
                  <a:pt x="12820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1" name="object 521"/>
          <p:cNvSpPr/>
          <p:nvPr/>
        </p:nvSpPr>
        <p:spPr>
          <a:xfrm>
            <a:off x="11598031" y="8924496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2" name="object 522"/>
          <p:cNvSpPr/>
          <p:nvPr/>
        </p:nvSpPr>
        <p:spPr>
          <a:xfrm>
            <a:off x="11607695" y="9337733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70" h="1904">
                <a:moveTo>
                  <a:pt x="128200" y="149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3" name="object 523"/>
          <p:cNvSpPr/>
          <p:nvPr/>
        </p:nvSpPr>
        <p:spPr>
          <a:xfrm>
            <a:off x="11598031" y="9325683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31"/>
                </a:lnTo>
                <a:lnTo>
                  <a:pt x="11931" y="2416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4" name="object 524"/>
          <p:cNvSpPr/>
          <p:nvPr/>
        </p:nvSpPr>
        <p:spPr>
          <a:xfrm>
            <a:off x="12788945" y="8938157"/>
            <a:ext cx="83820" cy="635"/>
          </a:xfrm>
          <a:custGeom>
            <a:avLst/>
            <a:gdLst/>
            <a:ahLst/>
            <a:cxnLst/>
            <a:rect l="l" t="t" r="r" b="b"/>
            <a:pathLst>
              <a:path w="83820" h="634">
                <a:moveTo>
                  <a:pt x="83578" y="0"/>
                </a:moveTo>
                <a:lnTo>
                  <a:pt x="0" y="59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5" name="object 525"/>
          <p:cNvSpPr/>
          <p:nvPr/>
        </p:nvSpPr>
        <p:spPr>
          <a:xfrm>
            <a:off x="12779281" y="8926107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6" name="object 526"/>
          <p:cNvSpPr/>
          <p:nvPr/>
        </p:nvSpPr>
        <p:spPr>
          <a:xfrm>
            <a:off x="12788945" y="8531004"/>
            <a:ext cx="83820" cy="635"/>
          </a:xfrm>
          <a:custGeom>
            <a:avLst/>
            <a:gdLst/>
            <a:ahLst/>
            <a:cxnLst/>
            <a:rect l="l" t="t" r="r" b="b"/>
            <a:pathLst>
              <a:path w="83820" h="634">
                <a:moveTo>
                  <a:pt x="83578" y="29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7" name="object 527"/>
          <p:cNvSpPr/>
          <p:nvPr/>
        </p:nvSpPr>
        <p:spPr>
          <a:xfrm>
            <a:off x="12779281" y="8518894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8" name="object 528"/>
          <p:cNvSpPr/>
          <p:nvPr/>
        </p:nvSpPr>
        <p:spPr>
          <a:xfrm>
            <a:off x="12788945" y="8118840"/>
            <a:ext cx="83820" cy="635"/>
          </a:xfrm>
          <a:custGeom>
            <a:avLst/>
            <a:gdLst/>
            <a:ahLst/>
            <a:cxnLst/>
            <a:rect l="l" t="t" r="r" b="b"/>
            <a:pathLst>
              <a:path w="83820" h="634">
                <a:moveTo>
                  <a:pt x="83578" y="29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29" name="object 529"/>
          <p:cNvSpPr/>
          <p:nvPr/>
        </p:nvSpPr>
        <p:spPr>
          <a:xfrm>
            <a:off x="12779281" y="8106730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0" name="object 530"/>
          <p:cNvSpPr/>
          <p:nvPr/>
        </p:nvSpPr>
        <p:spPr>
          <a:xfrm>
            <a:off x="10801980" y="8116335"/>
            <a:ext cx="276225" cy="1221740"/>
          </a:xfrm>
          <a:custGeom>
            <a:avLst/>
            <a:gdLst/>
            <a:ahLst/>
            <a:cxnLst/>
            <a:rect l="l" t="t" r="r" b="b"/>
            <a:pathLst>
              <a:path w="276225" h="1221740">
                <a:moveTo>
                  <a:pt x="275969" y="835"/>
                </a:moveTo>
                <a:lnTo>
                  <a:pt x="149557" y="0"/>
                </a:lnTo>
                <a:lnTo>
                  <a:pt x="149438" y="1221338"/>
                </a:lnTo>
                <a:lnTo>
                  <a:pt x="0" y="1221338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1" name="object 531"/>
          <p:cNvSpPr/>
          <p:nvPr/>
        </p:nvSpPr>
        <p:spPr>
          <a:xfrm>
            <a:off x="10792256" y="9325564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2" name="object 532"/>
          <p:cNvSpPr/>
          <p:nvPr/>
        </p:nvSpPr>
        <p:spPr>
          <a:xfrm>
            <a:off x="10951478" y="8936606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3" name="object 533"/>
          <p:cNvSpPr/>
          <p:nvPr/>
        </p:nvSpPr>
        <p:spPr>
          <a:xfrm>
            <a:off x="10951478" y="8529334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4" name="object 534"/>
          <p:cNvSpPr/>
          <p:nvPr/>
        </p:nvSpPr>
        <p:spPr>
          <a:xfrm>
            <a:off x="10951419" y="9337614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53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5" name="object 535"/>
          <p:cNvSpPr/>
          <p:nvPr/>
        </p:nvSpPr>
        <p:spPr>
          <a:xfrm>
            <a:off x="10192176" y="9274976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36" name="object 536"/>
          <p:cNvSpPr/>
          <p:nvPr/>
        </p:nvSpPr>
        <p:spPr>
          <a:xfrm>
            <a:off x="10192176" y="9274975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537" name="object 537"/>
          <p:cNvGraphicFramePr>
            <a:graphicFrameLocks noGrp="1"/>
          </p:cNvGraphicFramePr>
          <p:nvPr/>
        </p:nvGraphicFramePr>
        <p:xfrm>
          <a:off x="10028649" y="7770461"/>
          <a:ext cx="2894964" cy="1771843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222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607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4993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5565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0642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24323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L="140335">
                        <a:lnSpc>
                          <a:spcPct val="1000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Diagnosis Proposition:</a:t>
                      </a:r>
                      <a:r>
                        <a:rPr sz="300" spc="-10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alibri"/>
                          <a:cs typeface="Calibri"/>
                        </a:rPr>
                        <a:t>Stage</a:t>
                      </a:r>
                      <a:endParaRPr sz="300">
                        <a:latin typeface="Calibri"/>
                        <a:cs typeface="Calibri"/>
                      </a:endParaRPr>
                    </a:p>
                  </a:txBody>
                  <a:tcPr marL="0" marR="0" marT="635" marB="0">
                    <a:lnL w="3175">
                      <a:solidFill>
                        <a:srgbClr val="231F20"/>
                      </a:solidFill>
                      <a:prstDash val="solid"/>
                    </a:lnL>
                    <a:lnR w="3175">
                      <a:solidFill>
                        <a:srgbClr val="231F20"/>
                      </a:solidFill>
                      <a:prstDash val="solid"/>
                    </a:lnR>
                    <a:lnT w="3175">
                      <a:solidFill>
                        <a:srgbClr val="231F20"/>
                      </a:solidFill>
                      <a:prstDash val="solid"/>
                    </a:lnT>
                    <a:lnB w="9525">
                      <a:solidFill>
                        <a:srgbClr val="231F20"/>
                      </a:solidFill>
                      <a:prstDash val="solid"/>
                    </a:lnB>
                    <a:solidFill>
                      <a:srgbClr val="E97124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317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4996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83820" marR="26034" indent="-11430">
                        <a:lnSpc>
                          <a:spcPct val="1095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 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239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86360" marR="12700" indent="-23495">
                        <a:lnSpc>
                          <a:spcPct val="109300"/>
                        </a:lnSpc>
                      </a:pP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 marL="74930">
                        <a:lnSpc>
                          <a:spcPct val="100000"/>
                        </a:lnSpc>
                        <a:spcBef>
                          <a:spcPts val="3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2540" marB="0">
                    <a:lnL w="9525">
                      <a:solidFill>
                        <a:srgbClr val="231F20"/>
                      </a:solidFill>
                      <a:prstDash val="solid"/>
                    </a:lnL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25730" marR="128270" indent="635" algn="ctr">
                        <a:lnSpc>
                          <a:spcPct val="111500"/>
                        </a:lnSpc>
                        <a:spcBef>
                          <a:spcPts val="5"/>
                        </a:spcBef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  (Hours)</a:t>
                      </a:r>
                      <a:r>
                        <a:rPr sz="300" spc="-8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First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300" spc="-3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400">
                        <a:latin typeface="Times New Roman"/>
                        <a:cs typeface="Times New Roman"/>
                      </a:endParaRPr>
                    </a:p>
                    <a:p>
                      <a:pPr marL="114935" marR="116205" algn="ctr">
                        <a:lnSpc>
                          <a:spcPct val="111500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  (Hours)</a:t>
                      </a:r>
                      <a:r>
                        <a:rPr sz="300" spc="-8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Second </a:t>
                      </a:r>
                      <a:r>
                        <a:rPr sz="3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3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83515" algn="r">
                        <a:lnSpc>
                          <a:spcPct val="100000"/>
                        </a:lnSpc>
                        <a:spcBef>
                          <a:spcPts val="180"/>
                        </a:spcBef>
                      </a:pP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5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200025" marR="83820" indent="86360">
                        <a:lnSpc>
                          <a:spcPct val="110500"/>
                        </a:lnSpc>
                        <a:spcBef>
                          <a:spcPts val="195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</a:t>
                      </a:r>
                      <a:r>
                        <a:rPr sz="250" spc="-7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o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 marL="344805"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150">
                        <a:latin typeface="Times New Roman"/>
                        <a:cs typeface="Times New Roman"/>
                      </a:endParaRPr>
                    </a:p>
                    <a:p>
                      <a:pPr marL="81280" marR="287020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83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15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T w="9525">
                      <a:solidFill>
                        <a:srgbClr val="231F20"/>
                      </a:solidFill>
                      <a:prstDash val="soli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46382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83515" algn="r">
                        <a:lnSpc>
                          <a:spcPct val="100000"/>
                        </a:lnSpc>
                        <a:spcBef>
                          <a:spcPts val="215"/>
                        </a:spcBef>
                      </a:pP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4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90500" marR="73660" algn="ctr">
                        <a:lnSpc>
                          <a:spcPct val="110800"/>
                        </a:lnSpc>
                        <a:spcBef>
                          <a:spcPts val="229"/>
                        </a:spcBef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7020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83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3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415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R="183515" algn="r">
                        <a:lnSpc>
                          <a:spcPct val="100000"/>
                        </a:lnSpc>
                      </a:pP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3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90500" marR="73660" algn="ctr">
                        <a:lnSpc>
                          <a:spcPct val="1109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 Date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</a:t>
                      </a:r>
                      <a:r>
                        <a:rPr sz="250" spc="-4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ate1 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eat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than or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Equal to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5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Days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50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7020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83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01984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231F20"/>
                      </a:solidFill>
                      <a:prstDash val="solid"/>
                    </a:lnL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15"/>
                        </a:spcBef>
                      </a:pPr>
                      <a:endParaRPr sz="350">
                        <a:latin typeface="Times New Roman"/>
                        <a:cs typeface="Times New Roman"/>
                      </a:endParaRPr>
                    </a:p>
                    <a:p>
                      <a:pPr marL="99695" marR="121920" indent="-80645">
                        <a:lnSpc>
                          <a:spcPct val="113799"/>
                        </a:lnSpc>
                      </a:pP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Criteria</a:t>
                      </a:r>
                      <a:r>
                        <a:rPr sz="300" spc="-5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30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Diagnosis  </a:t>
                      </a:r>
                      <a:r>
                        <a:rPr sz="30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Proposition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40"/>
                        </a:spcBef>
                      </a:pPr>
                      <a:endParaRPr sz="250">
                        <a:latin typeface="Times New Roman"/>
                        <a:cs typeface="Times New Roman"/>
                      </a:endParaRPr>
                    </a:p>
                    <a:p>
                      <a:pPr marR="183515" algn="r">
                        <a:lnSpc>
                          <a:spcPct val="100000"/>
                        </a:lnSpc>
                      </a:pPr>
                      <a:r>
                        <a:rPr sz="30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2'</a:t>
                      </a:r>
                      <a:endParaRPr sz="3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30"/>
                        </a:spcBef>
                      </a:pPr>
                      <a:endParaRPr sz="300">
                        <a:latin typeface="Times New Roman"/>
                        <a:cs typeface="Times New Roman"/>
                      </a:endParaRPr>
                    </a:p>
                    <a:p>
                      <a:pPr marL="109220" algn="ctr">
                        <a:lnSpc>
                          <a:spcPct val="100000"/>
                        </a:lnSpc>
                      </a:pP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RMITTLUNG2 </a:t>
                      </a:r>
                      <a:r>
                        <a:rPr sz="250" spc="1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–</a:t>
                      </a:r>
                      <a:r>
                        <a:rPr sz="25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RMITTLUNG1</a:t>
                      </a:r>
                      <a:endParaRPr sz="250">
                        <a:latin typeface="Consolas"/>
                        <a:cs typeface="Consolas"/>
                      </a:endParaRPr>
                    </a:p>
                    <a:p>
                      <a:pPr marL="248285" marR="130810" algn="ctr">
                        <a:lnSpc>
                          <a:spcPct val="111000"/>
                        </a:lnSpc>
                      </a:pP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rösser </a:t>
                      </a:r>
                      <a:r>
                        <a:rPr sz="250" spc="1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oder</a:t>
                      </a:r>
                      <a:r>
                        <a:rPr sz="250" spc="-6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gleich 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90'</a:t>
                      </a:r>
                      <a:r>
                        <a:rPr sz="250" spc="-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50" spc="1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Tage</a:t>
                      </a:r>
                      <a:endParaRPr sz="25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endParaRPr sz="200">
                        <a:latin typeface="Times New Roman"/>
                        <a:cs typeface="Times New Roman"/>
                      </a:endParaRPr>
                    </a:p>
                    <a:p>
                      <a:pPr marL="81280" marR="287020" algn="ctr">
                        <a:lnSpc>
                          <a:spcPct val="100000"/>
                        </a:lnSpc>
                      </a:pPr>
                      <a:r>
                        <a:rPr sz="200" spc="-5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Highest</a:t>
                      </a:r>
                      <a:r>
                        <a:rPr sz="200" spc="-5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measured  </a:t>
                      </a:r>
                      <a:r>
                        <a:rPr sz="20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eGFR</a:t>
                      </a:r>
                      <a:r>
                        <a:rPr sz="200" spc="-20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spc="-5" dirty="0">
                          <a:solidFill>
                            <a:srgbClr val="231F20"/>
                          </a:solidFill>
                          <a:latin typeface="Consolas"/>
                          <a:cs typeface="Consolas"/>
                        </a:rPr>
                        <a:t>Value1</a:t>
                      </a:r>
                      <a:endParaRPr sz="200">
                        <a:latin typeface="Consolas"/>
                        <a:cs typeface="Consolas"/>
                      </a:endParaRPr>
                    </a:p>
                    <a:p>
                      <a:pPr marR="203835" algn="ctr">
                        <a:lnSpc>
                          <a:spcPct val="100000"/>
                        </a:lnSpc>
                        <a:spcBef>
                          <a:spcPts val="20"/>
                        </a:spcBef>
                      </a:pPr>
                      <a:r>
                        <a:rPr sz="20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&lt;</a:t>
                      </a:r>
                      <a:r>
                        <a:rPr sz="200" spc="-10" dirty="0">
                          <a:solidFill>
                            <a:srgbClr val="949698"/>
                          </a:solidFill>
                          <a:latin typeface="Consolas"/>
                          <a:cs typeface="Consolas"/>
                        </a:rPr>
                        <a:t> </a:t>
                      </a:r>
                      <a:r>
                        <a:rPr sz="200" dirty="0">
                          <a:solidFill>
                            <a:srgbClr val="ED1F24"/>
                          </a:solidFill>
                          <a:latin typeface="Consolas"/>
                          <a:cs typeface="Consolas"/>
                        </a:rPr>
                        <a:t>'60'</a:t>
                      </a:r>
                      <a:endParaRPr sz="200">
                        <a:latin typeface="Consolas"/>
                        <a:cs typeface="Consolas"/>
                      </a:endParaRPr>
                    </a:p>
                  </a:txBody>
                  <a:tcPr marL="0" marR="0" marT="0" marB="0">
                    <a:lnR w="9525">
                      <a:solidFill>
                        <a:srgbClr val="231F20"/>
                      </a:solidFill>
                      <a:prstDash val="solid"/>
                    </a:lnR>
                    <a:lnB w="9525">
                      <a:solidFill>
                        <a:srgbClr val="231F2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38" name="object 538"/>
          <p:cNvSpPr txBox="1"/>
          <p:nvPr/>
        </p:nvSpPr>
        <p:spPr>
          <a:xfrm>
            <a:off x="10037846" y="6473287"/>
            <a:ext cx="124396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48894" rIns="0" bIns="0" rtlCol="0">
            <a:spAutoFit/>
          </a:bodyPr>
          <a:lstStyle/>
          <a:p>
            <a:pPr marL="437515" marR="208279" indent="-219710">
              <a:lnSpc>
                <a:spcPts val="580"/>
              </a:lnSpc>
              <a:spcBef>
                <a:spcPts val="384"/>
              </a:spcBef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Algorithm: N18 Diagnosis  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Proposi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539" name="object 539"/>
          <p:cNvSpPr/>
          <p:nvPr/>
        </p:nvSpPr>
        <p:spPr>
          <a:xfrm>
            <a:off x="9635345" y="343082"/>
            <a:ext cx="6596380" cy="5844540"/>
          </a:xfrm>
          <a:custGeom>
            <a:avLst/>
            <a:gdLst/>
            <a:ahLst/>
            <a:cxnLst/>
            <a:rect l="l" t="t" r="r" b="b"/>
            <a:pathLst>
              <a:path w="6596380" h="5844540">
                <a:moveTo>
                  <a:pt x="0" y="5844154"/>
                </a:moveTo>
                <a:lnTo>
                  <a:pt x="6596119" y="5844154"/>
                </a:lnTo>
                <a:lnTo>
                  <a:pt x="6596119" y="0"/>
                </a:lnTo>
                <a:lnTo>
                  <a:pt x="0" y="0"/>
                </a:lnTo>
                <a:lnTo>
                  <a:pt x="0" y="5844154"/>
                </a:lnTo>
                <a:close/>
              </a:path>
            </a:pathLst>
          </a:custGeom>
          <a:ln w="17544">
            <a:solidFill>
              <a:srgbClr val="231F20"/>
            </a:solidFill>
            <a:prstDash val="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0" name="object 540"/>
          <p:cNvSpPr/>
          <p:nvPr/>
        </p:nvSpPr>
        <p:spPr>
          <a:xfrm>
            <a:off x="9946213" y="6311619"/>
            <a:ext cx="6099175" cy="4039870"/>
          </a:xfrm>
          <a:custGeom>
            <a:avLst/>
            <a:gdLst/>
            <a:ahLst/>
            <a:cxnLst/>
            <a:rect l="l" t="t" r="r" b="b"/>
            <a:pathLst>
              <a:path w="6099175" h="4039870">
                <a:moveTo>
                  <a:pt x="0" y="4039438"/>
                </a:moveTo>
                <a:lnTo>
                  <a:pt x="6098701" y="4039438"/>
                </a:lnTo>
                <a:lnTo>
                  <a:pt x="6098701" y="0"/>
                </a:lnTo>
                <a:lnTo>
                  <a:pt x="0" y="0"/>
                </a:lnTo>
                <a:lnTo>
                  <a:pt x="0" y="4039438"/>
                </a:lnTo>
                <a:close/>
              </a:path>
            </a:pathLst>
          </a:custGeom>
          <a:ln w="17544">
            <a:solidFill>
              <a:srgbClr val="231F20"/>
            </a:solidFill>
            <a:prstDash val="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1" name="object 541"/>
          <p:cNvSpPr/>
          <p:nvPr/>
        </p:nvSpPr>
        <p:spPr>
          <a:xfrm>
            <a:off x="14273666" y="10942304"/>
            <a:ext cx="1475105" cy="1499870"/>
          </a:xfrm>
          <a:custGeom>
            <a:avLst/>
            <a:gdLst/>
            <a:ahLst/>
            <a:cxnLst/>
            <a:rect l="l" t="t" r="r" b="b"/>
            <a:pathLst>
              <a:path w="1475105" h="1499870">
                <a:moveTo>
                  <a:pt x="0" y="0"/>
                </a:moveTo>
                <a:lnTo>
                  <a:pt x="0" y="1499455"/>
                </a:lnTo>
                <a:lnTo>
                  <a:pt x="1474877" y="1499455"/>
                </a:lnTo>
                <a:lnTo>
                  <a:pt x="1474877" y="0"/>
                </a:lnTo>
                <a:lnTo>
                  <a:pt x="0" y="0"/>
                </a:lnTo>
                <a:close/>
              </a:path>
            </a:pathLst>
          </a:custGeom>
          <a:solidFill>
            <a:srgbClr val="C7C8C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2" name="object 542"/>
          <p:cNvSpPr txBox="1"/>
          <p:nvPr/>
        </p:nvSpPr>
        <p:spPr>
          <a:xfrm>
            <a:off x="14280833" y="10945377"/>
            <a:ext cx="509270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X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= (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LAST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to</a:t>
            </a:r>
            <a:r>
              <a:rPr sz="250" spc="-8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FIFTH-LAST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):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543" name="object 543"/>
          <p:cNvSpPr/>
          <p:nvPr/>
        </p:nvSpPr>
        <p:spPr>
          <a:xfrm>
            <a:off x="10163004" y="11215176"/>
            <a:ext cx="2374900" cy="1206500"/>
          </a:xfrm>
          <a:custGeom>
            <a:avLst/>
            <a:gdLst/>
            <a:ahLst/>
            <a:cxnLst/>
            <a:rect l="l" t="t" r="r" b="b"/>
            <a:pathLst>
              <a:path w="2374900" h="1206500">
                <a:moveTo>
                  <a:pt x="0" y="0"/>
                </a:moveTo>
                <a:lnTo>
                  <a:pt x="0" y="1206126"/>
                </a:lnTo>
                <a:lnTo>
                  <a:pt x="2374377" y="1206126"/>
                </a:lnTo>
                <a:lnTo>
                  <a:pt x="2374377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4" name="object 544"/>
          <p:cNvSpPr/>
          <p:nvPr/>
        </p:nvSpPr>
        <p:spPr>
          <a:xfrm>
            <a:off x="10403955" y="11277338"/>
            <a:ext cx="2071370" cy="979169"/>
          </a:xfrm>
          <a:custGeom>
            <a:avLst/>
            <a:gdLst/>
            <a:ahLst/>
            <a:cxnLst/>
            <a:rect l="l" t="t" r="r" b="b"/>
            <a:pathLst>
              <a:path w="2071370" h="979170">
                <a:moveTo>
                  <a:pt x="0" y="62519"/>
                </a:moveTo>
                <a:lnTo>
                  <a:pt x="579081" y="62161"/>
                </a:lnTo>
                <a:lnTo>
                  <a:pt x="579081" y="0"/>
                </a:lnTo>
                <a:lnTo>
                  <a:pt x="2071199" y="0"/>
                </a:lnTo>
                <a:lnTo>
                  <a:pt x="2071199" y="978598"/>
                </a:lnTo>
                <a:lnTo>
                  <a:pt x="1994189" y="979075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5" name="object 545"/>
          <p:cNvSpPr/>
          <p:nvPr/>
        </p:nvSpPr>
        <p:spPr>
          <a:xfrm>
            <a:off x="12385909" y="12241141"/>
            <a:ext cx="15875" cy="30480"/>
          </a:xfrm>
          <a:custGeom>
            <a:avLst/>
            <a:gdLst/>
            <a:ahLst/>
            <a:cxnLst/>
            <a:rect l="l" t="t" r="r" b="b"/>
            <a:pathLst>
              <a:path w="15875" h="30479">
                <a:moveTo>
                  <a:pt x="15391" y="30484"/>
                </a:moveTo>
                <a:lnTo>
                  <a:pt x="15212" y="0"/>
                </a:lnTo>
                <a:lnTo>
                  <a:pt x="0" y="15331"/>
                </a:lnTo>
                <a:lnTo>
                  <a:pt x="15391" y="3048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6" name="object 546"/>
          <p:cNvSpPr/>
          <p:nvPr/>
        </p:nvSpPr>
        <p:spPr>
          <a:xfrm>
            <a:off x="10179409" y="11252819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7" name="object 547"/>
          <p:cNvSpPr txBox="1"/>
          <p:nvPr/>
        </p:nvSpPr>
        <p:spPr>
          <a:xfrm>
            <a:off x="10223261" y="11249487"/>
            <a:ext cx="140970" cy="17716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3495" marR="5080" indent="-11430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rst  eGFR</a:t>
            </a:r>
            <a:endParaRPr sz="300">
              <a:latin typeface="Consolas"/>
              <a:cs typeface="Consolas"/>
            </a:endParaRPr>
          </a:p>
          <a:p>
            <a:pPr marL="12700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48" name="object 548"/>
          <p:cNvSpPr/>
          <p:nvPr/>
        </p:nvSpPr>
        <p:spPr>
          <a:xfrm>
            <a:off x="10181617" y="11464658"/>
            <a:ext cx="224790" cy="174625"/>
          </a:xfrm>
          <a:custGeom>
            <a:avLst/>
            <a:gdLst/>
            <a:ahLst/>
            <a:cxnLst/>
            <a:rect l="l" t="t" r="r" b="b"/>
            <a:pathLst>
              <a:path w="224790" h="174625">
                <a:moveTo>
                  <a:pt x="0" y="0"/>
                </a:moveTo>
                <a:lnTo>
                  <a:pt x="0" y="174076"/>
                </a:lnTo>
                <a:lnTo>
                  <a:pt x="224485" y="174076"/>
                </a:lnTo>
                <a:lnTo>
                  <a:pt x="2244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49" name="object 549"/>
          <p:cNvSpPr txBox="1"/>
          <p:nvPr/>
        </p:nvSpPr>
        <p:spPr>
          <a:xfrm>
            <a:off x="10213954" y="11461325"/>
            <a:ext cx="163830" cy="17716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5560" marR="5080" indent="-23495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econd  eGFR</a:t>
            </a:r>
            <a:endParaRPr sz="300">
              <a:latin typeface="Consolas"/>
              <a:cs typeface="Consolas"/>
            </a:endParaRPr>
          </a:p>
          <a:p>
            <a:pPr marL="24130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50" name="object 550"/>
          <p:cNvSpPr/>
          <p:nvPr/>
        </p:nvSpPr>
        <p:spPr>
          <a:xfrm>
            <a:off x="10406102" y="11339500"/>
            <a:ext cx="577215" cy="212725"/>
          </a:xfrm>
          <a:custGeom>
            <a:avLst/>
            <a:gdLst/>
            <a:ahLst/>
            <a:cxnLst/>
            <a:rect l="l" t="t" r="r" b="b"/>
            <a:pathLst>
              <a:path w="577215" h="212725">
                <a:moveTo>
                  <a:pt x="0" y="212196"/>
                </a:moveTo>
                <a:lnTo>
                  <a:pt x="576933" y="211361"/>
                </a:lnTo>
                <a:lnTo>
                  <a:pt x="576933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1" name="object 551"/>
          <p:cNvSpPr/>
          <p:nvPr/>
        </p:nvSpPr>
        <p:spPr>
          <a:xfrm>
            <a:off x="10438734" y="11252820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2" name="object 552"/>
          <p:cNvSpPr/>
          <p:nvPr/>
        </p:nvSpPr>
        <p:spPr>
          <a:xfrm>
            <a:off x="10438734" y="11252819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3" name="object 553"/>
          <p:cNvSpPr txBox="1"/>
          <p:nvPr/>
        </p:nvSpPr>
        <p:spPr>
          <a:xfrm>
            <a:off x="10498754" y="11248174"/>
            <a:ext cx="324485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34290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  (Hours)</a:t>
            </a:r>
            <a:r>
              <a:rPr sz="300" spc="-7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rst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54" name="object 554"/>
          <p:cNvSpPr txBox="1"/>
          <p:nvPr/>
        </p:nvSpPr>
        <p:spPr>
          <a:xfrm>
            <a:off x="10533175" y="11350128"/>
            <a:ext cx="255904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55" name="object 555"/>
          <p:cNvSpPr/>
          <p:nvPr/>
        </p:nvSpPr>
        <p:spPr>
          <a:xfrm>
            <a:off x="10439451" y="11464659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6" name="object 556"/>
          <p:cNvSpPr/>
          <p:nvPr/>
        </p:nvSpPr>
        <p:spPr>
          <a:xfrm>
            <a:off x="10439450" y="11464658"/>
            <a:ext cx="440690" cy="174625"/>
          </a:xfrm>
          <a:custGeom>
            <a:avLst/>
            <a:gdLst/>
            <a:ahLst/>
            <a:cxnLst/>
            <a:rect l="l" t="t" r="r" b="b"/>
            <a:pathLst>
              <a:path w="440690" h="174625">
                <a:moveTo>
                  <a:pt x="0" y="0"/>
                </a:moveTo>
                <a:lnTo>
                  <a:pt x="0" y="174076"/>
                </a:lnTo>
                <a:lnTo>
                  <a:pt x="440202" y="174076"/>
                </a:lnTo>
                <a:lnTo>
                  <a:pt x="44020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57" name="object 557"/>
          <p:cNvSpPr txBox="1"/>
          <p:nvPr/>
        </p:nvSpPr>
        <p:spPr>
          <a:xfrm>
            <a:off x="10488076" y="11460072"/>
            <a:ext cx="347345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indent="45720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  (Hours)</a:t>
            </a:r>
            <a:r>
              <a:rPr sz="300" spc="-7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econ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58" name="object 558"/>
          <p:cNvSpPr txBox="1"/>
          <p:nvPr/>
        </p:nvSpPr>
        <p:spPr>
          <a:xfrm>
            <a:off x="10533951" y="11562026"/>
            <a:ext cx="255904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59" name="object 559"/>
          <p:cNvSpPr/>
          <p:nvPr/>
        </p:nvSpPr>
        <p:spPr>
          <a:xfrm>
            <a:off x="10163004" y="11090794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0" name="object 560"/>
          <p:cNvSpPr/>
          <p:nvPr/>
        </p:nvSpPr>
        <p:spPr>
          <a:xfrm>
            <a:off x="10163004" y="11090793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1" name="object 561"/>
          <p:cNvSpPr txBox="1"/>
          <p:nvPr/>
        </p:nvSpPr>
        <p:spPr>
          <a:xfrm>
            <a:off x="10230957" y="11085373"/>
            <a:ext cx="650875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243204" marR="5080" indent="-231140">
              <a:lnSpc>
                <a:spcPct val="115199"/>
              </a:lnSpc>
              <a:spcBef>
                <a:spcPts val="80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agnosevorschlag: Prognostizierte  Diagnose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562" name="object 562"/>
          <p:cNvSpPr/>
          <p:nvPr/>
        </p:nvSpPr>
        <p:spPr>
          <a:xfrm>
            <a:off x="11865827" y="113034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29"/>
                </a:move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lnTo>
                  <a:pt x="520081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3" name="object 563"/>
          <p:cNvSpPr/>
          <p:nvPr/>
        </p:nvSpPr>
        <p:spPr>
          <a:xfrm>
            <a:off x="11865827" y="11303407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29"/>
                </a:lnTo>
                <a:lnTo>
                  <a:pt x="260040" y="0"/>
                </a:lnTo>
                <a:lnTo>
                  <a:pt x="0" y="13362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4" name="object 564"/>
          <p:cNvSpPr txBox="1"/>
          <p:nvPr/>
        </p:nvSpPr>
        <p:spPr>
          <a:xfrm>
            <a:off x="11999283" y="11376777"/>
            <a:ext cx="255904" cy="1206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065" marR="5080" algn="ctr">
              <a:lnSpc>
                <a:spcPct val="100000"/>
              </a:lnSpc>
              <a:spcBef>
                <a:spcPts val="105"/>
              </a:spcBef>
            </a:pPr>
            <a:r>
              <a:rPr sz="200" spc="-5" dirty="0">
                <a:solidFill>
                  <a:srgbClr val="949698"/>
                </a:solidFill>
                <a:latin typeface="Consolas"/>
                <a:cs typeface="Consolas"/>
              </a:rPr>
              <a:t>Highest</a:t>
            </a:r>
            <a:r>
              <a:rPr sz="200" spc="-50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measured 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2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spc="-5" dirty="0">
                <a:solidFill>
                  <a:srgbClr val="231F20"/>
                </a:solidFill>
                <a:latin typeface="Consolas"/>
                <a:cs typeface="Consolas"/>
              </a:rPr>
              <a:t>Value1</a:t>
            </a:r>
            <a:endParaRPr sz="200">
              <a:latin typeface="Consolas"/>
              <a:cs typeface="Consolas"/>
            </a:endParaRPr>
          </a:p>
          <a:p>
            <a:pPr marL="1270" algn="ctr">
              <a:lnSpc>
                <a:spcPct val="100000"/>
              </a:lnSpc>
              <a:spcBef>
                <a:spcPts val="20"/>
              </a:spcBef>
            </a:pP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&lt;</a:t>
            </a:r>
            <a:r>
              <a:rPr sz="200" spc="-15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15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565" name="object 565"/>
          <p:cNvSpPr/>
          <p:nvPr/>
        </p:nvSpPr>
        <p:spPr>
          <a:xfrm>
            <a:off x="11865827" y="1171557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6" name="object 566"/>
          <p:cNvSpPr/>
          <p:nvPr/>
        </p:nvSpPr>
        <p:spPr>
          <a:xfrm>
            <a:off x="11865827" y="11715571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7" name="object 567"/>
          <p:cNvSpPr txBox="1"/>
          <p:nvPr/>
        </p:nvSpPr>
        <p:spPr>
          <a:xfrm>
            <a:off x="11999283" y="11789121"/>
            <a:ext cx="255904" cy="1206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5"/>
              </a:spcBef>
            </a:pPr>
            <a:r>
              <a:rPr sz="200" spc="-5" dirty="0">
                <a:solidFill>
                  <a:srgbClr val="949698"/>
                </a:solidFill>
                <a:latin typeface="Consolas"/>
                <a:cs typeface="Consolas"/>
              </a:rPr>
              <a:t>Highest</a:t>
            </a:r>
            <a:r>
              <a:rPr sz="200" spc="-50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measured 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2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spc="-5" dirty="0">
                <a:solidFill>
                  <a:srgbClr val="231F20"/>
                </a:solidFill>
                <a:latin typeface="Consolas"/>
                <a:cs typeface="Consolas"/>
              </a:rPr>
              <a:t>Value1</a:t>
            </a:r>
            <a:endParaRPr sz="200">
              <a:latin typeface="Consolas"/>
              <a:cs typeface="Consolas"/>
            </a:endParaRPr>
          </a:p>
          <a:p>
            <a:pPr marL="1270" algn="ctr">
              <a:lnSpc>
                <a:spcPct val="100000"/>
              </a:lnSpc>
              <a:spcBef>
                <a:spcPts val="20"/>
              </a:spcBef>
            </a:pP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&lt;</a:t>
            </a:r>
            <a:r>
              <a:rPr sz="200" spc="-15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30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568" name="object 568"/>
          <p:cNvSpPr/>
          <p:nvPr/>
        </p:nvSpPr>
        <p:spPr>
          <a:xfrm>
            <a:off x="11865827" y="1212278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69" name="object 569"/>
          <p:cNvSpPr/>
          <p:nvPr/>
        </p:nvSpPr>
        <p:spPr>
          <a:xfrm>
            <a:off x="11865827" y="12122784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0" name="object 570"/>
          <p:cNvSpPr txBox="1"/>
          <p:nvPr/>
        </p:nvSpPr>
        <p:spPr>
          <a:xfrm>
            <a:off x="11999283" y="12196453"/>
            <a:ext cx="255904" cy="1206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 algn="ctr">
              <a:lnSpc>
                <a:spcPct val="100000"/>
              </a:lnSpc>
              <a:spcBef>
                <a:spcPts val="105"/>
              </a:spcBef>
            </a:pPr>
            <a:r>
              <a:rPr sz="200" spc="-5" dirty="0">
                <a:solidFill>
                  <a:srgbClr val="949698"/>
                </a:solidFill>
                <a:latin typeface="Consolas"/>
                <a:cs typeface="Consolas"/>
              </a:rPr>
              <a:t>Highest</a:t>
            </a:r>
            <a:r>
              <a:rPr sz="200" spc="-50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measured 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2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spc="-5" dirty="0">
                <a:solidFill>
                  <a:srgbClr val="231F20"/>
                </a:solidFill>
                <a:latin typeface="Consolas"/>
                <a:cs typeface="Consolas"/>
              </a:rPr>
              <a:t>Value1</a:t>
            </a:r>
            <a:endParaRPr sz="200">
              <a:latin typeface="Consolas"/>
              <a:cs typeface="Consolas"/>
            </a:endParaRPr>
          </a:p>
          <a:p>
            <a:pPr marL="1270" algn="ctr">
              <a:lnSpc>
                <a:spcPct val="100000"/>
              </a:lnSpc>
              <a:spcBef>
                <a:spcPts val="20"/>
              </a:spcBef>
            </a:pPr>
            <a:r>
              <a:rPr sz="200" dirty="0">
                <a:solidFill>
                  <a:srgbClr val="949698"/>
                </a:solidFill>
                <a:latin typeface="Consolas"/>
                <a:cs typeface="Consolas"/>
              </a:rPr>
              <a:t>&lt;</a:t>
            </a:r>
            <a:r>
              <a:rPr sz="200" spc="-15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60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571" name="object 571"/>
          <p:cNvSpPr/>
          <p:nvPr/>
        </p:nvSpPr>
        <p:spPr>
          <a:xfrm>
            <a:off x="11209014" y="11374398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2" name="object 572"/>
          <p:cNvSpPr txBox="1"/>
          <p:nvPr/>
        </p:nvSpPr>
        <p:spPr>
          <a:xfrm>
            <a:off x="11217488" y="11371603"/>
            <a:ext cx="508000" cy="12700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N19'/</a:t>
            </a:r>
            <a:endParaRPr sz="300">
              <a:latin typeface="Consolas"/>
              <a:cs typeface="Consolas"/>
            </a:endParaRPr>
          </a:p>
          <a:p>
            <a:pPr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all Values </a:t>
            </a:r>
            <a:r>
              <a:rPr sz="300" spc="10" dirty="0">
                <a:solidFill>
                  <a:srgbClr val="ED1F24"/>
                </a:solidFill>
                <a:latin typeface="Consolas"/>
                <a:cs typeface="Consolas"/>
              </a:rPr>
              <a:t>under</a:t>
            </a:r>
            <a:r>
              <a:rPr sz="300" spc="-6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15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73" name="object 573"/>
          <p:cNvSpPr/>
          <p:nvPr/>
        </p:nvSpPr>
        <p:spPr>
          <a:xfrm>
            <a:off x="11209014" y="11786622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4" name="object 574"/>
          <p:cNvSpPr txBox="1"/>
          <p:nvPr/>
        </p:nvSpPr>
        <p:spPr>
          <a:xfrm>
            <a:off x="11217488" y="11783945"/>
            <a:ext cx="508000" cy="12700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N19'/</a:t>
            </a:r>
            <a:endParaRPr sz="300">
              <a:latin typeface="Consolas"/>
              <a:cs typeface="Consolas"/>
            </a:endParaRPr>
          </a:p>
          <a:p>
            <a:pPr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all Values </a:t>
            </a:r>
            <a:r>
              <a:rPr sz="300" spc="10" dirty="0">
                <a:solidFill>
                  <a:srgbClr val="ED1F24"/>
                </a:solidFill>
                <a:latin typeface="Consolas"/>
                <a:cs typeface="Consolas"/>
              </a:rPr>
              <a:t>under</a:t>
            </a:r>
            <a:r>
              <a:rPr sz="300" spc="-6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30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75" name="object 575"/>
          <p:cNvSpPr/>
          <p:nvPr/>
        </p:nvSpPr>
        <p:spPr>
          <a:xfrm>
            <a:off x="11209014" y="12193834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6" name="object 576"/>
          <p:cNvSpPr/>
          <p:nvPr/>
        </p:nvSpPr>
        <p:spPr>
          <a:xfrm>
            <a:off x="11209014" y="12193834"/>
            <a:ext cx="520700" cy="125730"/>
          </a:xfrm>
          <a:custGeom>
            <a:avLst/>
            <a:gdLst/>
            <a:ahLst/>
            <a:cxnLst/>
            <a:rect l="l" t="t" r="r" b="b"/>
            <a:pathLst>
              <a:path w="520700" h="125729">
                <a:moveTo>
                  <a:pt x="0" y="0"/>
                </a:moveTo>
                <a:lnTo>
                  <a:pt x="0" y="125277"/>
                </a:lnTo>
                <a:lnTo>
                  <a:pt x="520081" y="125277"/>
                </a:lnTo>
                <a:lnTo>
                  <a:pt x="52008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7" name="object 577"/>
          <p:cNvSpPr txBox="1"/>
          <p:nvPr/>
        </p:nvSpPr>
        <p:spPr>
          <a:xfrm>
            <a:off x="11217488" y="12191277"/>
            <a:ext cx="508000" cy="12700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N19'/</a:t>
            </a:r>
            <a:endParaRPr sz="300">
              <a:latin typeface="Consolas"/>
              <a:cs typeface="Consolas"/>
            </a:endParaRPr>
          </a:p>
          <a:p>
            <a:pPr algn="ctr">
              <a:lnSpc>
                <a:spcPct val="100000"/>
              </a:lnSpc>
              <a:spcBef>
                <a:spcPts val="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all Values </a:t>
            </a:r>
            <a:r>
              <a:rPr sz="300" spc="10" dirty="0">
                <a:solidFill>
                  <a:srgbClr val="ED1F24"/>
                </a:solidFill>
                <a:latin typeface="Consolas"/>
                <a:cs typeface="Consolas"/>
              </a:rPr>
              <a:t>under</a:t>
            </a:r>
            <a:r>
              <a:rPr sz="300" spc="-6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60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78" name="object 578"/>
          <p:cNvSpPr/>
          <p:nvPr/>
        </p:nvSpPr>
        <p:spPr>
          <a:xfrm>
            <a:off x="11738760" y="11437156"/>
            <a:ext cx="128270" cy="1905"/>
          </a:xfrm>
          <a:custGeom>
            <a:avLst/>
            <a:gdLst/>
            <a:ahLst/>
            <a:cxnLst/>
            <a:rect l="l" t="t" r="r" b="b"/>
            <a:pathLst>
              <a:path w="128270" h="1904">
                <a:moveTo>
                  <a:pt x="128200" y="1491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79" name="object 579"/>
          <p:cNvSpPr/>
          <p:nvPr/>
        </p:nvSpPr>
        <p:spPr>
          <a:xfrm>
            <a:off x="11729095" y="11425106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0"/>
                </a:moveTo>
                <a:lnTo>
                  <a:pt x="0" y="11931"/>
                </a:lnTo>
                <a:lnTo>
                  <a:pt x="11931" y="24160"/>
                </a:lnTo>
                <a:lnTo>
                  <a:pt x="12229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0" name="object 580"/>
          <p:cNvSpPr/>
          <p:nvPr/>
        </p:nvSpPr>
        <p:spPr>
          <a:xfrm>
            <a:off x="11738760" y="11849261"/>
            <a:ext cx="128270" cy="0"/>
          </a:xfrm>
          <a:custGeom>
            <a:avLst/>
            <a:gdLst/>
            <a:ahLst/>
            <a:cxnLst/>
            <a:rect l="l" t="t" r="r" b="b"/>
            <a:pathLst>
              <a:path w="128270">
                <a:moveTo>
                  <a:pt x="12820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1" name="object 581"/>
          <p:cNvSpPr/>
          <p:nvPr/>
        </p:nvSpPr>
        <p:spPr>
          <a:xfrm>
            <a:off x="11729095" y="11837151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2" name="object 582"/>
          <p:cNvSpPr/>
          <p:nvPr/>
        </p:nvSpPr>
        <p:spPr>
          <a:xfrm>
            <a:off x="11738760" y="12256473"/>
            <a:ext cx="128270" cy="0"/>
          </a:xfrm>
          <a:custGeom>
            <a:avLst/>
            <a:gdLst/>
            <a:ahLst/>
            <a:cxnLst/>
            <a:rect l="l" t="t" r="r" b="b"/>
            <a:pathLst>
              <a:path w="128270">
                <a:moveTo>
                  <a:pt x="12820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3" name="object 583"/>
          <p:cNvSpPr/>
          <p:nvPr/>
        </p:nvSpPr>
        <p:spPr>
          <a:xfrm>
            <a:off x="11729095" y="12244363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4" name="object 584"/>
          <p:cNvSpPr/>
          <p:nvPr/>
        </p:nvSpPr>
        <p:spPr>
          <a:xfrm>
            <a:off x="12395633" y="11849261"/>
            <a:ext cx="80010" cy="635"/>
          </a:xfrm>
          <a:custGeom>
            <a:avLst/>
            <a:gdLst/>
            <a:ahLst/>
            <a:cxnLst/>
            <a:rect l="l" t="t" r="r" b="b"/>
            <a:pathLst>
              <a:path w="80009" h="634">
                <a:moveTo>
                  <a:pt x="79521" y="59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5" name="object 585"/>
          <p:cNvSpPr/>
          <p:nvPr/>
        </p:nvSpPr>
        <p:spPr>
          <a:xfrm>
            <a:off x="12385909" y="11837151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6" name="object 586"/>
          <p:cNvSpPr/>
          <p:nvPr/>
        </p:nvSpPr>
        <p:spPr>
          <a:xfrm>
            <a:off x="12395633" y="11436500"/>
            <a:ext cx="80010" cy="635"/>
          </a:xfrm>
          <a:custGeom>
            <a:avLst/>
            <a:gdLst/>
            <a:ahLst/>
            <a:cxnLst/>
            <a:rect l="l" t="t" r="r" b="b"/>
            <a:pathLst>
              <a:path w="80009" h="634">
                <a:moveTo>
                  <a:pt x="79521" y="0"/>
                </a:moveTo>
                <a:lnTo>
                  <a:pt x="0" y="536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7" name="object 587"/>
          <p:cNvSpPr/>
          <p:nvPr/>
        </p:nvSpPr>
        <p:spPr>
          <a:xfrm>
            <a:off x="12385909" y="11424867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229" y="24220"/>
                </a:moveTo>
                <a:lnTo>
                  <a:pt x="12050" y="0"/>
                </a:lnTo>
                <a:lnTo>
                  <a:pt x="0" y="12169"/>
                </a:lnTo>
                <a:lnTo>
                  <a:pt x="12229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8" name="object 588"/>
          <p:cNvSpPr/>
          <p:nvPr/>
        </p:nvSpPr>
        <p:spPr>
          <a:xfrm>
            <a:off x="10882277" y="11436500"/>
            <a:ext cx="327025" cy="820419"/>
          </a:xfrm>
          <a:custGeom>
            <a:avLst/>
            <a:gdLst/>
            <a:ahLst/>
            <a:cxnLst/>
            <a:rect l="l" t="t" r="r" b="b"/>
            <a:pathLst>
              <a:path w="327025" h="820420">
                <a:moveTo>
                  <a:pt x="326736" y="536"/>
                </a:moveTo>
                <a:lnTo>
                  <a:pt x="200205" y="0"/>
                </a:lnTo>
                <a:lnTo>
                  <a:pt x="200205" y="820032"/>
                </a:lnTo>
                <a:lnTo>
                  <a:pt x="0" y="81997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89" name="object 589"/>
          <p:cNvSpPr/>
          <p:nvPr/>
        </p:nvSpPr>
        <p:spPr>
          <a:xfrm>
            <a:off x="10872554" y="12244363"/>
            <a:ext cx="12700" cy="24765"/>
          </a:xfrm>
          <a:custGeom>
            <a:avLst/>
            <a:gdLst/>
            <a:ahLst/>
            <a:cxnLst/>
            <a:rect l="l" t="t" r="r" b="b"/>
            <a:pathLst>
              <a:path w="12700" h="24765">
                <a:moveTo>
                  <a:pt x="12110" y="24220"/>
                </a:moveTo>
                <a:lnTo>
                  <a:pt x="12110" y="0"/>
                </a:lnTo>
                <a:lnTo>
                  <a:pt x="0" y="12110"/>
                </a:lnTo>
                <a:lnTo>
                  <a:pt x="12110" y="2422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0" name="object 590"/>
          <p:cNvSpPr/>
          <p:nvPr/>
        </p:nvSpPr>
        <p:spPr>
          <a:xfrm>
            <a:off x="11082483" y="12256473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53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1" name="object 591"/>
          <p:cNvSpPr/>
          <p:nvPr/>
        </p:nvSpPr>
        <p:spPr>
          <a:xfrm>
            <a:off x="11082542" y="11849261"/>
            <a:ext cx="127000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12647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2" name="object 592"/>
          <p:cNvSpPr/>
          <p:nvPr/>
        </p:nvSpPr>
        <p:spPr>
          <a:xfrm>
            <a:off x="10299080" y="1219383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3" name="object 593"/>
          <p:cNvSpPr/>
          <p:nvPr/>
        </p:nvSpPr>
        <p:spPr>
          <a:xfrm>
            <a:off x="10299079" y="12193834"/>
            <a:ext cx="574040" cy="125730"/>
          </a:xfrm>
          <a:custGeom>
            <a:avLst/>
            <a:gdLst/>
            <a:ahLst/>
            <a:cxnLst/>
            <a:rect l="l" t="t" r="r" b="b"/>
            <a:pathLst>
              <a:path w="574040" h="125729">
                <a:moveTo>
                  <a:pt x="0" y="0"/>
                </a:moveTo>
                <a:lnTo>
                  <a:pt x="0" y="125277"/>
                </a:lnTo>
                <a:lnTo>
                  <a:pt x="573414" y="125277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4" name="object 594"/>
          <p:cNvSpPr txBox="1"/>
          <p:nvPr/>
        </p:nvSpPr>
        <p:spPr>
          <a:xfrm>
            <a:off x="10311194" y="12216930"/>
            <a:ext cx="55181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N19 Prognosed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iagnosis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595" name="object 595"/>
          <p:cNvSpPr/>
          <p:nvPr/>
        </p:nvSpPr>
        <p:spPr>
          <a:xfrm>
            <a:off x="14321273" y="11189106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6" name="object 596"/>
          <p:cNvSpPr/>
          <p:nvPr/>
        </p:nvSpPr>
        <p:spPr>
          <a:xfrm>
            <a:off x="14321271" y="11189106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7" name="object 597"/>
          <p:cNvSpPr/>
          <p:nvPr/>
        </p:nvSpPr>
        <p:spPr>
          <a:xfrm>
            <a:off x="15119887" y="1148702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8" name="object 598"/>
          <p:cNvSpPr/>
          <p:nvPr/>
        </p:nvSpPr>
        <p:spPr>
          <a:xfrm>
            <a:off x="15119887" y="1148702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99" name="object 599"/>
          <p:cNvSpPr txBox="1"/>
          <p:nvPr/>
        </p:nvSpPr>
        <p:spPr>
          <a:xfrm>
            <a:off x="15271424" y="11509945"/>
            <a:ext cx="20447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spc="30" dirty="0">
                <a:solidFill>
                  <a:srgbClr val="231F20"/>
                </a:solidFill>
                <a:latin typeface="Calibri"/>
                <a:cs typeface="Calibri"/>
              </a:rPr>
              <a:t>a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x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i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um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00" name="object 600"/>
          <p:cNvSpPr/>
          <p:nvPr/>
        </p:nvSpPr>
        <p:spPr>
          <a:xfrm>
            <a:off x="15134623" y="11253058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480052" y="0"/>
                </a:moveTo>
                <a:lnTo>
                  <a:pt x="29828" y="0"/>
                </a:lnTo>
                <a:lnTo>
                  <a:pt x="0" y="100699"/>
                </a:lnTo>
                <a:lnTo>
                  <a:pt x="450164" y="100699"/>
                </a:lnTo>
                <a:lnTo>
                  <a:pt x="48005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1" name="object 601"/>
          <p:cNvSpPr/>
          <p:nvPr/>
        </p:nvSpPr>
        <p:spPr>
          <a:xfrm>
            <a:off x="15134623" y="11253058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0" y="100699"/>
                </a:moveTo>
                <a:lnTo>
                  <a:pt x="450164" y="100699"/>
                </a:lnTo>
                <a:lnTo>
                  <a:pt x="480052" y="0"/>
                </a:lnTo>
                <a:lnTo>
                  <a:pt x="29828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2" name="object 602"/>
          <p:cNvSpPr txBox="1"/>
          <p:nvPr/>
        </p:nvSpPr>
        <p:spPr>
          <a:xfrm>
            <a:off x="15226921" y="11257182"/>
            <a:ext cx="30226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nd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aximum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03" name="object 603"/>
          <p:cNvSpPr/>
          <p:nvPr/>
        </p:nvSpPr>
        <p:spPr>
          <a:xfrm>
            <a:off x="14936088" y="11312893"/>
            <a:ext cx="186690" cy="0"/>
          </a:xfrm>
          <a:custGeom>
            <a:avLst/>
            <a:gdLst/>
            <a:ahLst/>
            <a:cxnLst/>
            <a:rect l="l" t="t" r="r" b="b"/>
            <a:pathLst>
              <a:path w="186690">
                <a:moveTo>
                  <a:pt x="0" y="0"/>
                </a:moveTo>
                <a:lnTo>
                  <a:pt x="18630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4" name="object 604"/>
          <p:cNvSpPr/>
          <p:nvPr/>
        </p:nvSpPr>
        <p:spPr>
          <a:xfrm>
            <a:off x="15119351" y="11297621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5" name="object 605"/>
          <p:cNvSpPr/>
          <p:nvPr/>
        </p:nvSpPr>
        <p:spPr>
          <a:xfrm>
            <a:off x="15372053" y="11353757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6" name="object 606"/>
          <p:cNvSpPr/>
          <p:nvPr/>
        </p:nvSpPr>
        <p:spPr>
          <a:xfrm>
            <a:off x="15356782" y="11471697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7" name="object 607"/>
          <p:cNvSpPr/>
          <p:nvPr/>
        </p:nvSpPr>
        <p:spPr>
          <a:xfrm>
            <a:off x="14321273" y="11064599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8" name="object 608"/>
          <p:cNvSpPr/>
          <p:nvPr/>
        </p:nvSpPr>
        <p:spPr>
          <a:xfrm>
            <a:off x="14321271" y="11064599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09" name="object 609"/>
          <p:cNvSpPr txBox="1"/>
          <p:nvPr/>
        </p:nvSpPr>
        <p:spPr>
          <a:xfrm>
            <a:off x="14545586" y="11085552"/>
            <a:ext cx="33845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Valu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10" name="object 610"/>
          <p:cNvSpPr/>
          <p:nvPr/>
        </p:nvSpPr>
        <p:spPr>
          <a:xfrm>
            <a:off x="14321273" y="11913392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63"/>
                </a:lnTo>
                <a:lnTo>
                  <a:pt x="1352821" y="45386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1" name="object 611"/>
          <p:cNvSpPr/>
          <p:nvPr/>
        </p:nvSpPr>
        <p:spPr>
          <a:xfrm>
            <a:off x="14321271" y="11913391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63"/>
                </a:lnTo>
                <a:lnTo>
                  <a:pt x="1352821" y="45386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2" name="object 612"/>
          <p:cNvSpPr/>
          <p:nvPr/>
        </p:nvSpPr>
        <p:spPr>
          <a:xfrm>
            <a:off x="15119887" y="12211374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3" name="object 613"/>
          <p:cNvSpPr/>
          <p:nvPr/>
        </p:nvSpPr>
        <p:spPr>
          <a:xfrm>
            <a:off x="15119887" y="12211373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4" name="object 614"/>
          <p:cNvSpPr txBox="1"/>
          <p:nvPr/>
        </p:nvSpPr>
        <p:spPr>
          <a:xfrm>
            <a:off x="15212900" y="12234528"/>
            <a:ext cx="32512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arliest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Dat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15" name="object 615"/>
          <p:cNvSpPr/>
          <p:nvPr/>
        </p:nvSpPr>
        <p:spPr>
          <a:xfrm>
            <a:off x="15134623" y="11977402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480052" y="0"/>
                </a:moveTo>
                <a:lnTo>
                  <a:pt x="29828" y="0"/>
                </a:lnTo>
                <a:lnTo>
                  <a:pt x="0" y="100699"/>
                </a:lnTo>
                <a:lnTo>
                  <a:pt x="450164" y="100699"/>
                </a:lnTo>
                <a:lnTo>
                  <a:pt x="48005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6" name="object 616"/>
          <p:cNvSpPr/>
          <p:nvPr/>
        </p:nvSpPr>
        <p:spPr>
          <a:xfrm>
            <a:off x="15134623" y="11977402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0" y="100699"/>
                </a:moveTo>
                <a:lnTo>
                  <a:pt x="450164" y="100699"/>
                </a:lnTo>
                <a:lnTo>
                  <a:pt x="480052" y="0"/>
                </a:lnTo>
                <a:lnTo>
                  <a:pt x="29828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7" name="object 617"/>
          <p:cNvSpPr txBox="1"/>
          <p:nvPr/>
        </p:nvSpPr>
        <p:spPr>
          <a:xfrm>
            <a:off x="15234377" y="11981706"/>
            <a:ext cx="28321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Find</a:t>
            </a:r>
            <a:r>
              <a:rPr sz="300" spc="-1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inimum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18" name="object 618"/>
          <p:cNvSpPr/>
          <p:nvPr/>
        </p:nvSpPr>
        <p:spPr>
          <a:xfrm>
            <a:off x="14936088" y="12037297"/>
            <a:ext cx="186690" cy="0"/>
          </a:xfrm>
          <a:custGeom>
            <a:avLst/>
            <a:gdLst/>
            <a:ahLst/>
            <a:cxnLst/>
            <a:rect l="l" t="t" r="r" b="b"/>
            <a:pathLst>
              <a:path w="186690">
                <a:moveTo>
                  <a:pt x="0" y="0"/>
                </a:moveTo>
                <a:lnTo>
                  <a:pt x="186305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19" name="object 619"/>
          <p:cNvSpPr/>
          <p:nvPr/>
        </p:nvSpPr>
        <p:spPr>
          <a:xfrm>
            <a:off x="15119351" y="12022025"/>
            <a:ext cx="15875" cy="30480"/>
          </a:xfrm>
          <a:custGeom>
            <a:avLst/>
            <a:gdLst/>
            <a:ahLst/>
            <a:cxnLst/>
            <a:rect l="l" t="t" r="r" b="b"/>
            <a:pathLst>
              <a:path w="15875" h="30479">
                <a:moveTo>
                  <a:pt x="15271" y="15271"/>
                </a:moveTo>
                <a:lnTo>
                  <a:pt x="0" y="0"/>
                </a:lnTo>
                <a:lnTo>
                  <a:pt x="0" y="30484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0" name="object 620"/>
          <p:cNvSpPr/>
          <p:nvPr/>
        </p:nvSpPr>
        <p:spPr>
          <a:xfrm>
            <a:off x="15372053" y="12078101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1" name="object 621"/>
          <p:cNvSpPr/>
          <p:nvPr/>
        </p:nvSpPr>
        <p:spPr>
          <a:xfrm>
            <a:off x="15356782" y="12196041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2" name="object 622"/>
          <p:cNvSpPr/>
          <p:nvPr/>
        </p:nvSpPr>
        <p:spPr>
          <a:xfrm>
            <a:off x="14321273" y="11788949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3" name="object 623"/>
          <p:cNvSpPr/>
          <p:nvPr/>
        </p:nvSpPr>
        <p:spPr>
          <a:xfrm>
            <a:off x="14321271" y="11788948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4" name="object 624"/>
          <p:cNvSpPr txBox="1"/>
          <p:nvPr/>
        </p:nvSpPr>
        <p:spPr>
          <a:xfrm>
            <a:off x="14498279" y="11809956"/>
            <a:ext cx="43370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 Value</a:t>
            </a:r>
            <a:r>
              <a:rPr sz="300" spc="-3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Dat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25" name="object 625"/>
          <p:cNvSpPr/>
          <p:nvPr/>
        </p:nvSpPr>
        <p:spPr>
          <a:xfrm>
            <a:off x="14404075" y="12211374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6" name="object 626"/>
          <p:cNvSpPr/>
          <p:nvPr/>
        </p:nvSpPr>
        <p:spPr>
          <a:xfrm>
            <a:off x="14404074" y="12211373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7" name="object 627"/>
          <p:cNvSpPr txBox="1"/>
          <p:nvPr/>
        </p:nvSpPr>
        <p:spPr>
          <a:xfrm>
            <a:off x="14508419" y="12234528"/>
            <a:ext cx="30099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_</a:t>
            </a:r>
            <a:r>
              <a:rPr sz="300" spc="10" dirty="0">
                <a:solidFill>
                  <a:srgbClr val="ED1F24"/>
                </a:solidFill>
                <a:latin typeface="Consolas"/>
                <a:cs typeface="Consolas"/>
              </a:rPr>
              <a:t>X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_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28" name="object 628"/>
          <p:cNvSpPr/>
          <p:nvPr/>
        </p:nvSpPr>
        <p:spPr>
          <a:xfrm>
            <a:off x="14404075" y="1148702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29" name="object 629"/>
          <p:cNvSpPr/>
          <p:nvPr/>
        </p:nvSpPr>
        <p:spPr>
          <a:xfrm>
            <a:off x="14404074" y="1148702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0" name="object 630"/>
          <p:cNvSpPr txBox="1"/>
          <p:nvPr/>
        </p:nvSpPr>
        <p:spPr>
          <a:xfrm>
            <a:off x="14565751" y="11509945"/>
            <a:ext cx="18669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X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_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31" name="object 631"/>
          <p:cNvSpPr/>
          <p:nvPr/>
        </p:nvSpPr>
        <p:spPr>
          <a:xfrm>
            <a:off x="14920636" y="11549667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25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2" name="object 632"/>
          <p:cNvSpPr/>
          <p:nvPr/>
        </p:nvSpPr>
        <p:spPr>
          <a:xfrm>
            <a:off x="14908407" y="11534395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3" name="object 633"/>
          <p:cNvSpPr/>
          <p:nvPr/>
        </p:nvSpPr>
        <p:spPr>
          <a:xfrm>
            <a:off x="14920636" y="12274012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25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4" name="object 634"/>
          <p:cNvSpPr/>
          <p:nvPr/>
        </p:nvSpPr>
        <p:spPr>
          <a:xfrm>
            <a:off x="14908407" y="1225874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5" name="object 635"/>
          <p:cNvSpPr/>
          <p:nvPr/>
        </p:nvSpPr>
        <p:spPr>
          <a:xfrm>
            <a:off x="11576137" y="12645849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63"/>
                </a:lnTo>
                <a:lnTo>
                  <a:pt x="1352821" y="45386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6" name="object 636"/>
          <p:cNvSpPr/>
          <p:nvPr/>
        </p:nvSpPr>
        <p:spPr>
          <a:xfrm>
            <a:off x="12382270" y="12919670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7" name="object 637"/>
          <p:cNvSpPr txBox="1"/>
          <p:nvPr/>
        </p:nvSpPr>
        <p:spPr>
          <a:xfrm>
            <a:off x="12566436" y="12943004"/>
            <a:ext cx="14097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Count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38" name="object 638"/>
          <p:cNvSpPr/>
          <p:nvPr/>
        </p:nvSpPr>
        <p:spPr>
          <a:xfrm>
            <a:off x="12395991" y="12709859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480052" y="0"/>
                </a:moveTo>
                <a:lnTo>
                  <a:pt x="29828" y="0"/>
                </a:lnTo>
                <a:lnTo>
                  <a:pt x="0" y="100699"/>
                </a:lnTo>
                <a:lnTo>
                  <a:pt x="450164" y="100699"/>
                </a:lnTo>
                <a:lnTo>
                  <a:pt x="48005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39" name="object 639"/>
          <p:cNvSpPr/>
          <p:nvPr/>
        </p:nvSpPr>
        <p:spPr>
          <a:xfrm>
            <a:off x="12395991" y="12709859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0" y="100699"/>
                </a:moveTo>
                <a:lnTo>
                  <a:pt x="450164" y="100699"/>
                </a:lnTo>
                <a:lnTo>
                  <a:pt x="480052" y="0"/>
                </a:lnTo>
                <a:lnTo>
                  <a:pt x="29828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0" name="object 640"/>
          <p:cNvSpPr txBox="1"/>
          <p:nvPr/>
        </p:nvSpPr>
        <p:spPr>
          <a:xfrm>
            <a:off x="12487867" y="12714404"/>
            <a:ext cx="30226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Count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s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41" name="object 641"/>
          <p:cNvSpPr/>
          <p:nvPr/>
        </p:nvSpPr>
        <p:spPr>
          <a:xfrm>
            <a:off x="12190834" y="12769694"/>
            <a:ext cx="193040" cy="0"/>
          </a:xfrm>
          <a:custGeom>
            <a:avLst/>
            <a:gdLst/>
            <a:ahLst/>
            <a:cxnLst/>
            <a:rect l="l" t="t" r="r" b="b"/>
            <a:pathLst>
              <a:path w="193040">
                <a:moveTo>
                  <a:pt x="0" y="0"/>
                </a:moveTo>
                <a:lnTo>
                  <a:pt x="192927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2" name="object 642"/>
          <p:cNvSpPr/>
          <p:nvPr/>
        </p:nvSpPr>
        <p:spPr>
          <a:xfrm>
            <a:off x="12380719" y="1275442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3" name="object 643"/>
          <p:cNvSpPr/>
          <p:nvPr/>
        </p:nvSpPr>
        <p:spPr>
          <a:xfrm>
            <a:off x="12633422" y="12810559"/>
            <a:ext cx="1270" cy="97155"/>
          </a:xfrm>
          <a:custGeom>
            <a:avLst/>
            <a:gdLst/>
            <a:ahLst/>
            <a:cxnLst/>
            <a:rect l="l" t="t" r="r" b="b"/>
            <a:pathLst>
              <a:path w="1270" h="97154">
                <a:moveTo>
                  <a:pt x="0" y="0"/>
                </a:moveTo>
                <a:lnTo>
                  <a:pt x="894" y="96941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4" name="object 644"/>
          <p:cNvSpPr/>
          <p:nvPr/>
        </p:nvSpPr>
        <p:spPr>
          <a:xfrm>
            <a:off x="12619045" y="12904279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238"/>
                </a:lnTo>
                <a:lnTo>
                  <a:pt x="15450" y="1539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5" name="object 645"/>
          <p:cNvSpPr/>
          <p:nvPr/>
        </p:nvSpPr>
        <p:spPr>
          <a:xfrm>
            <a:off x="11576138" y="12521407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6" name="object 646"/>
          <p:cNvSpPr/>
          <p:nvPr/>
        </p:nvSpPr>
        <p:spPr>
          <a:xfrm>
            <a:off x="11576137" y="12521406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7" name="object 647"/>
          <p:cNvSpPr txBox="1"/>
          <p:nvPr/>
        </p:nvSpPr>
        <p:spPr>
          <a:xfrm>
            <a:off x="11608118" y="12516343"/>
            <a:ext cx="72263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302895" marR="5080" indent="-290830">
              <a:lnSpc>
                <a:spcPct val="115100"/>
              </a:lnSpc>
              <a:spcBef>
                <a:spcPts val="80"/>
              </a:spcBef>
            </a:pP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Number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of Measurements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rognosis  Perion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48" name="object 648"/>
          <p:cNvSpPr/>
          <p:nvPr/>
        </p:nvSpPr>
        <p:spPr>
          <a:xfrm>
            <a:off x="11665442" y="12894973"/>
            <a:ext cx="504825" cy="174625"/>
          </a:xfrm>
          <a:custGeom>
            <a:avLst/>
            <a:gdLst/>
            <a:ahLst/>
            <a:cxnLst/>
            <a:rect l="l" t="t" r="r" b="b"/>
            <a:pathLst>
              <a:path w="504825" h="174625">
                <a:moveTo>
                  <a:pt x="0" y="0"/>
                </a:moveTo>
                <a:lnTo>
                  <a:pt x="0" y="174136"/>
                </a:lnTo>
                <a:lnTo>
                  <a:pt x="504332" y="174136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49" name="object 649"/>
          <p:cNvSpPr/>
          <p:nvPr/>
        </p:nvSpPr>
        <p:spPr>
          <a:xfrm>
            <a:off x="11665442" y="12894972"/>
            <a:ext cx="504825" cy="174625"/>
          </a:xfrm>
          <a:custGeom>
            <a:avLst/>
            <a:gdLst/>
            <a:ahLst/>
            <a:cxnLst/>
            <a:rect l="l" t="t" r="r" b="b"/>
            <a:pathLst>
              <a:path w="504825" h="174625">
                <a:moveTo>
                  <a:pt x="0" y="0"/>
                </a:moveTo>
                <a:lnTo>
                  <a:pt x="0" y="174136"/>
                </a:lnTo>
                <a:lnTo>
                  <a:pt x="504332" y="174136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0" name="object 650"/>
          <p:cNvSpPr txBox="1"/>
          <p:nvPr/>
        </p:nvSpPr>
        <p:spPr>
          <a:xfrm>
            <a:off x="11723496" y="12890745"/>
            <a:ext cx="391160" cy="179070"/>
          </a:xfrm>
          <a:prstGeom prst="rect">
            <a:avLst/>
          </a:prstGeom>
        </p:spPr>
        <p:txBody>
          <a:bodyPr vert="horz" wrap="square" lIns="0" tIns="12065" rIns="0" bIns="0" rtlCol="0">
            <a:spAutoFit/>
          </a:bodyPr>
          <a:lstStyle/>
          <a:p>
            <a:pPr marL="12700" marR="5080" indent="80010">
              <a:lnSpc>
                <a:spcPct val="111500"/>
              </a:lnSpc>
              <a:spcBef>
                <a:spcPts val="9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Number of  Measurements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in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rognosis</a:t>
            </a:r>
            <a:r>
              <a:rPr sz="300" spc="-6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erio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51" name="object 651"/>
          <p:cNvSpPr/>
          <p:nvPr/>
        </p:nvSpPr>
        <p:spPr>
          <a:xfrm>
            <a:off x="12182004" y="12982070"/>
            <a:ext cx="200660" cy="635"/>
          </a:xfrm>
          <a:custGeom>
            <a:avLst/>
            <a:gdLst/>
            <a:ahLst/>
            <a:cxnLst/>
            <a:rect l="l" t="t" r="r" b="b"/>
            <a:pathLst>
              <a:path w="200659" h="634">
                <a:moveTo>
                  <a:pt x="200265" y="238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2" name="object 652"/>
          <p:cNvSpPr/>
          <p:nvPr/>
        </p:nvSpPr>
        <p:spPr>
          <a:xfrm>
            <a:off x="12169775" y="12966798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3" name="object 653"/>
          <p:cNvSpPr/>
          <p:nvPr/>
        </p:nvSpPr>
        <p:spPr>
          <a:xfrm>
            <a:off x="12990524" y="12645849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63"/>
                </a:lnTo>
                <a:lnTo>
                  <a:pt x="1352821" y="45386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4" name="object 654"/>
          <p:cNvSpPr/>
          <p:nvPr/>
        </p:nvSpPr>
        <p:spPr>
          <a:xfrm>
            <a:off x="13799520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5" name="object 655"/>
          <p:cNvSpPr txBox="1"/>
          <p:nvPr/>
        </p:nvSpPr>
        <p:spPr>
          <a:xfrm>
            <a:off x="13869384" y="12967166"/>
            <a:ext cx="36830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Arithmetic</a:t>
            </a:r>
            <a:r>
              <a:rPr sz="30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Mean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56" name="object 656"/>
          <p:cNvSpPr/>
          <p:nvPr/>
        </p:nvSpPr>
        <p:spPr>
          <a:xfrm>
            <a:off x="13814254" y="12709859"/>
            <a:ext cx="480695" cy="100965"/>
          </a:xfrm>
          <a:custGeom>
            <a:avLst/>
            <a:gdLst/>
            <a:ahLst/>
            <a:cxnLst/>
            <a:rect l="l" t="t" r="r" b="b"/>
            <a:pathLst>
              <a:path w="480694" h="100965">
                <a:moveTo>
                  <a:pt x="480112" y="0"/>
                </a:moveTo>
                <a:lnTo>
                  <a:pt x="29887" y="0"/>
                </a:lnTo>
                <a:lnTo>
                  <a:pt x="0" y="100699"/>
                </a:lnTo>
                <a:lnTo>
                  <a:pt x="450224" y="100699"/>
                </a:lnTo>
                <a:lnTo>
                  <a:pt x="48011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7" name="object 657"/>
          <p:cNvSpPr/>
          <p:nvPr/>
        </p:nvSpPr>
        <p:spPr>
          <a:xfrm>
            <a:off x="13814254" y="12709859"/>
            <a:ext cx="480695" cy="100965"/>
          </a:xfrm>
          <a:custGeom>
            <a:avLst/>
            <a:gdLst/>
            <a:ahLst/>
            <a:cxnLst/>
            <a:rect l="l" t="t" r="r" b="b"/>
            <a:pathLst>
              <a:path w="480694" h="100965">
                <a:moveTo>
                  <a:pt x="0" y="100699"/>
                </a:moveTo>
                <a:lnTo>
                  <a:pt x="450224" y="100699"/>
                </a:lnTo>
                <a:lnTo>
                  <a:pt x="480112" y="0"/>
                </a:lnTo>
                <a:lnTo>
                  <a:pt x="29887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58" name="object 658"/>
          <p:cNvSpPr txBox="1"/>
          <p:nvPr/>
        </p:nvSpPr>
        <p:spPr>
          <a:xfrm>
            <a:off x="13884178" y="12714404"/>
            <a:ext cx="34290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Calculate</a:t>
            </a:r>
            <a:r>
              <a:rPr sz="300" spc="-15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verage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59" name="object 659"/>
          <p:cNvSpPr/>
          <p:nvPr/>
        </p:nvSpPr>
        <p:spPr>
          <a:xfrm>
            <a:off x="13605279" y="12769694"/>
            <a:ext cx="196850" cy="0"/>
          </a:xfrm>
          <a:custGeom>
            <a:avLst/>
            <a:gdLst/>
            <a:ahLst/>
            <a:cxnLst/>
            <a:rect l="l" t="t" r="r" b="b"/>
            <a:pathLst>
              <a:path w="196850">
                <a:moveTo>
                  <a:pt x="0" y="0"/>
                </a:moveTo>
                <a:lnTo>
                  <a:pt x="196804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0" name="object 660"/>
          <p:cNvSpPr/>
          <p:nvPr/>
        </p:nvSpPr>
        <p:spPr>
          <a:xfrm>
            <a:off x="13799042" y="12754423"/>
            <a:ext cx="15240" cy="31115"/>
          </a:xfrm>
          <a:custGeom>
            <a:avLst/>
            <a:gdLst/>
            <a:ahLst/>
            <a:cxnLst/>
            <a:rect l="l" t="t" r="r" b="b"/>
            <a:pathLst>
              <a:path w="15240" h="31115">
                <a:moveTo>
                  <a:pt x="15212" y="15271"/>
                </a:moveTo>
                <a:lnTo>
                  <a:pt x="0" y="0"/>
                </a:lnTo>
                <a:lnTo>
                  <a:pt x="0" y="30543"/>
                </a:lnTo>
                <a:lnTo>
                  <a:pt x="15212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1" name="object 661"/>
          <p:cNvSpPr/>
          <p:nvPr/>
        </p:nvSpPr>
        <p:spPr>
          <a:xfrm>
            <a:off x="14051745" y="12810559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2" name="object 662"/>
          <p:cNvSpPr/>
          <p:nvPr/>
        </p:nvSpPr>
        <p:spPr>
          <a:xfrm>
            <a:off x="14036473" y="12928558"/>
            <a:ext cx="31115" cy="15240"/>
          </a:xfrm>
          <a:custGeom>
            <a:avLst/>
            <a:gdLst/>
            <a:ahLst/>
            <a:cxnLst/>
            <a:rect l="l" t="t" r="r" b="b"/>
            <a:pathLst>
              <a:path w="31115" h="15240">
                <a:moveTo>
                  <a:pt x="30543" y="0"/>
                </a:moveTo>
                <a:lnTo>
                  <a:pt x="0" y="0"/>
                </a:lnTo>
                <a:lnTo>
                  <a:pt x="15271" y="15212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3" name="object 663"/>
          <p:cNvSpPr/>
          <p:nvPr/>
        </p:nvSpPr>
        <p:spPr>
          <a:xfrm>
            <a:off x="12990524" y="12521407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4" name="object 664"/>
          <p:cNvSpPr/>
          <p:nvPr/>
        </p:nvSpPr>
        <p:spPr>
          <a:xfrm>
            <a:off x="12990524" y="12521406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5" name="object 665"/>
          <p:cNvSpPr txBox="1"/>
          <p:nvPr/>
        </p:nvSpPr>
        <p:spPr>
          <a:xfrm>
            <a:off x="13023102" y="12516343"/>
            <a:ext cx="72263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302895" marR="5080" indent="-290830">
              <a:lnSpc>
                <a:spcPct val="115100"/>
              </a:lnSpc>
              <a:spcBef>
                <a:spcPts val="80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verage of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easurements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rognosis  Period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66" name="object 666"/>
          <p:cNvSpPr/>
          <p:nvPr/>
        </p:nvSpPr>
        <p:spPr>
          <a:xfrm>
            <a:off x="13083767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7" name="object 667"/>
          <p:cNvSpPr/>
          <p:nvPr/>
        </p:nvSpPr>
        <p:spPr>
          <a:xfrm>
            <a:off x="13083765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68" name="object 668"/>
          <p:cNvSpPr txBox="1"/>
          <p:nvPr/>
        </p:nvSpPr>
        <p:spPr>
          <a:xfrm>
            <a:off x="13096121" y="12940200"/>
            <a:ext cx="483234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72720" marR="5080" indent="-160655">
              <a:lnSpc>
                <a:spcPct val="113599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Average in</a:t>
            </a:r>
            <a:r>
              <a:rPr sz="3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rognosis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io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69" name="object 669"/>
          <p:cNvSpPr/>
          <p:nvPr/>
        </p:nvSpPr>
        <p:spPr>
          <a:xfrm>
            <a:off x="13600327" y="13006410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19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0" name="object 670"/>
          <p:cNvSpPr/>
          <p:nvPr/>
        </p:nvSpPr>
        <p:spPr>
          <a:xfrm>
            <a:off x="13588038" y="12991197"/>
            <a:ext cx="15875" cy="30480"/>
          </a:xfrm>
          <a:custGeom>
            <a:avLst/>
            <a:gdLst/>
            <a:ahLst/>
            <a:cxnLst/>
            <a:rect l="l" t="t" r="r" b="b"/>
            <a:pathLst>
              <a:path w="15875" h="30480">
                <a:moveTo>
                  <a:pt x="15271" y="30484"/>
                </a:moveTo>
                <a:lnTo>
                  <a:pt x="15271" y="0"/>
                </a:lnTo>
                <a:lnTo>
                  <a:pt x="0" y="15212"/>
                </a:lnTo>
                <a:lnTo>
                  <a:pt x="15271" y="3048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1" name="object 671"/>
          <p:cNvSpPr/>
          <p:nvPr/>
        </p:nvSpPr>
        <p:spPr>
          <a:xfrm>
            <a:off x="10159245" y="12645849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63"/>
                </a:lnTo>
                <a:lnTo>
                  <a:pt x="1352821" y="45386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2" name="object 672"/>
          <p:cNvSpPr/>
          <p:nvPr/>
        </p:nvSpPr>
        <p:spPr>
          <a:xfrm>
            <a:off x="10948675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3" name="object 673"/>
          <p:cNvSpPr txBox="1"/>
          <p:nvPr/>
        </p:nvSpPr>
        <p:spPr>
          <a:xfrm>
            <a:off x="11121086" y="12967166"/>
            <a:ext cx="16383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edian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74" name="object 674"/>
          <p:cNvSpPr/>
          <p:nvPr/>
        </p:nvSpPr>
        <p:spPr>
          <a:xfrm>
            <a:off x="10966034" y="12709859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480052" y="0"/>
                </a:moveTo>
                <a:lnTo>
                  <a:pt x="29887" y="0"/>
                </a:lnTo>
                <a:lnTo>
                  <a:pt x="0" y="100699"/>
                </a:lnTo>
                <a:lnTo>
                  <a:pt x="450164" y="100699"/>
                </a:lnTo>
                <a:lnTo>
                  <a:pt x="48005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5" name="object 675"/>
          <p:cNvSpPr/>
          <p:nvPr/>
        </p:nvSpPr>
        <p:spPr>
          <a:xfrm>
            <a:off x="10966034" y="12709859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0" y="100699"/>
                </a:moveTo>
                <a:lnTo>
                  <a:pt x="450164" y="100699"/>
                </a:lnTo>
                <a:lnTo>
                  <a:pt x="480052" y="0"/>
                </a:lnTo>
                <a:lnTo>
                  <a:pt x="29887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6" name="object 676"/>
          <p:cNvSpPr txBox="1"/>
          <p:nvPr/>
        </p:nvSpPr>
        <p:spPr>
          <a:xfrm>
            <a:off x="11069005" y="12714404"/>
            <a:ext cx="27940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nd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edian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77" name="object 677"/>
          <p:cNvSpPr/>
          <p:nvPr/>
        </p:nvSpPr>
        <p:spPr>
          <a:xfrm>
            <a:off x="10774002" y="12769694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0" y="0"/>
                </a:moveTo>
                <a:lnTo>
                  <a:pt x="179862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8" name="object 678"/>
          <p:cNvSpPr/>
          <p:nvPr/>
        </p:nvSpPr>
        <p:spPr>
          <a:xfrm>
            <a:off x="10950762" y="12754423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9" name="object 679"/>
          <p:cNvSpPr/>
          <p:nvPr/>
        </p:nvSpPr>
        <p:spPr>
          <a:xfrm>
            <a:off x="11201079" y="12810559"/>
            <a:ext cx="2540" cy="121285"/>
          </a:xfrm>
          <a:custGeom>
            <a:avLst/>
            <a:gdLst/>
            <a:ahLst/>
            <a:cxnLst/>
            <a:rect l="l" t="t" r="r" b="b"/>
            <a:pathLst>
              <a:path w="2540" h="121284">
                <a:moveTo>
                  <a:pt x="2386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0" name="object 680"/>
          <p:cNvSpPr/>
          <p:nvPr/>
        </p:nvSpPr>
        <p:spPr>
          <a:xfrm>
            <a:off x="11185867" y="12928200"/>
            <a:ext cx="30480" cy="15875"/>
          </a:xfrm>
          <a:custGeom>
            <a:avLst/>
            <a:gdLst/>
            <a:ahLst/>
            <a:cxnLst/>
            <a:rect l="l" t="t" r="r" b="b"/>
            <a:pathLst>
              <a:path w="30479" h="15875">
                <a:moveTo>
                  <a:pt x="30484" y="656"/>
                </a:moveTo>
                <a:lnTo>
                  <a:pt x="0" y="0"/>
                </a:lnTo>
                <a:lnTo>
                  <a:pt x="14914" y="15570"/>
                </a:lnTo>
                <a:lnTo>
                  <a:pt x="30484" y="656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1" name="object 681"/>
          <p:cNvSpPr/>
          <p:nvPr/>
        </p:nvSpPr>
        <p:spPr>
          <a:xfrm>
            <a:off x="10159246" y="12521407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2" name="object 682"/>
          <p:cNvSpPr/>
          <p:nvPr/>
        </p:nvSpPr>
        <p:spPr>
          <a:xfrm>
            <a:off x="10159245" y="12521406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3" name="object 683"/>
          <p:cNvSpPr txBox="1"/>
          <p:nvPr/>
        </p:nvSpPr>
        <p:spPr>
          <a:xfrm>
            <a:off x="10195999" y="12516343"/>
            <a:ext cx="71247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298450" marR="5080" indent="-285750">
              <a:lnSpc>
                <a:spcPct val="115100"/>
              </a:lnSpc>
              <a:spcBef>
                <a:spcPts val="80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Median of Measurements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rognosis  Period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684" name="object 684"/>
          <p:cNvSpPr/>
          <p:nvPr/>
        </p:nvSpPr>
        <p:spPr>
          <a:xfrm>
            <a:off x="10235546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5" name="object 685"/>
          <p:cNvSpPr/>
          <p:nvPr/>
        </p:nvSpPr>
        <p:spPr>
          <a:xfrm>
            <a:off x="10235546" y="12943771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337"/>
                </a:lnTo>
                <a:lnTo>
                  <a:pt x="504332" y="12533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6" name="object 686"/>
          <p:cNvSpPr txBox="1"/>
          <p:nvPr/>
        </p:nvSpPr>
        <p:spPr>
          <a:xfrm>
            <a:off x="10258876" y="12940200"/>
            <a:ext cx="460375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61290" marR="5080" indent="-149225">
              <a:lnSpc>
                <a:spcPct val="113599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edian in</a:t>
            </a:r>
            <a:r>
              <a:rPr sz="3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rognosis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io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87" name="object 687"/>
          <p:cNvSpPr/>
          <p:nvPr/>
        </p:nvSpPr>
        <p:spPr>
          <a:xfrm>
            <a:off x="10752048" y="13006410"/>
            <a:ext cx="196850" cy="0"/>
          </a:xfrm>
          <a:custGeom>
            <a:avLst/>
            <a:gdLst/>
            <a:ahLst/>
            <a:cxnLst/>
            <a:rect l="l" t="t" r="r" b="b"/>
            <a:pathLst>
              <a:path w="196850">
                <a:moveTo>
                  <a:pt x="196626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8" name="object 688"/>
          <p:cNvSpPr/>
          <p:nvPr/>
        </p:nvSpPr>
        <p:spPr>
          <a:xfrm>
            <a:off x="10739818" y="12991197"/>
            <a:ext cx="15875" cy="30480"/>
          </a:xfrm>
          <a:custGeom>
            <a:avLst/>
            <a:gdLst/>
            <a:ahLst/>
            <a:cxnLst/>
            <a:rect l="l" t="t" r="r" b="b"/>
            <a:pathLst>
              <a:path w="15875" h="30480">
                <a:moveTo>
                  <a:pt x="15271" y="30484"/>
                </a:moveTo>
                <a:lnTo>
                  <a:pt x="15271" y="0"/>
                </a:lnTo>
                <a:lnTo>
                  <a:pt x="0" y="15212"/>
                </a:lnTo>
                <a:lnTo>
                  <a:pt x="15271" y="3048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89" name="object 689"/>
          <p:cNvSpPr/>
          <p:nvPr/>
        </p:nvSpPr>
        <p:spPr>
          <a:xfrm>
            <a:off x="12734480" y="10940693"/>
            <a:ext cx="1475105" cy="1499870"/>
          </a:xfrm>
          <a:custGeom>
            <a:avLst/>
            <a:gdLst/>
            <a:ahLst/>
            <a:cxnLst/>
            <a:rect l="l" t="t" r="r" b="b"/>
            <a:pathLst>
              <a:path w="1475105" h="1499870">
                <a:moveTo>
                  <a:pt x="0" y="0"/>
                </a:moveTo>
                <a:lnTo>
                  <a:pt x="0" y="1499455"/>
                </a:lnTo>
                <a:lnTo>
                  <a:pt x="1474877" y="1499455"/>
                </a:lnTo>
                <a:lnTo>
                  <a:pt x="1474877" y="0"/>
                </a:lnTo>
                <a:lnTo>
                  <a:pt x="0" y="0"/>
                </a:lnTo>
                <a:close/>
              </a:path>
            </a:pathLst>
          </a:custGeom>
          <a:solidFill>
            <a:srgbClr val="C7C8CA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0" name="object 690"/>
          <p:cNvSpPr txBox="1"/>
          <p:nvPr/>
        </p:nvSpPr>
        <p:spPr>
          <a:xfrm>
            <a:off x="12741406" y="10943767"/>
            <a:ext cx="933450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X</a:t>
            </a:r>
            <a:r>
              <a:rPr sz="25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(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LAST</a:t>
            </a:r>
            <a:r>
              <a:rPr sz="250" spc="-1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to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FIFTH-LAST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)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and</a:t>
            </a:r>
            <a:r>
              <a:rPr sz="250" spc="-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'N'</a:t>
            </a:r>
            <a:r>
              <a:rPr sz="250" spc="5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(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'1'</a:t>
            </a:r>
            <a:r>
              <a:rPr sz="25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to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'5'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)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691" name="object 691"/>
          <p:cNvSpPr/>
          <p:nvPr/>
        </p:nvSpPr>
        <p:spPr>
          <a:xfrm>
            <a:off x="12777372" y="11187854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2" name="object 692"/>
          <p:cNvSpPr/>
          <p:nvPr/>
        </p:nvSpPr>
        <p:spPr>
          <a:xfrm>
            <a:off x="12777372" y="11187854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3" name="object 693"/>
          <p:cNvSpPr/>
          <p:nvPr/>
        </p:nvSpPr>
        <p:spPr>
          <a:xfrm>
            <a:off x="13574199" y="1148541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4" name="object 694"/>
          <p:cNvSpPr/>
          <p:nvPr/>
        </p:nvSpPr>
        <p:spPr>
          <a:xfrm>
            <a:off x="13574199" y="1148541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5" name="object 695"/>
          <p:cNvSpPr txBox="1"/>
          <p:nvPr/>
        </p:nvSpPr>
        <p:spPr>
          <a:xfrm>
            <a:off x="13701273" y="11508394"/>
            <a:ext cx="255904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696" name="object 696"/>
          <p:cNvSpPr/>
          <p:nvPr/>
        </p:nvSpPr>
        <p:spPr>
          <a:xfrm>
            <a:off x="13396901" y="11311282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0" y="0"/>
                </a:moveTo>
                <a:lnTo>
                  <a:pt x="179802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7" name="object 697"/>
          <p:cNvSpPr/>
          <p:nvPr/>
        </p:nvSpPr>
        <p:spPr>
          <a:xfrm>
            <a:off x="13573661" y="11296010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8" name="object 698"/>
          <p:cNvSpPr/>
          <p:nvPr/>
        </p:nvSpPr>
        <p:spPr>
          <a:xfrm>
            <a:off x="13813598" y="11352146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9" name="object 699"/>
          <p:cNvSpPr/>
          <p:nvPr/>
        </p:nvSpPr>
        <p:spPr>
          <a:xfrm>
            <a:off x="13798326" y="11470146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0" name="object 700"/>
          <p:cNvSpPr/>
          <p:nvPr/>
        </p:nvSpPr>
        <p:spPr>
          <a:xfrm>
            <a:off x="12782145" y="11062994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1" name="object 701"/>
          <p:cNvSpPr/>
          <p:nvPr/>
        </p:nvSpPr>
        <p:spPr>
          <a:xfrm>
            <a:off x="12782145" y="11062993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2" name="object 702"/>
          <p:cNvSpPr txBox="1"/>
          <p:nvPr/>
        </p:nvSpPr>
        <p:spPr>
          <a:xfrm>
            <a:off x="13006100" y="11083882"/>
            <a:ext cx="33845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Valu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703" name="object 703"/>
          <p:cNvSpPr/>
          <p:nvPr/>
        </p:nvSpPr>
        <p:spPr>
          <a:xfrm>
            <a:off x="12781608" y="11912138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4" name="object 704"/>
          <p:cNvSpPr/>
          <p:nvPr/>
        </p:nvSpPr>
        <p:spPr>
          <a:xfrm>
            <a:off x="12781608" y="11912138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5" name="object 705"/>
          <p:cNvSpPr/>
          <p:nvPr/>
        </p:nvSpPr>
        <p:spPr>
          <a:xfrm>
            <a:off x="13574199" y="12209763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6" name="object 706"/>
          <p:cNvSpPr/>
          <p:nvPr/>
        </p:nvSpPr>
        <p:spPr>
          <a:xfrm>
            <a:off x="13574199" y="12209762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7" name="object 707"/>
          <p:cNvSpPr txBox="1"/>
          <p:nvPr/>
        </p:nvSpPr>
        <p:spPr>
          <a:xfrm>
            <a:off x="13598188" y="12205834"/>
            <a:ext cx="461645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61290" marR="5080" indent="-149225">
              <a:lnSpc>
                <a:spcPct val="113799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 Dates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v.</a:t>
            </a:r>
            <a:r>
              <a:rPr sz="300" spc="-8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 Values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08" name="object 708"/>
          <p:cNvSpPr/>
          <p:nvPr/>
        </p:nvSpPr>
        <p:spPr>
          <a:xfrm>
            <a:off x="13396901" y="12035626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0" y="0"/>
                </a:moveTo>
                <a:lnTo>
                  <a:pt x="179802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09" name="object 709"/>
          <p:cNvSpPr/>
          <p:nvPr/>
        </p:nvSpPr>
        <p:spPr>
          <a:xfrm>
            <a:off x="13573661" y="12020354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0" name="object 710"/>
          <p:cNvSpPr/>
          <p:nvPr/>
        </p:nvSpPr>
        <p:spPr>
          <a:xfrm>
            <a:off x="13812584" y="12076490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1" name="object 711"/>
          <p:cNvSpPr/>
          <p:nvPr/>
        </p:nvSpPr>
        <p:spPr>
          <a:xfrm>
            <a:off x="13797312" y="12194490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2" name="object 712"/>
          <p:cNvSpPr/>
          <p:nvPr/>
        </p:nvSpPr>
        <p:spPr>
          <a:xfrm>
            <a:off x="12782145" y="11787338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3" name="object 713"/>
          <p:cNvSpPr/>
          <p:nvPr/>
        </p:nvSpPr>
        <p:spPr>
          <a:xfrm>
            <a:off x="12782145" y="11787337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20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4" name="object 714"/>
          <p:cNvSpPr txBox="1"/>
          <p:nvPr/>
        </p:nvSpPr>
        <p:spPr>
          <a:xfrm>
            <a:off x="12958971" y="11808465"/>
            <a:ext cx="43370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ifference Value</a:t>
            </a:r>
            <a:r>
              <a:rPr sz="300" spc="-3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Date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715" name="object 715"/>
          <p:cNvSpPr/>
          <p:nvPr/>
        </p:nvSpPr>
        <p:spPr>
          <a:xfrm>
            <a:off x="12858385" y="12209763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D7E3B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6" name="object 716"/>
          <p:cNvSpPr/>
          <p:nvPr/>
        </p:nvSpPr>
        <p:spPr>
          <a:xfrm>
            <a:off x="12858385" y="12209762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7" name="object 717"/>
          <p:cNvSpPr txBox="1"/>
          <p:nvPr/>
        </p:nvSpPr>
        <p:spPr>
          <a:xfrm>
            <a:off x="12962491" y="12232859"/>
            <a:ext cx="30099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_</a:t>
            </a:r>
            <a:r>
              <a:rPr sz="300" spc="10" dirty="0">
                <a:solidFill>
                  <a:srgbClr val="ED1F24"/>
                </a:solidFill>
                <a:latin typeface="Consolas"/>
                <a:cs typeface="Consolas"/>
              </a:rPr>
              <a:t>X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_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18" name="object 718"/>
          <p:cNvSpPr/>
          <p:nvPr/>
        </p:nvSpPr>
        <p:spPr>
          <a:xfrm>
            <a:off x="12858385" y="1148541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19" name="object 719"/>
          <p:cNvSpPr/>
          <p:nvPr/>
        </p:nvSpPr>
        <p:spPr>
          <a:xfrm>
            <a:off x="12858385" y="1148541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29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0" name="object 720"/>
          <p:cNvSpPr txBox="1"/>
          <p:nvPr/>
        </p:nvSpPr>
        <p:spPr>
          <a:xfrm>
            <a:off x="13019702" y="11508394"/>
            <a:ext cx="18669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X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_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21" name="object 721"/>
          <p:cNvSpPr/>
          <p:nvPr/>
        </p:nvSpPr>
        <p:spPr>
          <a:xfrm>
            <a:off x="13374947" y="11548057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25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2" name="object 722"/>
          <p:cNvSpPr/>
          <p:nvPr/>
        </p:nvSpPr>
        <p:spPr>
          <a:xfrm>
            <a:off x="13362717" y="11532785"/>
            <a:ext cx="15875" cy="30480"/>
          </a:xfrm>
          <a:custGeom>
            <a:avLst/>
            <a:gdLst/>
            <a:ahLst/>
            <a:cxnLst/>
            <a:rect l="l" t="t" r="r" b="b"/>
            <a:pathLst>
              <a:path w="15875" h="30479">
                <a:moveTo>
                  <a:pt x="15271" y="30484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48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3" name="object 723"/>
          <p:cNvSpPr/>
          <p:nvPr/>
        </p:nvSpPr>
        <p:spPr>
          <a:xfrm>
            <a:off x="13374947" y="12272402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25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4" name="object 724"/>
          <p:cNvSpPr/>
          <p:nvPr/>
        </p:nvSpPr>
        <p:spPr>
          <a:xfrm>
            <a:off x="13362717" y="12257129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5" name="object 725"/>
          <p:cNvSpPr/>
          <p:nvPr/>
        </p:nvSpPr>
        <p:spPr>
          <a:xfrm>
            <a:off x="13589351" y="11196444"/>
            <a:ext cx="447675" cy="230504"/>
          </a:xfrm>
          <a:custGeom>
            <a:avLst/>
            <a:gdLst/>
            <a:ahLst/>
            <a:cxnLst/>
            <a:rect l="l" t="t" r="r" b="b"/>
            <a:pathLst>
              <a:path w="447675" h="230504">
                <a:moveTo>
                  <a:pt x="447659" y="115076"/>
                </a:moveTo>
                <a:lnTo>
                  <a:pt x="223829" y="0"/>
                </a:lnTo>
                <a:lnTo>
                  <a:pt x="0" y="115076"/>
                </a:lnTo>
                <a:lnTo>
                  <a:pt x="223829" y="230153"/>
                </a:lnTo>
                <a:lnTo>
                  <a:pt x="447659" y="115076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6" name="object 726"/>
          <p:cNvSpPr/>
          <p:nvPr/>
        </p:nvSpPr>
        <p:spPr>
          <a:xfrm>
            <a:off x="13589351" y="11196444"/>
            <a:ext cx="447675" cy="230504"/>
          </a:xfrm>
          <a:custGeom>
            <a:avLst/>
            <a:gdLst/>
            <a:ahLst/>
            <a:cxnLst/>
            <a:rect l="l" t="t" r="r" b="b"/>
            <a:pathLst>
              <a:path w="447675" h="230504">
                <a:moveTo>
                  <a:pt x="223829" y="230153"/>
                </a:moveTo>
                <a:lnTo>
                  <a:pt x="447659" y="115076"/>
                </a:lnTo>
                <a:lnTo>
                  <a:pt x="223829" y="0"/>
                </a:lnTo>
                <a:lnTo>
                  <a:pt x="0" y="115076"/>
                </a:lnTo>
                <a:lnTo>
                  <a:pt x="223829" y="230153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7" name="object 727"/>
          <p:cNvSpPr txBox="1"/>
          <p:nvPr/>
        </p:nvSpPr>
        <p:spPr>
          <a:xfrm>
            <a:off x="13730326" y="11275693"/>
            <a:ext cx="170180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Row =</a:t>
            </a:r>
            <a:r>
              <a:rPr sz="2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N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728" name="object 728"/>
          <p:cNvSpPr/>
          <p:nvPr/>
        </p:nvSpPr>
        <p:spPr>
          <a:xfrm>
            <a:off x="13588933" y="11920609"/>
            <a:ext cx="447675" cy="230504"/>
          </a:xfrm>
          <a:custGeom>
            <a:avLst/>
            <a:gdLst/>
            <a:ahLst/>
            <a:cxnLst/>
            <a:rect l="l" t="t" r="r" b="b"/>
            <a:pathLst>
              <a:path w="447675" h="230504">
                <a:moveTo>
                  <a:pt x="447599" y="115016"/>
                </a:moveTo>
                <a:lnTo>
                  <a:pt x="223829" y="0"/>
                </a:lnTo>
                <a:lnTo>
                  <a:pt x="0" y="115016"/>
                </a:lnTo>
                <a:lnTo>
                  <a:pt x="223829" y="230093"/>
                </a:lnTo>
                <a:lnTo>
                  <a:pt x="447599" y="115016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29" name="object 729"/>
          <p:cNvSpPr/>
          <p:nvPr/>
        </p:nvSpPr>
        <p:spPr>
          <a:xfrm>
            <a:off x="13588933" y="11920609"/>
            <a:ext cx="447675" cy="230504"/>
          </a:xfrm>
          <a:custGeom>
            <a:avLst/>
            <a:gdLst/>
            <a:ahLst/>
            <a:cxnLst/>
            <a:rect l="l" t="t" r="r" b="b"/>
            <a:pathLst>
              <a:path w="447675" h="230504">
                <a:moveTo>
                  <a:pt x="223829" y="230093"/>
                </a:moveTo>
                <a:lnTo>
                  <a:pt x="447599" y="115016"/>
                </a:lnTo>
                <a:lnTo>
                  <a:pt x="223829" y="0"/>
                </a:lnTo>
                <a:lnTo>
                  <a:pt x="0" y="115016"/>
                </a:lnTo>
                <a:lnTo>
                  <a:pt x="223829" y="230093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0" name="object 730"/>
          <p:cNvSpPr txBox="1"/>
          <p:nvPr/>
        </p:nvSpPr>
        <p:spPr>
          <a:xfrm>
            <a:off x="13729907" y="11999979"/>
            <a:ext cx="170180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Row =</a:t>
            </a:r>
            <a:r>
              <a:rPr sz="2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N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731" name="object 731"/>
          <p:cNvSpPr/>
          <p:nvPr/>
        </p:nvSpPr>
        <p:spPr>
          <a:xfrm>
            <a:off x="13958622" y="10904965"/>
            <a:ext cx="304800" cy="267335"/>
          </a:xfrm>
          <a:custGeom>
            <a:avLst/>
            <a:gdLst/>
            <a:ahLst/>
            <a:cxnLst/>
            <a:rect l="l" t="t" r="r" b="b"/>
            <a:pathLst>
              <a:path w="304800" h="267334">
                <a:moveTo>
                  <a:pt x="0" y="0"/>
                </a:moveTo>
                <a:lnTo>
                  <a:pt x="0" y="267318"/>
                </a:lnTo>
                <a:lnTo>
                  <a:pt x="304663" y="267318"/>
                </a:lnTo>
                <a:lnTo>
                  <a:pt x="304663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2" name="object 732"/>
          <p:cNvSpPr/>
          <p:nvPr/>
        </p:nvSpPr>
        <p:spPr>
          <a:xfrm>
            <a:off x="13958622" y="10904965"/>
            <a:ext cx="304800" cy="267335"/>
          </a:xfrm>
          <a:custGeom>
            <a:avLst/>
            <a:gdLst/>
            <a:ahLst/>
            <a:cxnLst/>
            <a:rect l="l" t="t" r="r" b="b"/>
            <a:pathLst>
              <a:path w="304800" h="267334">
                <a:moveTo>
                  <a:pt x="0" y="0"/>
                </a:moveTo>
                <a:lnTo>
                  <a:pt x="0" y="267318"/>
                </a:lnTo>
                <a:lnTo>
                  <a:pt x="304663" y="267318"/>
                </a:lnTo>
                <a:lnTo>
                  <a:pt x="304663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3" name="object 733"/>
          <p:cNvSpPr txBox="1"/>
          <p:nvPr/>
        </p:nvSpPr>
        <p:spPr>
          <a:xfrm>
            <a:off x="13965789" y="10909611"/>
            <a:ext cx="271780" cy="571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X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entspricht</a:t>
            </a:r>
            <a:r>
              <a:rPr sz="20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N'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;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734" name="object 734"/>
          <p:cNvSpPr txBox="1"/>
          <p:nvPr/>
        </p:nvSpPr>
        <p:spPr>
          <a:xfrm>
            <a:off x="13965789" y="10972786"/>
            <a:ext cx="213995" cy="571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200" spc="-5" dirty="0">
                <a:solidFill>
                  <a:srgbClr val="ED1F24"/>
                </a:solidFill>
                <a:latin typeface="Consolas"/>
                <a:cs typeface="Consolas"/>
              </a:rPr>
              <a:t>LETZTER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00" spc="-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spc="-5" dirty="0">
                <a:solidFill>
                  <a:srgbClr val="ED1F24"/>
                </a:solidFill>
                <a:latin typeface="Consolas"/>
                <a:cs typeface="Consolas"/>
              </a:rPr>
              <a:t>'1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735" name="object 735"/>
          <p:cNvSpPr txBox="1"/>
          <p:nvPr/>
        </p:nvSpPr>
        <p:spPr>
          <a:xfrm>
            <a:off x="13965786" y="11004404"/>
            <a:ext cx="286385" cy="889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ZWEITLETZTER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00" spc="-7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2'</a:t>
            </a:r>
            <a:endParaRPr sz="200">
              <a:latin typeface="Consolas"/>
              <a:cs typeface="Consolas"/>
            </a:endParaRPr>
          </a:p>
          <a:p>
            <a:pPr marL="12700">
              <a:lnSpc>
                <a:spcPct val="100000"/>
              </a:lnSpc>
              <a:spcBef>
                <a:spcPts val="10"/>
              </a:spcBef>
            </a:pP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DRITTLETZTER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00" spc="-7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3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736" name="object 736"/>
          <p:cNvSpPr txBox="1"/>
          <p:nvPr/>
        </p:nvSpPr>
        <p:spPr>
          <a:xfrm>
            <a:off x="13965786" y="11067522"/>
            <a:ext cx="286385" cy="571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VIERTLETZTER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0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4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737" name="object 737"/>
          <p:cNvSpPr txBox="1"/>
          <p:nvPr/>
        </p:nvSpPr>
        <p:spPr>
          <a:xfrm>
            <a:off x="13965786" y="11099197"/>
            <a:ext cx="286385" cy="5715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FUNFTLETZTER </a:t>
            </a:r>
            <a:r>
              <a:rPr sz="200" dirty="0">
                <a:solidFill>
                  <a:srgbClr val="231F20"/>
                </a:solidFill>
                <a:latin typeface="Consolas"/>
                <a:cs typeface="Consolas"/>
              </a:rPr>
              <a:t>=</a:t>
            </a:r>
            <a:r>
              <a:rPr sz="20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00" dirty="0">
                <a:solidFill>
                  <a:srgbClr val="ED1F24"/>
                </a:solidFill>
                <a:latin typeface="Consolas"/>
                <a:cs typeface="Consolas"/>
              </a:rPr>
              <a:t>'5'</a:t>
            </a:r>
            <a:endParaRPr sz="200">
              <a:latin typeface="Consolas"/>
              <a:cs typeface="Consolas"/>
            </a:endParaRPr>
          </a:p>
        </p:txBody>
      </p:sp>
      <p:sp>
        <p:nvSpPr>
          <p:cNvPr id="738" name="object 738"/>
          <p:cNvSpPr/>
          <p:nvPr/>
        </p:nvSpPr>
        <p:spPr>
          <a:xfrm>
            <a:off x="13827856" y="10976433"/>
            <a:ext cx="130810" cy="0"/>
          </a:xfrm>
          <a:custGeom>
            <a:avLst/>
            <a:gdLst/>
            <a:ahLst/>
            <a:cxnLst/>
            <a:rect l="l" t="t" r="r" b="b"/>
            <a:pathLst>
              <a:path w="130809">
                <a:moveTo>
                  <a:pt x="130766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39" name="object 739"/>
          <p:cNvSpPr/>
          <p:nvPr/>
        </p:nvSpPr>
        <p:spPr>
          <a:xfrm>
            <a:off x="13815626" y="10961161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0" name="object 740"/>
          <p:cNvSpPr/>
          <p:nvPr/>
        </p:nvSpPr>
        <p:spPr>
          <a:xfrm>
            <a:off x="10149879" y="10789942"/>
            <a:ext cx="1243965" cy="249554"/>
          </a:xfrm>
          <a:custGeom>
            <a:avLst/>
            <a:gdLst/>
            <a:ahLst/>
            <a:cxnLst/>
            <a:rect l="l" t="t" r="r" b="b"/>
            <a:pathLst>
              <a:path w="1243965" h="249554">
                <a:moveTo>
                  <a:pt x="0" y="0"/>
                </a:moveTo>
                <a:lnTo>
                  <a:pt x="0" y="249302"/>
                </a:lnTo>
                <a:lnTo>
                  <a:pt x="1243411" y="249302"/>
                </a:lnTo>
                <a:lnTo>
                  <a:pt x="1243411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1" name="object 741"/>
          <p:cNvSpPr txBox="1"/>
          <p:nvPr/>
        </p:nvSpPr>
        <p:spPr>
          <a:xfrm>
            <a:off x="10355280" y="10823430"/>
            <a:ext cx="835025" cy="17462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231775" marR="5080" indent="-219710">
              <a:lnSpc>
                <a:spcPts val="580"/>
              </a:lnSpc>
              <a:spcBef>
                <a:spcPts val="125"/>
              </a:spcBef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Algorithm: N19 Diagnosis  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Proposi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742" name="object 742"/>
          <p:cNvSpPr/>
          <p:nvPr/>
        </p:nvSpPr>
        <p:spPr>
          <a:xfrm>
            <a:off x="10200587" y="12682716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3" name="object 743"/>
          <p:cNvSpPr txBox="1"/>
          <p:nvPr/>
        </p:nvSpPr>
        <p:spPr>
          <a:xfrm>
            <a:off x="10304274" y="12704620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44" name="object 744"/>
          <p:cNvSpPr/>
          <p:nvPr/>
        </p:nvSpPr>
        <p:spPr>
          <a:xfrm>
            <a:off x="11617419" y="12682716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5" name="object 745"/>
          <p:cNvSpPr txBox="1"/>
          <p:nvPr/>
        </p:nvSpPr>
        <p:spPr>
          <a:xfrm>
            <a:off x="11721524" y="12704620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46" name="object 746"/>
          <p:cNvSpPr/>
          <p:nvPr/>
        </p:nvSpPr>
        <p:spPr>
          <a:xfrm>
            <a:off x="14362673" y="11950200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7" name="object 747"/>
          <p:cNvSpPr/>
          <p:nvPr/>
        </p:nvSpPr>
        <p:spPr>
          <a:xfrm>
            <a:off x="14362673" y="11950199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48" name="object 748"/>
          <p:cNvSpPr txBox="1"/>
          <p:nvPr/>
        </p:nvSpPr>
        <p:spPr>
          <a:xfrm>
            <a:off x="14409928" y="11972042"/>
            <a:ext cx="483234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8430" marR="5080" indent="-126364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s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  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49" name="object 749"/>
          <p:cNvSpPr/>
          <p:nvPr/>
        </p:nvSpPr>
        <p:spPr>
          <a:xfrm>
            <a:off x="14362673" y="11225855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0" name="object 750"/>
          <p:cNvSpPr/>
          <p:nvPr/>
        </p:nvSpPr>
        <p:spPr>
          <a:xfrm>
            <a:off x="14362673" y="11225855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1" name="object 751"/>
          <p:cNvSpPr txBox="1"/>
          <p:nvPr/>
        </p:nvSpPr>
        <p:spPr>
          <a:xfrm>
            <a:off x="14467138" y="11247518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52" name="object 752"/>
          <p:cNvSpPr/>
          <p:nvPr/>
        </p:nvSpPr>
        <p:spPr>
          <a:xfrm>
            <a:off x="12823487" y="11224304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3" name="object 753"/>
          <p:cNvSpPr/>
          <p:nvPr/>
        </p:nvSpPr>
        <p:spPr>
          <a:xfrm>
            <a:off x="12823487" y="11224304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4" name="object 754"/>
          <p:cNvSpPr txBox="1"/>
          <p:nvPr/>
        </p:nvSpPr>
        <p:spPr>
          <a:xfrm>
            <a:off x="12927711" y="11245967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55" name="object 755"/>
          <p:cNvSpPr/>
          <p:nvPr/>
        </p:nvSpPr>
        <p:spPr>
          <a:xfrm>
            <a:off x="12823487" y="11948648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6" name="object 756"/>
          <p:cNvSpPr/>
          <p:nvPr/>
        </p:nvSpPr>
        <p:spPr>
          <a:xfrm>
            <a:off x="12823487" y="11948648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7" name="object 757"/>
          <p:cNvSpPr txBox="1"/>
          <p:nvPr/>
        </p:nvSpPr>
        <p:spPr>
          <a:xfrm>
            <a:off x="12870502" y="11970372"/>
            <a:ext cx="483234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38430" marR="5080" indent="-126364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Dates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  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58" name="object 758"/>
          <p:cNvSpPr/>
          <p:nvPr/>
        </p:nvSpPr>
        <p:spPr>
          <a:xfrm>
            <a:off x="13031865" y="12682716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59" name="object 759"/>
          <p:cNvSpPr txBox="1"/>
          <p:nvPr/>
        </p:nvSpPr>
        <p:spPr>
          <a:xfrm>
            <a:off x="13147605" y="12704620"/>
            <a:ext cx="34798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9850" marR="5080" indent="-57785">
              <a:lnSpc>
                <a:spcPct val="1093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</a:t>
            </a:r>
            <a:r>
              <a:rPr sz="300" spc="-7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  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60" name="object 760"/>
          <p:cNvSpPr/>
          <p:nvPr/>
        </p:nvSpPr>
        <p:spPr>
          <a:xfrm>
            <a:off x="11567547" y="13313996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1" name="object 761"/>
          <p:cNvSpPr/>
          <p:nvPr/>
        </p:nvSpPr>
        <p:spPr>
          <a:xfrm>
            <a:off x="12359601" y="1361197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2" name="object 762"/>
          <p:cNvSpPr txBox="1"/>
          <p:nvPr/>
        </p:nvSpPr>
        <p:spPr>
          <a:xfrm>
            <a:off x="12452074" y="13635434"/>
            <a:ext cx="32512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Highest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63" name="object 763"/>
          <p:cNvSpPr/>
          <p:nvPr/>
        </p:nvSpPr>
        <p:spPr>
          <a:xfrm>
            <a:off x="12374276" y="13378008"/>
            <a:ext cx="480695" cy="100965"/>
          </a:xfrm>
          <a:custGeom>
            <a:avLst/>
            <a:gdLst/>
            <a:ahLst/>
            <a:cxnLst/>
            <a:rect l="l" t="t" r="r" b="b"/>
            <a:pathLst>
              <a:path w="480695" h="100965">
                <a:moveTo>
                  <a:pt x="480112" y="0"/>
                </a:moveTo>
                <a:lnTo>
                  <a:pt x="29887" y="0"/>
                </a:lnTo>
                <a:lnTo>
                  <a:pt x="0" y="100699"/>
                </a:lnTo>
                <a:lnTo>
                  <a:pt x="450224" y="100699"/>
                </a:lnTo>
                <a:lnTo>
                  <a:pt x="48011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4" name="object 764"/>
          <p:cNvSpPr/>
          <p:nvPr/>
        </p:nvSpPr>
        <p:spPr>
          <a:xfrm>
            <a:off x="12374276" y="13378008"/>
            <a:ext cx="480695" cy="100965"/>
          </a:xfrm>
          <a:custGeom>
            <a:avLst/>
            <a:gdLst/>
            <a:ahLst/>
            <a:cxnLst/>
            <a:rect l="l" t="t" r="r" b="b"/>
            <a:pathLst>
              <a:path w="480695" h="100965">
                <a:moveTo>
                  <a:pt x="0" y="100699"/>
                </a:moveTo>
                <a:lnTo>
                  <a:pt x="450224" y="100699"/>
                </a:lnTo>
                <a:lnTo>
                  <a:pt x="480112" y="0"/>
                </a:lnTo>
                <a:lnTo>
                  <a:pt x="29887" y="0"/>
                </a:lnTo>
                <a:lnTo>
                  <a:pt x="0" y="10069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5" name="object 765"/>
          <p:cNvSpPr txBox="1"/>
          <p:nvPr/>
        </p:nvSpPr>
        <p:spPr>
          <a:xfrm>
            <a:off x="12466152" y="13382443"/>
            <a:ext cx="302260" cy="7747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nd</a:t>
            </a:r>
            <a:r>
              <a:rPr sz="30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aximum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66" name="object 766"/>
          <p:cNvSpPr/>
          <p:nvPr/>
        </p:nvSpPr>
        <p:spPr>
          <a:xfrm>
            <a:off x="12182244" y="13437843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0" y="0"/>
                </a:moveTo>
                <a:lnTo>
                  <a:pt x="179862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7" name="object 767"/>
          <p:cNvSpPr/>
          <p:nvPr/>
        </p:nvSpPr>
        <p:spPr>
          <a:xfrm>
            <a:off x="12359064" y="13422571"/>
            <a:ext cx="15240" cy="31115"/>
          </a:xfrm>
          <a:custGeom>
            <a:avLst/>
            <a:gdLst/>
            <a:ahLst/>
            <a:cxnLst/>
            <a:rect l="l" t="t" r="r" b="b"/>
            <a:pathLst>
              <a:path w="15240" h="31115">
                <a:moveTo>
                  <a:pt x="15212" y="15271"/>
                </a:moveTo>
                <a:lnTo>
                  <a:pt x="0" y="0"/>
                </a:lnTo>
                <a:lnTo>
                  <a:pt x="0" y="30543"/>
                </a:lnTo>
                <a:lnTo>
                  <a:pt x="15212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8" name="object 768"/>
          <p:cNvSpPr/>
          <p:nvPr/>
        </p:nvSpPr>
        <p:spPr>
          <a:xfrm>
            <a:off x="12611767" y="13478707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104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69" name="object 769"/>
          <p:cNvSpPr/>
          <p:nvPr/>
        </p:nvSpPr>
        <p:spPr>
          <a:xfrm>
            <a:off x="12596495" y="13596647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0" name="object 770"/>
          <p:cNvSpPr/>
          <p:nvPr/>
        </p:nvSpPr>
        <p:spPr>
          <a:xfrm>
            <a:off x="11567547" y="13189554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1" name="object 771"/>
          <p:cNvSpPr/>
          <p:nvPr/>
        </p:nvSpPr>
        <p:spPr>
          <a:xfrm>
            <a:off x="11567547" y="13189554"/>
            <a:ext cx="783590" cy="121920"/>
          </a:xfrm>
          <a:custGeom>
            <a:avLst/>
            <a:gdLst/>
            <a:ahLst/>
            <a:cxnLst/>
            <a:rect l="l" t="t" r="r" b="b"/>
            <a:pathLst>
              <a:path w="783590" h="121919">
                <a:moveTo>
                  <a:pt x="0" y="0"/>
                </a:moveTo>
                <a:lnTo>
                  <a:pt x="0" y="121340"/>
                </a:lnTo>
                <a:lnTo>
                  <a:pt x="783344" y="12134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2" name="object 772"/>
          <p:cNvSpPr txBox="1"/>
          <p:nvPr/>
        </p:nvSpPr>
        <p:spPr>
          <a:xfrm>
            <a:off x="11582467" y="13184613"/>
            <a:ext cx="755015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320040" marR="5080" indent="-307975">
              <a:lnSpc>
                <a:spcPct val="115199"/>
              </a:lnSpc>
              <a:spcBef>
                <a:spcPts val="80"/>
              </a:spcBef>
            </a:pP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aximum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of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easurements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rognosis  Period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773" name="object 773"/>
          <p:cNvSpPr/>
          <p:nvPr/>
        </p:nvSpPr>
        <p:spPr>
          <a:xfrm>
            <a:off x="11643787" y="13611979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4" name="object 774"/>
          <p:cNvSpPr/>
          <p:nvPr/>
        </p:nvSpPr>
        <p:spPr>
          <a:xfrm>
            <a:off x="11643787" y="1361197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5" name="object 775"/>
          <p:cNvSpPr txBox="1"/>
          <p:nvPr/>
        </p:nvSpPr>
        <p:spPr>
          <a:xfrm>
            <a:off x="11655903" y="13608242"/>
            <a:ext cx="483234" cy="129539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72720" marR="5080" indent="-160655">
              <a:lnSpc>
                <a:spcPct val="113900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aximum in</a:t>
            </a:r>
            <a:r>
              <a:rPr sz="3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rognosis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io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76" name="object 776"/>
          <p:cNvSpPr/>
          <p:nvPr/>
        </p:nvSpPr>
        <p:spPr>
          <a:xfrm>
            <a:off x="12160349" y="13674557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251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7" name="object 777"/>
          <p:cNvSpPr/>
          <p:nvPr/>
        </p:nvSpPr>
        <p:spPr>
          <a:xfrm>
            <a:off x="12148120" y="13659285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8" name="object 778"/>
          <p:cNvSpPr/>
          <p:nvPr/>
        </p:nvSpPr>
        <p:spPr>
          <a:xfrm>
            <a:off x="11608829" y="13350805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79" name="object 779"/>
          <p:cNvSpPr txBox="1"/>
          <p:nvPr/>
        </p:nvSpPr>
        <p:spPr>
          <a:xfrm>
            <a:off x="11712815" y="13372887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80" name="object 780"/>
          <p:cNvSpPr/>
          <p:nvPr/>
        </p:nvSpPr>
        <p:spPr>
          <a:xfrm>
            <a:off x="12997443" y="13310716"/>
            <a:ext cx="1353185" cy="454025"/>
          </a:xfrm>
          <a:custGeom>
            <a:avLst/>
            <a:gdLst/>
            <a:ahLst/>
            <a:cxnLst/>
            <a:rect l="l" t="t" r="r" b="b"/>
            <a:pathLst>
              <a:path w="1353184" h="454025">
                <a:moveTo>
                  <a:pt x="0" y="0"/>
                </a:moveTo>
                <a:lnTo>
                  <a:pt x="0" y="453803"/>
                </a:lnTo>
                <a:lnTo>
                  <a:pt x="1352821" y="453803"/>
                </a:lnTo>
                <a:lnTo>
                  <a:pt x="1352821" y="0"/>
                </a:lnTo>
                <a:lnTo>
                  <a:pt x="0" y="0"/>
                </a:lnTo>
                <a:close/>
              </a:path>
            </a:pathLst>
          </a:custGeom>
          <a:ln w="6580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1" name="object 781"/>
          <p:cNvSpPr/>
          <p:nvPr/>
        </p:nvSpPr>
        <p:spPr>
          <a:xfrm>
            <a:off x="13789556" y="1360869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2" name="object 782"/>
          <p:cNvSpPr txBox="1"/>
          <p:nvPr/>
        </p:nvSpPr>
        <p:spPr>
          <a:xfrm>
            <a:off x="13893724" y="13632152"/>
            <a:ext cx="30226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Lowest</a:t>
            </a:r>
            <a:r>
              <a:rPr sz="30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83" name="object 783"/>
          <p:cNvSpPr/>
          <p:nvPr/>
        </p:nvSpPr>
        <p:spPr>
          <a:xfrm>
            <a:off x="13804292" y="13374667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479992" y="0"/>
                </a:moveTo>
                <a:lnTo>
                  <a:pt x="29887" y="0"/>
                </a:lnTo>
                <a:lnTo>
                  <a:pt x="0" y="100759"/>
                </a:lnTo>
                <a:lnTo>
                  <a:pt x="450164" y="100759"/>
                </a:lnTo>
                <a:lnTo>
                  <a:pt x="479992" y="0"/>
                </a:lnTo>
                <a:close/>
              </a:path>
            </a:pathLst>
          </a:custGeom>
          <a:solidFill>
            <a:srgbClr val="B8DDE8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4" name="object 784"/>
          <p:cNvSpPr/>
          <p:nvPr/>
        </p:nvSpPr>
        <p:spPr>
          <a:xfrm>
            <a:off x="13804292" y="13374667"/>
            <a:ext cx="480059" cy="100965"/>
          </a:xfrm>
          <a:custGeom>
            <a:avLst/>
            <a:gdLst/>
            <a:ahLst/>
            <a:cxnLst/>
            <a:rect l="l" t="t" r="r" b="b"/>
            <a:pathLst>
              <a:path w="480059" h="100965">
                <a:moveTo>
                  <a:pt x="0" y="100759"/>
                </a:moveTo>
                <a:lnTo>
                  <a:pt x="450164" y="100759"/>
                </a:lnTo>
                <a:lnTo>
                  <a:pt x="479992" y="0"/>
                </a:lnTo>
                <a:lnTo>
                  <a:pt x="29887" y="0"/>
                </a:lnTo>
                <a:lnTo>
                  <a:pt x="0" y="10075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5" name="object 785"/>
          <p:cNvSpPr txBox="1"/>
          <p:nvPr/>
        </p:nvSpPr>
        <p:spPr>
          <a:xfrm>
            <a:off x="13896348" y="13379160"/>
            <a:ext cx="302260" cy="7747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Find</a:t>
            </a:r>
            <a:r>
              <a:rPr sz="30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inimum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86" name="object 786"/>
          <p:cNvSpPr/>
          <p:nvPr/>
        </p:nvSpPr>
        <p:spPr>
          <a:xfrm>
            <a:off x="13612260" y="13434561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0" y="0"/>
                </a:moveTo>
                <a:lnTo>
                  <a:pt x="179802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7" name="object 787"/>
          <p:cNvSpPr/>
          <p:nvPr/>
        </p:nvSpPr>
        <p:spPr>
          <a:xfrm>
            <a:off x="13789020" y="13419289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15271"/>
                </a:moveTo>
                <a:lnTo>
                  <a:pt x="0" y="0"/>
                </a:lnTo>
                <a:lnTo>
                  <a:pt x="0" y="30543"/>
                </a:lnTo>
                <a:lnTo>
                  <a:pt x="15271" y="15271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8" name="object 788"/>
          <p:cNvSpPr/>
          <p:nvPr/>
        </p:nvSpPr>
        <p:spPr>
          <a:xfrm>
            <a:off x="14041724" y="13475425"/>
            <a:ext cx="0" cy="121285"/>
          </a:xfrm>
          <a:custGeom>
            <a:avLst/>
            <a:gdLst/>
            <a:ahLst/>
            <a:cxnLst/>
            <a:rect l="l" t="t" r="r" b="b"/>
            <a:pathLst>
              <a:path h="121284">
                <a:moveTo>
                  <a:pt x="0" y="0"/>
                </a:moveTo>
                <a:lnTo>
                  <a:pt x="0" y="120982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89" name="object 789"/>
          <p:cNvSpPr/>
          <p:nvPr/>
        </p:nvSpPr>
        <p:spPr>
          <a:xfrm>
            <a:off x="14026452" y="13593365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543" y="0"/>
                </a:moveTo>
                <a:lnTo>
                  <a:pt x="0" y="0"/>
                </a:lnTo>
                <a:lnTo>
                  <a:pt x="15271" y="15271"/>
                </a:lnTo>
                <a:lnTo>
                  <a:pt x="30543" y="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0" name="object 790"/>
          <p:cNvSpPr/>
          <p:nvPr/>
        </p:nvSpPr>
        <p:spPr>
          <a:xfrm>
            <a:off x="12997444" y="13186274"/>
            <a:ext cx="783590" cy="121285"/>
          </a:xfrm>
          <a:custGeom>
            <a:avLst/>
            <a:gdLst/>
            <a:ahLst/>
            <a:cxnLst/>
            <a:rect l="l" t="t" r="r" b="b"/>
            <a:pathLst>
              <a:path w="783590" h="121284">
                <a:moveTo>
                  <a:pt x="0" y="0"/>
                </a:moveTo>
                <a:lnTo>
                  <a:pt x="0" y="121280"/>
                </a:lnTo>
                <a:lnTo>
                  <a:pt x="783344" y="12128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solidFill>
            <a:srgbClr val="E971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1" name="object 791"/>
          <p:cNvSpPr/>
          <p:nvPr/>
        </p:nvSpPr>
        <p:spPr>
          <a:xfrm>
            <a:off x="12997443" y="13186272"/>
            <a:ext cx="783590" cy="121285"/>
          </a:xfrm>
          <a:custGeom>
            <a:avLst/>
            <a:gdLst/>
            <a:ahLst/>
            <a:cxnLst/>
            <a:rect l="l" t="t" r="r" b="b"/>
            <a:pathLst>
              <a:path w="783590" h="121284">
                <a:moveTo>
                  <a:pt x="0" y="0"/>
                </a:moveTo>
                <a:lnTo>
                  <a:pt x="0" y="121280"/>
                </a:lnTo>
                <a:lnTo>
                  <a:pt x="783344" y="121280"/>
                </a:lnTo>
                <a:lnTo>
                  <a:pt x="78334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2" name="object 792"/>
          <p:cNvSpPr txBox="1"/>
          <p:nvPr/>
        </p:nvSpPr>
        <p:spPr>
          <a:xfrm>
            <a:off x="13062177" y="13181333"/>
            <a:ext cx="655955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270510" marR="5080" indent="-258445">
              <a:lnSpc>
                <a:spcPct val="115199"/>
              </a:lnSpc>
              <a:spcBef>
                <a:spcPts val="80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Min. of </a:t>
            </a:r>
            <a:r>
              <a:rPr sz="300" spc="20" dirty="0">
                <a:solidFill>
                  <a:srgbClr val="231F20"/>
                </a:solidFill>
                <a:latin typeface="Calibri"/>
                <a:cs typeface="Calibri"/>
              </a:rPr>
              <a:t>Measurements</a:t>
            </a:r>
            <a:r>
              <a:rPr sz="300" spc="-5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in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Prognosis  Period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793" name="object 793"/>
          <p:cNvSpPr/>
          <p:nvPr/>
        </p:nvSpPr>
        <p:spPr>
          <a:xfrm>
            <a:off x="13073744" y="1360869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solidFill>
            <a:srgbClr val="C5D7A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4" name="object 794"/>
          <p:cNvSpPr/>
          <p:nvPr/>
        </p:nvSpPr>
        <p:spPr>
          <a:xfrm>
            <a:off x="13073744" y="13608698"/>
            <a:ext cx="504825" cy="125730"/>
          </a:xfrm>
          <a:custGeom>
            <a:avLst/>
            <a:gdLst/>
            <a:ahLst/>
            <a:cxnLst/>
            <a:rect l="l" t="t" r="r" b="b"/>
            <a:pathLst>
              <a:path w="504825" h="125730">
                <a:moveTo>
                  <a:pt x="0" y="0"/>
                </a:moveTo>
                <a:lnTo>
                  <a:pt x="0" y="125277"/>
                </a:lnTo>
                <a:lnTo>
                  <a:pt x="504332" y="125277"/>
                </a:lnTo>
                <a:lnTo>
                  <a:pt x="504332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5" name="object 795"/>
          <p:cNvSpPr txBox="1"/>
          <p:nvPr/>
        </p:nvSpPr>
        <p:spPr>
          <a:xfrm>
            <a:off x="13086159" y="13604958"/>
            <a:ext cx="483234" cy="129539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172720" marR="5080" indent="-160655">
              <a:lnSpc>
                <a:spcPct val="113900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Minimum in</a:t>
            </a:r>
            <a:r>
              <a:rPr sz="300" spc="-5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0" dirty="0">
                <a:solidFill>
                  <a:srgbClr val="231F20"/>
                </a:solidFill>
                <a:latin typeface="Consolas"/>
                <a:cs typeface="Consolas"/>
              </a:rPr>
              <a:t>Prognosis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erio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796" name="object 796"/>
          <p:cNvSpPr/>
          <p:nvPr/>
        </p:nvSpPr>
        <p:spPr>
          <a:xfrm>
            <a:off x="13590246" y="13671277"/>
            <a:ext cx="199390" cy="0"/>
          </a:xfrm>
          <a:custGeom>
            <a:avLst/>
            <a:gdLst/>
            <a:ahLst/>
            <a:cxnLst/>
            <a:rect l="l" t="t" r="r" b="b"/>
            <a:pathLst>
              <a:path w="199390">
                <a:moveTo>
                  <a:pt x="199310" y="0"/>
                </a:moveTo>
                <a:lnTo>
                  <a:pt x="0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7" name="object 797"/>
          <p:cNvSpPr/>
          <p:nvPr/>
        </p:nvSpPr>
        <p:spPr>
          <a:xfrm>
            <a:off x="13578076" y="13656005"/>
            <a:ext cx="15875" cy="31115"/>
          </a:xfrm>
          <a:custGeom>
            <a:avLst/>
            <a:gdLst/>
            <a:ahLst/>
            <a:cxnLst/>
            <a:rect l="l" t="t" r="r" b="b"/>
            <a:pathLst>
              <a:path w="15875" h="31115">
                <a:moveTo>
                  <a:pt x="15271" y="30543"/>
                </a:moveTo>
                <a:lnTo>
                  <a:pt x="15271" y="0"/>
                </a:lnTo>
                <a:lnTo>
                  <a:pt x="0" y="15271"/>
                </a:lnTo>
                <a:lnTo>
                  <a:pt x="15271" y="30543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8" name="object 798"/>
          <p:cNvSpPr/>
          <p:nvPr/>
        </p:nvSpPr>
        <p:spPr>
          <a:xfrm>
            <a:off x="13038845" y="13347523"/>
            <a:ext cx="574040" cy="174625"/>
          </a:xfrm>
          <a:custGeom>
            <a:avLst/>
            <a:gdLst/>
            <a:ahLst/>
            <a:cxnLst/>
            <a:rect l="l" t="t" r="r" b="b"/>
            <a:pathLst>
              <a:path w="574040" h="174625">
                <a:moveTo>
                  <a:pt x="0" y="0"/>
                </a:moveTo>
                <a:lnTo>
                  <a:pt x="0" y="174076"/>
                </a:lnTo>
                <a:lnTo>
                  <a:pt x="573414" y="174076"/>
                </a:lnTo>
                <a:lnTo>
                  <a:pt x="5734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99" name="object 799"/>
          <p:cNvSpPr txBox="1"/>
          <p:nvPr/>
        </p:nvSpPr>
        <p:spPr>
          <a:xfrm>
            <a:off x="13143070" y="13369607"/>
            <a:ext cx="368300" cy="12700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1280" marR="5080" indent="-69215">
              <a:lnSpc>
                <a:spcPct val="109500"/>
              </a:lnSpc>
              <a:spcBef>
                <a:spcPts val="100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eGFR Values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5" dirty="0">
                <a:solidFill>
                  <a:srgbClr val="231F20"/>
                </a:solidFill>
                <a:latin typeface="Consolas"/>
                <a:cs typeface="Consolas"/>
              </a:rPr>
              <a:t>per 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ID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800" name="object 800"/>
          <p:cNvSpPr/>
          <p:nvPr/>
        </p:nvSpPr>
        <p:spPr>
          <a:xfrm>
            <a:off x="10055623" y="10562300"/>
            <a:ext cx="5912485" cy="3311525"/>
          </a:xfrm>
          <a:custGeom>
            <a:avLst/>
            <a:gdLst/>
            <a:ahLst/>
            <a:cxnLst/>
            <a:rect l="l" t="t" r="r" b="b"/>
            <a:pathLst>
              <a:path w="5912484" h="3311525">
                <a:moveTo>
                  <a:pt x="0" y="3311210"/>
                </a:moveTo>
                <a:lnTo>
                  <a:pt x="5912216" y="3311210"/>
                </a:lnTo>
                <a:lnTo>
                  <a:pt x="5912216" y="0"/>
                </a:lnTo>
                <a:lnTo>
                  <a:pt x="0" y="0"/>
                </a:lnTo>
                <a:lnTo>
                  <a:pt x="0" y="3311210"/>
                </a:lnTo>
                <a:close/>
              </a:path>
            </a:pathLst>
          </a:custGeom>
          <a:ln w="17544">
            <a:solidFill>
              <a:srgbClr val="231F20"/>
            </a:solidFill>
            <a:prstDash val="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1" name="object 801"/>
          <p:cNvSpPr/>
          <p:nvPr/>
        </p:nvSpPr>
        <p:spPr>
          <a:xfrm>
            <a:off x="9402091" y="249827"/>
            <a:ext cx="7040880" cy="13833475"/>
          </a:xfrm>
          <a:custGeom>
            <a:avLst/>
            <a:gdLst/>
            <a:ahLst/>
            <a:cxnLst/>
            <a:rect l="l" t="t" r="r" b="b"/>
            <a:pathLst>
              <a:path w="7040880" h="13833475">
                <a:moveTo>
                  <a:pt x="0" y="0"/>
                </a:moveTo>
                <a:lnTo>
                  <a:pt x="0" y="13833249"/>
                </a:lnTo>
                <a:lnTo>
                  <a:pt x="7040736" y="13833249"/>
                </a:lnTo>
                <a:lnTo>
                  <a:pt x="7040736" y="0"/>
                </a:lnTo>
                <a:lnTo>
                  <a:pt x="0" y="0"/>
                </a:lnTo>
                <a:close/>
              </a:path>
            </a:pathLst>
          </a:custGeom>
          <a:ln w="17544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2" name="object 802"/>
          <p:cNvSpPr/>
          <p:nvPr/>
        </p:nvSpPr>
        <p:spPr>
          <a:xfrm>
            <a:off x="5240667" y="2930241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69">
                <a:moveTo>
                  <a:pt x="520069" y="133701"/>
                </a:moveTo>
                <a:lnTo>
                  <a:pt x="260034" y="0"/>
                </a:lnTo>
                <a:lnTo>
                  <a:pt x="0" y="133701"/>
                </a:lnTo>
                <a:lnTo>
                  <a:pt x="260034" y="267360"/>
                </a:lnTo>
                <a:lnTo>
                  <a:pt x="520069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3" name="object 803"/>
          <p:cNvSpPr/>
          <p:nvPr/>
        </p:nvSpPr>
        <p:spPr>
          <a:xfrm>
            <a:off x="5240667" y="2930241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69">
                <a:moveTo>
                  <a:pt x="260034" y="267360"/>
                </a:moveTo>
                <a:lnTo>
                  <a:pt x="520069" y="133701"/>
                </a:lnTo>
                <a:lnTo>
                  <a:pt x="260034" y="0"/>
                </a:lnTo>
                <a:lnTo>
                  <a:pt x="0" y="133701"/>
                </a:lnTo>
                <a:lnTo>
                  <a:pt x="260034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4" name="object 804"/>
          <p:cNvSpPr/>
          <p:nvPr/>
        </p:nvSpPr>
        <p:spPr>
          <a:xfrm>
            <a:off x="4977470" y="306714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75" y="133701"/>
                </a:moveTo>
                <a:lnTo>
                  <a:pt x="260034" y="0"/>
                </a:lnTo>
                <a:lnTo>
                  <a:pt x="0" y="133701"/>
                </a:lnTo>
                <a:lnTo>
                  <a:pt x="260034" y="267360"/>
                </a:lnTo>
                <a:lnTo>
                  <a:pt x="520075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5" name="object 805"/>
          <p:cNvSpPr/>
          <p:nvPr/>
        </p:nvSpPr>
        <p:spPr>
          <a:xfrm>
            <a:off x="4977470" y="3067145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34" y="267360"/>
                </a:moveTo>
                <a:lnTo>
                  <a:pt x="520075" y="133701"/>
                </a:lnTo>
                <a:lnTo>
                  <a:pt x="260034" y="0"/>
                </a:lnTo>
                <a:lnTo>
                  <a:pt x="0" y="133701"/>
                </a:lnTo>
                <a:lnTo>
                  <a:pt x="260034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6" name="object 806"/>
          <p:cNvSpPr/>
          <p:nvPr/>
        </p:nvSpPr>
        <p:spPr>
          <a:xfrm>
            <a:off x="5241192" y="3203000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5">
                <a:moveTo>
                  <a:pt x="520069" y="133653"/>
                </a:moveTo>
                <a:lnTo>
                  <a:pt x="260034" y="0"/>
                </a:lnTo>
                <a:lnTo>
                  <a:pt x="0" y="133653"/>
                </a:lnTo>
                <a:lnTo>
                  <a:pt x="260034" y="267312"/>
                </a:lnTo>
                <a:lnTo>
                  <a:pt x="520069" y="133653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7" name="object 807"/>
          <p:cNvSpPr/>
          <p:nvPr/>
        </p:nvSpPr>
        <p:spPr>
          <a:xfrm>
            <a:off x="5241192" y="3203000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5">
                <a:moveTo>
                  <a:pt x="260034" y="267312"/>
                </a:moveTo>
                <a:lnTo>
                  <a:pt x="520069" y="133653"/>
                </a:lnTo>
                <a:lnTo>
                  <a:pt x="260034" y="0"/>
                </a:lnTo>
                <a:lnTo>
                  <a:pt x="0" y="133653"/>
                </a:lnTo>
                <a:lnTo>
                  <a:pt x="260034" y="267312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8" name="object 808"/>
          <p:cNvSpPr/>
          <p:nvPr/>
        </p:nvSpPr>
        <p:spPr>
          <a:xfrm>
            <a:off x="4713970" y="3203000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5">
                <a:moveTo>
                  <a:pt x="520069" y="133653"/>
                </a:moveTo>
                <a:lnTo>
                  <a:pt x="260034" y="0"/>
                </a:lnTo>
                <a:lnTo>
                  <a:pt x="0" y="133653"/>
                </a:lnTo>
                <a:lnTo>
                  <a:pt x="260034" y="267312"/>
                </a:lnTo>
                <a:lnTo>
                  <a:pt x="520069" y="133653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09" name="object 809"/>
          <p:cNvSpPr/>
          <p:nvPr/>
        </p:nvSpPr>
        <p:spPr>
          <a:xfrm>
            <a:off x="4713970" y="3203000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5">
                <a:moveTo>
                  <a:pt x="260034" y="267312"/>
                </a:moveTo>
                <a:lnTo>
                  <a:pt x="520069" y="133653"/>
                </a:lnTo>
                <a:lnTo>
                  <a:pt x="260034" y="0"/>
                </a:lnTo>
                <a:lnTo>
                  <a:pt x="0" y="133653"/>
                </a:lnTo>
                <a:lnTo>
                  <a:pt x="260034" y="267312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0" name="object 810"/>
          <p:cNvSpPr txBox="1"/>
          <p:nvPr/>
        </p:nvSpPr>
        <p:spPr>
          <a:xfrm>
            <a:off x="4724208" y="3271169"/>
            <a:ext cx="920115" cy="126364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35"/>
              </a:spcBef>
              <a:tabLst>
                <a:tab pos="674370" algn="l"/>
              </a:tabLst>
            </a:pP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FID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oesn’t begin</a:t>
            </a:r>
            <a:r>
              <a:rPr sz="250" spc="2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with	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ANALYSE</a:t>
            </a:r>
            <a:r>
              <a:rPr sz="300" spc="-3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949698"/>
                </a:solidFill>
                <a:latin typeface="Consolas"/>
                <a:cs typeface="Consolas"/>
              </a:rPr>
              <a:t>=</a:t>
            </a:r>
            <a:endParaRPr sz="300">
              <a:latin typeface="Consolas"/>
              <a:cs typeface="Consolas"/>
            </a:endParaRPr>
          </a:p>
          <a:p>
            <a:pPr marL="230504">
              <a:lnSpc>
                <a:spcPct val="100000"/>
              </a:lnSpc>
              <a:spcBef>
                <a:spcPts val="25"/>
              </a:spcBef>
              <a:tabLst>
                <a:tab pos="731520" algn="l"/>
              </a:tabLst>
            </a:pPr>
            <a:r>
              <a:rPr sz="375" spc="22" baseline="11111" dirty="0">
                <a:solidFill>
                  <a:srgbClr val="ED1F24"/>
                </a:solidFill>
                <a:latin typeface="Consolas"/>
                <a:cs typeface="Consolas"/>
              </a:rPr>
              <a:t>'E'	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53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811" name="object 811"/>
          <p:cNvSpPr/>
          <p:nvPr/>
        </p:nvSpPr>
        <p:spPr>
          <a:xfrm>
            <a:off x="4714936" y="2930378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69">
                <a:moveTo>
                  <a:pt x="520028" y="133659"/>
                </a:moveTo>
                <a:lnTo>
                  <a:pt x="260034" y="0"/>
                </a:lnTo>
                <a:lnTo>
                  <a:pt x="0" y="133659"/>
                </a:lnTo>
                <a:lnTo>
                  <a:pt x="260034" y="267360"/>
                </a:lnTo>
                <a:lnTo>
                  <a:pt x="520028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2" name="object 812"/>
          <p:cNvSpPr/>
          <p:nvPr/>
        </p:nvSpPr>
        <p:spPr>
          <a:xfrm>
            <a:off x="4714936" y="2930378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69">
                <a:moveTo>
                  <a:pt x="260034" y="267360"/>
                </a:moveTo>
                <a:lnTo>
                  <a:pt x="520028" y="133659"/>
                </a:lnTo>
                <a:lnTo>
                  <a:pt x="260034" y="0"/>
                </a:lnTo>
                <a:lnTo>
                  <a:pt x="0" y="133659"/>
                </a:lnTo>
                <a:lnTo>
                  <a:pt x="260034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3" name="object 813"/>
          <p:cNvSpPr txBox="1"/>
          <p:nvPr/>
        </p:nvSpPr>
        <p:spPr>
          <a:xfrm>
            <a:off x="4740790" y="3005230"/>
            <a:ext cx="948690" cy="227329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R="5080" algn="r">
              <a:lnSpc>
                <a:spcPct val="100000"/>
              </a:lnSpc>
              <a:spcBef>
                <a:spcPts val="135"/>
              </a:spcBef>
              <a:tabLst>
                <a:tab pos="574040" algn="l"/>
              </a:tabLst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Entry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Date –</a:t>
            </a:r>
            <a:r>
              <a:rPr sz="250" spc="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 Date	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is 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of</a:t>
            </a:r>
            <a:r>
              <a:rPr sz="25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Type</a:t>
            </a:r>
            <a:endParaRPr sz="250">
              <a:latin typeface="Consolas"/>
              <a:cs typeface="Consolas"/>
            </a:endParaRPr>
          </a:p>
          <a:p>
            <a:pPr marR="5080" algn="r">
              <a:lnSpc>
                <a:spcPct val="100000"/>
              </a:lnSpc>
              <a:spcBef>
                <a:spcPts val="30"/>
              </a:spcBef>
              <a:tabLst>
                <a:tab pos="448309" algn="l"/>
              </a:tabLst>
            </a:pP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lt;=</a:t>
            </a:r>
            <a:r>
              <a:rPr sz="250" spc="5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30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Days	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Standard</a:t>
            </a:r>
            <a:r>
              <a:rPr sz="250" spc="-55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Patient'</a:t>
            </a:r>
            <a:endParaRPr sz="250">
              <a:latin typeface="Consolas"/>
              <a:cs typeface="Consolas"/>
            </a:endParaRPr>
          </a:p>
          <a:p>
            <a:pPr>
              <a:lnSpc>
                <a:spcPct val="100000"/>
              </a:lnSpc>
            </a:pPr>
            <a:endParaRPr sz="300">
              <a:latin typeface="Consolas"/>
              <a:cs typeface="Consolas"/>
            </a:endParaRPr>
          </a:p>
          <a:p>
            <a:pPr marL="284480">
              <a:lnSpc>
                <a:spcPct val="100000"/>
              </a:lnSpc>
              <a:spcBef>
                <a:spcPts val="26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 Status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aktiv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14" name="object 814"/>
          <p:cNvSpPr/>
          <p:nvPr/>
        </p:nvSpPr>
        <p:spPr>
          <a:xfrm>
            <a:off x="4687780" y="2923219"/>
            <a:ext cx="1099185" cy="560070"/>
          </a:xfrm>
          <a:custGeom>
            <a:avLst/>
            <a:gdLst/>
            <a:ahLst/>
            <a:cxnLst/>
            <a:rect l="l" t="t" r="r" b="b"/>
            <a:pathLst>
              <a:path w="1099185" h="560070">
                <a:moveTo>
                  <a:pt x="0" y="0"/>
                </a:moveTo>
                <a:lnTo>
                  <a:pt x="0" y="559556"/>
                </a:lnTo>
                <a:lnTo>
                  <a:pt x="1098793" y="559556"/>
                </a:lnTo>
                <a:lnTo>
                  <a:pt x="1098793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5" name="object 815"/>
          <p:cNvSpPr/>
          <p:nvPr/>
        </p:nvSpPr>
        <p:spPr>
          <a:xfrm>
            <a:off x="5241765" y="790318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520069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lnTo>
                  <a:pt x="520069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6" name="object 816"/>
          <p:cNvSpPr/>
          <p:nvPr/>
        </p:nvSpPr>
        <p:spPr>
          <a:xfrm>
            <a:off x="5241765" y="7903184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260034" y="267378"/>
                </a:moveTo>
                <a:lnTo>
                  <a:pt x="520069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7" name="object 817"/>
          <p:cNvSpPr txBox="1"/>
          <p:nvPr/>
        </p:nvSpPr>
        <p:spPr>
          <a:xfrm>
            <a:off x="5316138" y="7979156"/>
            <a:ext cx="374650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112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is 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of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Type 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Standard</a:t>
            </a:r>
            <a:r>
              <a:rPr sz="250" spc="-35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Patient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18" name="object 818"/>
          <p:cNvSpPr/>
          <p:nvPr/>
        </p:nvSpPr>
        <p:spPr>
          <a:xfrm>
            <a:off x="4978568" y="8040094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520069" y="133629"/>
                </a:move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lnTo>
                  <a:pt x="520069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19" name="object 819"/>
          <p:cNvSpPr/>
          <p:nvPr/>
        </p:nvSpPr>
        <p:spPr>
          <a:xfrm>
            <a:off x="4978568" y="8040095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260034" y="267318"/>
                </a:moveTo>
                <a:lnTo>
                  <a:pt x="520069" y="133629"/>
                </a:ln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0" name="object 820"/>
          <p:cNvSpPr txBox="1"/>
          <p:nvPr/>
        </p:nvSpPr>
        <p:spPr>
          <a:xfrm>
            <a:off x="5066054" y="8106384"/>
            <a:ext cx="347980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92710" marR="5080" indent="-80645">
              <a:lnSpc>
                <a:spcPct val="113599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Patient</a:t>
            </a:r>
            <a:r>
              <a:rPr sz="300" spc="-7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Status 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aktiv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821" name="object 821"/>
          <p:cNvSpPr/>
          <p:nvPr/>
        </p:nvSpPr>
        <p:spPr>
          <a:xfrm>
            <a:off x="5241454" y="817676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75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lnTo>
                  <a:pt x="520075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2" name="object 822"/>
          <p:cNvSpPr/>
          <p:nvPr/>
        </p:nvSpPr>
        <p:spPr>
          <a:xfrm>
            <a:off x="5241454" y="817676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34" y="267318"/>
                </a:moveTo>
                <a:lnTo>
                  <a:pt x="520075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3" name="object 823"/>
          <p:cNvSpPr txBox="1"/>
          <p:nvPr/>
        </p:nvSpPr>
        <p:spPr>
          <a:xfrm>
            <a:off x="5386318" y="8243056"/>
            <a:ext cx="232410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69850" marR="5080" indent="-57785">
              <a:lnSpc>
                <a:spcPct val="113599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ANALYSE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949698"/>
                </a:solidFill>
                <a:latin typeface="Consolas"/>
                <a:cs typeface="Consolas"/>
              </a:rPr>
              <a:t>= 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64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824" name="object 824"/>
          <p:cNvSpPr/>
          <p:nvPr/>
        </p:nvSpPr>
        <p:spPr>
          <a:xfrm>
            <a:off x="4714232" y="817676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75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lnTo>
                  <a:pt x="520075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5" name="object 825"/>
          <p:cNvSpPr/>
          <p:nvPr/>
        </p:nvSpPr>
        <p:spPr>
          <a:xfrm>
            <a:off x="4714232" y="817676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34" y="267318"/>
                </a:moveTo>
                <a:lnTo>
                  <a:pt x="520075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6" name="object 826"/>
          <p:cNvSpPr txBox="1"/>
          <p:nvPr/>
        </p:nvSpPr>
        <p:spPr>
          <a:xfrm>
            <a:off x="4720830" y="8274096"/>
            <a:ext cx="508634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FID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oesn’t begin</a:t>
            </a:r>
            <a:r>
              <a:rPr sz="250" spc="-4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with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E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27" name="object 827"/>
          <p:cNvSpPr/>
          <p:nvPr/>
        </p:nvSpPr>
        <p:spPr>
          <a:xfrm>
            <a:off x="4715199" y="7903303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520069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lnTo>
                  <a:pt x="520069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8" name="object 828"/>
          <p:cNvSpPr/>
          <p:nvPr/>
        </p:nvSpPr>
        <p:spPr>
          <a:xfrm>
            <a:off x="4715199" y="7903303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260034" y="267378"/>
                </a:moveTo>
                <a:lnTo>
                  <a:pt x="520069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29" name="object 829"/>
          <p:cNvSpPr txBox="1"/>
          <p:nvPr/>
        </p:nvSpPr>
        <p:spPr>
          <a:xfrm>
            <a:off x="4741143" y="7979334"/>
            <a:ext cx="470534" cy="11112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35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Entry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Date –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250" spc="-6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ate</a:t>
            </a:r>
            <a:endParaRPr sz="250">
              <a:latin typeface="Consolas"/>
              <a:cs typeface="Consolas"/>
            </a:endParaRPr>
          </a:p>
          <a:p>
            <a:pPr marL="635" algn="ctr">
              <a:lnSpc>
                <a:spcPct val="100000"/>
              </a:lnSpc>
              <a:spcBef>
                <a:spcPts val="30"/>
              </a:spcBef>
            </a:pP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lt;=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365</a:t>
            </a:r>
            <a:r>
              <a:rPr sz="250" spc="-3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Days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30" name="object 830"/>
          <p:cNvSpPr/>
          <p:nvPr/>
        </p:nvSpPr>
        <p:spPr>
          <a:xfrm>
            <a:off x="4688043" y="7896979"/>
            <a:ext cx="1098550" cy="560070"/>
          </a:xfrm>
          <a:custGeom>
            <a:avLst/>
            <a:gdLst/>
            <a:ahLst/>
            <a:cxnLst/>
            <a:rect l="l" t="t" r="r" b="b"/>
            <a:pathLst>
              <a:path w="1098550" h="560070">
                <a:moveTo>
                  <a:pt x="0" y="0"/>
                </a:moveTo>
                <a:lnTo>
                  <a:pt x="0" y="559574"/>
                </a:lnTo>
                <a:lnTo>
                  <a:pt x="1098489" y="559574"/>
                </a:lnTo>
                <a:lnTo>
                  <a:pt x="1098489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1" name="object 831"/>
          <p:cNvSpPr/>
          <p:nvPr/>
        </p:nvSpPr>
        <p:spPr>
          <a:xfrm>
            <a:off x="5241765" y="11913331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520069" y="133629"/>
                </a:move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lnTo>
                  <a:pt x="520069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2" name="object 832"/>
          <p:cNvSpPr/>
          <p:nvPr/>
        </p:nvSpPr>
        <p:spPr>
          <a:xfrm>
            <a:off x="5241765" y="11913331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260034" y="267318"/>
                </a:moveTo>
                <a:lnTo>
                  <a:pt x="520069" y="133629"/>
                </a:ln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3" name="object 833"/>
          <p:cNvSpPr txBox="1"/>
          <p:nvPr/>
        </p:nvSpPr>
        <p:spPr>
          <a:xfrm>
            <a:off x="5316138" y="11990136"/>
            <a:ext cx="374650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>
              <a:lnSpc>
                <a:spcPct val="1112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is 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of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Type 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Standard</a:t>
            </a:r>
            <a:r>
              <a:rPr sz="250" spc="-35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Patient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34" name="object 834"/>
          <p:cNvSpPr/>
          <p:nvPr/>
        </p:nvSpPr>
        <p:spPr>
          <a:xfrm>
            <a:off x="4978568" y="12050183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520069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lnTo>
                  <a:pt x="520069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5" name="object 835"/>
          <p:cNvSpPr/>
          <p:nvPr/>
        </p:nvSpPr>
        <p:spPr>
          <a:xfrm>
            <a:off x="4978568" y="12050183"/>
            <a:ext cx="520065" cy="267335"/>
          </a:xfrm>
          <a:custGeom>
            <a:avLst/>
            <a:gdLst/>
            <a:ahLst/>
            <a:cxnLst/>
            <a:rect l="l" t="t" r="r" b="b"/>
            <a:pathLst>
              <a:path w="520064" h="267334">
                <a:moveTo>
                  <a:pt x="260034" y="267318"/>
                </a:moveTo>
                <a:lnTo>
                  <a:pt x="520069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6" name="object 836"/>
          <p:cNvSpPr txBox="1"/>
          <p:nvPr/>
        </p:nvSpPr>
        <p:spPr>
          <a:xfrm>
            <a:off x="5091414" y="12126938"/>
            <a:ext cx="295275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80010" marR="5080" indent="-67945">
              <a:lnSpc>
                <a:spcPct val="1113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</a:t>
            </a:r>
            <a:r>
              <a:rPr sz="250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status 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aktiv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37" name="object 837"/>
          <p:cNvSpPr/>
          <p:nvPr/>
        </p:nvSpPr>
        <p:spPr>
          <a:xfrm>
            <a:off x="5241454" y="1218685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75" y="133629"/>
                </a:move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lnTo>
                  <a:pt x="520075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8" name="object 838"/>
          <p:cNvSpPr/>
          <p:nvPr/>
        </p:nvSpPr>
        <p:spPr>
          <a:xfrm>
            <a:off x="5241454" y="1218685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34" y="267318"/>
                </a:moveTo>
                <a:lnTo>
                  <a:pt x="520075" y="133629"/>
                </a:ln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39" name="object 839"/>
          <p:cNvSpPr txBox="1"/>
          <p:nvPr/>
        </p:nvSpPr>
        <p:spPr>
          <a:xfrm>
            <a:off x="5386318" y="12254035"/>
            <a:ext cx="232410" cy="128905"/>
          </a:xfrm>
          <a:prstGeom prst="rect">
            <a:avLst/>
          </a:prstGeom>
        </p:spPr>
        <p:txBody>
          <a:bodyPr vert="horz" wrap="square" lIns="0" tIns="10795" rIns="0" bIns="0" rtlCol="0">
            <a:spAutoFit/>
          </a:bodyPr>
          <a:lstStyle/>
          <a:p>
            <a:pPr marL="69850" marR="5080" indent="-57785">
              <a:lnSpc>
                <a:spcPct val="113500"/>
              </a:lnSpc>
              <a:spcBef>
                <a:spcPts val="85"/>
              </a:spcBef>
            </a:pPr>
            <a:r>
              <a:rPr sz="300" spc="15" dirty="0">
                <a:solidFill>
                  <a:srgbClr val="231F20"/>
                </a:solidFill>
                <a:latin typeface="Consolas"/>
                <a:cs typeface="Consolas"/>
              </a:rPr>
              <a:t>ANALYSE</a:t>
            </a:r>
            <a:r>
              <a:rPr sz="30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300" spc="20" dirty="0">
                <a:solidFill>
                  <a:srgbClr val="949698"/>
                </a:solidFill>
                <a:latin typeface="Consolas"/>
                <a:cs typeface="Consolas"/>
              </a:rPr>
              <a:t>=  </a:t>
            </a:r>
            <a:r>
              <a:rPr sz="300" spc="15" dirty="0">
                <a:solidFill>
                  <a:srgbClr val="ED1F24"/>
                </a:solidFill>
                <a:latin typeface="Consolas"/>
                <a:cs typeface="Consolas"/>
              </a:rPr>
              <a:t>'64'</a:t>
            </a:r>
            <a:endParaRPr sz="300">
              <a:latin typeface="Consolas"/>
              <a:cs typeface="Consolas"/>
            </a:endParaRPr>
          </a:p>
        </p:txBody>
      </p:sp>
      <p:sp>
        <p:nvSpPr>
          <p:cNvPr id="840" name="object 840"/>
          <p:cNvSpPr/>
          <p:nvPr/>
        </p:nvSpPr>
        <p:spPr>
          <a:xfrm>
            <a:off x="4714232" y="1218685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75" y="133629"/>
                </a:move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lnTo>
                  <a:pt x="520075" y="13362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1" name="object 841"/>
          <p:cNvSpPr/>
          <p:nvPr/>
        </p:nvSpPr>
        <p:spPr>
          <a:xfrm>
            <a:off x="4714232" y="1218685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34" y="267318"/>
                </a:moveTo>
                <a:lnTo>
                  <a:pt x="520075" y="133629"/>
                </a:lnTo>
                <a:lnTo>
                  <a:pt x="260034" y="0"/>
                </a:lnTo>
                <a:lnTo>
                  <a:pt x="0" y="133629"/>
                </a:lnTo>
                <a:lnTo>
                  <a:pt x="260034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2" name="object 842"/>
          <p:cNvSpPr txBox="1"/>
          <p:nvPr/>
        </p:nvSpPr>
        <p:spPr>
          <a:xfrm>
            <a:off x="4749828" y="12263778"/>
            <a:ext cx="452120" cy="1111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95580" marR="5080" indent="-183515">
              <a:lnSpc>
                <a:spcPct val="111000"/>
              </a:lnSpc>
              <a:spcBef>
                <a:spcPts val="100"/>
              </a:spcBef>
            </a:pP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FID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oesn’t begin with 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E'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43" name="object 843"/>
          <p:cNvSpPr/>
          <p:nvPr/>
        </p:nvSpPr>
        <p:spPr>
          <a:xfrm>
            <a:off x="4715199" y="11913391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520069" y="133689"/>
                </a:move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lnTo>
                  <a:pt x="520069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4" name="object 844"/>
          <p:cNvSpPr/>
          <p:nvPr/>
        </p:nvSpPr>
        <p:spPr>
          <a:xfrm>
            <a:off x="4715199" y="11913391"/>
            <a:ext cx="520065" cy="267970"/>
          </a:xfrm>
          <a:custGeom>
            <a:avLst/>
            <a:gdLst/>
            <a:ahLst/>
            <a:cxnLst/>
            <a:rect l="l" t="t" r="r" b="b"/>
            <a:pathLst>
              <a:path w="520064" h="267970">
                <a:moveTo>
                  <a:pt x="260034" y="267378"/>
                </a:moveTo>
                <a:lnTo>
                  <a:pt x="520069" y="133689"/>
                </a:lnTo>
                <a:lnTo>
                  <a:pt x="260034" y="0"/>
                </a:lnTo>
                <a:lnTo>
                  <a:pt x="0" y="133689"/>
                </a:lnTo>
                <a:lnTo>
                  <a:pt x="260034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5" name="object 845"/>
          <p:cNvSpPr txBox="1"/>
          <p:nvPr/>
        </p:nvSpPr>
        <p:spPr>
          <a:xfrm>
            <a:off x="4750795" y="11969197"/>
            <a:ext cx="449580" cy="1536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ctr">
              <a:lnSpc>
                <a:spcPct val="1105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Admission </a:t>
            </a:r>
            <a:r>
              <a:rPr sz="250" spc="5" dirty="0">
                <a:solidFill>
                  <a:srgbClr val="231F20"/>
                </a:solidFill>
                <a:latin typeface="Consolas"/>
                <a:cs typeface="Consolas"/>
              </a:rPr>
              <a:t>Date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–</a:t>
            </a:r>
            <a:r>
              <a:rPr sz="250" spc="-4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 Date</a:t>
            </a:r>
            <a:endParaRPr sz="250">
              <a:latin typeface="Consolas"/>
              <a:cs typeface="Consolas"/>
            </a:endParaRPr>
          </a:p>
          <a:p>
            <a:pPr marL="2540" algn="ctr">
              <a:lnSpc>
                <a:spcPct val="100000"/>
              </a:lnSpc>
              <a:spcBef>
                <a:spcPts val="35"/>
              </a:spcBef>
            </a:pP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lt;=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365</a:t>
            </a:r>
            <a:r>
              <a:rPr sz="250" spc="-3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Tage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46" name="object 846"/>
          <p:cNvSpPr/>
          <p:nvPr/>
        </p:nvSpPr>
        <p:spPr>
          <a:xfrm>
            <a:off x="4688043" y="11907067"/>
            <a:ext cx="1098550" cy="560070"/>
          </a:xfrm>
          <a:custGeom>
            <a:avLst/>
            <a:gdLst/>
            <a:ahLst/>
            <a:cxnLst/>
            <a:rect l="l" t="t" r="r" b="b"/>
            <a:pathLst>
              <a:path w="1098550" h="560070">
                <a:moveTo>
                  <a:pt x="0" y="0"/>
                </a:moveTo>
                <a:lnTo>
                  <a:pt x="0" y="559574"/>
                </a:lnTo>
                <a:lnTo>
                  <a:pt x="1098489" y="559574"/>
                </a:lnTo>
                <a:lnTo>
                  <a:pt x="1098489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7" name="object 847"/>
          <p:cNvSpPr/>
          <p:nvPr/>
        </p:nvSpPr>
        <p:spPr>
          <a:xfrm>
            <a:off x="8322906" y="279960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520081" y="133659"/>
                </a:move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lnTo>
                  <a:pt x="520081" y="13365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8" name="object 848"/>
          <p:cNvSpPr/>
          <p:nvPr/>
        </p:nvSpPr>
        <p:spPr>
          <a:xfrm>
            <a:off x="8322906" y="2799606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5">
                <a:moveTo>
                  <a:pt x="260040" y="267318"/>
                </a:moveTo>
                <a:lnTo>
                  <a:pt x="520081" y="133659"/>
                </a:lnTo>
                <a:lnTo>
                  <a:pt x="260040" y="0"/>
                </a:lnTo>
                <a:lnTo>
                  <a:pt x="0" y="13365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49" name="object 849"/>
          <p:cNvSpPr txBox="1"/>
          <p:nvPr/>
        </p:nvSpPr>
        <p:spPr>
          <a:xfrm>
            <a:off x="8339917" y="2874422"/>
            <a:ext cx="489584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99060" marR="5080" indent="-86995">
              <a:lnSpc>
                <a:spcPct val="1111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Creatinine Values Belong 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to </a:t>
            </a:r>
            <a:r>
              <a:rPr sz="250" spc="5" dirty="0">
                <a:solidFill>
                  <a:srgbClr val="231F20"/>
                </a:solidFill>
                <a:latin typeface="Consolas"/>
                <a:cs typeface="Consolas"/>
              </a:rPr>
              <a:t>Same</a:t>
            </a:r>
            <a:r>
              <a:rPr sz="250" spc="-1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Patient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50" name="object 850"/>
          <p:cNvSpPr/>
          <p:nvPr/>
        </p:nvSpPr>
        <p:spPr>
          <a:xfrm>
            <a:off x="8322906" y="3067981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81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1" name="object 851"/>
          <p:cNvSpPr/>
          <p:nvPr/>
        </p:nvSpPr>
        <p:spPr>
          <a:xfrm>
            <a:off x="8322906" y="3067981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2" name="object 852"/>
          <p:cNvSpPr txBox="1"/>
          <p:nvPr/>
        </p:nvSpPr>
        <p:spPr>
          <a:xfrm>
            <a:off x="8330252" y="3142881"/>
            <a:ext cx="509270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243840" marR="5080" indent="-231775">
              <a:lnSpc>
                <a:spcPct val="111100"/>
              </a:lnSpc>
              <a:spcBef>
                <a:spcPts val="100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Date 1 </a:t>
            </a: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lt;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25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ate  </a:t>
            </a:r>
            <a:r>
              <a:rPr sz="2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2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53" name="object 853"/>
          <p:cNvSpPr/>
          <p:nvPr/>
        </p:nvSpPr>
        <p:spPr>
          <a:xfrm>
            <a:off x="8322906" y="2796975"/>
            <a:ext cx="523240" cy="810260"/>
          </a:xfrm>
          <a:custGeom>
            <a:avLst/>
            <a:gdLst/>
            <a:ahLst/>
            <a:cxnLst/>
            <a:rect l="l" t="t" r="r" b="b"/>
            <a:pathLst>
              <a:path w="523240" h="810260">
                <a:moveTo>
                  <a:pt x="0" y="0"/>
                </a:moveTo>
                <a:lnTo>
                  <a:pt x="0" y="810111"/>
                </a:lnTo>
                <a:lnTo>
                  <a:pt x="522885" y="810111"/>
                </a:lnTo>
                <a:lnTo>
                  <a:pt x="5228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4" name="object 854"/>
          <p:cNvSpPr/>
          <p:nvPr/>
        </p:nvSpPr>
        <p:spPr>
          <a:xfrm>
            <a:off x="8322906" y="3335741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01"/>
                </a:move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lnTo>
                  <a:pt x="520081" y="133701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5" name="object 855"/>
          <p:cNvSpPr/>
          <p:nvPr/>
        </p:nvSpPr>
        <p:spPr>
          <a:xfrm>
            <a:off x="8322906" y="3335741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60"/>
                </a:moveTo>
                <a:lnTo>
                  <a:pt x="520081" y="133701"/>
                </a:lnTo>
                <a:lnTo>
                  <a:pt x="260040" y="0"/>
                </a:lnTo>
                <a:lnTo>
                  <a:pt x="0" y="133701"/>
                </a:lnTo>
                <a:lnTo>
                  <a:pt x="260040" y="26736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6" name="object 856"/>
          <p:cNvSpPr txBox="1"/>
          <p:nvPr/>
        </p:nvSpPr>
        <p:spPr>
          <a:xfrm>
            <a:off x="8436381" y="3389624"/>
            <a:ext cx="296545" cy="15367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31750">
              <a:lnSpc>
                <a:spcPct val="100000"/>
              </a:lnSpc>
              <a:spcBef>
                <a:spcPts val="135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Date</a:t>
            </a:r>
            <a:r>
              <a:rPr sz="250" spc="-9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2</a:t>
            </a:r>
            <a:endParaRPr sz="250">
              <a:latin typeface="Consolas"/>
              <a:cs typeface="Consolas"/>
            </a:endParaRPr>
          </a:p>
          <a:p>
            <a:pPr marL="12700">
              <a:lnSpc>
                <a:spcPct val="100000"/>
              </a:lnSpc>
              <a:spcBef>
                <a:spcPts val="30"/>
              </a:spcBef>
            </a:pP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-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Date</a:t>
            </a:r>
            <a:r>
              <a:rPr sz="250" spc="-9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1</a:t>
            </a:r>
            <a:endParaRPr sz="250">
              <a:latin typeface="Consolas"/>
              <a:cs typeface="Consolas"/>
            </a:endParaRPr>
          </a:p>
          <a:p>
            <a:pPr marL="41275">
              <a:lnSpc>
                <a:spcPct val="100000"/>
              </a:lnSpc>
              <a:spcBef>
                <a:spcPts val="35"/>
              </a:spcBef>
            </a:pP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lt;=</a:t>
            </a:r>
            <a:r>
              <a:rPr sz="250" spc="-20" dirty="0">
                <a:solidFill>
                  <a:srgbClr val="949698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'30'Tage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57" name="object 857"/>
          <p:cNvSpPr/>
          <p:nvPr/>
        </p:nvSpPr>
        <p:spPr>
          <a:xfrm>
            <a:off x="8273451" y="777331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748"/>
                </a:moveTo>
                <a:lnTo>
                  <a:pt x="260040" y="0"/>
                </a:lnTo>
                <a:lnTo>
                  <a:pt x="0" y="133748"/>
                </a:lnTo>
                <a:lnTo>
                  <a:pt x="260040" y="267378"/>
                </a:lnTo>
                <a:lnTo>
                  <a:pt x="520081" y="133748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8" name="object 858"/>
          <p:cNvSpPr/>
          <p:nvPr/>
        </p:nvSpPr>
        <p:spPr>
          <a:xfrm>
            <a:off x="8273451" y="7773313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748"/>
                </a:lnTo>
                <a:lnTo>
                  <a:pt x="260040" y="0"/>
                </a:lnTo>
                <a:lnTo>
                  <a:pt x="0" y="133748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59" name="object 859"/>
          <p:cNvSpPr txBox="1"/>
          <p:nvPr/>
        </p:nvSpPr>
        <p:spPr>
          <a:xfrm>
            <a:off x="8300066" y="7849223"/>
            <a:ext cx="469900" cy="1117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67005" marR="5080" indent="-154940">
              <a:lnSpc>
                <a:spcPct val="111300"/>
              </a:lnSpc>
              <a:spcBef>
                <a:spcPts val="100"/>
              </a:spcBef>
            </a:pP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eGFR Come </a:t>
            </a:r>
            <a:r>
              <a:rPr sz="250" spc="5" dirty="0">
                <a:solidFill>
                  <a:srgbClr val="231F20"/>
                </a:solidFill>
                <a:latin typeface="Consolas"/>
                <a:cs typeface="Consolas"/>
              </a:rPr>
              <a:t>From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the</a:t>
            </a:r>
            <a:r>
              <a:rPr sz="250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Same  Patient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60" name="object 860"/>
          <p:cNvSpPr/>
          <p:nvPr/>
        </p:nvSpPr>
        <p:spPr>
          <a:xfrm>
            <a:off x="8273451" y="804176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1" name="object 861"/>
          <p:cNvSpPr/>
          <p:nvPr/>
        </p:nvSpPr>
        <p:spPr>
          <a:xfrm>
            <a:off x="8273451" y="8041764"/>
            <a:ext cx="520700" cy="267335"/>
          </a:xfrm>
          <a:custGeom>
            <a:avLst/>
            <a:gdLst/>
            <a:ahLst/>
            <a:cxnLst/>
            <a:rect l="l" t="t" r="r" b="b"/>
            <a:pathLst>
              <a:path w="520700" h="267334">
                <a:moveTo>
                  <a:pt x="260040" y="26731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1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2" name="object 862"/>
          <p:cNvSpPr txBox="1"/>
          <p:nvPr/>
        </p:nvSpPr>
        <p:spPr>
          <a:xfrm>
            <a:off x="8280737" y="8139094"/>
            <a:ext cx="508634" cy="6921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Date2 </a:t>
            </a: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gt;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250" spc="-3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ate1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63" name="object 863"/>
          <p:cNvSpPr/>
          <p:nvPr/>
        </p:nvSpPr>
        <p:spPr>
          <a:xfrm>
            <a:off x="8273451" y="7770747"/>
            <a:ext cx="523240" cy="810260"/>
          </a:xfrm>
          <a:custGeom>
            <a:avLst/>
            <a:gdLst/>
            <a:ahLst/>
            <a:cxnLst/>
            <a:rect l="l" t="t" r="r" b="b"/>
            <a:pathLst>
              <a:path w="523240" h="810259">
                <a:moveTo>
                  <a:pt x="0" y="0"/>
                </a:moveTo>
                <a:lnTo>
                  <a:pt x="0" y="810129"/>
                </a:lnTo>
                <a:lnTo>
                  <a:pt x="522885" y="810129"/>
                </a:lnTo>
                <a:lnTo>
                  <a:pt x="522885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FDC01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4" name="object 864"/>
          <p:cNvSpPr/>
          <p:nvPr/>
        </p:nvSpPr>
        <p:spPr>
          <a:xfrm>
            <a:off x="8273451" y="830950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520081" y="133689"/>
                </a:move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lnTo>
                  <a:pt x="520081" y="133689"/>
                </a:lnTo>
                <a:close/>
              </a:path>
            </a:pathLst>
          </a:custGeom>
          <a:solidFill>
            <a:srgbClr val="FDC01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5" name="object 865"/>
          <p:cNvSpPr/>
          <p:nvPr/>
        </p:nvSpPr>
        <p:spPr>
          <a:xfrm>
            <a:off x="8273451" y="8309502"/>
            <a:ext cx="520700" cy="267970"/>
          </a:xfrm>
          <a:custGeom>
            <a:avLst/>
            <a:gdLst/>
            <a:ahLst/>
            <a:cxnLst/>
            <a:rect l="l" t="t" r="r" b="b"/>
            <a:pathLst>
              <a:path w="520700" h="267970">
                <a:moveTo>
                  <a:pt x="260040" y="267378"/>
                </a:moveTo>
                <a:lnTo>
                  <a:pt x="520081" y="133689"/>
                </a:lnTo>
                <a:lnTo>
                  <a:pt x="260040" y="0"/>
                </a:lnTo>
                <a:lnTo>
                  <a:pt x="0" y="133689"/>
                </a:lnTo>
                <a:lnTo>
                  <a:pt x="260040" y="267378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6" name="object 866"/>
          <p:cNvSpPr txBox="1"/>
          <p:nvPr/>
        </p:nvSpPr>
        <p:spPr>
          <a:xfrm>
            <a:off x="8280737" y="8385593"/>
            <a:ext cx="508634" cy="11176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135"/>
              </a:spcBef>
            </a:pP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 Date2 </a:t>
            </a:r>
            <a:r>
              <a:rPr sz="250" spc="15" dirty="0">
                <a:solidFill>
                  <a:srgbClr val="231F20"/>
                </a:solidFill>
                <a:latin typeface="Consolas"/>
                <a:cs typeface="Consolas"/>
              </a:rPr>
              <a:t>–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Value</a:t>
            </a:r>
            <a:r>
              <a:rPr sz="250" spc="-35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231F20"/>
                </a:solidFill>
                <a:latin typeface="Consolas"/>
                <a:cs typeface="Consolas"/>
              </a:rPr>
              <a:t>Date1</a:t>
            </a:r>
            <a:endParaRPr sz="250">
              <a:latin typeface="Consolas"/>
              <a:cs typeface="Consolas"/>
            </a:endParaRPr>
          </a:p>
          <a:p>
            <a:pPr marL="1270" algn="ctr">
              <a:lnSpc>
                <a:spcPct val="100000"/>
              </a:lnSpc>
              <a:spcBef>
                <a:spcPts val="30"/>
              </a:spcBef>
            </a:pPr>
            <a:r>
              <a:rPr sz="250" spc="15" dirty="0">
                <a:solidFill>
                  <a:srgbClr val="949698"/>
                </a:solidFill>
                <a:latin typeface="Consolas"/>
                <a:cs typeface="Consolas"/>
              </a:rPr>
              <a:t>&gt;= </a:t>
            </a:r>
            <a:r>
              <a:rPr sz="250" spc="15" dirty="0">
                <a:solidFill>
                  <a:srgbClr val="ED1F24"/>
                </a:solidFill>
                <a:latin typeface="Consolas"/>
                <a:cs typeface="Consolas"/>
              </a:rPr>
              <a:t>90</a:t>
            </a:r>
            <a:r>
              <a:rPr sz="250" spc="-20" dirty="0">
                <a:solidFill>
                  <a:srgbClr val="ED1F24"/>
                </a:solidFill>
                <a:latin typeface="Consolas"/>
                <a:cs typeface="Consolas"/>
              </a:rPr>
              <a:t> </a:t>
            </a:r>
            <a:r>
              <a:rPr sz="250" spc="10" dirty="0">
                <a:solidFill>
                  <a:srgbClr val="ED1F24"/>
                </a:solidFill>
                <a:latin typeface="Consolas"/>
                <a:cs typeface="Consolas"/>
              </a:rPr>
              <a:t>Tage</a:t>
            </a:r>
            <a:endParaRPr sz="250">
              <a:latin typeface="Consolas"/>
              <a:cs typeface="Consolas"/>
            </a:endParaRPr>
          </a:p>
        </p:txBody>
      </p:sp>
      <p:sp>
        <p:nvSpPr>
          <p:cNvPr id="867" name="object 867"/>
          <p:cNvSpPr/>
          <p:nvPr/>
        </p:nvSpPr>
        <p:spPr>
          <a:xfrm>
            <a:off x="4418797" y="249827"/>
            <a:ext cx="3233420" cy="13833475"/>
          </a:xfrm>
          <a:custGeom>
            <a:avLst/>
            <a:gdLst/>
            <a:ahLst/>
            <a:cxnLst/>
            <a:rect l="l" t="t" r="r" b="b"/>
            <a:pathLst>
              <a:path w="3233420" h="13833475">
                <a:moveTo>
                  <a:pt x="0" y="0"/>
                </a:moveTo>
                <a:lnTo>
                  <a:pt x="0" y="13833249"/>
                </a:lnTo>
                <a:lnTo>
                  <a:pt x="3232983" y="13833249"/>
                </a:lnTo>
                <a:lnTo>
                  <a:pt x="3232983" y="0"/>
                </a:lnTo>
                <a:lnTo>
                  <a:pt x="0" y="0"/>
                </a:lnTo>
                <a:close/>
              </a:path>
            </a:pathLst>
          </a:custGeom>
          <a:ln w="17544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8" name="object 868"/>
          <p:cNvSpPr/>
          <p:nvPr/>
        </p:nvSpPr>
        <p:spPr>
          <a:xfrm>
            <a:off x="7900422" y="249821"/>
            <a:ext cx="1344930" cy="8449310"/>
          </a:xfrm>
          <a:custGeom>
            <a:avLst/>
            <a:gdLst/>
            <a:ahLst/>
            <a:cxnLst/>
            <a:rect l="l" t="t" r="r" b="b"/>
            <a:pathLst>
              <a:path w="1344929" h="8449310">
                <a:moveTo>
                  <a:pt x="0" y="0"/>
                </a:moveTo>
                <a:lnTo>
                  <a:pt x="0" y="8448876"/>
                </a:lnTo>
                <a:lnTo>
                  <a:pt x="1344349" y="8448876"/>
                </a:lnTo>
                <a:lnTo>
                  <a:pt x="1344349" y="0"/>
                </a:lnTo>
                <a:lnTo>
                  <a:pt x="0" y="0"/>
                </a:lnTo>
                <a:close/>
              </a:path>
            </a:pathLst>
          </a:custGeom>
          <a:ln w="17544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69" name="object 869"/>
          <p:cNvSpPr/>
          <p:nvPr/>
        </p:nvSpPr>
        <p:spPr>
          <a:xfrm>
            <a:off x="6307366" y="0"/>
            <a:ext cx="1243965" cy="231775"/>
          </a:xfrm>
          <a:custGeom>
            <a:avLst/>
            <a:gdLst/>
            <a:ahLst/>
            <a:cxnLst/>
            <a:rect l="l" t="t" r="r" b="b"/>
            <a:pathLst>
              <a:path w="1243965" h="231775">
                <a:moveTo>
                  <a:pt x="0" y="0"/>
                </a:moveTo>
                <a:lnTo>
                  <a:pt x="0" y="231440"/>
                </a:lnTo>
                <a:lnTo>
                  <a:pt x="1243411" y="231440"/>
                </a:lnTo>
                <a:lnTo>
                  <a:pt x="1243411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0" name="object 870"/>
          <p:cNvSpPr txBox="1"/>
          <p:nvPr/>
        </p:nvSpPr>
        <p:spPr>
          <a:xfrm>
            <a:off x="6410756" y="50120"/>
            <a:ext cx="1036955" cy="1009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Patient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</a:t>
            </a:r>
            <a:r>
              <a:rPr sz="500" b="1" spc="-5" dirty="0">
                <a:solidFill>
                  <a:srgbClr val="231F20"/>
                </a:solidFill>
                <a:latin typeface="Consolas"/>
                <a:cs typeface="Consolas"/>
              </a:rPr>
              <a:t>/</a:t>
            </a:r>
            <a:r>
              <a:rPr sz="500" b="1" spc="-8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Valida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71" name="object 871"/>
          <p:cNvSpPr/>
          <p:nvPr/>
        </p:nvSpPr>
        <p:spPr>
          <a:xfrm>
            <a:off x="7900422" y="0"/>
            <a:ext cx="1243965" cy="231775"/>
          </a:xfrm>
          <a:custGeom>
            <a:avLst/>
            <a:gdLst/>
            <a:ahLst/>
            <a:cxnLst/>
            <a:rect l="l" t="t" r="r" b="b"/>
            <a:pathLst>
              <a:path w="1243965" h="231775">
                <a:moveTo>
                  <a:pt x="0" y="0"/>
                </a:moveTo>
                <a:lnTo>
                  <a:pt x="0" y="231440"/>
                </a:lnTo>
                <a:lnTo>
                  <a:pt x="1243411" y="231440"/>
                </a:lnTo>
                <a:lnTo>
                  <a:pt x="1243411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2" name="object 872"/>
          <p:cNvSpPr txBox="1"/>
          <p:nvPr/>
        </p:nvSpPr>
        <p:spPr>
          <a:xfrm>
            <a:off x="8037878" y="50120"/>
            <a:ext cx="969010" cy="1009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Value Selection </a:t>
            </a:r>
            <a:r>
              <a:rPr sz="500" b="1" spc="-5" dirty="0">
                <a:solidFill>
                  <a:srgbClr val="231F20"/>
                </a:solidFill>
                <a:latin typeface="Consolas"/>
                <a:cs typeface="Consolas"/>
              </a:rPr>
              <a:t>/</a:t>
            </a:r>
            <a:r>
              <a:rPr sz="500" b="1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Valida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73" name="object 873"/>
          <p:cNvSpPr/>
          <p:nvPr/>
        </p:nvSpPr>
        <p:spPr>
          <a:xfrm>
            <a:off x="9402091" y="0"/>
            <a:ext cx="1243965" cy="231775"/>
          </a:xfrm>
          <a:custGeom>
            <a:avLst/>
            <a:gdLst/>
            <a:ahLst/>
            <a:cxnLst/>
            <a:rect l="l" t="t" r="r" b="b"/>
            <a:pathLst>
              <a:path w="1243965" h="231775">
                <a:moveTo>
                  <a:pt x="0" y="0"/>
                </a:moveTo>
                <a:lnTo>
                  <a:pt x="0" y="231440"/>
                </a:lnTo>
                <a:lnTo>
                  <a:pt x="1243411" y="231440"/>
                </a:lnTo>
                <a:lnTo>
                  <a:pt x="1243411" y="0"/>
                </a:lnTo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4" name="object 874"/>
          <p:cNvSpPr txBox="1"/>
          <p:nvPr/>
        </p:nvSpPr>
        <p:spPr>
          <a:xfrm>
            <a:off x="9843728" y="50120"/>
            <a:ext cx="361315" cy="1009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500" b="1" spc="-20" dirty="0">
                <a:solidFill>
                  <a:srgbClr val="231F20"/>
                </a:solidFill>
                <a:latin typeface="Consolas"/>
                <a:cs typeface="Consolas"/>
              </a:rPr>
              <a:t>E</a:t>
            </a:r>
            <a:r>
              <a:rPr sz="500" b="1" spc="5" dirty="0">
                <a:solidFill>
                  <a:srgbClr val="231F20"/>
                </a:solidFill>
                <a:latin typeface="Consolas"/>
                <a:cs typeface="Consolas"/>
              </a:rPr>
              <a:t>v</a:t>
            </a:r>
            <a:r>
              <a:rPr sz="500" b="1" spc="-20" dirty="0">
                <a:solidFill>
                  <a:srgbClr val="231F20"/>
                </a:solidFill>
                <a:latin typeface="Consolas"/>
                <a:cs typeface="Consolas"/>
              </a:rPr>
              <a:t>alu</a:t>
            </a:r>
            <a:r>
              <a:rPr sz="500" b="1" spc="5" dirty="0">
                <a:solidFill>
                  <a:srgbClr val="231F20"/>
                </a:solidFill>
                <a:latin typeface="Consolas"/>
                <a:cs typeface="Consolas"/>
              </a:rPr>
              <a:t>a</a:t>
            </a:r>
            <a:r>
              <a:rPr sz="500" b="1" spc="-20" dirty="0">
                <a:solidFill>
                  <a:srgbClr val="231F20"/>
                </a:solidFill>
                <a:latin typeface="Consolas"/>
                <a:cs typeface="Consolas"/>
              </a:rPr>
              <a:t>tion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75" name="object 875"/>
          <p:cNvSpPr/>
          <p:nvPr/>
        </p:nvSpPr>
        <p:spPr>
          <a:xfrm>
            <a:off x="3144012" y="6544755"/>
            <a:ext cx="249554" cy="1243965"/>
          </a:xfrm>
          <a:custGeom>
            <a:avLst/>
            <a:gdLst/>
            <a:ahLst/>
            <a:cxnLst/>
            <a:rect l="l" t="t" r="r" b="b"/>
            <a:pathLst>
              <a:path w="249554" h="1243965">
                <a:moveTo>
                  <a:pt x="0" y="0"/>
                </a:moveTo>
                <a:lnTo>
                  <a:pt x="0" y="1243411"/>
                </a:lnTo>
                <a:lnTo>
                  <a:pt x="249314" y="1243411"/>
                </a:lnTo>
                <a:lnTo>
                  <a:pt x="249314" y="0"/>
                </a:lnTo>
                <a:lnTo>
                  <a:pt x="0" y="0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6" name="object 876"/>
          <p:cNvSpPr/>
          <p:nvPr/>
        </p:nvSpPr>
        <p:spPr>
          <a:xfrm>
            <a:off x="3144012" y="6544755"/>
            <a:ext cx="249554" cy="1243965"/>
          </a:xfrm>
          <a:custGeom>
            <a:avLst/>
            <a:gdLst/>
            <a:ahLst/>
            <a:cxnLst/>
            <a:rect l="l" t="t" r="r" b="b"/>
            <a:pathLst>
              <a:path w="249554" h="1243965">
                <a:moveTo>
                  <a:pt x="0" y="0"/>
                </a:moveTo>
                <a:lnTo>
                  <a:pt x="0" y="1243411"/>
                </a:lnTo>
                <a:lnTo>
                  <a:pt x="249314" y="1243411"/>
                </a:lnTo>
                <a:lnTo>
                  <a:pt x="249314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7" name="object 877"/>
          <p:cNvSpPr txBox="1"/>
          <p:nvPr/>
        </p:nvSpPr>
        <p:spPr>
          <a:xfrm>
            <a:off x="3146425" y="6806428"/>
            <a:ext cx="257175" cy="72199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algn="ctr">
              <a:lnSpc>
                <a:spcPts val="875"/>
              </a:lnSpc>
            </a:pPr>
            <a:r>
              <a:rPr sz="800" b="1" spc="10" dirty="0">
                <a:solidFill>
                  <a:srgbClr val="FFFFFF"/>
                </a:solidFill>
                <a:latin typeface="Consolas"/>
                <a:cs typeface="Consolas"/>
              </a:rPr>
              <a:t>Execution</a:t>
            </a:r>
            <a:r>
              <a:rPr sz="800" b="1" spc="-60" dirty="0">
                <a:solidFill>
                  <a:srgbClr val="FFFFFF"/>
                </a:solidFill>
                <a:latin typeface="Consolas"/>
                <a:cs typeface="Consolas"/>
              </a:rPr>
              <a:t> </a:t>
            </a:r>
            <a:r>
              <a:rPr sz="800" b="1" spc="20" dirty="0">
                <a:solidFill>
                  <a:srgbClr val="FFFFFF"/>
                </a:solidFill>
                <a:latin typeface="Consolas"/>
                <a:cs typeface="Consolas"/>
              </a:rPr>
              <a:t>of</a:t>
            </a:r>
            <a:endParaRPr sz="800">
              <a:latin typeface="Consolas"/>
              <a:cs typeface="Consolas"/>
            </a:endParaRPr>
          </a:p>
          <a:p>
            <a:pPr algn="ctr">
              <a:lnSpc>
                <a:spcPct val="100000"/>
              </a:lnSpc>
              <a:spcBef>
                <a:spcPts val="35"/>
              </a:spcBef>
            </a:pPr>
            <a:r>
              <a:rPr sz="800" b="1" spc="10" dirty="0">
                <a:solidFill>
                  <a:srgbClr val="FFFFFF"/>
                </a:solidFill>
                <a:latin typeface="Consolas"/>
                <a:cs typeface="Consolas"/>
              </a:rPr>
              <a:t>Algorithm</a:t>
            </a:r>
            <a:endParaRPr sz="800">
              <a:latin typeface="Consolas"/>
              <a:cs typeface="Consolas"/>
            </a:endParaRPr>
          </a:p>
        </p:txBody>
      </p:sp>
      <p:sp>
        <p:nvSpPr>
          <p:cNvPr id="878" name="object 878"/>
          <p:cNvSpPr/>
          <p:nvPr/>
        </p:nvSpPr>
        <p:spPr>
          <a:xfrm>
            <a:off x="3393303" y="7166431"/>
            <a:ext cx="948055" cy="1010285"/>
          </a:xfrm>
          <a:custGeom>
            <a:avLst/>
            <a:gdLst/>
            <a:ahLst/>
            <a:cxnLst/>
            <a:rect l="l" t="t" r="r" b="b"/>
            <a:pathLst>
              <a:path w="948054" h="1010284">
                <a:moveTo>
                  <a:pt x="947941" y="1010275"/>
                </a:moveTo>
                <a:lnTo>
                  <a:pt x="335088" y="1009977"/>
                </a:lnTo>
                <a:lnTo>
                  <a:pt x="335088" y="2803"/>
                </a:ln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79" name="object 879"/>
          <p:cNvSpPr/>
          <p:nvPr/>
        </p:nvSpPr>
        <p:spPr>
          <a:xfrm>
            <a:off x="4329617" y="8118661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081" y="58105"/>
                </a:moveTo>
                <a:lnTo>
                  <a:pt x="41" y="0"/>
                </a:lnTo>
                <a:lnTo>
                  <a:pt x="0" y="116150"/>
                </a:lnTo>
                <a:lnTo>
                  <a:pt x="58081" y="58105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0" name="object 880"/>
          <p:cNvSpPr/>
          <p:nvPr/>
        </p:nvSpPr>
        <p:spPr>
          <a:xfrm>
            <a:off x="5786574" y="12180352"/>
            <a:ext cx="4222750" cy="6985"/>
          </a:xfrm>
          <a:custGeom>
            <a:avLst/>
            <a:gdLst/>
            <a:ahLst/>
            <a:cxnLst/>
            <a:rect l="l" t="t" r="r" b="b"/>
            <a:pathLst>
              <a:path w="4222750" h="6984">
                <a:moveTo>
                  <a:pt x="4222576" y="0"/>
                </a:moveTo>
                <a:lnTo>
                  <a:pt x="0" y="6502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1" name="object 881"/>
          <p:cNvSpPr/>
          <p:nvPr/>
        </p:nvSpPr>
        <p:spPr>
          <a:xfrm>
            <a:off x="9997458" y="12122307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164" y="57985"/>
                </a:moveTo>
                <a:lnTo>
                  <a:pt x="0" y="0"/>
                </a:lnTo>
                <a:lnTo>
                  <a:pt x="178" y="116150"/>
                </a:lnTo>
                <a:lnTo>
                  <a:pt x="58164" y="57985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2" name="object 882"/>
          <p:cNvSpPr/>
          <p:nvPr/>
        </p:nvSpPr>
        <p:spPr>
          <a:xfrm>
            <a:off x="8793539" y="8175454"/>
            <a:ext cx="1106805" cy="0"/>
          </a:xfrm>
          <a:custGeom>
            <a:avLst/>
            <a:gdLst/>
            <a:ahLst/>
            <a:cxnLst/>
            <a:rect l="l" t="t" r="r" b="b"/>
            <a:pathLst>
              <a:path w="1106804">
                <a:moveTo>
                  <a:pt x="1106202" y="0"/>
                </a:move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3" name="object 883"/>
          <p:cNvSpPr/>
          <p:nvPr/>
        </p:nvSpPr>
        <p:spPr>
          <a:xfrm>
            <a:off x="9888108" y="8117349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105" y="58105"/>
                </a:moveTo>
                <a:lnTo>
                  <a:pt x="0" y="0"/>
                </a:lnTo>
                <a:lnTo>
                  <a:pt x="0" y="116210"/>
                </a:lnTo>
                <a:lnTo>
                  <a:pt x="58105" y="58105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4" name="object 884"/>
          <p:cNvSpPr/>
          <p:nvPr/>
        </p:nvSpPr>
        <p:spPr>
          <a:xfrm>
            <a:off x="5786574" y="3202040"/>
            <a:ext cx="2489835" cy="0"/>
          </a:xfrm>
          <a:custGeom>
            <a:avLst/>
            <a:gdLst/>
            <a:ahLst/>
            <a:cxnLst/>
            <a:rect l="l" t="t" r="r" b="b"/>
            <a:pathLst>
              <a:path w="2489834">
                <a:moveTo>
                  <a:pt x="2489800" y="0"/>
                </a:move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5" name="object 885"/>
          <p:cNvSpPr/>
          <p:nvPr/>
        </p:nvSpPr>
        <p:spPr>
          <a:xfrm>
            <a:off x="8264801" y="3143953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105" y="58081"/>
                </a:moveTo>
                <a:lnTo>
                  <a:pt x="0" y="0"/>
                </a:lnTo>
                <a:lnTo>
                  <a:pt x="0" y="116156"/>
                </a:lnTo>
                <a:lnTo>
                  <a:pt x="58105" y="58081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6" name="object 886"/>
          <p:cNvSpPr/>
          <p:nvPr/>
        </p:nvSpPr>
        <p:spPr>
          <a:xfrm>
            <a:off x="8842988" y="3200757"/>
            <a:ext cx="746125" cy="1270"/>
          </a:xfrm>
          <a:custGeom>
            <a:avLst/>
            <a:gdLst/>
            <a:ahLst/>
            <a:cxnLst/>
            <a:rect l="l" t="t" r="r" b="b"/>
            <a:pathLst>
              <a:path w="746125" h="1269">
                <a:moveTo>
                  <a:pt x="745880" y="0"/>
                </a:moveTo>
                <a:lnTo>
                  <a:pt x="0" y="924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7" name="object 887"/>
          <p:cNvSpPr/>
          <p:nvPr/>
        </p:nvSpPr>
        <p:spPr>
          <a:xfrm>
            <a:off x="9577181" y="3142682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164" y="58033"/>
                </a:moveTo>
                <a:lnTo>
                  <a:pt x="0" y="0"/>
                </a:lnTo>
                <a:lnTo>
                  <a:pt x="119" y="116156"/>
                </a:lnTo>
                <a:lnTo>
                  <a:pt x="58164" y="58033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8" name="object 888"/>
          <p:cNvSpPr/>
          <p:nvPr/>
        </p:nvSpPr>
        <p:spPr>
          <a:xfrm>
            <a:off x="3728391" y="8176408"/>
            <a:ext cx="613410" cy="4016375"/>
          </a:xfrm>
          <a:custGeom>
            <a:avLst/>
            <a:gdLst/>
            <a:ahLst/>
            <a:cxnLst/>
            <a:rect l="l" t="t" r="r" b="b"/>
            <a:pathLst>
              <a:path w="613410" h="4016375">
                <a:moveTo>
                  <a:pt x="612852" y="4010863"/>
                </a:moveTo>
                <a:lnTo>
                  <a:pt x="0" y="4016292"/>
                </a:ln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89" name="object 889"/>
          <p:cNvSpPr/>
          <p:nvPr/>
        </p:nvSpPr>
        <p:spPr>
          <a:xfrm>
            <a:off x="4329092" y="12129286"/>
            <a:ext cx="59055" cy="116205"/>
          </a:xfrm>
          <a:custGeom>
            <a:avLst/>
            <a:gdLst/>
            <a:ahLst/>
            <a:cxnLst/>
            <a:rect l="l" t="t" r="r" b="b"/>
            <a:pathLst>
              <a:path w="59054" h="116204">
                <a:moveTo>
                  <a:pt x="58606" y="57568"/>
                </a:moveTo>
                <a:lnTo>
                  <a:pt x="0" y="0"/>
                </a:lnTo>
                <a:lnTo>
                  <a:pt x="1049" y="116150"/>
                </a:lnTo>
                <a:lnTo>
                  <a:pt x="58606" y="57568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0" name="object 890"/>
          <p:cNvSpPr/>
          <p:nvPr/>
        </p:nvSpPr>
        <p:spPr>
          <a:xfrm>
            <a:off x="3393303" y="3202654"/>
            <a:ext cx="948055" cy="3966845"/>
          </a:xfrm>
          <a:custGeom>
            <a:avLst/>
            <a:gdLst/>
            <a:ahLst/>
            <a:cxnLst/>
            <a:rect l="l" t="t" r="r" b="b"/>
            <a:pathLst>
              <a:path w="948054" h="3966845">
                <a:moveTo>
                  <a:pt x="947672" y="304"/>
                </a:moveTo>
                <a:lnTo>
                  <a:pt x="335088" y="0"/>
                </a:lnTo>
                <a:lnTo>
                  <a:pt x="335088" y="3966586"/>
                </a:lnTo>
                <a:lnTo>
                  <a:pt x="0" y="3963782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1" name="object 891"/>
          <p:cNvSpPr/>
          <p:nvPr/>
        </p:nvSpPr>
        <p:spPr>
          <a:xfrm>
            <a:off x="4329313" y="3144883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20" h="116204">
                <a:moveTo>
                  <a:pt x="58116" y="58122"/>
                </a:moveTo>
                <a:lnTo>
                  <a:pt x="83" y="0"/>
                </a:lnTo>
                <a:lnTo>
                  <a:pt x="0" y="116156"/>
                </a:lnTo>
                <a:lnTo>
                  <a:pt x="58116" y="58122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2" name="object 892"/>
          <p:cNvSpPr/>
          <p:nvPr/>
        </p:nvSpPr>
        <p:spPr>
          <a:xfrm>
            <a:off x="16442827" y="7166431"/>
            <a:ext cx="488315" cy="0"/>
          </a:xfrm>
          <a:custGeom>
            <a:avLst/>
            <a:gdLst/>
            <a:ahLst/>
            <a:cxnLst/>
            <a:rect l="l" t="t" r="r" b="b"/>
            <a:pathLst>
              <a:path w="488315">
                <a:moveTo>
                  <a:pt x="488225" y="0"/>
                </a:moveTo>
                <a:lnTo>
                  <a:pt x="0" y="0"/>
                </a:lnTo>
              </a:path>
            </a:pathLst>
          </a:custGeom>
          <a:ln w="43865">
            <a:solidFill>
              <a:srgbClr val="923A31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3" name="object 893"/>
          <p:cNvSpPr/>
          <p:nvPr/>
        </p:nvSpPr>
        <p:spPr>
          <a:xfrm>
            <a:off x="16919472" y="7108386"/>
            <a:ext cx="58419" cy="116205"/>
          </a:xfrm>
          <a:custGeom>
            <a:avLst/>
            <a:gdLst/>
            <a:ahLst/>
            <a:cxnLst/>
            <a:rect l="l" t="t" r="r" b="b"/>
            <a:pathLst>
              <a:path w="58419" h="116204">
                <a:moveTo>
                  <a:pt x="58045" y="58045"/>
                </a:moveTo>
                <a:lnTo>
                  <a:pt x="0" y="0"/>
                </a:lnTo>
                <a:lnTo>
                  <a:pt x="0" y="116150"/>
                </a:lnTo>
                <a:lnTo>
                  <a:pt x="58045" y="58045"/>
                </a:lnTo>
                <a:close/>
              </a:path>
            </a:pathLst>
          </a:custGeom>
          <a:solidFill>
            <a:srgbClr val="923A31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4" name="object 894"/>
          <p:cNvSpPr txBox="1"/>
          <p:nvPr/>
        </p:nvSpPr>
        <p:spPr>
          <a:xfrm>
            <a:off x="16977518" y="6548871"/>
            <a:ext cx="249554" cy="1243965"/>
          </a:xfrm>
          <a:prstGeom prst="rect">
            <a:avLst/>
          </a:prstGeom>
          <a:solidFill>
            <a:srgbClr val="923A31"/>
          </a:solidFill>
          <a:ln w="3175">
            <a:solidFill>
              <a:srgbClr val="231F20"/>
            </a:solidFill>
          </a:ln>
        </p:spPr>
        <p:txBody>
          <a:bodyPr vert="vert270" wrap="square" lIns="0" tIns="57150" rIns="0" bIns="0" rtlCol="0">
            <a:spAutoFit/>
          </a:bodyPr>
          <a:lstStyle/>
          <a:p>
            <a:pPr algn="ctr">
              <a:lnSpc>
                <a:spcPct val="100000"/>
              </a:lnSpc>
              <a:spcBef>
                <a:spcPts val="450"/>
              </a:spcBef>
            </a:pPr>
            <a:r>
              <a:rPr sz="800" b="1" spc="10" dirty="0">
                <a:solidFill>
                  <a:srgbClr val="FFFFFF"/>
                </a:solidFill>
                <a:latin typeface="Consolas"/>
                <a:cs typeface="Consolas"/>
              </a:rPr>
              <a:t>Report</a:t>
            </a:r>
            <a:endParaRPr sz="800">
              <a:latin typeface="Consolas"/>
              <a:cs typeface="Consolas"/>
            </a:endParaRPr>
          </a:p>
        </p:txBody>
      </p:sp>
      <p:sp>
        <p:nvSpPr>
          <p:cNvPr id="895" name="object 895"/>
          <p:cNvSpPr txBox="1"/>
          <p:nvPr/>
        </p:nvSpPr>
        <p:spPr>
          <a:xfrm>
            <a:off x="4687780" y="2605175"/>
            <a:ext cx="109918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698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5"/>
              </a:spcBef>
            </a:pPr>
            <a:endParaRPr sz="500">
              <a:latin typeface="Times New Roman"/>
              <a:cs typeface="Times New Roman"/>
            </a:endParaRPr>
          </a:p>
          <a:p>
            <a:pPr marL="262255">
              <a:lnSpc>
                <a:spcPct val="100000"/>
              </a:lnSpc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for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N17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96" name="object 896"/>
          <p:cNvSpPr txBox="1"/>
          <p:nvPr/>
        </p:nvSpPr>
        <p:spPr>
          <a:xfrm>
            <a:off x="4687780" y="7578953"/>
            <a:ext cx="109918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63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"/>
              </a:spcBef>
            </a:pPr>
            <a:endParaRPr sz="550">
              <a:latin typeface="Times New Roman"/>
              <a:cs typeface="Times New Roman"/>
            </a:endParaRPr>
          </a:p>
          <a:p>
            <a:pPr marL="262255">
              <a:lnSpc>
                <a:spcPct val="100000"/>
              </a:lnSpc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for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N18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97" name="object 897"/>
          <p:cNvSpPr/>
          <p:nvPr/>
        </p:nvSpPr>
        <p:spPr>
          <a:xfrm>
            <a:off x="4687780" y="11604849"/>
            <a:ext cx="1099185" cy="249554"/>
          </a:xfrm>
          <a:custGeom>
            <a:avLst/>
            <a:gdLst/>
            <a:ahLst/>
            <a:cxnLst/>
            <a:rect l="l" t="t" r="r" b="b"/>
            <a:pathLst>
              <a:path w="1099185" h="249554">
                <a:moveTo>
                  <a:pt x="0" y="0"/>
                </a:moveTo>
                <a:lnTo>
                  <a:pt x="0" y="249302"/>
                </a:lnTo>
                <a:lnTo>
                  <a:pt x="1098793" y="249302"/>
                </a:lnTo>
                <a:lnTo>
                  <a:pt x="1098793" y="0"/>
                </a:lnTo>
                <a:lnTo>
                  <a:pt x="0" y="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98" name="object 898"/>
          <p:cNvSpPr txBox="1"/>
          <p:nvPr/>
        </p:nvSpPr>
        <p:spPr>
          <a:xfrm>
            <a:off x="4937966" y="11675379"/>
            <a:ext cx="600075" cy="100965"/>
          </a:xfrm>
          <a:prstGeom prst="rect">
            <a:avLst/>
          </a:prstGeom>
        </p:spPr>
        <p:txBody>
          <a:bodyPr vert="horz" wrap="square" lIns="0" tIns="1143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90"/>
              </a:spcBef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for</a:t>
            </a:r>
            <a:r>
              <a:rPr sz="500" b="1" spc="-5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N19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899" name="object 899"/>
          <p:cNvSpPr txBox="1"/>
          <p:nvPr/>
        </p:nvSpPr>
        <p:spPr>
          <a:xfrm>
            <a:off x="7985491" y="7455226"/>
            <a:ext cx="109918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63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"/>
              </a:spcBef>
            </a:pPr>
            <a:endParaRPr sz="550">
              <a:latin typeface="Times New Roman"/>
              <a:cs typeface="Times New Roman"/>
            </a:endParaRPr>
          </a:p>
          <a:p>
            <a:pPr marL="263525">
              <a:lnSpc>
                <a:spcPct val="100000"/>
              </a:lnSpc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for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N18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900" name="object 900"/>
          <p:cNvSpPr txBox="1"/>
          <p:nvPr/>
        </p:nvSpPr>
        <p:spPr>
          <a:xfrm>
            <a:off x="8023194" y="2480857"/>
            <a:ext cx="1099185" cy="249554"/>
          </a:xfrm>
          <a:prstGeom prst="rect">
            <a:avLst/>
          </a:prstGeom>
          <a:ln w="3175">
            <a:solidFill>
              <a:srgbClr val="231F20"/>
            </a:solidFill>
          </a:ln>
        </p:spPr>
        <p:txBody>
          <a:bodyPr vert="horz" wrap="square" lIns="0" tIns="698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55"/>
              </a:spcBef>
            </a:pPr>
            <a:endParaRPr sz="500">
              <a:latin typeface="Times New Roman"/>
              <a:cs typeface="Times New Roman"/>
            </a:endParaRPr>
          </a:p>
          <a:p>
            <a:pPr marL="263525">
              <a:lnSpc>
                <a:spcPct val="100000"/>
              </a:lnSpc>
            </a:pPr>
            <a:r>
              <a:rPr sz="500" b="1" spc="-15" dirty="0">
                <a:solidFill>
                  <a:srgbClr val="231F20"/>
                </a:solidFill>
                <a:latin typeface="Consolas"/>
                <a:cs typeface="Consolas"/>
              </a:rPr>
              <a:t>Selection for</a:t>
            </a:r>
            <a:r>
              <a:rPr sz="500" b="1" spc="-10" dirty="0">
                <a:solidFill>
                  <a:srgbClr val="231F20"/>
                </a:solidFill>
                <a:latin typeface="Consolas"/>
                <a:cs typeface="Consolas"/>
              </a:rPr>
              <a:t> </a:t>
            </a:r>
            <a:r>
              <a:rPr sz="500" b="1" spc="-20" dirty="0">
                <a:solidFill>
                  <a:srgbClr val="231F20"/>
                </a:solidFill>
                <a:latin typeface="Consolas"/>
                <a:cs typeface="Consolas"/>
              </a:rPr>
              <a:t>N17</a:t>
            </a:r>
            <a:endParaRPr sz="500">
              <a:latin typeface="Consolas"/>
              <a:cs typeface="Consolas"/>
            </a:endParaRPr>
          </a:p>
        </p:txBody>
      </p:sp>
      <p:sp>
        <p:nvSpPr>
          <p:cNvPr id="901" name="object 901"/>
          <p:cNvSpPr/>
          <p:nvPr/>
        </p:nvSpPr>
        <p:spPr>
          <a:xfrm>
            <a:off x="4543150" y="4080666"/>
            <a:ext cx="4538980" cy="149225"/>
          </a:xfrm>
          <a:custGeom>
            <a:avLst/>
            <a:gdLst/>
            <a:ahLst/>
            <a:cxnLst/>
            <a:rect l="l" t="t" r="r" b="b"/>
            <a:pathLst>
              <a:path w="4538980" h="149225">
                <a:moveTo>
                  <a:pt x="4282537" y="99488"/>
                </a:moveTo>
                <a:lnTo>
                  <a:pt x="4282537" y="49747"/>
                </a:lnTo>
                <a:lnTo>
                  <a:pt x="0" y="49747"/>
                </a:lnTo>
                <a:lnTo>
                  <a:pt x="0" y="99488"/>
                </a:lnTo>
                <a:lnTo>
                  <a:pt x="4282537" y="99488"/>
                </a:lnTo>
                <a:close/>
              </a:path>
              <a:path w="4538980" h="149225">
                <a:moveTo>
                  <a:pt x="4538521" y="74617"/>
                </a:moveTo>
                <a:lnTo>
                  <a:pt x="4289875" y="0"/>
                </a:lnTo>
                <a:lnTo>
                  <a:pt x="4275557" y="47641"/>
                </a:lnTo>
                <a:lnTo>
                  <a:pt x="4282537" y="49747"/>
                </a:lnTo>
                <a:lnTo>
                  <a:pt x="4282537" y="124774"/>
                </a:lnTo>
                <a:lnTo>
                  <a:pt x="4289875" y="149187"/>
                </a:lnTo>
                <a:lnTo>
                  <a:pt x="4538521" y="74617"/>
                </a:lnTo>
                <a:close/>
              </a:path>
              <a:path w="4538980" h="149225">
                <a:moveTo>
                  <a:pt x="4282537" y="124774"/>
                </a:moveTo>
                <a:lnTo>
                  <a:pt x="4282537" y="99488"/>
                </a:lnTo>
                <a:lnTo>
                  <a:pt x="4275557" y="101552"/>
                </a:lnTo>
                <a:lnTo>
                  <a:pt x="4282537" y="124774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2" name="object 902"/>
          <p:cNvSpPr/>
          <p:nvPr/>
        </p:nvSpPr>
        <p:spPr>
          <a:xfrm>
            <a:off x="4543150" y="4080666"/>
            <a:ext cx="4538980" cy="149225"/>
          </a:xfrm>
          <a:custGeom>
            <a:avLst/>
            <a:gdLst/>
            <a:ahLst/>
            <a:cxnLst/>
            <a:rect l="l" t="t" r="r" b="b"/>
            <a:pathLst>
              <a:path w="4538980" h="149225">
                <a:moveTo>
                  <a:pt x="4538521" y="74617"/>
                </a:moveTo>
                <a:lnTo>
                  <a:pt x="4289874" y="149187"/>
                </a:lnTo>
                <a:lnTo>
                  <a:pt x="4275557" y="101552"/>
                </a:lnTo>
                <a:lnTo>
                  <a:pt x="4282537" y="99488"/>
                </a:lnTo>
                <a:lnTo>
                  <a:pt x="0" y="99488"/>
                </a:lnTo>
                <a:lnTo>
                  <a:pt x="0" y="49747"/>
                </a:lnTo>
                <a:lnTo>
                  <a:pt x="4282537" y="49747"/>
                </a:lnTo>
                <a:lnTo>
                  <a:pt x="4275557" y="47641"/>
                </a:lnTo>
                <a:lnTo>
                  <a:pt x="4289874" y="0"/>
                </a:lnTo>
                <a:lnTo>
                  <a:pt x="4538521" y="74617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3" name="object 903"/>
          <p:cNvSpPr/>
          <p:nvPr/>
        </p:nvSpPr>
        <p:spPr>
          <a:xfrm>
            <a:off x="5219477" y="403092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488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4" name="object 904"/>
          <p:cNvSpPr/>
          <p:nvPr/>
        </p:nvSpPr>
        <p:spPr>
          <a:xfrm>
            <a:off x="6711595" y="403092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488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5" name="object 905"/>
          <p:cNvSpPr/>
          <p:nvPr/>
        </p:nvSpPr>
        <p:spPr>
          <a:xfrm>
            <a:off x="5219477" y="4083082"/>
            <a:ext cx="1492250" cy="0"/>
          </a:xfrm>
          <a:custGeom>
            <a:avLst/>
            <a:gdLst/>
            <a:ahLst/>
            <a:cxnLst/>
            <a:rect l="l" t="t" r="r" b="b"/>
            <a:pathLst>
              <a:path w="1492250">
                <a:moveTo>
                  <a:pt x="1492117" y="0"/>
                </a:moveTo>
                <a:lnTo>
                  <a:pt x="0" y="0"/>
                </a:lnTo>
              </a:path>
            </a:pathLst>
          </a:custGeom>
          <a:ln w="5482">
            <a:solidFill>
              <a:srgbClr val="231F20"/>
            </a:solidFill>
            <a:prstDash val="sysDash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06" name="object 906"/>
          <p:cNvSpPr txBox="1"/>
          <p:nvPr/>
        </p:nvSpPr>
        <p:spPr>
          <a:xfrm>
            <a:off x="5777996" y="3989580"/>
            <a:ext cx="25336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25" dirty="0">
                <a:solidFill>
                  <a:srgbClr val="ED1F24"/>
                </a:solidFill>
                <a:latin typeface="Calibri"/>
                <a:cs typeface="Calibri"/>
              </a:rPr>
              <a:t>Max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30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Day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07" name="object 907"/>
          <p:cNvSpPr txBox="1"/>
          <p:nvPr/>
        </p:nvSpPr>
        <p:spPr>
          <a:xfrm>
            <a:off x="5115317" y="3937072"/>
            <a:ext cx="20891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dmission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08" name="object 908"/>
          <p:cNvSpPr txBox="1"/>
          <p:nvPr/>
        </p:nvSpPr>
        <p:spPr>
          <a:xfrm>
            <a:off x="6573619" y="3901108"/>
            <a:ext cx="27686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86995" marR="5080" indent="-74930">
              <a:lnSpc>
                <a:spcPct val="115100"/>
              </a:lnSpc>
              <a:spcBef>
                <a:spcPts val="80"/>
              </a:spcBef>
            </a:pP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a</a:t>
            </a:r>
            <a:r>
              <a:rPr sz="300" spc="30" dirty="0">
                <a:solidFill>
                  <a:srgbClr val="231F20"/>
                </a:solidFill>
                <a:latin typeface="Calibri"/>
                <a:cs typeface="Calibri"/>
              </a:rPr>
              <a:t>s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u</a:t>
            </a:r>
            <a:r>
              <a:rPr sz="300" spc="-5" dirty="0">
                <a:solidFill>
                  <a:srgbClr val="231F20"/>
                </a:solidFill>
                <a:latin typeface="Calibri"/>
                <a:cs typeface="Calibri"/>
              </a:rPr>
              <a:t>r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40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nt 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Krea1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09" name="object 909"/>
          <p:cNvSpPr/>
          <p:nvPr/>
        </p:nvSpPr>
        <p:spPr>
          <a:xfrm>
            <a:off x="4543108" y="9059259"/>
            <a:ext cx="4663440" cy="149860"/>
          </a:xfrm>
          <a:custGeom>
            <a:avLst/>
            <a:gdLst/>
            <a:ahLst/>
            <a:cxnLst/>
            <a:rect l="l" t="t" r="r" b="b"/>
            <a:pathLst>
              <a:path w="4663440" h="149859">
                <a:moveTo>
                  <a:pt x="4406962" y="99506"/>
                </a:moveTo>
                <a:lnTo>
                  <a:pt x="4406962" y="49753"/>
                </a:lnTo>
                <a:lnTo>
                  <a:pt x="0" y="49753"/>
                </a:lnTo>
                <a:lnTo>
                  <a:pt x="0" y="99506"/>
                </a:lnTo>
                <a:lnTo>
                  <a:pt x="4406962" y="99506"/>
                </a:lnTo>
                <a:close/>
              </a:path>
              <a:path w="4663440" h="149859">
                <a:moveTo>
                  <a:pt x="4662946" y="74629"/>
                </a:moveTo>
                <a:lnTo>
                  <a:pt x="4414240" y="0"/>
                </a:lnTo>
                <a:lnTo>
                  <a:pt x="4399982" y="47665"/>
                </a:lnTo>
                <a:lnTo>
                  <a:pt x="4406962" y="49753"/>
                </a:lnTo>
                <a:lnTo>
                  <a:pt x="4406962" y="124928"/>
                </a:lnTo>
                <a:lnTo>
                  <a:pt x="4414240" y="149259"/>
                </a:lnTo>
                <a:lnTo>
                  <a:pt x="4662946" y="74629"/>
                </a:lnTo>
                <a:close/>
              </a:path>
              <a:path w="4663440" h="149859">
                <a:moveTo>
                  <a:pt x="4406962" y="124928"/>
                </a:moveTo>
                <a:lnTo>
                  <a:pt x="4406962" y="99506"/>
                </a:lnTo>
                <a:lnTo>
                  <a:pt x="4399982" y="101594"/>
                </a:lnTo>
                <a:lnTo>
                  <a:pt x="4406962" y="124928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0" name="object 910"/>
          <p:cNvSpPr/>
          <p:nvPr/>
        </p:nvSpPr>
        <p:spPr>
          <a:xfrm>
            <a:off x="4543109" y="9059259"/>
            <a:ext cx="4663440" cy="149860"/>
          </a:xfrm>
          <a:custGeom>
            <a:avLst/>
            <a:gdLst/>
            <a:ahLst/>
            <a:cxnLst/>
            <a:rect l="l" t="t" r="r" b="b"/>
            <a:pathLst>
              <a:path w="4663440" h="149859">
                <a:moveTo>
                  <a:pt x="4662946" y="74629"/>
                </a:moveTo>
                <a:lnTo>
                  <a:pt x="4414239" y="149259"/>
                </a:lnTo>
                <a:lnTo>
                  <a:pt x="4399982" y="101594"/>
                </a:lnTo>
                <a:lnTo>
                  <a:pt x="4406961" y="99506"/>
                </a:lnTo>
                <a:lnTo>
                  <a:pt x="0" y="99506"/>
                </a:lnTo>
                <a:lnTo>
                  <a:pt x="0" y="49753"/>
                </a:lnTo>
                <a:lnTo>
                  <a:pt x="4406961" y="49753"/>
                </a:lnTo>
                <a:lnTo>
                  <a:pt x="4399982" y="47665"/>
                </a:lnTo>
                <a:lnTo>
                  <a:pt x="4414239" y="0"/>
                </a:lnTo>
                <a:lnTo>
                  <a:pt x="4662946" y="74629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1" name="object 911"/>
          <p:cNvSpPr/>
          <p:nvPr/>
        </p:nvSpPr>
        <p:spPr>
          <a:xfrm>
            <a:off x="5219477" y="900950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50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2" name="object 912"/>
          <p:cNvSpPr/>
          <p:nvPr/>
        </p:nvSpPr>
        <p:spPr>
          <a:xfrm>
            <a:off x="7776039" y="900950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50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3" name="object 913"/>
          <p:cNvSpPr/>
          <p:nvPr/>
        </p:nvSpPr>
        <p:spPr>
          <a:xfrm>
            <a:off x="5219477" y="9071727"/>
            <a:ext cx="2557145" cy="0"/>
          </a:xfrm>
          <a:custGeom>
            <a:avLst/>
            <a:gdLst/>
            <a:ahLst/>
            <a:cxnLst/>
            <a:rect l="l" t="t" r="r" b="b"/>
            <a:pathLst>
              <a:path w="2557145">
                <a:moveTo>
                  <a:pt x="2556561" y="0"/>
                </a:moveTo>
                <a:lnTo>
                  <a:pt x="0" y="0"/>
                </a:lnTo>
              </a:path>
            </a:pathLst>
          </a:custGeom>
          <a:ln w="5482">
            <a:solidFill>
              <a:srgbClr val="231F20"/>
            </a:solidFill>
            <a:prstDash val="sysDash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4" name="object 914"/>
          <p:cNvSpPr txBox="1"/>
          <p:nvPr/>
        </p:nvSpPr>
        <p:spPr>
          <a:xfrm>
            <a:off x="6209776" y="8969371"/>
            <a:ext cx="27368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25" dirty="0">
                <a:solidFill>
                  <a:srgbClr val="ED1F24"/>
                </a:solidFill>
                <a:latin typeface="Calibri"/>
                <a:cs typeface="Calibri"/>
              </a:rPr>
              <a:t>Max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5" dirty="0">
                <a:solidFill>
                  <a:srgbClr val="ED1F24"/>
                </a:solidFill>
                <a:latin typeface="Calibri"/>
                <a:cs typeface="Calibri"/>
              </a:rPr>
              <a:t>365</a:t>
            </a:r>
            <a:r>
              <a:rPr sz="300" spc="-25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ED1F24"/>
                </a:solidFill>
                <a:latin typeface="Calibri"/>
                <a:cs typeface="Calibri"/>
              </a:rPr>
              <a:t>Tage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15" name="object 915"/>
          <p:cNvSpPr txBox="1"/>
          <p:nvPr/>
        </p:nvSpPr>
        <p:spPr>
          <a:xfrm>
            <a:off x="5115315" y="8916811"/>
            <a:ext cx="20891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dmission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16" name="object 916"/>
          <p:cNvSpPr txBox="1"/>
          <p:nvPr/>
        </p:nvSpPr>
        <p:spPr>
          <a:xfrm>
            <a:off x="7678271" y="8880611"/>
            <a:ext cx="276860" cy="130175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86995" marR="5080" indent="-74930">
              <a:lnSpc>
                <a:spcPct val="115300"/>
              </a:lnSpc>
              <a:spcBef>
                <a:spcPts val="80"/>
              </a:spcBef>
            </a:pP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a</a:t>
            </a:r>
            <a:r>
              <a:rPr sz="300" spc="30" dirty="0">
                <a:solidFill>
                  <a:srgbClr val="231F20"/>
                </a:solidFill>
                <a:latin typeface="Calibri"/>
                <a:cs typeface="Calibri"/>
              </a:rPr>
              <a:t>s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u</a:t>
            </a:r>
            <a:r>
              <a:rPr sz="300" spc="-5" dirty="0">
                <a:solidFill>
                  <a:srgbClr val="231F20"/>
                </a:solidFill>
                <a:latin typeface="Calibri"/>
                <a:cs typeface="Calibri"/>
              </a:rPr>
              <a:t>r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45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nt 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Krea1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17" name="object 917"/>
          <p:cNvSpPr/>
          <p:nvPr/>
        </p:nvSpPr>
        <p:spPr>
          <a:xfrm>
            <a:off x="4543156" y="13095596"/>
            <a:ext cx="3020695" cy="149225"/>
          </a:xfrm>
          <a:custGeom>
            <a:avLst/>
            <a:gdLst/>
            <a:ahLst/>
            <a:cxnLst/>
            <a:rect l="l" t="t" r="r" b="b"/>
            <a:pathLst>
              <a:path w="3020695" h="149225">
                <a:moveTo>
                  <a:pt x="2764403" y="99446"/>
                </a:moveTo>
                <a:lnTo>
                  <a:pt x="2764403" y="49693"/>
                </a:lnTo>
                <a:lnTo>
                  <a:pt x="0" y="49693"/>
                </a:lnTo>
                <a:lnTo>
                  <a:pt x="0" y="99446"/>
                </a:lnTo>
                <a:lnTo>
                  <a:pt x="2764403" y="99446"/>
                </a:lnTo>
                <a:close/>
              </a:path>
              <a:path w="3020695" h="149225">
                <a:moveTo>
                  <a:pt x="3020387" y="74570"/>
                </a:moveTo>
                <a:lnTo>
                  <a:pt x="2771681" y="0"/>
                </a:lnTo>
                <a:lnTo>
                  <a:pt x="2757363" y="47665"/>
                </a:lnTo>
                <a:lnTo>
                  <a:pt x="2764403" y="49693"/>
                </a:lnTo>
                <a:lnTo>
                  <a:pt x="2764403" y="125000"/>
                </a:lnTo>
                <a:lnTo>
                  <a:pt x="2771681" y="149199"/>
                </a:lnTo>
                <a:lnTo>
                  <a:pt x="3020387" y="74570"/>
                </a:lnTo>
                <a:close/>
              </a:path>
              <a:path w="3020695" h="149225">
                <a:moveTo>
                  <a:pt x="2764403" y="125000"/>
                </a:moveTo>
                <a:lnTo>
                  <a:pt x="2764403" y="99446"/>
                </a:lnTo>
                <a:lnTo>
                  <a:pt x="2757363" y="101594"/>
                </a:lnTo>
                <a:lnTo>
                  <a:pt x="2764403" y="125000"/>
                </a:lnTo>
                <a:close/>
              </a:path>
            </a:pathLst>
          </a:custGeom>
          <a:solidFill>
            <a:srgbClr val="231F2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8" name="object 918"/>
          <p:cNvSpPr/>
          <p:nvPr/>
        </p:nvSpPr>
        <p:spPr>
          <a:xfrm>
            <a:off x="4543156" y="13095596"/>
            <a:ext cx="3020695" cy="149225"/>
          </a:xfrm>
          <a:custGeom>
            <a:avLst/>
            <a:gdLst/>
            <a:ahLst/>
            <a:cxnLst/>
            <a:rect l="l" t="t" r="r" b="b"/>
            <a:pathLst>
              <a:path w="3020695" h="149225">
                <a:moveTo>
                  <a:pt x="3020387" y="74570"/>
                </a:moveTo>
                <a:lnTo>
                  <a:pt x="2771681" y="149199"/>
                </a:lnTo>
                <a:lnTo>
                  <a:pt x="2757363" y="101594"/>
                </a:lnTo>
                <a:lnTo>
                  <a:pt x="2764403" y="99446"/>
                </a:lnTo>
                <a:lnTo>
                  <a:pt x="0" y="99446"/>
                </a:lnTo>
                <a:lnTo>
                  <a:pt x="0" y="49693"/>
                </a:lnTo>
                <a:lnTo>
                  <a:pt x="2764403" y="49693"/>
                </a:lnTo>
                <a:lnTo>
                  <a:pt x="2757363" y="47665"/>
                </a:lnTo>
                <a:lnTo>
                  <a:pt x="2771681" y="0"/>
                </a:lnTo>
                <a:lnTo>
                  <a:pt x="3020387" y="74570"/>
                </a:lnTo>
                <a:close/>
              </a:path>
            </a:pathLst>
          </a:custGeom>
          <a:ln w="31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19" name="object 919"/>
          <p:cNvSpPr/>
          <p:nvPr/>
        </p:nvSpPr>
        <p:spPr>
          <a:xfrm>
            <a:off x="5219477" y="13045902"/>
            <a:ext cx="0" cy="99695"/>
          </a:xfrm>
          <a:custGeom>
            <a:avLst/>
            <a:gdLst/>
            <a:ahLst/>
            <a:cxnLst/>
            <a:rect l="l" t="t" r="r" b="b"/>
            <a:pathLst>
              <a:path h="99694">
                <a:moveTo>
                  <a:pt x="0" y="99387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0" name="object 920"/>
          <p:cNvSpPr/>
          <p:nvPr/>
        </p:nvSpPr>
        <p:spPr>
          <a:xfrm>
            <a:off x="6711595" y="13045902"/>
            <a:ext cx="0" cy="99695"/>
          </a:xfrm>
          <a:custGeom>
            <a:avLst/>
            <a:gdLst/>
            <a:ahLst/>
            <a:cxnLst/>
            <a:rect l="l" t="t" r="r" b="b"/>
            <a:pathLst>
              <a:path h="99694">
                <a:moveTo>
                  <a:pt x="0" y="99387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1" name="object 921"/>
          <p:cNvSpPr/>
          <p:nvPr/>
        </p:nvSpPr>
        <p:spPr>
          <a:xfrm>
            <a:off x="5219477" y="13097981"/>
            <a:ext cx="1492250" cy="0"/>
          </a:xfrm>
          <a:custGeom>
            <a:avLst/>
            <a:gdLst/>
            <a:ahLst/>
            <a:cxnLst/>
            <a:rect l="l" t="t" r="r" b="b"/>
            <a:pathLst>
              <a:path w="1492250">
                <a:moveTo>
                  <a:pt x="1492117" y="0"/>
                </a:moveTo>
                <a:lnTo>
                  <a:pt x="0" y="0"/>
                </a:lnTo>
              </a:path>
            </a:pathLst>
          </a:custGeom>
          <a:ln w="5482">
            <a:solidFill>
              <a:srgbClr val="231F20"/>
            </a:solidFill>
            <a:prstDash val="sysDash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2" name="object 922"/>
          <p:cNvSpPr txBox="1"/>
          <p:nvPr/>
        </p:nvSpPr>
        <p:spPr>
          <a:xfrm>
            <a:off x="5766811" y="13006480"/>
            <a:ext cx="275590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25" dirty="0">
                <a:solidFill>
                  <a:srgbClr val="ED1F24"/>
                </a:solidFill>
                <a:latin typeface="Calibri"/>
                <a:cs typeface="Calibri"/>
              </a:rPr>
              <a:t>Max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365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Day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23" name="object 923"/>
          <p:cNvSpPr txBox="1"/>
          <p:nvPr/>
        </p:nvSpPr>
        <p:spPr>
          <a:xfrm>
            <a:off x="5115316" y="12953986"/>
            <a:ext cx="20891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dmission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24" name="object 924"/>
          <p:cNvSpPr txBox="1"/>
          <p:nvPr/>
        </p:nvSpPr>
        <p:spPr>
          <a:xfrm>
            <a:off x="6573618" y="12918012"/>
            <a:ext cx="27686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97790" marR="5080" indent="-85725">
              <a:lnSpc>
                <a:spcPct val="115199"/>
              </a:lnSpc>
              <a:spcBef>
                <a:spcPts val="80"/>
              </a:spcBef>
            </a:pP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a</a:t>
            </a:r>
            <a:r>
              <a:rPr sz="300" spc="30" dirty="0">
                <a:solidFill>
                  <a:srgbClr val="231F20"/>
                </a:solidFill>
                <a:latin typeface="Calibri"/>
                <a:cs typeface="Calibri"/>
              </a:rPr>
              <a:t>s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u</a:t>
            </a:r>
            <a:r>
              <a:rPr sz="300" spc="-5" dirty="0">
                <a:solidFill>
                  <a:srgbClr val="231F20"/>
                </a:solidFill>
                <a:latin typeface="Calibri"/>
                <a:cs typeface="Calibri"/>
              </a:rPr>
              <a:t>r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40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nt 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Krea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25" name="object 925"/>
          <p:cNvSpPr/>
          <p:nvPr/>
        </p:nvSpPr>
        <p:spPr>
          <a:xfrm>
            <a:off x="4635140" y="8036993"/>
            <a:ext cx="1711325" cy="908050"/>
          </a:xfrm>
          <a:custGeom>
            <a:avLst/>
            <a:gdLst/>
            <a:ahLst/>
            <a:cxnLst/>
            <a:rect l="l" t="t" r="r" b="b"/>
            <a:pathLst>
              <a:path w="1711325" h="908050">
                <a:moveTo>
                  <a:pt x="80058" y="0"/>
                </a:moveTo>
                <a:lnTo>
                  <a:pt x="1228" y="178"/>
                </a:lnTo>
                <a:lnTo>
                  <a:pt x="0" y="594532"/>
                </a:lnTo>
                <a:lnTo>
                  <a:pt x="1711002" y="599483"/>
                </a:lnTo>
                <a:lnTo>
                  <a:pt x="1711002" y="907667"/>
                </a:lnTo>
              </a:path>
            </a:pathLst>
          </a:custGeom>
          <a:ln w="4384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6" name="object 926"/>
          <p:cNvSpPr/>
          <p:nvPr/>
        </p:nvSpPr>
        <p:spPr>
          <a:xfrm>
            <a:off x="6330691" y="8941617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4" h="15875">
                <a:moveTo>
                  <a:pt x="30901" y="0"/>
                </a:moveTo>
                <a:lnTo>
                  <a:pt x="0" y="0"/>
                </a:lnTo>
                <a:lnTo>
                  <a:pt x="15450" y="15450"/>
                </a:lnTo>
                <a:lnTo>
                  <a:pt x="30901" y="0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7" name="object 927"/>
          <p:cNvSpPr/>
          <p:nvPr/>
        </p:nvSpPr>
        <p:spPr>
          <a:xfrm>
            <a:off x="4605312" y="12047021"/>
            <a:ext cx="1298575" cy="934085"/>
          </a:xfrm>
          <a:custGeom>
            <a:avLst/>
            <a:gdLst/>
            <a:ahLst/>
            <a:cxnLst/>
            <a:rect l="l" t="t" r="r" b="b"/>
            <a:pathLst>
              <a:path w="1298575" h="934084">
                <a:moveTo>
                  <a:pt x="109886" y="59"/>
                </a:moveTo>
                <a:lnTo>
                  <a:pt x="0" y="0"/>
                </a:lnTo>
                <a:lnTo>
                  <a:pt x="0" y="536129"/>
                </a:lnTo>
                <a:lnTo>
                  <a:pt x="1298164" y="531177"/>
                </a:lnTo>
                <a:lnTo>
                  <a:pt x="1298080" y="934035"/>
                </a:lnTo>
              </a:path>
            </a:pathLst>
          </a:custGeom>
          <a:ln w="4384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8" name="object 928"/>
          <p:cNvSpPr/>
          <p:nvPr/>
        </p:nvSpPr>
        <p:spPr>
          <a:xfrm>
            <a:off x="5887947" y="1297795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4" h="15875">
                <a:moveTo>
                  <a:pt x="30883" y="0"/>
                </a:moveTo>
                <a:lnTo>
                  <a:pt x="0" y="0"/>
                </a:lnTo>
                <a:lnTo>
                  <a:pt x="15444" y="15391"/>
                </a:lnTo>
                <a:lnTo>
                  <a:pt x="30883" y="0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29" name="object 929"/>
          <p:cNvSpPr/>
          <p:nvPr/>
        </p:nvSpPr>
        <p:spPr>
          <a:xfrm>
            <a:off x="4648563" y="3064031"/>
            <a:ext cx="570865" cy="854710"/>
          </a:xfrm>
          <a:custGeom>
            <a:avLst/>
            <a:gdLst/>
            <a:ahLst/>
            <a:cxnLst/>
            <a:rect l="l" t="t" r="r" b="b"/>
            <a:pathLst>
              <a:path w="570864" h="854710">
                <a:moveTo>
                  <a:pt x="66373" y="0"/>
                </a:moveTo>
                <a:lnTo>
                  <a:pt x="0" y="214"/>
                </a:lnTo>
                <a:lnTo>
                  <a:pt x="351" y="599251"/>
                </a:lnTo>
                <a:lnTo>
                  <a:pt x="569471" y="598851"/>
                </a:lnTo>
                <a:lnTo>
                  <a:pt x="570610" y="854418"/>
                </a:lnTo>
              </a:path>
            </a:pathLst>
          </a:custGeom>
          <a:ln w="4384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0" name="object 930"/>
          <p:cNvSpPr/>
          <p:nvPr/>
        </p:nvSpPr>
        <p:spPr>
          <a:xfrm>
            <a:off x="5203728" y="391529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4" h="15875">
                <a:moveTo>
                  <a:pt x="30883" y="0"/>
                </a:moveTo>
                <a:lnTo>
                  <a:pt x="0" y="131"/>
                </a:lnTo>
                <a:lnTo>
                  <a:pt x="15486" y="15486"/>
                </a:lnTo>
                <a:lnTo>
                  <a:pt x="30883" y="0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1" name="object 931"/>
          <p:cNvSpPr txBox="1"/>
          <p:nvPr/>
        </p:nvSpPr>
        <p:spPr>
          <a:xfrm>
            <a:off x="4605598" y="13216121"/>
            <a:ext cx="248285" cy="15176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800" b="1" spc="10" dirty="0">
                <a:solidFill>
                  <a:srgbClr val="231F20"/>
                </a:solidFill>
                <a:latin typeface="Calibri"/>
                <a:cs typeface="Calibri"/>
              </a:rPr>
              <a:t>T</a:t>
            </a:r>
            <a:r>
              <a:rPr sz="800" b="1" spc="-10" dirty="0">
                <a:solidFill>
                  <a:srgbClr val="231F20"/>
                </a:solidFill>
                <a:latin typeface="Calibri"/>
                <a:cs typeface="Calibri"/>
              </a:rPr>
              <a:t>I</a:t>
            </a:r>
            <a:r>
              <a:rPr sz="800" b="1" spc="1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932" name="object 932"/>
          <p:cNvSpPr txBox="1"/>
          <p:nvPr/>
        </p:nvSpPr>
        <p:spPr>
          <a:xfrm>
            <a:off x="4605598" y="9183603"/>
            <a:ext cx="248285" cy="15176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800" b="1" spc="10" dirty="0">
                <a:solidFill>
                  <a:srgbClr val="231F20"/>
                </a:solidFill>
                <a:latin typeface="Calibri"/>
                <a:cs typeface="Calibri"/>
              </a:rPr>
              <a:t>T</a:t>
            </a:r>
            <a:r>
              <a:rPr sz="800" b="1" spc="-10" dirty="0">
                <a:solidFill>
                  <a:srgbClr val="231F20"/>
                </a:solidFill>
                <a:latin typeface="Calibri"/>
                <a:cs typeface="Calibri"/>
              </a:rPr>
              <a:t>I</a:t>
            </a:r>
            <a:r>
              <a:rPr sz="800" b="1" spc="1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933" name="object 933"/>
          <p:cNvSpPr/>
          <p:nvPr/>
        </p:nvSpPr>
        <p:spPr>
          <a:xfrm>
            <a:off x="8522158" y="9156617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50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4" name="object 934"/>
          <p:cNvSpPr/>
          <p:nvPr/>
        </p:nvSpPr>
        <p:spPr>
          <a:xfrm>
            <a:off x="7776754" y="9158228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50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5" name="object 935"/>
          <p:cNvSpPr txBox="1"/>
          <p:nvPr/>
        </p:nvSpPr>
        <p:spPr>
          <a:xfrm>
            <a:off x="4605598" y="4208821"/>
            <a:ext cx="248285" cy="151765"/>
          </a:xfrm>
          <a:prstGeom prst="rect">
            <a:avLst/>
          </a:prstGeom>
        </p:spPr>
        <p:txBody>
          <a:bodyPr vert="horz" wrap="square" lIns="0" tIns="1587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25"/>
              </a:spcBef>
            </a:pPr>
            <a:r>
              <a:rPr sz="800" b="1" spc="10" dirty="0">
                <a:solidFill>
                  <a:srgbClr val="231F20"/>
                </a:solidFill>
                <a:latin typeface="Calibri"/>
                <a:cs typeface="Calibri"/>
              </a:rPr>
              <a:t>T</a:t>
            </a:r>
            <a:r>
              <a:rPr sz="800" b="1" spc="-10" dirty="0">
                <a:solidFill>
                  <a:srgbClr val="231F20"/>
                </a:solidFill>
                <a:latin typeface="Calibri"/>
                <a:cs typeface="Calibri"/>
              </a:rPr>
              <a:t>I</a:t>
            </a:r>
            <a:r>
              <a:rPr sz="800" b="1" spc="1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936" name="object 936"/>
          <p:cNvSpPr/>
          <p:nvPr/>
        </p:nvSpPr>
        <p:spPr>
          <a:xfrm>
            <a:off x="8207352" y="417221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44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7" name="object 937"/>
          <p:cNvSpPr/>
          <p:nvPr/>
        </p:nvSpPr>
        <p:spPr>
          <a:xfrm>
            <a:off x="6711595" y="4180155"/>
            <a:ext cx="0" cy="99695"/>
          </a:xfrm>
          <a:custGeom>
            <a:avLst/>
            <a:gdLst/>
            <a:ahLst/>
            <a:cxnLst/>
            <a:rect l="l" t="t" r="r" b="b"/>
            <a:pathLst>
              <a:path h="99695">
                <a:moveTo>
                  <a:pt x="0" y="99446"/>
                </a:moveTo>
                <a:lnTo>
                  <a:pt x="0" y="0"/>
                </a:lnTo>
              </a:path>
            </a:pathLst>
          </a:custGeom>
          <a:ln w="8775">
            <a:solidFill>
              <a:srgbClr val="231F2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8" name="object 938"/>
          <p:cNvSpPr/>
          <p:nvPr/>
        </p:nvSpPr>
        <p:spPr>
          <a:xfrm>
            <a:off x="6715235" y="4234376"/>
            <a:ext cx="1492250" cy="0"/>
          </a:xfrm>
          <a:custGeom>
            <a:avLst/>
            <a:gdLst/>
            <a:ahLst/>
            <a:cxnLst/>
            <a:rect l="l" t="t" r="r" b="b"/>
            <a:pathLst>
              <a:path w="1492250">
                <a:moveTo>
                  <a:pt x="1492117" y="0"/>
                </a:moveTo>
                <a:lnTo>
                  <a:pt x="0" y="0"/>
                </a:lnTo>
              </a:path>
            </a:pathLst>
          </a:custGeom>
          <a:ln w="5482">
            <a:solidFill>
              <a:srgbClr val="231F20"/>
            </a:solidFill>
            <a:prstDash val="sysDash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39" name="object 939"/>
          <p:cNvSpPr txBox="1"/>
          <p:nvPr/>
        </p:nvSpPr>
        <p:spPr>
          <a:xfrm>
            <a:off x="7340081" y="4240929"/>
            <a:ext cx="253365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25" dirty="0">
                <a:solidFill>
                  <a:srgbClr val="ED1F24"/>
                </a:solidFill>
                <a:latin typeface="Calibri"/>
                <a:cs typeface="Calibri"/>
              </a:rPr>
              <a:t>Max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30</a:t>
            </a:r>
            <a:r>
              <a:rPr sz="300" spc="-20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Day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40" name="object 940"/>
          <p:cNvSpPr txBox="1"/>
          <p:nvPr/>
        </p:nvSpPr>
        <p:spPr>
          <a:xfrm>
            <a:off x="8073616" y="4288745"/>
            <a:ext cx="276860" cy="129539"/>
          </a:xfrm>
          <a:prstGeom prst="rect">
            <a:avLst/>
          </a:prstGeom>
        </p:spPr>
        <p:txBody>
          <a:bodyPr vert="horz" wrap="square" lIns="0" tIns="10160" rIns="0" bIns="0" rtlCol="0">
            <a:spAutoFit/>
          </a:bodyPr>
          <a:lstStyle/>
          <a:p>
            <a:pPr marL="86995" marR="5080" indent="-74930">
              <a:lnSpc>
                <a:spcPct val="115100"/>
              </a:lnSpc>
              <a:spcBef>
                <a:spcPts val="80"/>
              </a:spcBef>
            </a:pP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Me</a:t>
            </a:r>
            <a:r>
              <a:rPr sz="300" spc="5" dirty="0">
                <a:solidFill>
                  <a:srgbClr val="231F20"/>
                </a:solidFill>
                <a:latin typeface="Calibri"/>
                <a:cs typeface="Calibri"/>
              </a:rPr>
              <a:t>a</a:t>
            </a:r>
            <a:r>
              <a:rPr sz="300" spc="30" dirty="0">
                <a:solidFill>
                  <a:srgbClr val="231F20"/>
                </a:solidFill>
                <a:latin typeface="Calibri"/>
                <a:cs typeface="Calibri"/>
              </a:rPr>
              <a:t>s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u</a:t>
            </a:r>
            <a:r>
              <a:rPr sz="300" spc="-5" dirty="0">
                <a:solidFill>
                  <a:srgbClr val="231F20"/>
                </a:solidFill>
                <a:latin typeface="Calibri"/>
                <a:cs typeface="Calibri"/>
              </a:rPr>
              <a:t>r</a:t>
            </a:r>
            <a:r>
              <a:rPr sz="300" spc="25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40" dirty="0">
                <a:solidFill>
                  <a:srgbClr val="231F20"/>
                </a:solidFill>
                <a:latin typeface="Calibri"/>
                <a:cs typeface="Calibri"/>
              </a:rPr>
              <a:t>m</a:t>
            </a:r>
            <a:r>
              <a:rPr sz="300" dirty="0">
                <a:solidFill>
                  <a:srgbClr val="231F20"/>
                </a:solidFill>
                <a:latin typeface="Calibri"/>
                <a:cs typeface="Calibri"/>
              </a:rPr>
              <a:t>e</a:t>
            </a:r>
            <a:r>
              <a:rPr sz="300" spc="10" dirty="0">
                <a:solidFill>
                  <a:srgbClr val="231F20"/>
                </a:solidFill>
                <a:latin typeface="Calibri"/>
                <a:cs typeface="Calibri"/>
              </a:rPr>
              <a:t>nt 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Krea2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41" name="object 941"/>
          <p:cNvSpPr/>
          <p:nvPr/>
        </p:nvSpPr>
        <p:spPr>
          <a:xfrm>
            <a:off x="7777888" y="9214663"/>
            <a:ext cx="744855" cy="1905"/>
          </a:xfrm>
          <a:custGeom>
            <a:avLst/>
            <a:gdLst/>
            <a:ahLst/>
            <a:cxnLst/>
            <a:rect l="l" t="t" r="r" b="b"/>
            <a:pathLst>
              <a:path w="744854" h="1904">
                <a:moveTo>
                  <a:pt x="744269" y="1670"/>
                </a:moveTo>
                <a:lnTo>
                  <a:pt x="0" y="0"/>
                </a:lnTo>
              </a:path>
            </a:pathLst>
          </a:custGeom>
          <a:ln w="5482">
            <a:solidFill>
              <a:srgbClr val="231F20"/>
            </a:solidFill>
            <a:prstDash val="sysDash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2" name="object 942"/>
          <p:cNvSpPr txBox="1"/>
          <p:nvPr/>
        </p:nvSpPr>
        <p:spPr>
          <a:xfrm>
            <a:off x="7996417" y="9249096"/>
            <a:ext cx="246379" cy="76835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ED1F24"/>
                </a:solidFill>
                <a:latin typeface="Calibri"/>
                <a:cs typeface="Calibri"/>
              </a:rPr>
              <a:t>Min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90</a:t>
            </a:r>
            <a:r>
              <a:rPr sz="300" spc="-35" dirty="0">
                <a:solidFill>
                  <a:srgbClr val="ED1F24"/>
                </a:solidFill>
                <a:latin typeface="Calibri"/>
                <a:cs typeface="Calibri"/>
              </a:rPr>
              <a:t> </a:t>
            </a:r>
            <a:r>
              <a:rPr sz="300" spc="20" dirty="0">
                <a:solidFill>
                  <a:srgbClr val="ED1F24"/>
                </a:solidFill>
                <a:latin typeface="Calibri"/>
                <a:cs typeface="Calibri"/>
              </a:rPr>
              <a:t>Days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43" name="object 943"/>
          <p:cNvSpPr txBox="1"/>
          <p:nvPr/>
        </p:nvSpPr>
        <p:spPr>
          <a:xfrm>
            <a:off x="8386926" y="9270345"/>
            <a:ext cx="322580" cy="77470"/>
          </a:xfrm>
          <a:prstGeom prst="rect">
            <a:avLst/>
          </a:prstGeom>
        </p:spPr>
        <p:txBody>
          <a:bodyPr vert="horz" wrap="square" lIns="0" tIns="1714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35"/>
              </a:spcBef>
            </a:pP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Admission</a:t>
            </a:r>
            <a:r>
              <a:rPr sz="300" spc="-10" dirty="0">
                <a:solidFill>
                  <a:srgbClr val="231F20"/>
                </a:solidFill>
                <a:latin typeface="Calibri"/>
                <a:cs typeface="Calibri"/>
              </a:rPr>
              <a:t> </a:t>
            </a:r>
            <a:r>
              <a:rPr sz="300" spc="15" dirty="0">
                <a:solidFill>
                  <a:srgbClr val="231F20"/>
                </a:solidFill>
                <a:latin typeface="Calibri"/>
                <a:cs typeface="Calibri"/>
              </a:rPr>
              <a:t>Krea2</a:t>
            </a:r>
            <a:endParaRPr sz="300">
              <a:latin typeface="Calibri"/>
              <a:cs typeface="Calibri"/>
            </a:endParaRPr>
          </a:p>
        </p:txBody>
      </p:sp>
      <p:sp>
        <p:nvSpPr>
          <p:cNvPr id="944" name="object 944"/>
          <p:cNvSpPr/>
          <p:nvPr/>
        </p:nvSpPr>
        <p:spPr>
          <a:xfrm>
            <a:off x="7427886" y="3469442"/>
            <a:ext cx="895350" cy="748030"/>
          </a:xfrm>
          <a:custGeom>
            <a:avLst/>
            <a:gdLst/>
            <a:ahLst/>
            <a:cxnLst/>
            <a:rect l="l" t="t" r="r" b="b"/>
            <a:pathLst>
              <a:path w="895350" h="748029">
                <a:moveTo>
                  <a:pt x="895020" y="0"/>
                </a:moveTo>
                <a:lnTo>
                  <a:pt x="0" y="572"/>
                </a:lnTo>
                <a:lnTo>
                  <a:pt x="0" y="747956"/>
                </a:lnTo>
              </a:path>
            </a:pathLst>
          </a:custGeom>
          <a:ln w="4384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5" name="object 945"/>
          <p:cNvSpPr/>
          <p:nvPr/>
        </p:nvSpPr>
        <p:spPr>
          <a:xfrm>
            <a:off x="7412435" y="421428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901" y="0"/>
                </a:moveTo>
                <a:lnTo>
                  <a:pt x="0" y="0"/>
                </a:lnTo>
                <a:lnTo>
                  <a:pt x="15450" y="15438"/>
                </a:lnTo>
                <a:lnTo>
                  <a:pt x="30901" y="0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6" name="object 946"/>
          <p:cNvSpPr/>
          <p:nvPr/>
        </p:nvSpPr>
        <p:spPr>
          <a:xfrm>
            <a:off x="8116794" y="8442535"/>
            <a:ext cx="156845" cy="782320"/>
          </a:xfrm>
          <a:custGeom>
            <a:avLst/>
            <a:gdLst/>
            <a:ahLst/>
            <a:cxnLst/>
            <a:rect l="l" t="t" r="r" b="b"/>
            <a:pathLst>
              <a:path w="156845" h="782320">
                <a:moveTo>
                  <a:pt x="156656" y="656"/>
                </a:moveTo>
                <a:lnTo>
                  <a:pt x="0" y="0"/>
                </a:lnTo>
                <a:lnTo>
                  <a:pt x="1193" y="781912"/>
                </a:lnTo>
              </a:path>
            </a:pathLst>
          </a:custGeom>
          <a:ln w="4384">
            <a:solidFill>
              <a:srgbClr val="ED1F24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47" name="object 947"/>
          <p:cNvSpPr/>
          <p:nvPr/>
        </p:nvSpPr>
        <p:spPr>
          <a:xfrm>
            <a:off x="8102537" y="9221344"/>
            <a:ext cx="31115" cy="15875"/>
          </a:xfrm>
          <a:custGeom>
            <a:avLst/>
            <a:gdLst/>
            <a:ahLst/>
            <a:cxnLst/>
            <a:rect l="l" t="t" r="r" b="b"/>
            <a:pathLst>
              <a:path w="31115" h="15875">
                <a:moveTo>
                  <a:pt x="30901" y="0"/>
                </a:moveTo>
                <a:lnTo>
                  <a:pt x="0" y="59"/>
                </a:lnTo>
                <a:lnTo>
                  <a:pt x="15510" y="15510"/>
                </a:lnTo>
                <a:lnTo>
                  <a:pt x="30901" y="0"/>
                </a:lnTo>
                <a:close/>
              </a:path>
            </a:pathLst>
          </a:custGeom>
          <a:solidFill>
            <a:srgbClr val="ED1F24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535</Words>
  <Application>Microsoft Office PowerPoint</Application>
  <PresentationFormat>Benutzerdefiniert</PresentationFormat>
  <Paragraphs>86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Calibri</vt:lpstr>
      <vt:lpstr>Consolas</vt:lpstr>
      <vt:lpstr>Times New Roman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4 Algorithm all dignoses.pdf</dc:title>
  <dc:creator>Torbica, Nenad</dc:creator>
  <cp:lastModifiedBy>Triep, Karen</cp:lastModifiedBy>
  <cp:revision>1</cp:revision>
  <dcterms:created xsi:type="dcterms:W3CDTF">2021-06-20T13:22:29Z</dcterms:created>
  <dcterms:modified xsi:type="dcterms:W3CDTF">2021-06-20T13:57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6-20T00:00:00Z</vt:filetime>
  </property>
  <property fmtid="{D5CDD505-2E9C-101B-9397-08002B2CF9AE}" pid="3" name="Creator">
    <vt:lpwstr>Microsoft® Visio® 2016</vt:lpwstr>
  </property>
  <property fmtid="{D5CDD505-2E9C-101B-9397-08002B2CF9AE}" pid="4" name="LastSaved">
    <vt:filetime>2021-06-20T00:00:00Z</vt:filetime>
  </property>
</Properties>
</file>